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74" r:id="rId6"/>
    <p:sldId id="264" r:id="rId7"/>
    <p:sldId id="293" r:id="rId8"/>
    <p:sldId id="280" r:id="rId9"/>
    <p:sldId id="284" r:id="rId10"/>
    <p:sldId id="270" r:id="rId11"/>
    <p:sldId id="286" r:id="rId12"/>
    <p:sldId id="297" r:id="rId13"/>
    <p:sldId id="283" r:id="rId14"/>
    <p:sldId id="282" r:id="rId15"/>
    <p:sldId id="288" r:id="rId16"/>
    <p:sldId id="294" r:id="rId17"/>
    <p:sldId id="295" r:id="rId18"/>
    <p:sldId id="259" r:id="rId19"/>
    <p:sldId id="299" r:id="rId20"/>
    <p:sldId id="296" r:id="rId21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FFFF"/>
    <a:srgbClr val="0000FF"/>
    <a:srgbClr val="FF3BFF"/>
    <a:srgbClr val="E7E77D"/>
    <a:srgbClr val="E9E9B1"/>
    <a:srgbClr val="F7F593"/>
    <a:srgbClr val="E0E971"/>
    <a:srgbClr val="E7E593"/>
    <a:srgbClr val="E8DC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14AEB8-544A-8E4F-5BA9-926F3199FE47}" v="65" dt="2025-11-06T16:20:17.0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76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75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useppe Aprea" userId="S::giuseppe.aprea@enea.it::60880867-f14e-4284-b11a-7a8fe9983c7a" providerId="AD" clId="Web-{5914AEB8-544A-8E4F-5BA9-926F3199FE47}"/>
    <pc:docChg chg="addSld modSld">
      <pc:chgData name="Giuseppe Aprea" userId="S::giuseppe.aprea@enea.it::60880867-f14e-4284-b11a-7a8fe9983c7a" providerId="AD" clId="Web-{5914AEB8-544A-8E4F-5BA9-926F3199FE47}" dt="2025-11-06T16:20:17.084" v="63" actId="14100"/>
      <pc:docMkLst>
        <pc:docMk/>
      </pc:docMkLst>
      <pc:sldChg chg="mod modShow">
        <pc:chgData name="Giuseppe Aprea" userId="S::giuseppe.aprea@enea.it::60880867-f14e-4284-b11a-7a8fe9983c7a" providerId="AD" clId="Web-{5914AEB8-544A-8E4F-5BA9-926F3199FE47}" dt="2025-11-06T16:03:24.155" v="1"/>
        <pc:sldMkLst>
          <pc:docMk/>
          <pc:sldMk cId="2157721222" sldId="267"/>
        </pc:sldMkLst>
      </pc:sldChg>
      <pc:sldChg chg="addSp delSp modSp add replId">
        <pc:chgData name="Giuseppe Aprea" userId="S::giuseppe.aprea@enea.it::60880867-f14e-4284-b11a-7a8fe9983c7a" providerId="AD" clId="Web-{5914AEB8-544A-8E4F-5BA9-926F3199FE47}" dt="2025-11-06T16:20:17.084" v="63" actId="14100"/>
        <pc:sldMkLst>
          <pc:docMk/>
          <pc:sldMk cId="1124696691" sldId="279"/>
        </pc:sldMkLst>
        <pc:spChg chg="del">
          <ac:chgData name="Giuseppe Aprea" userId="S::giuseppe.aprea@enea.it::60880867-f14e-4284-b11a-7a8fe9983c7a" providerId="AD" clId="Web-{5914AEB8-544A-8E4F-5BA9-926F3199FE47}" dt="2025-11-06T16:03:37.031" v="5"/>
          <ac:spMkLst>
            <pc:docMk/>
            <pc:sldMk cId="1124696691" sldId="279"/>
            <ac:spMk id="2" creationId="{4E7C3350-930A-9520-0A1F-D069594C648C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4"/>
          <ac:spMkLst>
            <pc:docMk/>
            <pc:sldMk cId="1124696691" sldId="279"/>
            <ac:spMk id="3" creationId="{8D5BA87E-1C04-6B5D-E8F9-F44C3D5B9E49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7"/>
          <ac:spMkLst>
            <pc:docMk/>
            <pc:sldMk cId="1124696691" sldId="279"/>
            <ac:spMk id="4" creationId="{B60CC9BA-94CD-5380-97B4-E577F3356ACB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6"/>
          <ac:spMkLst>
            <pc:docMk/>
            <pc:sldMk cId="1124696691" sldId="279"/>
            <ac:spMk id="5" creationId="{E9DF02C4-6A7F-3E28-9F35-775EB967DBAB}"/>
          </ac:spMkLst>
        </pc:spChg>
        <pc:spChg chg="mod">
          <ac:chgData name="Giuseppe Aprea" userId="S::giuseppe.aprea@enea.it::60880867-f14e-4284-b11a-7a8fe9983c7a" providerId="AD" clId="Web-{5914AEB8-544A-8E4F-5BA9-926F3199FE47}" dt="2025-11-06T16:20:12.506" v="62" actId="1076"/>
          <ac:spMkLst>
            <pc:docMk/>
            <pc:sldMk cId="1124696691" sldId="279"/>
            <ac:spMk id="6" creationId="{D5783CAC-2A27-DFC0-4981-2AC43D128173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5"/>
          <ac:spMkLst>
            <pc:docMk/>
            <pc:sldMk cId="1124696691" sldId="279"/>
            <ac:spMk id="8" creationId="{5DE9A61F-E090-7BE1-66D9-ED28853335E9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23"/>
          <ac:spMkLst>
            <pc:docMk/>
            <pc:sldMk cId="1124696691" sldId="279"/>
            <ac:spMk id="9" creationId="{00E680D5-8673-B32E-1923-17846E35E4F5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22"/>
          <ac:spMkLst>
            <pc:docMk/>
            <pc:sldMk cId="1124696691" sldId="279"/>
            <ac:spMk id="10" creationId="{78FEB81F-838E-D278-D8BA-8164BF1249D9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3"/>
          <ac:spMkLst>
            <pc:docMk/>
            <pc:sldMk cId="1124696691" sldId="279"/>
            <ac:spMk id="11" creationId="{5117E3C6-9D31-330A-728A-8B321B7E1926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14.157" v="53"/>
          <ac:spMkLst>
            <pc:docMk/>
            <pc:sldMk cId="1124696691" sldId="279"/>
            <ac:spMk id="13" creationId="{BA5B882B-B143-021D-3ADD-C02594643272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21"/>
          <ac:spMkLst>
            <pc:docMk/>
            <pc:sldMk cId="1124696691" sldId="279"/>
            <ac:spMk id="14" creationId="{345B7B38-48C4-0158-FB55-02501D0B6093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3"/>
          <ac:spMkLst>
            <pc:docMk/>
            <pc:sldMk cId="1124696691" sldId="279"/>
            <ac:spMk id="15" creationId="{A551C39B-5909-CB6D-D4D5-CA1CF51671BF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20"/>
          <ac:spMkLst>
            <pc:docMk/>
            <pc:sldMk cId="1124696691" sldId="279"/>
            <ac:spMk id="16" creationId="{097713FB-7DEB-DE8F-4670-CB256B0DA657}"/>
          </ac:spMkLst>
        </pc:spChg>
        <pc:spChg chg="mod">
          <ac:chgData name="Giuseppe Aprea" userId="S::giuseppe.aprea@enea.it::60880867-f14e-4284-b11a-7a8fe9983c7a" providerId="AD" clId="Web-{5914AEB8-544A-8E4F-5BA9-926F3199FE47}" dt="2025-11-06T16:19:38.598" v="59" actId="1076"/>
          <ac:spMkLst>
            <pc:docMk/>
            <pc:sldMk cId="1124696691" sldId="279"/>
            <ac:spMk id="17" creationId="{516E0F35-5E8A-2771-4E07-6F576F3F1EC5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2"/>
          <ac:spMkLst>
            <pc:docMk/>
            <pc:sldMk cId="1124696691" sldId="279"/>
            <ac:spMk id="18" creationId="{12987A63-170F-A666-EC35-0F376B076E2C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10"/>
          <ac:spMkLst>
            <pc:docMk/>
            <pc:sldMk cId="1124696691" sldId="279"/>
            <ac:spMk id="20" creationId="{CE369E8C-8F5F-75EE-912B-E3ED3E81D9D7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8"/>
          <ac:spMkLst>
            <pc:docMk/>
            <pc:sldMk cId="1124696691" sldId="279"/>
            <ac:spMk id="22" creationId="{5D6610C0-B523-9673-D77C-F64A9B69CF32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19"/>
          <ac:spMkLst>
            <pc:docMk/>
            <pc:sldMk cId="1124696691" sldId="279"/>
            <ac:spMk id="24" creationId="{265BFBA9-57F1-A5AE-62C2-FFF2F6185AEE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37.031" v="2"/>
          <ac:spMkLst>
            <pc:docMk/>
            <pc:sldMk cId="1124696691" sldId="279"/>
            <ac:spMk id="26" creationId="{8DC796BC-1F64-13A2-7192-54A4515377FA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14.157" v="49"/>
          <ac:spMkLst>
            <pc:docMk/>
            <pc:sldMk cId="1124696691" sldId="279"/>
            <ac:spMk id="31" creationId="{9941E400-42FC-862D-D146-EDF594782FC6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3:56.828" v="18"/>
          <ac:spMkLst>
            <pc:docMk/>
            <pc:sldMk cId="1124696691" sldId="279"/>
            <ac:spMk id="35" creationId="{23B25D72-0B3F-E9DC-9FF6-1CF2DA04D0B1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34"/>
          <ac:spMkLst>
            <pc:docMk/>
            <pc:sldMk cId="1124696691" sldId="279"/>
            <ac:spMk id="36" creationId="{635B46C7-55BD-5A4F-0DC8-5969B79911ED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33"/>
          <ac:spMkLst>
            <pc:docMk/>
            <pc:sldMk cId="1124696691" sldId="279"/>
            <ac:spMk id="37" creationId="{CAAC711E-5965-8D19-2A79-197BCCE8591D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32"/>
          <ac:spMkLst>
            <pc:docMk/>
            <pc:sldMk cId="1124696691" sldId="279"/>
            <ac:spMk id="38" creationId="{10F7E07C-43BB-1589-05DA-75B7E135FF40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45"/>
          <ac:spMkLst>
            <pc:docMk/>
            <pc:sldMk cId="1124696691" sldId="279"/>
            <ac:spMk id="39" creationId="{64636020-887D-BA37-F48E-51EDFC9EE0A1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31"/>
          <ac:spMkLst>
            <pc:docMk/>
            <pc:sldMk cId="1124696691" sldId="279"/>
            <ac:spMk id="40" creationId="{F984C68B-492E-E143-DAE0-6F4F29E9488D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30"/>
          <ac:spMkLst>
            <pc:docMk/>
            <pc:sldMk cId="1124696691" sldId="279"/>
            <ac:spMk id="41" creationId="{DE28CE96-0FC1-E6D4-05A8-653453C17131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9"/>
          <ac:spMkLst>
            <pc:docMk/>
            <pc:sldMk cId="1124696691" sldId="279"/>
            <ac:spMk id="43" creationId="{D5C86899-017E-67C5-B1BC-854BDC4D4352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8"/>
          <ac:spMkLst>
            <pc:docMk/>
            <pc:sldMk cId="1124696691" sldId="279"/>
            <ac:spMk id="44" creationId="{95C239D2-3B4D-6158-F0DD-82A503BBC63F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7"/>
          <ac:spMkLst>
            <pc:docMk/>
            <pc:sldMk cId="1124696691" sldId="279"/>
            <ac:spMk id="45" creationId="{CAB39B1C-26B9-E7CE-EC85-E1C63871A2B5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43"/>
          <ac:spMkLst>
            <pc:docMk/>
            <pc:sldMk cId="1124696691" sldId="279"/>
            <ac:spMk id="46" creationId="{E997CBEA-B5E8-095A-3301-5A16A1CF2420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6"/>
          <ac:spMkLst>
            <pc:docMk/>
            <pc:sldMk cId="1124696691" sldId="279"/>
            <ac:spMk id="48" creationId="{B65E82EF-5EBF-883D-06D4-30FC963DAB9E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5"/>
          <ac:spMkLst>
            <pc:docMk/>
            <pc:sldMk cId="1124696691" sldId="279"/>
            <ac:spMk id="50" creationId="{80F73370-5A59-3ACF-2CC8-18F1C4A68211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1.844" v="24"/>
          <ac:spMkLst>
            <pc:docMk/>
            <pc:sldMk cId="1124696691" sldId="279"/>
            <ac:spMk id="52" creationId="{E8340156-A8BF-13B7-C671-DB30AE8CA08A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38"/>
          <ac:spMkLst>
            <pc:docMk/>
            <pc:sldMk cId="1124696691" sldId="279"/>
            <ac:spMk id="54" creationId="{2C4F2A79-EDA0-A2CA-3D61-E7CE28D582AC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37"/>
          <ac:spMkLst>
            <pc:docMk/>
            <pc:sldMk cId="1124696691" sldId="279"/>
            <ac:spMk id="55" creationId="{D553898E-CB39-C9D8-E28D-443DDE88EAB3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36"/>
          <ac:spMkLst>
            <pc:docMk/>
            <pc:sldMk cId="1124696691" sldId="279"/>
            <ac:spMk id="56" creationId="{C049F508-6A7C-04F4-677C-85AC4070654B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07.766" v="35"/>
          <ac:spMkLst>
            <pc:docMk/>
            <pc:sldMk cId="1124696691" sldId="279"/>
            <ac:spMk id="57" creationId="{C5D46506-7160-950F-F175-40D498B32354}"/>
          </ac:spMkLst>
        </pc:spChg>
        <pc:spChg chg="del">
          <ac:chgData name="Giuseppe Aprea" userId="S::giuseppe.aprea@enea.it::60880867-f14e-4284-b11a-7a8fe9983c7a" providerId="AD" clId="Web-{5914AEB8-544A-8E4F-5BA9-926F3199FE47}" dt="2025-11-06T16:04:14.157" v="46"/>
          <ac:spMkLst>
            <pc:docMk/>
            <pc:sldMk cId="1124696691" sldId="279"/>
            <ac:spMk id="60" creationId="{6D89F748-5CE0-1CEC-AD99-5286339C5D63}"/>
          </ac:spMkLst>
        </pc:spChg>
        <pc:picChg chg="add del mod">
          <ac:chgData name="Giuseppe Aprea" userId="S::giuseppe.aprea@enea.it::60880867-f14e-4284-b11a-7a8fe9983c7a" providerId="AD" clId="Web-{5914AEB8-544A-8E4F-5BA9-926F3199FE47}" dt="2025-11-06T16:18:37.784" v="55"/>
          <ac:picMkLst>
            <pc:docMk/>
            <pc:sldMk cId="1124696691" sldId="279"/>
            <ac:picMk id="7" creationId="{E79B50EA-6D5E-D59F-38FD-59C54E74B809}"/>
          </ac:picMkLst>
        </pc:picChg>
        <pc:picChg chg="add mod">
          <ac:chgData name="Giuseppe Aprea" userId="S::giuseppe.aprea@enea.it::60880867-f14e-4284-b11a-7a8fe9983c7a" providerId="AD" clId="Web-{5914AEB8-544A-8E4F-5BA9-926F3199FE47}" dt="2025-11-06T16:20:17.084" v="63" actId="14100"/>
          <ac:picMkLst>
            <pc:docMk/>
            <pc:sldMk cId="1124696691" sldId="279"/>
            <ac:picMk id="27" creationId="{E2D29DFF-EBA2-7577-D869-CAB0B94F7960}"/>
          </ac:picMkLst>
        </pc:picChg>
        <pc:cxnChg chg="del">
          <ac:chgData name="Giuseppe Aprea" userId="S::giuseppe.aprea@enea.it::60880867-f14e-4284-b11a-7a8fe9983c7a" providerId="AD" clId="Web-{5914AEB8-544A-8E4F-5BA9-926F3199FE47}" dt="2025-11-06T16:03:37.031" v="14"/>
          <ac:cxnSpMkLst>
            <pc:docMk/>
            <pc:sldMk cId="1124696691" sldId="279"/>
            <ac:cxnSpMk id="12" creationId="{805E6B59-551C-0757-6D44-8257A125D3A2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3:37.031" v="11"/>
          <ac:cxnSpMkLst>
            <pc:docMk/>
            <pc:sldMk cId="1124696691" sldId="279"/>
            <ac:cxnSpMk id="19" creationId="{D7DA80EE-B533-6D91-49A1-5C404CA2C4AC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3:37.031" v="9"/>
          <ac:cxnSpMkLst>
            <pc:docMk/>
            <pc:sldMk cId="1124696691" sldId="279"/>
            <ac:cxnSpMk id="21" creationId="{B3F74C25-1FBF-6758-70E2-F32084DD5411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3:37.031" v="7"/>
          <ac:cxnSpMkLst>
            <pc:docMk/>
            <pc:sldMk cId="1124696691" sldId="279"/>
            <ac:cxnSpMk id="23" creationId="{67C5C295-9B70-2B45-07E1-658D2CE9EEF0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3:37.031" v="6"/>
          <ac:cxnSpMkLst>
            <pc:docMk/>
            <pc:sldMk cId="1124696691" sldId="279"/>
            <ac:cxnSpMk id="25" creationId="{8FCFE9CF-9E5A-9B89-5712-EA6D99E1542D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14.157" v="52"/>
          <ac:cxnSpMkLst>
            <pc:docMk/>
            <pc:sldMk cId="1124696691" sldId="279"/>
            <ac:cxnSpMk id="28" creationId="{4D6ACEA0-C3FB-F027-EB62-AC0000282FB3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14.157" v="51"/>
          <ac:cxnSpMkLst>
            <pc:docMk/>
            <pc:sldMk cId="1124696691" sldId="279"/>
            <ac:cxnSpMk id="29" creationId="{1C799412-72C0-42DD-79E8-B1770F0AE9B0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14.157" v="50"/>
          <ac:cxnSpMkLst>
            <pc:docMk/>
            <pc:sldMk cId="1124696691" sldId="279"/>
            <ac:cxnSpMk id="30" creationId="{A169D196-22C3-A3CC-F488-EE161B8C56D3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07.766" v="44"/>
          <ac:cxnSpMkLst>
            <pc:docMk/>
            <pc:sldMk cId="1124696691" sldId="279"/>
            <ac:cxnSpMk id="42" creationId="{29B95810-E65B-23B6-AFA8-B9A1B6C4983B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07.766" v="42"/>
          <ac:cxnSpMkLst>
            <pc:docMk/>
            <pc:sldMk cId="1124696691" sldId="279"/>
            <ac:cxnSpMk id="47" creationId="{31E91684-449E-B95C-0ABB-5632A00B4717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07.766" v="41"/>
          <ac:cxnSpMkLst>
            <pc:docMk/>
            <pc:sldMk cId="1124696691" sldId="279"/>
            <ac:cxnSpMk id="49" creationId="{5C2D0576-D9C6-649D-4AF1-C8E0EF44F772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07.766" v="40"/>
          <ac:cxnSpMkLst>
            <pc:docMk/>
            <pc:sldMk cId="1124696691" sldId="279"/>
            <ac:cxnSpMk id="51" creationId="{A54FD77A-154E-2A56-816E-40BC5924B5A3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07.766" v="39"/>
          <ac:cxnSpMkLst>
            <pc:docMk/>
            <pc:sldMk cId="1124696691" sldId="279"/>
            <ac:cxnSpMk id="53" creationId="{95C88D4F-D7ED-47D9-7A25-A968458DDCEC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14.157" v="48"/>
          <ac:cxnSpMkLst>
            <pc:docMk/>
            <pc:sldMk cId="1124696691" sldId="279"/>
            <ac:cxnSpMk id="58" creationId="{60EC8BAD-BFF5-0C74-4B91-0BD93101A5C5}"/>
          </ac:cxnSpMkLst>
        </pc:cxnChg>
        <pc:cxnChg chg="del">
          <ac:chgData name="Giuseppe Aprea" userId="S::giuseppe.aprea@enea.it::60880867-f14e-4284-b11a-7a8fe9983c7a" providerId="AD" clId="Web-{5914AEB8-544A-8E4F-5BA9-926F3199FE47}" dt="2025-11-06T16:04:14.157" v="47"/>
          <ac:cxnSpMkLst>
            <pc:docMk/>
            <pc:sldMk cId="1124696691" sldId="279"/>
            <ac:cxnSpMk id="59" creationId="{86326E34-DE65-5C4D-0359-F24580B5640B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Classeur10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Classeur10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3%20fenotipizzazioni%20Avignon%202023-07-24%20-%20per%20articol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rlo%20Rosati\Desktop\CARLO\2006-____%20ENEA\0-Publis%20Rosati\2025%20articolo%20mapping%20F2%20INRAe-ENEA\2025-06-18%20INRAE%202025-03-07%20Tables_v2_revCR%20-%20INRAE%20data%20x%20articolo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b="1">
                <a:latin typeface="Calibri" panose="020F0502020204030204" pitchFamily="34" charset="0"/>
                <a:cs typeface="Calibri" panose="020F0502020204030204" pitchFamily="34" charset="0"/>
              </a:rPr>
              <a:t>FW</a:t>
            </a:r>
            <a:r>
              <a:rPr lang="en-US" b="1" baseline="-30000">
                <a:latin typeface="Calibri" panose="020F0502020204030204" pitchFamily="34" charset="0"/>
                <a:cs typeface="Calibri" panose="020F0502020204030204" pitchFamily="34" charset="0"/>
              </a:rPr>
              <a:t>T0</a:t>
            </a:r>
          </a:p>
        </c:rich>
      </c:tx>
      <c:layout>
        <c:manualLayout>
          <c:xMode val="edge"/>
          <c:yMode val="edge"/>
          <c:x val="0.43890201005025126"/>
          <c:y val="1.86902133922001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669570072585148"/>
          <c:y val="0.10788925680647535"/>
          <c:w val="0.82221663874930206"/>
          <c:h val="0.73135945548197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C$5:$AC$14</c:f>
              <c:numCache>
                <c:formatCode>General</c:formatCode>
                <c:ptCount val="10"/>
                <c:pt idx="0">
                  <c:v>39</c:v>
                </c:pt>
                <c:pt idx="1">
                  <c:v>58</c:v>
                </c:pt>
                <c:pt idx="2">
                  <c:v>77</c:v>
                </c:pt>
                <c:pt idx="3">
                  <c:v>96</c:v>
                </c:pt>
                <c:pt idx="4">
                  <c:v>115</c:v>
                </c:pt>
                <c:pt idx="5">
                  <c:v>134</c:v>
                </c:pt>
                <c:pt idx="6">
                  <c:v>153</c:v>
                </c:pt>
                <c:pt idx="7">
                  <c:v>172</c:v>
                </c:pt>
                <c:pt idx="8">
                  <c:v>191</c:v>
                </c:pt>
                <c:pt idx="9">
                  <c:v>210</c:v>
                </c:pt>
              </c:numCache>
            </c:numRef>
          </c:cat>
          <c:val>
            <c:numRef>
              <c:f>'Table S1 INRAe pheno'!$AD$5:$AD$14</c:f>
              <c:numCache>
                <c:formatCode>General</c:formatCode>
                <c:ptCount val="10"/>
                <c:pt idx="0">
                  <c:v>2</c:v>
                </c:pt>
                <c:pt idx="1">
                  <c:v>11</c:v>
                </c:pt>
                <c:pt idx="2">
                  <c:v>40</c:v>
                </c:pt>
                <c:pt idx="3">
                  <c:v>68</c:v>
                </c:pt>
                <c:pt idx="4">
                  <c:v>66</c:v>
                </c:pt>
                <c:pt idx="5">
                  <c:v>22</c:v>
                </c:pt>
                <c:pt idx="6">
                  <c:v>0</c:v>
                </c:pt>
                <c:pt idx="7">
                  <c:v>2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DC-416A-BF8B-12B050EDBF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431535216"/>
        <c:axId val="431537568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E$5:$AE$14</c:f>
              <c:numCache>
                <c:formatCode>0.00000</c:formatCode>
                <c:ptCount val="10"/>
                <c:pt idx="0">
                  <c:v>8.3587937554891216E-4</c:v>
                </c:pt>
                <c:pt idx="1">
                  <c:v>5.3318515722205325E-3</c:v>
                </c:pt>
                <c:pt idx="2">
                  <c:v>1.4988368166687714E-2</c:v>
                </c:pt>
                <c:pt idx="3">
                  <c:v>1.8568315788596218E-2</c:v>
                </c:pt>
                <c:pt idx="4">
                  <c:v>1.0137538918391349E-2</c:v>
                </c:pt>
                <c:pt idx="5">
                  <c:v>2.4391270094665076E-3</c:v>
                </c:pt>
                <c:pt idx="6">
                  <c:v>2.5862955708143824E-4</c:v>
                </c:pt>
                <c:pt idx="7">
                  <c:v>1.2085475898805591E-5</c:v>
                </c:pt>
                <c:pt idx="8">
                  <c:v>2.4888069853034504E-7</c:v>
                </c:pt>
                <c:pt idx="9">
                  <c:v>2.2587103259782358E-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ADC-416A-BF8B-12B050EDBF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1534432"/>
        <c:axId val="431532864"/>
      </c:lineChart>
      <c:catAx>
        <c:axId val="431535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FW</a:t>
                </a:r>
                <a:r>
                  <a:rPr lang="en-US" baseline="-30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0</a:t>
                </a: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 bin (grams)</a:t>
                </a:r>
              </a:p>
            </c:rich>
          </c:tx>
          <c:layout>
            <c:manualLayout>
              <c:xMode val="edge"/>
              <c:yMode val="edge"/>
              <c:x val="0.40794863204913456"/>
              <c:y val="0.921956217807211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431537568"/>
        <c:crosses val="autoZero"/>
        <c:auto val="1"/>
        <c:lblAlgn val="ctr"/>
        <c:lblOffset val="100"/>
        <c:noMultiLvlLbl val="0"/>
      </c:catAx>
      <c:valAx>
        <c:axId val="43153756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>
                    <a:latin typeface="Calibri" panose="020F0502020204030204" pitchFamily="34" charset="0"/>
                    <a:cs typeface="Calibri" panose="020F0502020204030204" pitchFamily="34" charset="0"/>
                  </a:rPr>
                  <a:t>Frequency</a:t>
                </a:r>
              </a:p>
            </c:rich>
          </c:tx>
          <c:layout>
            <c:manualLayout>
              <c:xMode val="edge"/>
              <c:yMode val="edge"/>
              <c:x val="1.3762144053601337E-2"/>
              <c:y val="0.386623620309050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431535216"/>
        <c:crosses val="autoZero"/>
        <c:crossBetween val="between"/>
      </c:valAx>
      <c:valAx>
        <c:axId val="431532864"/>
        <c:scaling>
          <c:orientation val="minMax"/>
          <c:max val="2.5000000000000005E-2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34432"/>
        <c:crosses val="max"/>
        <c:crossBetween val="between"/>
      </c:valAx>
      <c:catAx>
        <c:axId val="431534432"/>
        <c:scaling>
          <c:orientation val="minMax"/>
        </c:scaling>
        <c:delete val="1"/>
        <c:axPos val="b"/>
        <c:majorTickMark val="out"/>
        <c:minorTickMark val="none"/>
        <c:tickLblPos val="nextTo"/>
        <c:crossAx val="43153286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L*</a:t>
            </a:r>
            <a:r>
              <a:rPr lang="en-US" b="1" baseline="-30000"/>
              <a:t>T0</a:t>
            </a:r>
          </a:p>
        </c:rich>
      </c:tx>
      <c:layout>
        <c:manualLayout>
          <c:xMode val="edge"/>
          <c:yMode val="edge"/>
          <c:x val="0.51386717429993922"/>
          <c:y val="1.85185185185185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786613800716394"/>
          <c:y val="0.1115277777777778"/>
          <c:w val="0.76702561445403139"/>
          <c:h val="0.729197652376786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CB$31:$CB$38</c:f>
              <c:numCache>
                <c:formatCode>General</c:formatCode>
                <c:ptCount val="8"/>
                <c:pt idx="0">
                  <c:v>47.5</c:v>
                </c:pt>
                <c:pt idx="1">
                  <c:v>50</c:v>
                </c:pt>
                <c:pt idx="2">
                  <c:v>52.5</c:v>
                </c:pt>
                <c:pt idx="3">
                  <c:v>55</c:v>
                </c:pt>
                <c:pt idx="4">
                  <c:v>57.5</c:v>
                </c:pt>
                <c:pt idx="5">
                  <c:v>60</c:v>
                </c:pt>
                <c:pt idx="6">
                  <c:v>62.5</c:v>
                </c:pt>
                <c:pt idx="7">
                  <c:v>65</c:v>
                </c:pt>
              </c:numCache>
            </c:numRef>
          </c:cat>
          <c:val>
            <c:numRef>
              <c:f>'Sampl-clean-work'!$CC$31:$CC$38</c:f>
              <c:numCache>
                <c:formatCode>General</c:formatCode>
                <c:ptCount val="8"/>
                <c:pt idx="0">
                  <c:v>0</c:v>
                </c:pt>
                <c:pt idx="1">
                  <c:v>5</c:v>
                </c:pt>
                <c:pt idx="2">
                  <c:v>46</c:v>
                </c:pt>
                <c:pt idx="3">
                  <c:v>68</c:v>
                </c:pt>
                <c:pt idx="4">
                  <c:v>64</c:v>
                </c:pt>
                <c:pt idx="5">
                  <c:v>27</c:v>
                </c:pt>
                <c:pt idx="6">
                  <c:v>4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D8-40DE-A253-2D1D9EF8B1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2838888"/>
        <c:axId val="532834576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CD$31:$CD$38</c:f>
              <c:numCache>
                <c:formatCode>General</c:formatCode>
                <c:ptCount val="8"/>
                <c:pt idx="0">
                  <c:v>3.8269016170385086E-3</c:v>
                </c:pt>
                <c:pt idx="1">
                  <c:v>3.1636328113019196E-2</c:v>
                </c:pt>
                <c:pt idx="2">
                  <c:v>0.10734381302536712</c:v>
                </c:pt>
                <c:pt idx="3">
                  <c:v>0.1494927524653821</c:v>
                </c:pt>
                <c:pt idx="4">
                  <c:v>8.545066198899727E-2</c:v>
                </c:pt>
                <c:pt idx="5">
                  <c:v>2.0047623526541693E-2</c:v>
                </c:pt>
                <c:pt idx="6">
                  <c:v>1.9304676927546607E-3</c:v>
                </c:pt>
                <c:pt idx="7">
                  <c:v>7.6298210284902644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4D8-40DE-A253-2D1D9EF8B1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835752"/>
        <c:axId val="532834968"/>
      </c:lineChart>
      <c:catAx>
        <c:axId val="5328388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L*</a:t>
                </a:r>
                <a:r>
                  <a:rPr lang="en-US" baseline="-25000" dirty="0"/>
                  <a:t>T0</a:t>
                </a:r>
                <a:r>
                  <a:rPr lang="en-US" dirty="0"/>
                  <a:t> bin (absolute units)</a:t>
                </a:r>
              </a:p>
            </c:rich>
          </c:tx>
          <c:layout>
            <c:manualLayout>
              <c:xMode val="edge"/>
              <c:yMode val="edge"/>
              <c:x val="0.38897375767727527"/>
              <c:y val="0.901785504047093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4576"/>
        <c:crosses val="autoZero"/>
        <c:auto val="1"/>
        <c:lblAlgn val="ctr"/>
        <c:lblOffset val="100"/>
        <c:noMultiLvlLbl val="0"/>
      </c:catAx>
      <c:valAx>
        <c:axId val="532834576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8888"/>
        <c:crosses val="autoZero"/>
        <c:crossBetween val="between"/>
      </c:valAx>
      <c:valAx>
        <c:axId val="532834968"/>
        <c:scaling>
          <c:orientation val="minMax"/>
          <c:max val="0.18000000000000002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5752"/>
        <c:crosses val="max"/>
        <c:crossBetween val="between"/>
      </c:valAx>
      <c:catAx>
        <c:axId val="532835752"/>
        <c:scaling>
          <c:orientation val="minMax"/>
        </c:scaling>
        <c:delete val="1"/>
        <c:axPos val="b"/>
        <c:majorTickMark val="out"/>
        <c:minorTickMark val="none"/>
        <c:tickLblPos val="nextTo"/>
        <c:crossAx val="53283496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it-IT" sz="1400" b="1" i="0" baseline="0" dirty="0">
                <a:effectLst/>
              </a:rPr>
              <a:t>delta L*</a:t>
            </a:r>
            <a:r>
              <a:rPr lang="it-IT" sz="1400" b="1" i="0" baseline="-20000" dirty="0">
                <a:effectLst/>
              </a:rPr>
              <a:t>T14</a:t>
            </a:r>
            <a:endParaRPr lang="en-US" sz="14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652983981796471"/>
          <c:y val="0.12886865342163356"/>
          <c:w val="0.81120260436614322"/>
          <c:h val="0.72180721118469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J$20:$AJ$28</c:f>
              <c:numCache>
                <c:formatCode>0.0</c:formatCode>
                <c:ptCount val="9"/>
                <c:pt idx="0">
                  <c:v>-21</c:v>
                </c:pt>
                <c:pt idx="1">
                  <c:v>-19</c:v>
                </c:pt>
                <c:pt idx="2">
                  <c:v>-17</c:v>
                </c:pt>
                <c:pt idx="3">
                  <c:v>-15</c:v>
                </c:pt>
                <c:pt idx="4">
                  <c:v>-13</c:v>
                </c:pt>
                <c:pt idx="5">
                  <c:v>-11</c:v>
                </c:pt>
                <c:pt idx="6">
                  <c:v>-9</c:v>
                </c:pt>
                <c:pt idx="7">
                  <c:v>-7</c:v>
                </c:pt>
                <c:pt idx="8">
                  <c:v>-5</c:v>
                </c:pt>
              </c:numCache>
            </c:numRef>
          </c:cat>
          <c:val>
            <c:numRef>
              <c:f>'Sampl-clean-work'!$AK$20:$AK$28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20</c:v>
                </c:pt>
                <c:pt idx="3">
                  <c:v>57</c:v>
                </c:pt>
                <c:pt idx="4">
                  <c:v>72</c:v>
                </c:pt>
                <c:pt idx="5">
                  <c:v>50</c:v>
                </c:pt>
                <c:pt idx="6">
                  <c:v>12</c:v>
                </c:pt>
                <c:pt idx="7">
                  <c:v>2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38-44E9-BAD6-3135DDB837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32835360"/>
        <c:axId val="532839280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Sampl-clean-work'!$AJ$20:$AJ$28</c:f>
              <c:numCache>
                <c:formatCode>0.0</c:formatCode>
                <c:ptCount val="9"/>
                <c:pt idx="0">
                  <c:v>-21</c:v>
                </c:pt>
                <c:pt idx="1">
                  <c:v>-19</c:v>
                </c:pt>
                <c:pt idx="2">
                  <c:v>-17</c:v>
                </c:pt>
                <c:pt idx="3">
                  <c:v>-15</c:v>
                </c:pt>
                <c:pt idx="4">
                  <c:v>-13</c:v>
                </c:pt>
                <c:pt idx="5">
                  <c:v>-11</c:v>
                </c:pt>
                <c:pt idx="6">
                  <c:v>-9</c:v>
                </c:pt>
                <c:pt idx="7">
                  <c:v>-7</c:v>
                </c:pt>
                <c:pt idx="8">
                  <c:v>-5</c:v>
                </c:pt>
              </c:numCache>
            </c:numRef>
          </c:cat>
          <c:val>
            <c:numRef>
              <c:f>'Sampl-clean-work'!$AL$20:$AL$28</c:f>
              <c:numCache>
                <c:formatCode>0.00%</c:formatCode>
                <c:ptCount val="9"/>
                <c:pt idx="0">
                  <c:v>9.9487881251554837E-4</c:v>
                </c:pt>
                <c:pt idx="1">
                  <c:v>1.3753968893170565E-2</c:v>
                </c:pt>
                <c:pt idx="2">
                  <c:v>7.7142333609801786E-2</c:v>
                </c:pt>
                <c:pt idx="3">
                  <c:v>0.17553526772210243</c:v>
                </c:pt>
                <c:pt idx="4">
                  <c:v>0.1620477026374969</c:v>
                </c:pt>
                <c:pt idx="5">
                  <c:v>6.0691552878807183E-2</c:v>
                </c:pt>
                <c:pt idx="6">
                  <c:v>9.2219019386067906E-3</c:v>
                </c:pt>
                <c:pt idx="7">
                  <c:v>5.6848581017951178E-4</c:v>
                </c:pt>
                <c:pt idx="8">
                  <c:v>1.4217578563445165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F38-44E9-BAD6-3135DDB837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838104"/>
        <c:axId val="532837712"/>
      </c:lineChart>
      <c:catAx>
        <c:axId val="5328353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l-GR" sz="1000" b="1" i="0" u="none" strike="noStrike" baseline="0" dirty="0">
                    <a:effectLst/>
                  </a:rPr>
                  <a:t>Δ</a:t>
                </a:r>
                <a:r>
                  <a:rPr lang="en-US" sz="1000" b="0" i="0" baseline="0" dirty="0">
                    <a:effectLst/>
                  </a:rPr>
                  <a:t>L*</a:t>
                </a:r>
                <a:r>
                  <a:rPr lang="en-US" sz="1000" b="0" i="0" baseline="-25000" dirty="0">
                    <a:effectLst/>
                  </a:rPr>
                  <a:t>T14</a:t>
                </a:r>
                <a:r>
                  <a:rPr lang="en-US" sz="1000" b="0" i="0" baseline="0" dirty="0">
                    <a:effectLst/>
                  </a:rPr>
                  <a:t> bin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2583245094284355"/>
              <c:y val="0.916105809354475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9280"/>
        <c:crosses val="autoZero"/>
        <c:auto val="1"/>
        <c:lblAlgn val="ctr"/>
        <c:lblOffset val="100"/>
        <c:noMultiLvlLbl val="0"/>
      </c:catAx>
      <c:valAx>
        <c:axId val="532839280"/>
        <c:scaling>
          <c:orientation val="minMax"/>
          <c:max val="9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1.0729492869533872E-2"/>
              <c:y val="0.394324177219782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5360"/>
        <c:crosses val="autoZero"/>
        <c:crossBetween val="between"/>
      </c:valAx>
      <c:valAx>
        <c:axId val="532837712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838104"/>
        <c:crosses val="max"/>
        <c:crossBetween val="between"/>
      </c:valAx>
      <c:catAx>
        <c:axId val="532838104"/>
        <c:scaling>
          <c:orientation val="minMax"/>
        </c:scaling>
        <c:delete val="1"/>
        <c:axPos val="b"/>
        <c:numFmt formatCode="0.0" sourceLinked="1"/>
        <c:majorTickMark val="out"/>
        <c:minorTickMark val="none"/>
        <c:tickLblPos val="nextTo"/>
        <c:crossAx val="5328377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sz="1400" b="1" i="0" baseline="0" dirty="0">
                <a:effectLst/>
              </a:rPr>
              <a:t>delta L*</a:t>
            </a:r>
            <a:r>
              <a:rPr lang="en-US" sz="1400" b="1" i="0" baseline="-30000" dirty="0">
                <a:effectLst/>
              </a:rPr>
              <a:t>T14</a:t>
            </a:r>
            <a:endParaRPr lang="en-US" sz="14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415912897822446"/>
          <c:y val="0.13004629629629633"/>
          <c:w val="0.79527498604131774"/>
          <c:h val="0.729197652376786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T$41:$AT$49</c:f>
              <c:numCache>
                <c:formatCode>0</c:formatCode>
                <c:ptCount val="9"/>
                <c:pt idx="0">
                  <c:v>-21</c:v>
                </c:pt>
                <c:pt idx="1">
                  <c:v>-19</c:v>
                </c:pt>
                <c:pt idx="2">
                  <c:v>-17</c:v>
                </c:pt>
                <c:pt idx="3">
                  <c:v>-15</c:v>
                </c:pt>
                <c:pt idx="4">
                  <c:v>-13</c:v>
                </c:pt>
                <c:pt idx="5">
                  <c:v>-11</c:v>
                </c:pt>
                <c:pt idx="6">
                  <c:v>-9</c:v>
                </c:pt>
                <c:pt idx="7">
                  <c:v>-7</c:v>
                </c:pt>
                <c:pt idx="8">
                  <c:v>-5</c:v>
                </c:pt>
              </c:numCache>
            </c:numRef>
          </c:cat>
          <c:val>
            <c:numRef>
              <c:f>'Table S1 INRAe pheno'!$AU$41:$AU$49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7</c:v>
                </c:pt>
                <c:pt idx="3">
                  <c:v>24</c:v>
                </c:pt>
                <c:pt idx="4">
                  <c:v>66</c:v>
                </c:pt>
                <c:pt idx="5">
                  <c:v>86</c:v>
                </c:pt>
                <c:pt idx="6">
                  <c:v>28</c:v>
                </c:pt>
                <c:pt idx="7">
                  <c:v>6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2C-49E3-AEBE-FB4EE03205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2839672"/>
        <c:axId val="532836536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V$41:$AV$49</c:f>
              <c:numCache>
                <c:formatCode>0.00000</c:formatCode>
                <c:ptCount val="9"/>
                <c:pt idx="0">
                  <c:v>8.7396209436965818E-5</c:v>
                </c:pt>
                <c:pt idx="1">
                  <c:v>2.358058567147857E-3</c:v>
                </c:pt>
                <c:pt idx="2">
                  <c:v>2.5457473916647027E-2</c:v>
                </c:pt>
                <c:pt idx="3">
                  <c:v>0.10997013462924937</c:v>
                </c:pt>
                <c:pt idx="4">
                  <c:v>0.19007847337999972</c:v>
                </c:pt>
                <c:pt idx="5">
                  <c:v>0.13145885433287169</c:v>
                </c:pt>
                <c:pt idx="6">
                  <c:v>3.6378557997062411E-2</c:v>
                </c:pt>
                <c:pt idx="7">
                  <c:v>4.0280963165104039E-3</c:v>
                </c:pt>
                <c:pt idx="8">
                  <c:v>1.7846495306995686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52C-49E3-AEBE-FB4EE03205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840848"/>
        <c:axId val="532840456"/>
      </c:lineChart>
      <c:catAx>
        <c:axId val="532839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l-GR" sz="1000" b="1" i="0" baseline="0" dirty="0">
                    <a:effectLst/>
                  </a:rPr>
                  <a:t>Δ</a:t>
                </a:r>
                <a:r>
                  <a:rPr lang="en-US" sz="1000" b="0" i="0" baseline="0" dirty="0">
                    <a:effectLst/>
                  </a:rPr>
                  <a:t>L*</a:t>
                </a:r>
                <a:r>
                  <a:rPr lang="en-US" sz="1000" b="0" i="0" baseline="-25000" dirty="0">
                    <a:effectLst/>
                  </a:rPr>
                  <a:t>T14</a:t>
                </a:r>
                <a:r>
                  <a:rPr lang="en-US" sz="1000" b="0" i="0" baseline="0" dirty="0">
                    <a:effectLst/>
                  </a:rPr>
                  <a:t> bin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2539251814628698"/>
              <c:y val="0.920475717439293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36536"/>
        <c:crosses val="autoZero"/>
        <c:auto val="1"/>
        <c:lblAlgn val="ctr"/>
        <c:lblOffset val="100"/>
        <c:noMultiLvlLbl val="0"/>
      </c:catAx>
      <c:valAx>
        <c:axId val="532836536"/>
        <c:scaling>
          <c:orientation val="minMax"/>
          <c:max val="9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1.0793100234473729E-2"/>
              <c:y val="0.40309419655876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39672"/>
        <c:crosses val="autoZero"/>
        <c:crossBetween val="between"/>
      </c:valAx>
      <c:valAx>
        <c:axId val="532840456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40848"/>
        <c:crosses val="max"/>
        <c:crossBetween val="between"/>
      </c:valAx>
      <c:catAx>
        <c:axId val="532840848"/>
        <c:scaling>
          <c:orientation val="minMax"/>
        </c:scaling>
        <c:delete val="1"/>
        <c:axPos val="b"/>
        <c:majorTickMark val="out"/>
        <c:minorTickMark val="none"/>
        <c:tickLblPos val="nextTo"/>
        <c:crossAx val="5328404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 dirty="0">
                <a:effectLst/>
              </a:rPr>
              <a:t>a*</a:t>
            </a:r>
            <a:r>
              <a:rPr lang="en-US" sz="1400" b="1" i="0" baseline="-20000" dirty="0">
                <a:effectLst/>
              </a:rPr>
              <a:t>T0</a:t>
            </a:r>
            <a:endParaRPr lang="en-US" sz="1400" baseline="-20000" dirty="0">
              <a:effectLst/>
            </a:endParaRPr>
          </a:p>
        </c:rich>
      </c:tx>
      <c:layout>
        <c:manualLayout>
          <c:xMode val="edge"/>
          <c:yMode val="edge"/>
          <c:x val="0.49071044695372634"/>
          <c:y val="9.259259259259258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94671371967875"/>
          <c:y val="0.13965771611435526"/>
          <c:w val="0.81928308112591297"/>
          <c:h val="0.716316345873432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BN$31:$BN$37</c:f>
              <c:numCache>
                <c:formatCode>General</c:formatCode>
                <c:ptCount val="7"/>
                <c:pt idx="0">
                  <c:v>-5</c:v>
                </c:pt>
                <c:pt idx="1">
                  <c:v>0</c:v>
                </c:pt>
                <c:pt idx="2">
                  <c:v>5</c:v>
                </c:pt>
                <c:pt idx="3">
                  <c:v>10</c:v>
                </c:pt>
                <c:pt idx="4">
                  <c:v>15</c:v>
                </c:pt>
                <c:pt idx="5">
                  <c:v>20</c:v>
                </c:pt>
                <c:pt idx="6">
                  <c:v>25</c:v>
                </c:pt>
              </c:numCache>
            </c:numRef>
          </c:cat>
          <c:val>
            <c:numRef>
              <c:f>'Sampl-clean-work'!$BO$31:$BO$37</c:f>
              <c:numCache>
                <c:formatCode>General</c:formatCode>
                <c:ptCount val="7"/>
                <c:pt idx="0">
                  <c:v>1</c:v>
                </c:pt>
                <c:pt idx="1">
                  <c:v>16</c:v>
                </c:pt>
                <c:pt idx="2">
                  <c:v>80</c:v>
                </c:pt>
                <c:pt idx="3">
                  <c:v>76</c:v>
                </c:pt>
                <c:pt idx="4">
                  <c:v>37</c:v>
                </c:pt>
                <c:pt idx="5">
                  <c:v>3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05-4F0E-A6F6-FA4068FDC6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33435984"/>
        <c:axId val="533438336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BP$31:$BP$37</c:f>
              <c:numCache>
                <c:formatCode>General</c:formatCode>
                <c:ptCount val="7"/>
                <c:pt idx="0">
                  <c:v>5.5144459923377196E-3</c:v>
                </c:pt>
                <c:pt idx="1">
                  <c:v>3.8214226319727748E-2</c:v>
                </c:pt>
                <c:pt idx="2">
                  <c:v>8.3894392845493881E-2</c:v>
                </c:pt>
                <c:pt idx="3">
                  <c:v>5.8347933551391527E-2</c:v>
                </c:pt>
                <c:pt idx="4">
                  <c:v>1.2855906476132162E-2</c:v>
                </c:pt>
                <c:pt idx="5">
                  <c:v>8.9735566608741143E-4</c:v>
                </c:pt>
                <c:pt idx="6">
                  <c:v>1.9843176471978845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05-4F0E-A6F6-FA4068FDC6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439904"/>
        <c:axId val="533432848"/>
      </c:lineChart>
      <c:catAx>
        <c:axId val="533435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*</a:t>
                </a:r>
                <a:r>
                  <a:rPr lang="en-US" baseline="-20000" dirty="0"/>
                  <a:t>T0</a:t>
                </a:r>
                <a:r>
                  <a:rPr lang="en-US" dirty="0"/>
                  <a:t> bin</a:t>
                </a:r>
                <a:r>
                  <a:rPr lang="en-US" sz="1000" b="0" i="0" u="none" strike="noStrike" baseline="0" dirty="0">
                    <a:effectLst/>
                  </a:rPr>
                  <a:t> (absolute units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34967922948073704"/>
              <c:y val="0.925270878721859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8336"/>
        <c:crosses val="autoZero"/>
        <c:auto val="1"/>
        <c:lblAlgn val="ctr"/>
        <c:lblOffset val="100"/>
        <c:noMultiLvlLbl val="0"/>
      </c:catAx>
      <c:valAx>
        <c:axId val="533438336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requ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5984"/>
        <c:crosses val="autoZero"/>
        <c:crossBetween val="between"/>
      </c:valAx>
      <c:valAx>
        <c:axId val="533432848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9904"/>
        <c:crosses val="max"/>
        <c:crossBetween val="between"/>
      </c:valAx>
      <c:catAx>
        <c:axId val="533439904"/>
        <c:scaling>
          <c:orientation val="minMax"/>
        </c:scaling>
        <c:delete val="1"/>
        <c:axPos val="b"/>
        <c:majorTickMark val="out"/>
        <c:minorTickMark val="none"/>
        <c:tickLblPos val="nextTo"/>
        <c:crossAx val="5334328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19050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b="1" dirty="0"/>
              <a:t>delta a*</a:t>
            </a:r>
            <a:r>
              <a:rPr lang="it-IT" b="1" baseline="-20000" dirty="0"/>
              <a:t>T14</a:t>
            </a:r>
            <a:endParaRPr lang="en-US" b="1" baseline="-20000" dirty="0"/>
          </a:p>
        </c:rich>
      </c:tx>
      <c:layout>
        <c:manualLayout>
          <c:xMode val="edge"/>
          <c:yMode val="edge"/>
          <c:x val="0.44159711286089243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133212017428354"/>
          <c:y val="0.10226851851851854"/>
          <c:w val="0.82975328458341624"/>
          <c:h val="0.763132473024205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M$20:$AM$27</c:f>
              <c:numCache>
                <c:formatCode>0.0</c:formatCode>
                <c:ptCount val="8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</c:numCache>
            </c:numRef>
          </c:cat>
          <c:val>
            <c:numRef>
              <c:f>'Sampl-clean-work'!$AN$20:$AN$27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10</c:v>
                </c:pt>
                <c:pt idx="3">
                  <c:v>50</c:v>
                </c:pt>
                <c:pt idx="4">
                  <c:v>78</c:v>
                </c:pt>
                <c:pt idx="5">
                  <c:v>58</c:v>
                </c:pt>
                <c:pt idx="6">
                  <c:v>15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C0-4721-AF13-3FFE08539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33435592"/>
        <c:axId val="533434024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AO$20:$AO$27</c:f>
              <c:numCache>
                <c:formatCode>0.00%</c:formatCode>
                <c:ptCount val="8"/>
                <c:pt idx="0">
                  <c:v>1.9260603803755843E-4</c:v>
                </c:pt>
                <c:pt idx="1">
                  <c:v>3.4755849357047948E-3</c:v>
                </c:pt>
                <c:pt idx="2">
                  <c:v>2.4404403190533188E-2</c:v>
                </c:pt>
                <c:pt idx="3">
                  <c:v>6.6679257260473926E-2</c:v>
                </c:pt>
                <c:pt idx="4">
                  <c:v>7.0891732908210284E-2</c:v>
                </c:pt>
                <c:pt idx="5">
                  <c:v>2.9328017610855722E-2</c:v>
                </c:pt>
                <c:pt idx="6">
                  <c:v>4.721196767471343E-3</c:v>
                </c:pt>
                <c:pt idx="7">
                  <c:v>2.9573571137897936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CC0-4721-AF13-3FFE08539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433240"/>
        <c:axId val="533434416"/>
      </c:lineChart>
      <c:catAx>
        <c:axId val="5334355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l-GR" dirty="0">
                    <a:latin typeface="Calibri" panose="020F0502020204030204" pitchFamily="34" charset="0"/>
                    <a:cs typeface="Calibri" panose="020F0502020204030204" pitchFamily="34" charset="0"/>
                  </a:rPr>
                  <a:t>Δ</a:t>
                </a:r>
                <a:r>
                  <a:rPr lang="en-US" dirty="0"/>
                  <a:t>a*</a:t>
                </a:r>
                <a:r>
                  <a:rPr lang="en-US" baseline="-20000" dirty="0"/>
                  <a:t>T14</a:t>
                </a:r>
                <a:r>
                  <a:rPr lang="en-US" dirty="0"/>
                  <a:t> bin</a:t>
                </a:r>
              </a:p>
            </c:rich>
          </c:tx>
          <c:layout>
            <c:manualLayout>
              <c:xMode val="edge"/>
              <c:yMode val="edge"/>
              <c:x val="0.46350183426965663"/>
              <c:y val="0.92949573149492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4024"/>
        <c:crosses val="autoZero"/>
        <c:auto val="1"/>
        <c:lblAlgn val="ctr"/>
        <c:lblOffset val="100"/>
        <c:noMultiLvlLbl val="0"/>
      </c:catAx>
      <c:valAx>
        <c:axId val="53343402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5592"/>
        <c:crosses val="autoZero"/>
        <c:crossBetween val="between"/>
      </c:valAx>
      <c:valAx>
        <c:axId val="533434416"/>
        <c:scaling>
          <c:orientation val="minMax"/>
          <c:max val="9.0000000000000024E-2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433240"/>
        <c:crosses val="max"/>
        <c:crossBetween val="between"/>
      </c:valAx>
      <c:catAx>
        <c:axId val="533433240"/>
        <c:scaling>
          <c:orientation val="minMax"/>
        </c:scaling>
        <c:delete val="1"/>
        <c:axPos val="b"/>
        <c:majorTickMark val="out"/>
        <c:minorTickMark val="none"/>
        <c:tickLblPos val="nextTo"/>
        <c:crossAx val="5334344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sz="1400" b="1" i="0" baseline="0">
                <a:effectLst/>
              </a:rPr>
              <a:t>a*</a:t>
            </a:r>
            <a:r>
              <a:rPr lang="en-US" sz="1400" b="1" i="0" baseline="-30000">
                <a:effectLst/>
              </a:rPr>
              <a:t>T0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994835287548855"/>
          <c:y val="0.12543500363108206"/>
          <c:w val="0.82613735343383587"/>
          <c:h val="0.7060312273057370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Z$5:$AZ$11</c:f>
              <c:numCache>
                <c:formatCode>General</c:formatCode>
                <c:ptCount val="7"/>
                <c:pt idx="0">
                  <c:v>-5</c:v>
                </c:pt>
                <c:pt idx="1">
                  <c:v>0</c:v>
                </c:pt>
                <c:pt idx="2">
                  <c:v>5</c:v>
                </c:pt>
                <c:pt idx="3">
                  <c:v>10</c:v>
                </c:pt>
                <c:pt idx="4">
                  <c:v>15</c:v>
                </c:pt>
                <c:pt idx="5">
                  <c:v>20</c:v>
                </c:pt>
                <c:pt idx="6">
                  <c:v>25</c:v>
                </c:pt>
              </c:numCache>
            </c:numRef>
          </c:cat>
          <c:val>
            <c:numRef>
              <c:f>'Table S1 INRAe pheno'!$BA$5:$BA$11</c:f>
              <c:numCache>
                <c:formatCode>General</c:formatCode>
                <c:ptCount val="7"/>
                <c:pt idx="0">
                  <c:v>4</c:v>
                </c:pt>
                <c:pt idx="1">
                  <c:v>63</c:v>
                </c:pt>
                <c:pt idx="2">
                  <c:v>99</c:v>
                </c:pt>
                <c:pt idx="3">
                  <c:v>37</c:v>
                </c:pt>
                <c:pt idx="4">
                  <c:v>10</c:v>
                </c:pt>
                <c:pt idx="5">
                  <c:v>3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73-444C-89DE-4527DB557F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438728"/>
        <c:axId val="533437160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BB$5:$BB$11</c:f>
              <c:numCache>
                <c:formatCode>0.00000</c:formatCode>
                <c:ptCount val="7"/>
                <c:pt idx="0">
                  <c:v>2.5978696706739038E-2</c:v>
                </c:pt>
                <c:pt idx="1">
                  <c:v>6.8634674011723365E-2</c:v>
                </c:pt>
                <c:pt idx="2">
                  <c:v>6.9761291991018548E-2</c:v>
                </c:pt>
                <c:pt idx="3">
                  <c:v>2.7279108893839096E-2</c:v>
                </c:pt>
                <c:pt idx="4">
                  <c:v>4.1038413965281796E-3</c:v>
                </c:pt>
                <c:pt idx="5">
                  <c:v>2.3751753689339177E-4</c:v>
                </c:pt>
                <c:pt idx="6">
                  <c:v>5.2886584207357237E-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F73-444C-89DE-4527DB557F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437552"/>
        <c:axId val="533436376"/>
      </c:lineChart>
      <c:catAx>
        <c:axId val="533438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000" b="0" i="0" baseline="0" dirty="0">
                    <a:effectLst/>
                  </a:rPr>
                  <a:t>a*</a:t>
                </a:r>
                <a:r>
                  <a:rPr lang="en-US" sz="1000" b="0" i="0" baseline="-30000" dirty="0">
                    <a:effectLst/>
                  </a:rPr>
                  <a:t>T0</a:t>
                </a:r>
                <a:r>
                  <a:rPr lang="en-US" sz="1000" b="0" i="0" baseline="0" dirty="0">
                    <a:effectLst/>
                  </a:rPr>
                  <a:t> bin</a:t>
                </a:r>
                <a:r>
                  <a:rPr lang="en-US" sz="1000" b="0" i="0" u="none" strike="noStrike" baseline="0" dirty="0">
                    <a:effectLst/>
                  </a:rPr>
                  <a:t> (absolute units)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34950558347292016"/>
              <c:y val="0.906458242556281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7160"/>
        <c:crosses val="autoZero"/>
        <c:auto val="1"/>
        <c:lblAlgn val="ctr"/>
        <c:lblOffset val="100"/>
        <c:noMultiLvlLbl val="0"/>
      </c:catAx>
      <c:valAx>
        <c:axId val="533437160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0"/>
              <c:y val="0.37068663761801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8728"/>
        <c:crosses val="autoZero"/>
        <c:crossBetween val="between"/>
      </c:valAx>
      <c:valAx>
        <c:axId val="533436376"/>
        <c:scaling>
          <c:orientation val="minMax"/>
          <c:max val="7.0000000000000007E-2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7552"/>
        <c:crosses val="max"/>
        <c:crossBetween val="between"/>
      </c:valAx>
      <c:catAx>
        <c:axId val="533437552"/>
        <c:scaling>
          <c:orientation val="minMax"/>
        </c:scaling>
        <c:delete val="1"/>
        <c:axPos val="b"/>
        <c:majorTickMark val="out"/>
        <c:minorTickMark val="none"/>
        <c:tickLblPos val="nextTo"/>
        <c:crossAx val="5334363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sz="1400" b="1" i="0" u="none" strike="noStrike" baseline="0" dirty="0">
                <a:effectLst/>
              </a:rPr>
              <a:t>delta </a:t>
            </a:r>
            <a:r>
              <a:rPr lang="it-IT" sz="1400" b="1" i="0" baseline="0" dirty="0">
                <a:effectLst/>
              </a:rPr>
              <a:t>a*</a:t>
            </a:r>
            <a:r>
              <a:rPr lang="it-IT" sz="1400" b="1" i="0" baseline="-20000" dirty="0">
                <a:effectLst/>
              </a:rPr>
              <a:t>T14</a:t>
            </a:r>
            <a:endParaRPr lang="en-US" sz="14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042294807370185"/>
          <c:y val="0.17171296296296296"/>
          <c:w val="0.82566275823562252"/>
          <c:h val="0.659753207932341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Z$41:$AZ$48</c:f>
              <c:numCache>
                <c:formatCode>0</c:formatCode>
                <c:ptCount val="8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</c:numCache>
            </c:numRef>
          </c:cat>
          <c:val>
            <c:numRef>
              <c:f>'Table S1 INRAe pheno'!$BA$41:$BA$48</c:f>
              <c:numCache>
                <c:formatCode>General</c:formatCode>
                <c:ptCount val="8"/>
                <c:pt idx="0">
                  <c:v>1</c:v>
                </c:pt>
                <c:pt idx="1">
                  <c:v>4</c:v>
                </c:pt>
                <c:pt idx="2">
                  <c:v>5</c:v>
                </c:pt>
                <c:pt idx="3">
                  <c:v>19</c:v>
                </c:pt>
                <c:pt idx="4">
                  <c:v>75</c:v>
                </c:pt>
                <c:pt idx="5">
                  <c:v>92</c:v>
                </c:pt>
                <c:pt idx="6">
                  <c:v>23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7C-4176-9400-A8C54BF1D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437944"/>
        <c:axId val="533439512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BB$41:$BB$48</c:f>
              <c:numCache>
                <c:formatCode>0.00000</c:formatCode>
                <c:ptCount val="8"/>
                <c:pt idx="0">
                  <c:v>2.7891402467374146E-5</c:v>
                </c:pt>
                <c:pt idx="1">
                  <c:v>9.5468690156438939E-4</c:v>
                </c:pt>
                <c:pt idx="2">
                  <c:v>1.1701293131755105E-2</c:v>
                </c:pt>
                <c:pt idx="3">
                  <c:v>5.1355745466647965E-2</c:v>
                </c:pt>
                <c:pt idx="4">
                  <c:v>8.0709842510523849E-2</c:v>
                </c:pt>
                <c:pt idx="5">
                  <c:v>4.5419907516454583E-2</c:v>
                </c:pt>
                <c:pt idx="6">
                  <c:v>9.1526799199587762E-3</c:v>
                </c:pt>
                <c:pt idx="7">
                  <c:v>6.6043881218461346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97C-4176-9400-A8C54BF1D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433632"/>
        <c:axId val="533440296"/>
      </c:lineChart>
      <c:catAx>
        <c:axId val="5334379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l-GR" sz="1000" b="0" i="0" u="none" strike="noStrike" baseline="0">
                    <a:effectLst/>
                  </a:rPr>
                  <a:t>Δ</a:t>
                </a:r>
                <a:r>
                  <a:rPr lang="en-US" sz="1000" b="0" i="0" baseline="0">
                    <a:effectLst/>
                  </a:rPr>
                  <a:t>a*</a:t>
                </a:r>
                <a:r>
                  <a:rPr lang="en-US" sz="1000" b="0" i="0" baseline="-30000">
                    <a:effectLst/>
                  </a:rPr>
                  <a:t>T0</a:t>
                </a:r>
                <a:r>
                  <a:rPr lang="en-US" sz="1000" b="0" i="0" baseline="0">
                    <a:effectLst/>
                  </a:rPr>
                  <a:t> bin</a:t>
                </a:r>
                <a:endParaRPr lang="en-US" sz="1000" b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8206255468066489"/>
              <c:y val="0.906458151064450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9512"/>
        <c:crosses val="autoZero"/>
        <c:auto val="1"/>
        <c:lblAlgn val="ctr"/>
        <c:lblOffset val="100"/>
        <c:noMultiLvlLbl val="0"/>
      </c:catAx>
      <c:valAx>
        <c:axId val="5334395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0"/>
              <c:y val="0.403510893246187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7944"/>
        <c:crosses val="autoZero"/>
        <c:crossBetween val="between"/>
      </c:valAx>
      <c:valAx>
        <c:axId val="533440296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433632"/>
        <c:crosses val="max"/>
        <c:crossBetween val="between"/>
      </c:valAx>
      <c:catAx>
        <c:axId val="533433632"/>
        <c:scaling>
          <c:orientation val="minMax"/>
        </c:scaling>
        <c:delete val="1"/>
        <c:axPos val="b"/>
        <c:majorTickMark val="out"/>
        <c:minorTickMark val="none"/>
        <c:tickLblPos val="nextTo"/>
        <c:crossAx val="5334402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>
                <a:effectLst/>
              </a:rPr>
              <a:t>b*</a:t>
            </a:r>
            <a:r>
              <a:rPr lang="en-US" sz="1400" b="1" i="0" baseline="-30000">
                <a:effectLst/>
              </a:rPr>
              <a:t>T0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378671133445005"/>
          <c:y val="0.1157018881626725"/>
          <c:w val="0.7973981016192071"/>
          <c:h val="0.730259622367465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CH$39:$CH$47</c:f>
              <c:numCache>
                <c:formatCode>General</c:formatCode>
                <c:ptCount val="9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</c:numCache>
            </c:numRef>
          </c:cat>
          <c:val>
            <c:numRef>
              <c:f>'Sampl-clean-work'!$CI$39:$CI$47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35</c:v>
                </c:pt>
                <c:pt idx="5">
                  <c:v>62</c:v>
                </c:pt>
                <c:pt idx="6">
                  <c:v>94</c:v>
                </c:pt>
                <c:pt idx="7">
                  <c:v>23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28-4212-8A91-A5E1E97B87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4300680"/>
        <c:axId val="534305776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Sampl-clean-work'!$CH$39:$CH$47</c:f>
              <c:numCache>
                <c:formatCode>General</c:formatCode>
                <c:ptCount val="9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</c:numCache>
            </c:numRef>
          </c:cat>
          <c:val>
            <c:numRef>
              <c:f>'Sampl-clean-work'!$CJ$39:$CJ$47</c:f>
              <c:numCache>
                <c:formatCode>General</c:formatCode>
                <c:ptCount val="9"/>
                <c:pt idx="0">
                  <c:v>3.5737554554532499E-9</c:v>
                </c:pt>
                <c:pt idx="1">
                  <c:v>1.6919272473370712E-6</c:v>
                </c:pt>
                <c:pt idx="2">
                  <c:v>2.0312209797022923E-4</c:v>
                </c:pt>
                <c:pt idx="3">
                  <c:v>6.1837411026210605E-3</c:v>
                </c:pt>
                <c:pt idx="4">
                  <c:v>4.7737982324260318E-2</c:v>
                </c:pt>
                <c:pt idx="5">
                  <c:v>9.3453475239711689E-2</c:v>
                </c:pt>
                <c:pt idx="6">
                  <c:v>4.6392255617326975E-2</c:v>
                </c:pt>
                <c:pt idx="7">
                  <c:v>5.8400176166094374E-3</c:v>
                </c:pt>
                <c:pt idx="8">
                  <c:v>1.8642384521516575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28-4212-8A91-A5E1E97B87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4298720"/>
        <c:axId val="534300288"/>
      </c:lineChart>
      <c:catAx>
        <c:axId val="534300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dirty="0">
                    <a:effectLst/>
                  </a:rPr>
                  <a:t>b*</a:t>
                </a:r>
                <a:r>
                  <a:rPr lang="en-US" sz="1000" b="0" i="0" baseline="-25000" dirty="0">
                    <a:effectLst/>
                  </a:rPr>
                  <a:t>T0</a:t>
                </a:r>
                <a:r>
                  <a:rPr lang="en-US" sz="1000" b="0" i="0" baseline="0" dirty="0">
                    <a:effectLst/>
                  </a:rPr>
                  <a:t> bin</a:t>
                </a:r>
                <a:r>
                  <a:rPr lang="en-US" sz="1000" b="0" i="0" u="none" strike="noStrike" baseline="0" dirty="0">
                    <a:effectLst/>
                  </a:rPr>
                  <a:t> (absolute units)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36272194304857619"/>
              <c:y val="0.920256354393609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305776"/>
        <c:crosses val="autoZero"/>
        <c:auto val="1"/>
        <c:lblAlgn val="ctr"/>
        <c:lblOffset val="100"/>
        <c:noMultiLvlLbl val="0"/>
      </c:catAx>
      <c:valAx>
        <c:axId val="534305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ancy</a:t>
                </a:r>
              </a:p>
            </c:rich>
          </c:tx>
          <c:layout>
            <c:manualLayout>
              <c:xMode val="edge"/>
              <c:yMode val="edge"/>
              <c:x val="1.0636515912897822E-2"/>
              <c:y val="0.371620551924473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300680"/>
        <c:crosses val="autoZero"/>
        <c:crossBetween val="between"/>
      </c:valAx>
      <c:valAx>
        <c:axId val="534300288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298720"/>
        <c:crosses val="max"/>
        <c:crossBetween val="between"/>
      </c:valAx>
      <c:catAx>
        <c:axId val="5342987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53430028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b="1"/>
              <a:t>b*</a:t>
            </a:r>
            <a:r>
              <a:rPr lang="en-US" b="1" baseline="-30000"/>
              <a:t>T0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554270677789021"/>
          <c:y val="0.17171296296296296"/>
          <c:w val="0.79554246634092118"/>
          <c:h val="0.68753098571011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BF$5:$BF$13</c:f>
              <c:numCache>
                <c:formatCode>General</c:formatCode>
                <c:ptCount val="9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  <c:pt idx="6">
                  <c:v>35</c:v>
                </c:pt>
                <c:pt idx="7">
                  <c:v>40</c:v>
                </c:pt>
                <c:pt idx="8">
                  <c:v>45</c:v>
                </c:pt>
              </c:numCache>
            </c:numRef>
          </c:cat>
          <c:val>
            <c:numRef>
              <c:f>'Table S1 INRAe pheno'!$BG$5:$BG$13</c:f>
              <c:numCache>
                <c:formatCode>General</c:formatCode>
                <c:ptCount val="9"/>
                <c:pt idx="0">
                  <c:v>2</c:v>
                </c:pt>
                <c:pt idx="1">
                  <c:v>5</c:v>
                </c:pt>
                <c:pt idx="2">
                  <c:v>8</c:v>
                </c:pt>
                <c:pt idx="3">
                  <c:v>4</c:v>
                </c:pt>
                <c:pt idx="4">
                  <c:v>20</c:v>
                </c:pt>
                <c:pt idx="5">
                  <c:v>84</c:v>
                </c:pt>
                <c:pt idx="6">
                  <c:v>77</c:v>
                </c:pt>
                <c:pt idx="7">
                  <c:v>17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DA-4005-9C44-92C2875C41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4303816"/>
        <c:axId val="534299112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BH$5:$BH$13</c:f>
              <c:numCache>
                <c:formatCode>0.00000</c:formatCode>
                <c:ptCount val="9"/>
                <c:pt idx="0">
                  <c:v>1.0281763898429296E-4</c:v>
                </c:pt>
                <c:pt idx="1">
                  <c:v>1.1823943923056802E-3</c:v>
                </c:pt>
                <c:pt idx="2">
                  <c:v>7.5699945256639629E-3</c:v>
                </c:pt>
                <c:pt idx="3">
                  <c:v>2.6981571392313473E-2</c:v>
                </c:pt>
                <c:pt idx="4">
                  <c:v>5.3539878648239767E-2</c:v>
                </c:pt>
                <c:pt idx="5">
                  <c:v>5.9146083963034821E-2</c:v>
                </c:pt>
                <c:pt idx="6">
                  <c:v>3.6375843946102396E-2</c:v>
                </c:pt>
                <c:pt idx="7">
                  <c:v>1.2454853693883971E-2</c:v>
                </c:pt>
                <c:pt idx="8">
                  <c:v>2.3741199208628921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FDA-4005-9C44-92C2875C41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4302248"/>
        <c:axId val="534301072"/>
      </c:lineChart>
      <c:catAx>
        <c:axId val="5343038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/>
                  <a:t>b*</a:t>
                </a:r>
                <a:r>
                  <a:rPr lang="en-US" baseline="-30000" dirty="0"/>
                  <a:t>T0</a:t>
                </a:r>
                <a:r>
                  <a:rPr lang="en-US" dirty="0"/>
                  <a:t> bin</a:t>
                </a:r>
                <a:r>
                  <a:rPr lang="en-US" sz="1000" b="0" i="0" u="none" strike="noStrike" baseline="0" dirty="0">
                    <a:effectLst/>
                  </a:rPr>
                  <a:t> (absolute units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36139140145170295"/>
              <c:y val="0.929606390704429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299112"/>
        <c:crosses val="autoZero"/>
        <c:auto val="1"/>
        <c:lblAlgn val="ctr"/>
        <c:lblOffset val="100"/>
        <c:noMultiLvlLbl val="0"/>
      </c:catAx>
      <c:valAx>
        <c:axId val="53429911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3.550638961245195E-3"/>
              <c:y val="0.416983085447652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303816"/>
        <c:crosses val="autoZero"/>
        <c:crossBetween val="between"/>
      </c:valAx>
      <c:valAx>
        <c:axId val="534301072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302248"/>
        <c:crosses val="max"/>
        <c:crossBetween val="between"/>
      </c:valAx>
      <c:catAx>
        <c:axId val="534302248"/>
        <c:scaling>
          <c:orientation val="minMax"/>
        </c:scaling>
        <c:delete val="1"/>
        <c:axPos val="b"/>
        <c:majorTickMark val="out"/>
        <c:minorTickMark val="none"/>
        <c:tickLblPos val="nextTo"/>
        <c:crossAx val="5343010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400" b="1" i="0" u="none" strike="noStrike" baseline="0" dirty="0">
                <a:effectLst/>
              </a:rPr>
              <a:t>delta </a:t>
            </a:r>
            <a:r>
              <a:rPr lang="en-US" sz="1400" b="1" i="0" baseline="0" dirty="0">
                <a:effectLst/>
              </a:rPr>
              <a:t>b*</a:t>
            </a:r>
            <a:r>
              <a:rPr lang="en-US" sz="1400" b="1" i="0" baseline="-30000" dirty="0">
                <a:effectLst/>
              </a:rPr>
              <a:t>T14</a:t>
            </a:r>
            <a:endParaRPr lang="en-US" sz="1400" baseline="-300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811947946981112"/>
          <c:y val="0.14393518518518519"/>
          <c:w val="0.80527153777080207"/>
          <c:h val="0.701419874599008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S$20:$AS$29</c:f>
              <c:numCache>
                <c:formatCode>0.0</c:formatCode>
                <c:ptCount val="10"/>
                <c:pt idx="0">
                  <c:v>-10</c:v>
                </c:pt>
                <c:pt idx="1">
                  <c:v>-6</c:v>
                </c:pt>
                <c:pt idx="2">
                  <c:v>-2</c:v>
                </c:pt>
                <c:pt idx="3">
                  <c:v>2</c:v>
                </c:pt>
                <c:pt idx="4">
                  <c:v>6</c:v>
                </c:pt>
                <c:pt idx="5">
                  <c:v>10</c:v>
                </c:pt>
                <c:pt idx="6">
                  <c:v>14</c:v>
                </c:pt>
                <c:pt idx="7">
                  <c:v>18</c:v>
                </c:pt>
                <c:pt idx="8">
                  <c:v>22</c:v>
                </c:pt>
                <c:pt idx="9">
                  <c:v>26</c:v>
                </c:pt>
              </c:numCache>
            </c:numRef>
          </c:cat>
          <c:val>
            <c:numRef>
              <c:f>'Sampl-clean-work'!$AT$20:$AT$29</c:f>
              <c:numCache>
                <c:formatCode>General</c:formatCode>
                <c:ptCount val="10"/>
                <c:pt idx="0">
                  <c:v>13</c:v>
                </c:pt>
                <c:pt idx="1">
                  <c:v>95</c:v>
                </c:pt>
                <c:pt idx="2">
                  <c:v>88</c:v>
                </c:pt>
                <c:pt idx="3">
                  <c:v>19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7B-4665-8BD4-5B66091E61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4301464"/>
        <c:axId val="534301856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AU$20:$AU$29</c:f>
              <c:numCache>
                <c:formatCode>0.00</c:formatCode>
                <c:ptCount val="10"/>
                <c:pt idx="0">
                  <c:v>4.9238102499993879E-2</c:v>
                </c:pt>
                <c:pt idx="1">
                  <c:v>0.14565953405448234</c:v>
                </c:pt>
                <c:pt idx="2">
                  <c:v>5.1040412972487625E-2</c:v>
                </c:pt>
                <c:pt idx="3">
                  <c:v>2.1184933149475484E-3</c:v>
                </c:pt>
                <c:pt idx="4">
                  <c:v>1.0415441191708834E-5</c:v>
                </c:pt>
                <c:pt idx="5">
                  <c:v>6.065490115540573E-9</c:v>
                </c:pt>
                <c:pt idx="6">
                  <c:v>4.1840010275142009E-13</c:v>
                </c:pt>
                <c:pt idx="7">
                  <c:v>3.4186553567023468E-18</c:v>
                </c:pt>
                <c:pt idx="8">
                  <c:v>3.3086933137855631E-24</c:v>
                </c:pt>
                <c:pt idx="9">
                  <c:v>3.793109340900509E-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67B-4665-8BD4-5B66091E61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4303032"/>
        <c:axId val="534304992"/>
      </c:lineChart>
      <c:catAx>
        <c:axId val="5343014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l-GR" sz="1000" b="0" i="0" baseline="0">
                    <a:effectLst/>
                  </a:rPr>
                  <a:t>Δ</a:t>
                </a:r>
                <a:r>
                  <a:rPr lang="en-US" sz="1000" b="0" i="0" baseline="0">
                    <a:effectLst/>
                  </a:rPr>
                  <a:t>b*</a:t>
                </a:r>
                <a:r>
                  <a:rPr lang="en-US" sz="1000" b="0" i="0" baseline="-30000">
                    <a:effectLst/>
                  </a:rPr>
                  <a:t>T14</a:t>
                </a:r>
                <a:r>
                  <a:rPr lang="en-US" sz="1000" b="0"/>
                  <a:t> bin</a:t>
                </a:r>
              </a:p>
            </c:rich>
          </c:tx>
          <c:layout>
            <c:manualLayout>
              <c:xMode val="edge"/>
              <c:yMode val="edge"/>
              <c:x val="0.43166644794400699"/>
              <c:y val="0.920347039953339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301856"/>
        <c:crosses val="autoZero"/>
        <c:auto val="1"/>
        <c:lblAlgn val="ctr"/>
        <c:lblOffset val="100"/>
        <c:noMultiLvlLbl val="0"/>
      </c:catAx>
      <c:valAx>
        <c:axId val="534301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8.3333333333333332E-3"/>
              <c:y val="0.400779381743948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301464"/>
        <c:crosses val="autoZero"/>
        <c:crossBetween val="between"/>
      </c:valAx>
      <c:valAx>
        <c:axId val="534304992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303032"/>
        <c:crosses val="max"/>
        <c:crossBetween val="between"/>
      </c:valAx>
      <c:catAx>
        <c:axId val="534303032"/>
        <c:scaling>
          <c:orientation val="minMax"/>
        </c:scaling>
        <c:delete val="1"/>
        <c:axPos val="b"/>
        <c:majorTickMark val="out"/>
        <c:minorTickMark val="none"/>
        <c:tickLblPos val="nextTo"/>
        <c:crossAx val="5343049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 dirty="0">
                <a:effectLst/>
              </a:rPr>
              <a:t>FW</a:t>
            </a:r>
            <a:r>
              <a:rPr lang="en-US" sz="1400" b="1" i="0" baseline="-20000" dirty="0">
                <a:effectLst/>
              </a:rPr>
              <a:t>T0</a:t>
            </a:r>
            <a:endParaRPr lang="en-US" sz="1400" baseline="-20000" dirty="0">
              <a:effectLst/>
            </a:endParaRPr>
          </a:p>
        </c:rich>
      </c:tx>
      <c:layout>
        <c:manualLayout>
          <c:xMode val="edge"/>
          <c:yMode val="edge"/>
          <c:x val="0.43890201005025126"/>
          <c:y val="2.33627667402501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669570072585148"/>
          <c:y val="0.11256181015452539"/>
          <c:w val="0.81512562814070355"/>
          <c:h val="0.73135945548197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R$19:$AR$28</c:f>
              <c:numCache>
                <c:formatCode>General</c:formatCode>
                <c:ptCount val="10"/>
                <c:pt idx="0">
                  <c:v>39</c:v>
                </c:pt>
                <c:pt idx="1">
                  <c:v>58</c:v>
                </c:pt>
                <c:pt idx="2">
                  <c:v>77</c:v>
                </c:pt>
                <c:pt idx="3">
                  <c:v>96</c:v>
                </c:pt>
                <c:pt idx="4">
                  <c:v>115</c:v>
                </c:pt>
                <c:pt idx="5">
                  <c:v>134</c:v>
                </c:pt>
                <c:pt idx="6">
                  <c:v>153</c:v>
                </c:pt>
                <c:pt idx="7">
                  <c:v>172</c:v>
                </c:pt>
                <c:pt idx="8">
                  <c:v>191</c:v>
                </c:pt>
                <c:pt idx="9">
                  <c:v>210</c:v>
                </c:pt>
              </c:numCache>
            </c:numRef>
          </c:cat>
          <c:val>
            <c:numRef>
              <c:f>'Sampl-clean-work'!$AS$19:$AS$28</c:f>
              <c:numCache>
                <c:formatCode>General</c:formatCode>
                <c:ptCount val="10"/>
                <c:pt idx="0">
                  <c:v>1</c:v>
                </c:pt>
                <c:pt idx="1">
                  <c:v>60</c:v>
                </c:pt>
                <c:pt idx="2">
                  <c:v>100</c:v>
                </c:pt>
                <c:pt idx="3">
                  <c:v>33</c:v>
                </c:pt>
                <c:pt idx="4">
                  <c:v>8</c:v>
                </c:pt>
                <c:pt idx="5">
                  <c:v>5</c:v>
                </c:pt>
                <c:pt idx="6">
                  <c:v>3</c:v>
                </c:pt>
                <c:pt idx="7">
                  <c:v>2</c:v>
                </c:pt>
                <c:pt idx="8">
                  <c:v>1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44-4F62-A241-9A9C4A5D23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431536000"/>
        <c:axId val="431576744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AT$19:$AT$28</c:f>
              <c:numCache>
                <c:formatCode>0.00000</c:formatCode>
                <c:ptCount val="10"/>
                <c:pt idx="0">
                  <c:v>7.0136445411499585E-3</c:v>
                </c:pt>
                <c:pt idx="1">
                  <c:v>1.3232379053837768E-2</c:v>
                </c:pt>
                <c:pt idx="2">
                  <c:v>1.4839116319517901E-2</c:v>
                </c:pt>
                <c:pt idx="3">
                  <c:v>9.8913158406621383E-3</c:v>
                </c:pt>
                <c:pt idx="4">
                  <c:v>3.9190068670256406E-3</c:v>
                </c:pt>
                <c:pt idx="5">
                  <c:v>9.2294092480119658E-4</c:v>
                </c:pt>
                <c:pt idx="6">
                  <c:v>1.2919559534507922E-4</c:v>
                </c:pt>
                <c:pt idx="7">
                  <c:v>1.0749727017214246E-5</c:v>
                </c:pt>
                <c:pt idx="8">
                  <c:v>5.3164665824579221E-7</c:v>
                </c:pt>
                <c:pt idx="9">
                  <c:v>1.5628765160770488E-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F44-4F62-A241-9A9C4A5D23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1573608"/>
        <c:axId val="431577136"/>
      </c:lineChart>
      <c:catAx>
        <c:axId val="4315360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W</a:t>
                </a:r>
                <a:r>
                  <a:rPr lang="en-US" baseline="-20000" dirty="0"/>
                  <a:t>T0</a:t>
                </a:r>
                <a:r>
                  <a:rPr lang="en-US" dirty="0"/>
                  <a:t> bin (grams)</a:t>
                </a:r>
              </a:p>
            </c:rich>
          </c:tx>
          <c:layout>
            <c:manualLayout>
              <c:xMode val="edge"/>
              <c:yMode val="edge"/>
              <c:x val="0.40274678950307091"/>
              <c:y val="0.924281089036055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76744"/>
        <c:crosses val="autoZero"/>
        <c:auto val="1"/>
        <c:lblAlgn val="ctr"/>
        <c:lblOffset val="100"/>
        <c:noMultiLvlLbl val="0"/>
      </c:catAx>
      <c:valAx>
        <c:axId val="43157674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1.0636515912897822E-2"/>
              <c:y val="0.392850625459896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36000"/>
        <c:crosses val="autoZero"/>
        <c:crossBetween val="between"/>
      </c:valAx>
      <c:valAx>
        <c:axId val="431577136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73608"/>
        <c:crosses val="max"/>
        <c:crossBetween val="between"/>
      </c:valAx>
      <c:catAx>
        <c:axId val="431573608"/>
        <c:scaling>
          <c:orientation val="minMax"/>
        </c:scaling>
        <c:delete val="1"/>
        <c:axPos val="b"/>
        <c:majorTickMark val="out"/>
        <c:minorTickMark val="none"/>
        <c:tickLblPos val="nextTo"/>
        <c:crossAx val="4315771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sz="1400" b="1" i="0" u="none" strike="noStrike" baseline="0" dirty="0">
                <a:effectLst/>
              </a:rPr>
              <a:t>delta </a:t>
            </a:r>
            <a:r>
              <a:rPr lang="en-US" b="1" dirty="0"/>
              <a:t>b*</a:t>
            </a:r>
            <a:r>
              <a:rPr lang="en-US" b="1" baseline="-30000" dirty="0"/>
              <a:t>T1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815048118985127"/>
          <c:y val="0.13004629629629633"/>
          <c:w val="0.80793525809273836"/>
          <c:h val="0.724568022747156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BF$41:$BF$50</c:f>
              <c:numCache>
                <c:formatCode>0.0</c:formatCode>
                <c:ptCount val="10"/>
                <c:pt idx="0">
                  <c:v>-10</c:v>
                </c:pt>
                <c:pt idx="1">
                  <c:v>-6</c:v>
                </c:pt>
                <c:pt idx="2">
                  <c:v>-2</c:v>
                </c:pt>
                <c:pt idx="3">
                  <c:v>2</c:v>
                </c:pt>
                <c:pt idx="4">
                  <c:v>6</c:v>
                </c:pt>
                <c:pt idx="5">
                  <c:v>10</c:v>
                </c:pt>
                <c:pt idx="6">
                  <c:v>14</c:v>
                </c:pt>
                <c:pt idx="7">
                  <c:v>18</c:v>
                </c:pt>
                <c:pt idx="8">
                  <c:v>22</c:v>
                </c:pt>
                <c:pt idx="9">
                  <c:v>26</c:v>
                </c:pt>
              </c:numCache>
            </c:numRef>
          </c:cat>
          <c:val>
            <c:numRef>
              <c:f>'Table S1 INRAe pheno'!$BG$41:$BG$50</c:f>
              <c:numCache>
                <c:formatCode>General</c:formatCode>
                <c:ptCount val="10"/>
                <c:pt idx="0">
                  <c:v>3</c:v>
                </c:pt>
                <c:pt idx="1">
                  <c:v>17</c:v>
                </c:pt>
                <c:pt idx="2">
                  <c:v>65</c:v>
                </c:pt>
                <c:pt idx="3">
                  <c:v>81</c:v>
                </c:pt>
                <c:pt idx="4">
                  <c:v>28</c:v>
                </c:pt>
                <c:pt idx="5">
                  <c:v>6</c:v>
                </c:pt>
                <c:pt idx="6">
                  <c:v>6</c:v>
                </c:pt>
                <c:pt idx="7">
                  <c:v>5</c:v>
                </c:pt>
                <c:pt idx="8">
                  <c:v>4</c:v>
                </c:pt>
                <c:pt idx="9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4-40D1-9F82-5351363006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4303424"/>
        <c:axId val="534304208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BH$41:$BH$50</c:f>
              <c:numCache>
                <c:formatCode>0.00000</c:formatCode>
                <c:ptCount val="10"/>
                <c:pt idx="0">
                  <c:v>1.6939627328947746E-2</c:v>
                </c:pt>
                <c:pt idx="1">
                  <c:v>3.8592916479446175E-2</c:v>
                </c:pt>
                <c:pt idx="2">
                  <c:v>5.9037472123996369E-2</c:v>
                </c:pt>
                <c:pt idx="3">
                  <c:v>6.0640715017278864E-2</c:v>
                </c:pt>
                <c:pt idx="4">
                  <c:v>4.1823201984394015E-2</c:v>
                </c:pt>
                <c:pt idx="5">
                  <c:v>1.9368083609310398E-2</c:v>
                </c:pt>
                <c:pt idx="6">
                  <c:v>6.0224392673570932E-3</c:v>
                </c:pt>
                <c:pt idx="7">
                  <c:v>1.2574033496485005E-3</c:v>
                </c:pt>
                <c:pt idx="8">
                  <c:v>1.7627600637833994E-4</c:v>
                </c:pt>
                <c:pt idx="9">
                  <c:v>1.6593125525966183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1E4-40D1-9F82-5351363006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4304600"/>
        <c:axId val="534299896"/>
      </c:lineChart>
      <c:catAx>
        <c:axId val="534303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l-GR"/>
                  <a:t>Δ</a:t>
                </a:r>
                <a:r>
                  <a:rPr lang="en-US"/>
                  <a:t>b*</a:t>
                </a:r>
                <a:r>
                  <a:rPr lang="en-US" baseline="-30000"/>
                  <a:t>T14</a:t>
                </a:r>
                <a:r>
                  <a:rPr lang="en-US"/>
                  <a:t> bin</a:t>
                </a:r>
              </a:p>
            </c:rich>
          </c:tx>
          <c:layout>
            <c:manualLayout>
              <c:xMode val="edge"/>
              <c:yMode val="edge"/>
              <c:x val="0.47690266841644796"/>
              <c:y val="0.929606299212598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304208"/>
        <c:crosses val="autoZero"/>
        <c:auto val="1"/>
        <c:lblAlgn val="ctr"/>
        <c:lblOffset val="100"/>
        <c:noMultiLvlLbl val="0"/>
      </c:catAx>
      <c:valAx>
        <c:axId val="53430420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1.3108388096375483E-2"/>
              <c:y val="0.370686789151356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303424"/>
        <c:crosses val="autoZero"/>
        <c:crossBetween val="between"/>
      </c:valAx>
      <c:valAx>
        <c:axId val="534299896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4304600"/>
        <c:crosses val="max"/>
        <c:crossBetween val="between"/>
      </c:valAx>
      <c:catAx>
        <c:axId val="534304600"/>
        <c:scaling>
          <c:orientation val="minMax"/>
        </c:scaling>
        <c:delete val="1"/>
        <c:axPos val="b"/>
        <c:majorTickMark val="out"/>
        <c:minorTickMark val="none"/>
        <c:tickLblPos val="nextTo"/>
        <c:crossAx val="5342998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160841597688277"/>
          <c:y val="0.22406636423628271"/>
          <c:w val="0.5603036087028036"/>
          <c:h val="0.6008378450280375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P$1</c:f>
              <c:strCache>
                <c:ptCount val="1"/>
                <c:pt idx="0">
                  <c:v>Δ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O$2:$O$249</c:f>
              <c:numCache>
                <c:formatCode>0.0</c:formatCode>
                <c:ptCount val="248"/>
                <c:pt idx="0">
                  <c:v>60.612119612554402</c:v>
                </c:pt>
                <c:pt idx="1">
                  <c:v>78.375142007888499</c:v>
                </c:pt>
                <c:pt idx="2">
                  <c:v>72.089812247928094</c:v>
                </c:pt>
                <c:pt idx="3">
                  <c:v>55.783196557192703</c:v>
                </c:pt>
                <c:pt idx="4">
                  <c:v>63.2875527305549</c:v>
                </c:pt>
                <c:pt idx="5">
                  <c:v>67.683381174835901</c:v>
                </c:pt>
                <c:pt idx="6">
                  <c:v>64.699255389798907</c:v>
                </c:pt>
                <c:pt idx="7">
                  <c:v>57.173256677537303</c:v>
                </c:pt>
                <c:pt idx="8">
                  <c:v>64.122983875689002</c:v>
                </c:pt>
                <c:pt idx="9">
                  <c:v>74.521742330854593</c:v>
                </c:pt>
                <c:pt idx="10">
                  <c:v>69.329019877224795</c:v>
                </c:pt>
                <c:pt idx="11">
                  <c:v>70.996616588148896</c:v>
                </c:pt>
                <c:pt idx="12">
                  <c:v>59.928935265816001</c:v>
                </c:pt>
                <c:pt idx="13">
                  <c:v>75.701810477081295</c:v>
                </c:pt>
                <c:pt idx="14">
                  <c:v>63.947656516623802</c:v>
                </c:pt>
                <c:pt idx="15">
                  <c:v>54.230279685581898</c:v>
                </c:pt>
                <c:pt idx="16">
                  <c:v>72.144984233573297</c:v>
                </c:pt>
                <c:pt idx="17">
                  <c:v>63.344507028037903</c:v>
                </c:pt>
                <c:pt idx="18">
                  <c:v>53.079608540027699</c:v>
                </c:pt>
                <c:pt idx="19">
                  <c:v>71.007959128412693</c:v>
                </c:pt>
                <c:pt idx="20">
                  <c:v>66.128562759848293</c:v>
                </c:pt>
                <c:pt idx="21">
                  <c:v>61.989366400640698</c:v>
                </c:pt>
                <c:pt idx="22">
                  <c:v>69.021255917086506</c:v>
                </c:pt>
                <c:pt idx="23">
                  <c:v>56.561207688859902</c:v>
                </c:pt>
                <c:pt idx="24">
                  <c:v>61.570623298623403</c:v>
                </c:pt>
                <c:pt idx="25">
                  <c:v>60.633796553931703</c:v>
                </c:pt>
                <c:pt idx="26">
                  <c:v>44.941800379841503</c:v>
                </c:pt>
                <c:pt idx="27">
                  <c:v>59.166379966534699</c:v>
                </c:pt>
                <c:pt idx="28">
                  <c:v>67.464418154876199</c:v>
                </c:pt>
                <c:pt idx="29">
                  <c:v>71.928845325920094</c:v>
                </c:pt>
                <c:pt idx="30">
                  <c:v>66.152216945116606</c:v>
                </c:pt>
                <c:pt idx="31">
                  <c:v>70.799940907587995</c:v>
                </c:pt>
                <c:pt idx="32">
                  <c:v>61.769395354222098</c:v>
                </c:pt>
                <c:pt idx="33">
                  <c:v>64.339207512405096</c:v>
                </c:pt>
                <c:pt idx="34">
                  <c:v>63.5276974035744</c:v>
                </c:pt>
                <c:pt idx="35">
                  <c:v>65.749298850937294</c:v>
                </c:pt>
                <c:pt idx="36">
                  <c:v>65.497936454994104</c:v>
                </c:pt>
                <c:pt idx="37">
                  <c:v>66.536321332989203</c:v>
                </c:pt>
                <c:pt idx="38">
                  <c:v>54.634081765924499</c:v>
                </c:pt>
                <c:pt idx="39">
                  <c:v>57.275345827668502</c:v>
                </c:pt>
                <c:pt idx="40">
                  <c:v>56.473693862895203</c:v>
                </c:pt>
                <c:pt idx="41">
                  <c:v>71.790711628590202</c:v>
                </c:pt>
                <c:pt idx="42">
                  <c:v>62.233162843799803</c:v>
                </c:pt>
                <c:pt idx="43">
                  <c:v>66.499386917615695</c:v>
                </c:pt>
                <c:pt idx="44">
                  <c:v>76.369805792363806</c:v>
                </c:pt>
                <c:pt idx="45">
                  <c:v>65.247656128922699</c:v>
                </c:pt>
                <c:pt idx="46">
                  <c:v>58.720910255084398</c:v>
                </c:pt>
                <c:pt idx="47">
                  <c:v>63.563153563425502</c:v>
                </c:pt>
                <c:pt idx="48">
                  <c:v>61.436302001150104</c:v>
                </c:pt>
                <c:pt idx="49">
                  <c:v>71.788495549552906</c:v>
                </c:pt>
                <c:pt idx="50">
                  <c:v>58.472242050278197</c:v>
                </c:pt>
                <c:pt idx="51">
                  <c:v>58.496024816359601</c:v>
                </c:pt>
                <c:pt idx="52">
                  <c:v>63.084109620717101</c:v>
                </c:pt>
                <c:pt idx="53">
                  <c:v>59.671507573557598</c:v>
                </c:pt>
                <c:pt idx="54">
                  <c:v>60.403766290293703</c:v>
                </c:pt>
                <c:pt idx="55">
                  <c:v>64.426811575008898</c:v>
                </c:pt>
                <c:pt idx="56">
                  <c:v>57.347635644022397</c:v>
                </c:pt>
                <c:pt idx="57">
                  <c:v>70.881567444083601</c:v>
                </c:pt>
                <c:pt idx="58">
                  <c:v>61.505145335646702</c:v>
                </c:pt>
                <c:pt idx="59">
                  <c:v>61.867622220174297</c:v>
                </c:pt>
                <c:pt idx="60">
                  <c:v>69.670676615421002</c:v>
                </c:pt>
                <c:pt idx="61">
                  <c:v>58.087582458887603</c:v>
                </c:pt>
                <c:pt idx="62">
                  <c:v>74.821593514608296</c:v>
                </c:pt>
                <c:pt idx="63">
                  <c:v>80.241275224403196</c:v>
                </c:pt>
                <c:pt idx="64">
                  <c:v>74.933549981723502</c:v>
                </c:pt>
                <c:pt idx="65">
                  <c:v>74.106488824760007</c:v>
                </c:pt>
                <c:pt idx="66">
                  <c:v>62.2808809892787</c:v>
                </c:pt>
                <c:pt idx="67">
                  <c:v>64.291779113186195</c:v>
                </c:pt>
                <c:pt idx="68">
                  <c:v>76.469826205212499</c:v>
                </c:pt>
                <c:pt idx="69">
                  <c:v>50.182408226441197</c:v>
                </c:pt>
                <c:pt idx="70">
                  <c:v>56.967827487920999</c:v>
                </c:pt>
                <c:pt idx="71">
                  <c:v>69.699071515971994</c:v>
                </c:pt>
                <c:pt idx="72">
                  <c:v>47.862156353897198</c:v>
                </c:pt>
                <c:pt idx="73">
                  <c:v>61.341728020402698</c:v>
                </c:pt>
                <c:pt idx="74">
                  <c:v>72.429207192494204</c:v>
                </c:pt>
                <c:pt idx="75">
                  <c:v>66.939996061732899</c:v>
                </c:pt>
                <c:pt idx="76">
                  <c:v>76.917573523387702</c:v>
                </c:pt>
                <c:pt idx="77">
                  <c:v>60.148582621185597</c:v>
                </c:pt>
                <c:pt idx="78">
                  <c:v>57.100600541353799</c:v>
                </c:pt>
                <c:pt idx="79">
                  <c:v>71.601802546035202</c:v>
                </c:pt>
                <c:pt idx="80">
                  <c:v>54.704063901656703</c:v>
                </c:pt>
                <c:pt idx="81">
                  <c:v>64.411480721104198</c:v>
                </c:pt>
                <c:pt idx="82">
                  <c:v>65.2760842549134</c:v>
                </c:pt>
                <c:pt idx="83">
                  <c:v>69.057482885777404</c:v>
                </c:pt>
                <c:pt idx="84">
                  <c:v>67.692704720924596</c:v>
                </c:pt>
                <c:pt idx="85">
                  <c:v>58.508444377234198</c:v>
                </c:pt>
                <c:pt idx="86">
                  <c:v>71.0190561227176</c:v>
                </c:pt>
                <c:pt idx="87">
                  <c:v>63.5806327886079</c:v>
                </c:pt>
                <c:pt idx="88">
                  <c:v>67.643139191188695</c:v>
                </c:pt>
                <c:pt idx="89">
                  <c:v>64.900132484072401</c:v>
                </c:pt>
                <c:pt idx="90">
                  <c:v>56.733407914392799</c:v>
                </c:pt>
                <c:pt idx="91">
                  <c:v>68.267204570525706</c:v>
                </c:pt>
                <c:pt idx="92">
                  <c:v>66.735590734716197</c:v>
                </c:pt>
                <c:pt idx="93">
                  <c:v>67.535279940065195</c:v>
                </c:pt>
                <c:pt idx="94">
                  <c:v>63.211167045303696</c:v>
                </c:pt>
                <c:pt idx="95">
                  <c:v>60.953096729562603</c:v>
                </c:pt>
                <c:pt idx="96">
                  <c:v>63.198020959498002</c:v>
                </c:pt>
                <c:pt idx="97">
                  <c:v>64.654478364709902</c:v>
                </c:pt>
                <c:pt idx="98">
                  <c:v>56.304140216376801</c:v>
                </c:pt>
                <c:pt idx="99">
                  <c:v>71.132695665942407</c:v>
                </c:pt>
                <c:pt idx="100">
                  <c:v>62.820940328018203</c:v>
                </c:pt>
                <c:pt idx="101">
                  <c:v>70.154524990345493</c:v>
                </c:pt>
                <c:pt idx="102">
                  <c:v>80.627721834456807</c:v>
                </c:pt>
                <c:pt idx="103">
                  <c:v>66.587476018521997</c:v>
                </c:pt>
                <c:pt idx="104">
                  <c:v>65.754330621870594</c:v>
                </c:pt>
                <c:pt idx="105">
                  <c:v>69.150162981654105</c:v>
                </c:pt>
                <c:pt idx="106">
                  <c:v>78.906588758744206</c:v>
                </c:pt>
                <c:pt idx="107">
                  <c:v>69.243248930461704</c:v>
                </c:pt>
                <c:pt idx="108">
                  <c:v>68.362466685799305</c:v>
                </c:pt>
                <c:pt idx="109">
                  <c:v>57.665123129982298</c:v>
                </c:pt>
                <c:pt idx="110">
                  <c:v>39.920199068237203</c:v>
                </c:pt>
                <c:pt idx="111">
                  <c:v>49.754233794975697</c:v>
                </c:pt>
                <c:pt idx="112">
                  <c:v>63.3373113074042</c:v>
                </c:pt>
                <c:pt idx="113">
                  <c:v>77.551043226797503</c:v>
                </c:pt>
                <c:pt idx="114">
                  <c:v>71.206494543829606</c:v>
                </c:pt>
                <c:pt idx="115">
                  <c:v>67.066323473428596</c:v>
                </c:pt>
                <c:pt idx="116">
                  <c:v>72.441783756487993</c:v>
                </c:pt>
                <c:pt idx="117">
                  <c:v>69.812273992792697</c:v>
                </c:pt>
                <c:pt idx="118">
                  <c:v>68.073796671703306</c:v>
                </c:pt>
                <c:pt idx="119">
                  <c:v>72.311701540816898</c:v>
                </c:pt>
                <c:pt idx="120">
                  <c:v>65.675606450864706</c:v>
                </c:pt>
                <c:pt idx="121">
                  <c:v>65.342200202553897</c:v>
                </c:pt>
                <c:pt idx="122">
                  <c:v>77.230306914777501</c:v>
                </c:pt>
                <c:pt idx="123">
                  <c:v>64.395220332086595</c:v>
                </c:pt>
                <c:pt idx="124">
                  <c:v>57.812730478806003</c:v>
                </c:pt>
                <c:pt idx="125">
                  <c:v>61.000508522299199</c:v>
                </c:pt>
                <c:pt idx="126">
                  <c:v>67.410269128374907</c:v>
                </c:pt>
                <c:pt idx="127">
                  <c:v>49.007843789442603</c:v>
                </c:pt>
                <c:pt idx="128">
                  <c:v>75.318145164217299</c:v>
                </c:pt>
                <c:pt idx="129">
                  <c:v>74.949355349188906</c:v>
                </c:pt>
                <c:pt idx="130">
                  <c:v>64.282629494744</c:v>
                </c:pt>
                <c:pt idx="131">
                  <c:v>75.442343743735705</c:v>
                </c:pt>
                <c:pt idx="132">
                  <c:v>59.679468874073002</c:v>
                </c:pt>
                <c:pt idx="133">
                  <c:v>72.639795148172098</c:v>
                </c:pt>
                <c:pt idx="134">
                  <c:v>43.635654107099</c:v>
                </c:pt>
                <c:pt idx="135">
                  <c:v>67.405451714392797</c:v>
                </c:pt>
                <c:pt idx="136">
                  <c:v>57.6797208001678</c:v>
                </c:pt>
                <c:pt idx="137">
                  <c:v>68.439966909901301</c:v>
                </c:pt>
                <c:pt idx="138">
                  <c:v>73.869006116575093</c:v>
                </c:pt>
                <c:pt idx="139">
                  <c:v>65.838823991740796</c:v>
                </c:pt>
                <c:pt idx="140">
                  <c:v>72.849054966390398</c:v>
                </c:pt>
                <c:pt idx="141">
                  <c:v>69.854504943610493</c:v>
                </c:pt>
                <c:pt idx="142">
                  <c:v>58.2976864162288</c:v>
                </c:pt>
                <c:pt idx="143">
                  <c:v>63.762185367030902</c:v>
                </c:pt>
                <c:pt idx="144">
                  <c:v>65.754511019521004</c:v>
                </c:pt>
                <c:pt idx="145">
                  <c:v>56.699732381253803</c:v>
                </c:pt>
                <c:pt idx="146">
                  <c:v>66.740619808722997</c:v>
                </c:pt>
                <c:pt idx="147">
                  <c:v>64.684772782304705</c:v>
                </c:pt>
                <c:pt idx="148">
                  <c:v>69.344375354115797</c:v>
                </c:pt>
                <c:pt idx="149">
                  <c:v>68.756334295935801</c:v>
                </c:pt>
                <c:pt idx="150">
                  <c:v>71.581868079673797</c:v>
                </c:pt>
                <c:pt idx="151">
                  <c:v>65.171141793301601</c:v>
                </c:pt>
                <c:pt idx="152">
                  <c:v>67.834225146692305</c:v>
                </c:pt>
                <c:pt idx="153">
                  <c:v>62.939087822818202</c:v>
                </c:pt>
                <c:pt idx="154">
                  <c:v>70.675912707660302</c:v>
                </c:pt>
                <c:pt idx="155">
                  <c:v>71.236452625395003</c:v>
                </c:pt>
                <c:pt idx="156">
                  <c:v>71.051794974335195</c:v>
                </c:pt>
                <c:pt idx="157">
                  <c:v>52.548679785780401</c:v>
                </c:pt>
                <c:pt idx="158">
                  <c:v>71.130448294963401</c:v>
                </c:pt>
                <c:pt idx="159">
                  <c:v>54.565163634591798</c:v>
                </c:pt>
                <c:pt idx="160">
                  <c:v>62.950675120676202</c:v>
                </c:pt>
                <c:pt idx="161">
                  <c:v>52.019365933287602</c:v>
                </c:pt>
                <c:pt idx="162">
                  <c:v>70.419447029197798</c:v>
                </c:pt>
                <c:pt idx="163">
                  <c:v>72.076394334452402</c:v>
                </c:pt>
                <c:pt idx="164">
                  <c:v>66.9260432106651</c:v>
                </c:pt>
                <c:pt idx="165">
                  <c:v>64.074333180120206</c:v>
                </c:pt>
                <c:pt idx="166">
                  <c:v>76.715192110952401</c:v>
                </c:pt>
                <c:pt idx="167">
                  <c:v>71.281673559158605</c:v>
                </c:pt>
                <c:pt idx="168">
                  <c:v>67.129982906582697</c:v>
                </c:pt>
                <c:pt idx="169">
                  <c:v>64.530315212194196</c:v>
                </c:pt>
                <c:pt idx="170">
                  <c:v>76.949128438444205</c:v>
                </c:pt>
                <c:pt idx="171">
                  <c:v>63.050490248901298</c:v>
                </c:pt>
                <c:pt idx="172">
                  <c:v>58.145518012840398</c:v>
                </c:pt>
                <c:pt idx="173">
                  <c:v>66.095499822458194</c:v>
                </c:pt>
                <c:pt idx="174">
                  <c:v>63.634206655047997</c:v>
                </c:pt>
                <c:pt idx="175">
                  <c:v>60.968682865434097</c:v>
                </c:pt>
                <c:pt idx="176">
                  <c:v>71.949353880969895</c:v>
                </c:pt>
                <c:pt idx="177">
                  <c:v>70.430063253306898</c:v>
                </c:pt>
                <c:pt idx="178">
                  <c:v>52.406034723636701</c:v>
                </c:pt>
                <c:pt idx="179">
                  <c:v>64.033874313981201</c:v>
                </c:pt>
                <c:pt idx="180">
                  <c:v>79.859124693743098</c:v>
                </c:pt>
                <c:pt idx="181">
                  <c:v>52.333645247143501</c:v>
                </c:pt>
                <c:pt idx="182">
                  <c:v>57.079380697643899</c:v>
                </c:pt>
                <c:pt idx="183">
                  <c:v>62.066823287112697</c:v>
                </c:pt>
                <c:pt idx="184">
                  <c:v>60.103324977405698</c:v>
                </c:pt>
                <c:pt idx="185">
                  <c:v>60.041648687342096</c:v>
                </c:pt>
                <c:pt idx="186">
                  <c:v>60.881660358045302</c:v>
                </c:pt>
                <c:pt idx="187">
                  <c:v>66.843397666554296</c:v>
                </c:pt>
                <c:pt idx="188">
                  <c:v>60.251898942758103</c:v>
                </c:pt>
                <c:pt idx="189">
                  <c:v>71.960560774843401</c:v>
                </c:pt>
                <c:pt idx="190">
                  <c:v>61.986270328986599</c:v>
                </c:pt>
                <c:pt idx="191">
                  <c:v>66.981146852841604</c:v>
                </c:pt>
                <c:pt idx="192">
                  <c:v>65.277081962733902</c:v>
                </c:pt>
                <c:pt idx="193">
                  <c:v>67.126100102082404</c:v>
                </c:pt>
                <c:pt idx="194">
                  <c:v>75.405925153434296</c:v>
                </c:pt>
                <c:pt idx="195">
                  <c:v>61.076136624840601</c:v>
                </c:pt>
                <c:pt idx="196">
                  <c:v>57.9101165293376</c:v>
                </c:pt>
                <c:pt idx="197">
                  <c:v>56.175354611741398</c:v>
                </c:pt>
                <c:pt idx="198">
                  <c:v>57.429436050340499</c:v>
                </c:pt>
                <c:pt idx="199">
                  <c:v>58.846731355708798</c:v>
                </c:pt>
                <c:pt idx="200">
                  <c:v>59.367247948039399</c:v>
                </c:pt>
                <c:pt idx="201">
                  <c:v>60.810453904950599</c:v>
                </c:pt>
                <c:pt idx="202">
                  <c:v>74.761381630258299</c:v>
                </c:pt>
                <c:pt idx="203">
                  <c:v>65.241423622944794</c:v>
                </c:pt>
                <c:pt idx="204">
                  <c:v>59.556581883535401</c:v>
                </c:pt>
                <c:pt idx="205">
                  <c:v>52.824275727121403</c:v>
                </c:pt>
                <c:pt idx="206">
                  <c:v>57.353497816777903</c:v>
                </c:pt>
                <c:pt idx="207">
                  <c:v>46.569296352754598</c:v>
                </c:pt>
                <c:pt idx="208">
                  <c:v>63.6207708760735</c:v>
                </c:pt>
                <c:pt idx="209">
                  <c:v>56.333736080908302</c:v>
                </c:pt>
                <c:pt idx="210">
                  <c:v>58.698533217241398</c:v>
                </c:pt>
              </c:numCache>
            </c:numRef>
          </c:xVal>
          <c:yVal>
            <c:numRef>
              <c:f>Feuil1!$P$2:$P$249</c:f>
              <c:numCache>
                <c:formatCode>0%</c:formatCode>
                <c:ptCount val="248"/>
                <c:pt idx="0">
                  <c:v>0.28682948240786599</c:v>
                </c:pt>
                <c:pt idx="1">
                  <c:v>0.17885900308307001</c:v>
                </c:pt>
                <c:pt idx="2">
                  <c:v>0.23797154658929201</c:v>
                </c:pt>
                <c:pt idx="3">
                  <c:v>0.30189691870441798</c:v>
                </c:pt>
                <c:pt idx="4">
                  <c:v>0.29087988465132503</c:v>
                </c:pt>
                <c:pt idx="5">
                  <c:v>0.24366201946028401</c:v>
                </c:pt>
                <c:pt idx="6">
                  <c:v>0.33803630137979201</c:v>
                </c:pt>
                <c:pt idx="7">
                  <c:v>0.32783144229219902</c:v>
                </c:pt>
                <c:pt idx="8">
                  <c:v>0.30335674513432498</c:v>
                </c:pt>
                <c:pt idx="9">
                  <c:v>0.115062140277499</c:v>
                </c:pt>
                <c:pt idx="10">
                  <c:v>0.25184870215552002</c:v>
                </c:pt>
                <c:pt idx="11">
                  <c:v>0.20680293273295799</c:v>
                </c:pt>
                <c:pt idx="12">
                  <c:v>0.35987518197034601</c:v>
                </c:pt>
                <c:pt idx="13">
                  <c:v>0.20238602656629301</c:v>
                </c:pt>
                <c:pt idx="14">
                  <c:v>0.27968285137697702</c:v>
                </c:pt>
                <c:pt idx="15">
                  <c:v>0.37775929545981501</c:v>
                </c:pt>
                <c:pt idx="16">
                  <c:v>0.20515170767942301</c:v>
                </c:pt>
                <c:pt idx="17">
                  <c:v>0.29768892542949599</c:v>
                </c:pt>
                <c:pt idx="18">
                  <c:v>0.33785678322047102</c:v>
                </c:pt>
                <c:pt idx="19">
                  <c:v>0.238260343502811</c:v>
                </c:pt>
                <c:pt idx="20">
                  <c:v>0.245430865500505</c:v>
                </c:pt>
                <c:pt idx="21">
                  <c:v>0.26770821033324199</c:v>
                </c:pt>
                <c:pt idx="22">
                  <c:v>0.23093887084704201</c:v>
                </c:pt>
                <c:pt idx="23">
                  <c:v>0.34677137432128302</c:v>
                </c:pt>
                <c:pt idx="24">
                  <c:v>0.27962533794418898</c:v>
                </c:pt>
                <c:pt idx="25">
                  <c:v>0.33158001793867498</c:v>
                </c:pt>
                <c:pt idx="26">
                  <c:v>0.47018820835040898</c:v>
                </c:pt>
                <c:pt idx="27">
                  <c:v>0.31271610234362202</c:v>
                </c:pt>
                <c:pt idx="28">
                  <c:v>0.24399009180773201</c:v>
                </c:pt>
                <c:pt idx="29">
                  <c:v>0.21747325940571499</c:v>
                </c:pt>
                <c:pt idx="30">
                  <c:v>0.23710563429950199</c:v>
                </c:pt>
                <c:pt idx="31">
                  <c:v>0.19786124568501201</c:v>
                </c:pt>
                <c:pt idx="32">
                  <c:v>0.32822300969594498</c:v>
                </c:pt>
                <c:pt idx="33">
                  <c:v>0.248642132402809</c:v>
                </c:pt>
                <c:pt idx="34">
                  <c:v>0.28880517064658101</c:v>
                </c:pt>
                <c:pt idx="35">
                  <c:v>0.283348704072589</c:v>
                </c:pt>
                <c:pt idx="36">
                  <c:v>0.32913309450358802</c:v>
                </c:pt>
                <c:pt idx="37">
                  <c:v>0.24316349230415399</c:v>
                </c:pt>
                <c:pt idx="38">
                  <c:v>0.29604238900923902</c:v>
                </c:pt>
                <c:pt idx="39">
                  <c:v>0.34244859023204299</c:v>
                </c:pt>
                <c:pt idx="40">
                  <c:v>0.33752823439185897</c:v>
                </c:pt>
                <c:pt idx="41">
                  <c:v>0.22137643944663499</c:v>
                </c:pt>
                <c:pt idx="42">
                  <c:v>0.26833662789240398</c:v>
                </c:pt>
                <c:pt idx="43">
                  <c:v>0.23315170804650501</c:v>
                </c:pt>
                <c:pt idx="44">
                  <c:v>0.173702752109197</c:v>
                </c:pt>
                <c:pt idx="45">
                  <c:v>0.26656325629260502</c:v>
                </c:pt>
                <c:pt idx="46">
                  <c:v>0.30337663411780602</c:v>
                </c:pt>
                <c:pt idx="47">
                  <c:v>0.28818745487615999</c:v>
                </c:pt>
                <c:pt idx="48">
                  <c:v>0.27126204722724401</c:v>
                </c:pt>
                <c:pt idx="49">
                  <c:v>0.20193523391285501</c:v>
                </c:pt>
                <c:pt idx="50">
                  <c:v>0.347776165490296</c:v>
                </c:pt>
                <c:pt idx="51">
                  <c:v>0.347882758933651</c:v>
                </c:pt>
                <c:pt idx="52">
                  <c:v>0.28319058687801402</c:v>
                </c:pt>
                <c:pt idx="53">
                  <c:v>0.31895809525725799</c:v>
                </c:pt>
                <c:pt idx="54">
                  <c:v>0.256763624738306</c:v>
                </c:pt>
                <c:pt idx="55">
                  <c:v>0.27510530479783402</c:v>
                </c:pt>
                <c:pt idx="56">
                  <c:v>0.351320909544169</c:v>
                </c:pt>
                <c:pt idx="57">
                  <c:v>0.16934541775638101</c:v>
                </c:pt>
                <c:pt idx="58">
                  <c:v>0.30341574237992902</c:v>
                </c:pt>
                <c:pt idx="59">
                  <c:v>0.27742948604526002</c:v>
                </c:pt>
                <c:pt idx="60">
                  <c:v>0.24690893706691699</c:v>
                </c:pt>
                <c:pt idx="61">
                  <c:v>0.318447295134896</c:v>
                </c:pt>
                <c:pt idx="62">
                  <c:v>0.18274635885823601</c:v>
                </c:pt>
                <c:pt idx="63">
                  <c:v>0.110898726139144</c:v>
                </c:pt>
                <c:pt idx="64">
                  <c:v>0.19626525315610899</c:v>
                </c:pt>
                <c:pt idx="65">
                  <c:v>0.19321697412039299</c:v>
                </c:pt>
                <c:pt idx="66">
                  <c:v>0.29415082648815499</c:v>
                </c:pt>
                <c:pt idx="67">
                  <c:v>0.28293628792543402</c:v>
                </c:pt>
                <c:pt idx="68">
                  <c:v>0.19985444477214601</c:v>
                </c:pt>
                <c:pt idx="69">
                  <c:v>0.42663500109760599</c:v>
                </c:pt>
                <c:pt idx="70">
                  <c:v>0.36161741432252598</c:v>
                </c:pt>
                <c:pt idx="71">
                  <c:v>0.240569140278936</c:v>
                </c:pt>
                <c:pt idx="72">
                  <c:v>0.35021294180275397</c:v>
                </c:pt>
                <c:pt idx="73">
                  <c:v>0.26602673094024598</c:v>
                </c:pt>
                <c:pt idx="74">
                  <c:v>0.210844824839068</c:v>
                </c:pt>
                <c:pt idx="75">
                  <c:v>0.25407293454364199</c:v>
                </c:pt>
                <c:pt idx="76">
                  <c:v>0.167743408479686</c:v>
                </c:pt>
                <c:pt idx="77">
                  <c:v>0.34243762125767901</c:v>
                </c:pt>
                <c:pt idx="78">
                  <c:v>0.33739367917294799</c:v>
                </c:pt>
                <c:pt idx="79">
                  <c:v>0.188979842689145</c:v>
                </c:pt>
                <c:pt idx="80">
                  <c:v>0.34732201024679898</c:v>
                </c:pt>
                <c:pt idx="81">
                  <c:v>0.31164490033626802</c:v>
                </c:pt>
                <c:pt idx="82">
                  <c:v>0.303386538666162</c:v>
                </c:pt>
                <c:pt idx="83">
                  <c:v>0.19924030806423901</c:v>
                </c:pt>
                <c:pt idx="84">
                  <c:v>8.8682351814771895E-2</c:v>
                </c:pt>
                <c:pt idx="85">
                  <c:v>0.33726637858026398</c:v>
                </c:pt>
                <c:pt idx="86">
                  <c:v>0.19392996085465899</c:v>
                </c:pt>
                <c:pt idx="87">
                  <c:v>0.27704849905578099</c:v>
                </c:pt>
                <c:pt idx="88">
                  <c:v>0.238849989405062</c:v>
                </c:pt>
                <c:pt idx="89">
                  <c:v>0.28680235891115902</c:v>
                </c:pt>
                <c:pt idx="90">
                  <c:v>0.37303685887766203</c:v>
                </c:pt>
                <c:pt idx="91">
                  <c:v>0.241205952980896</c:v>
                </c:pt>
                <c:pt idx="92">
                  <c:v>0.24425733897702301</c:v>
                </c:pt>
                <c:pt idx="93">
                  <c:v>0.19177432588524501</c:v>
                </c:pt>
                <c:pt idx="94">
                  <c:v>0.26514086746131399</c:v>
                </c:pt>
                <c:pt idx="95">
                  <c:v>0.271466092002276</c:v>
                </c:pt>
                <c:pt idx="96">
                  <c:v>0.28349146222247001</c:v>
                </c:pt>
                <c:pt idx="97">
                  <c:v>0.29639301661928802</c:v>
                </c:pt>
                <c:pt idx="98">
                  <c:v>0.34768909539182902</c:v>
                </c:pt>
                <c:pt idx="99">
                  <c:v>0.21290520272664301</c:v>
                </c:pt>
                <c:pt idx="100">
                  <c:v>0.28532312080965</c:v>
                </c:pt>
                <c:pt idx="101">
                  <c:v>0.22994653062468501</c:v>
                </c:pt>
                <c:pt idx="102">
                  <c:v>0.14620240395751799</c:v>
                </c:pt>
                <c:pt idx="103">
                  <c:v>0.26202975010151502</c:v>
                </c:pt>
                <c:pt idx="104">
                  <c:v>0.26652847101577998</c:v>
                </c:pt>
                <c:pt idx="105">
                  <c:v>0.27743494367064903</c:v>
                </c:pt>
                <c:pt idx="106">
                  <c:v>0.17251567232715601</c:v>
                </c:pt>
                <c:pt idx="107">
                  <c:v>0.168531211447281</c:v>
                </c:pt>
                <c:pt idx="108">
                  <c:v>0.24670287932871901</c:v>
                </c:pt>
                <c:pt idx="109">
                  <c:v>0.362741150497638</c:v>
                </c:pt>
                <c:pt idx="110">
                  <c:v>0.54917630373298998</c:v>
                </c:pt>
                <c:pt idx="111">
                  <c:v>0.41246199427543101</c:v>
                </c:pt>
                <c:pt idx="112">
                  <c:v>0.230321902211298</c:v>
                </c:pt>
                <c:pt idx="113">
                  <c:v>0.15459481786353199</c:v>
                </c:pt>
                <c:pt idx="114">
                  <c:v>0.22665119963604599</c:v>
                </c:pt>
                <c:pt idx="115">
                  <c:v>0.26697078896443999</c:v>
                </c:pt>
                <c:pt idx="116">
                  <c:v>0.195216217079591</c:v>
                </c:pt>
                <c:pt idx="117">
                  <c:v>0.22656459654480501</c:v>
                </c:pt>
                <c:pt idx="118">
                  <c:v>0.21453791006284101</c:v>
                </c:pt>
                <c:pt idx="119">
                  <c:v>0.23225388798026</c:v>
                </c:pt>
                <c:pt idx="120">
                  <c:v>0.29072156810115302</c:v>
                </c:pt>
                <c:pt idx="121">
                  <c:v>0.26967186608216498</c:v>
                </c:pt>
                <c:pt idx="122">
                  <c:v>0.18423806723848399</c:v>
                </c:pt>
                <c:pt idx="123">
                  <c:v>0.24909523586093299</c:v>
                </c:pt>
                <c:pt idx="124">
                  <c:v>0.30276841516702002</c:v>
                </c:pt>
                <c:pt idx="125">
                  <c:v>0.33852469737444402</c:v>
                </c:pt>
                <c:pt idx="126">
                  <c:v>0.25138029246877402</c:v>
                </c:pt>
                <c:pt idx="127">
                  <c:v>0.43444733600771501</c:v>
                </c:pt>
                <c:pt idx="128">
                  <c:v>0.20343504220870001</c:v>
                </c:pt>
                <c:pt idx="129">
                  <c:v>0.14707491955231</c:v>
                </c:pt>
                <c:pt idx="130">
                  <c:v>0.25676582928910002</c:v>
                </c:pt>
                <c:pt idx="131">
                  <c:v>0.19649340776145299</c:v>
                </c:pt>
                <c:pt idx="132">
                  <c:v>0.28529454883737898</c:v>
                </c:pt>
                <c:pt idx="133">
                  <c:v>0.18268164856756999</c:v>
                </c:pt>
                <c:pt idx="134">
                  <c:v>0.46889659264415801</c:v>
                </c:pt>
                <c:pt idx="135">
                  <c:v>0.23150417112451299</c:v>
                </c:pt>
                <c:pt idx="136">
                  <c:v>0.34118325236417002</c:v>
                </c:pt>
                <c:pt idx="137">
                  <c:v>0.26842494004203699</c:v>
                </c:pt>
                <c:pt idx="138">
                  <c:v>0.209670383518198</c:v>
                </c:pt>
                <c:pt idx="139">
                  <c:v>0.29251899062001202</c:v>
                </c:pt>
                <c:pt idx="140">
                  <c:v>0.26230126700471101</c:v>
                </c:pt>
                <c:pt idx="141">
                  <c:v>0.17603926249843499</c:v>
                </c:pt>
                <c:pt idx="142">
                  <c:v>0.33927677762458203</c:v>
                </c:pt>
                <c:pt idx="143">
                  <c:v>0.33416490193582998</c:v>
                </c:pt>
                <c:pt idx="144">
                  <c:v>0.248864404753739</c:v>
                </c:pt>
                <c:pt idx="145">
                  <c:v>0.305030649992029</c:v>
                </c:pt>
                <c:pt idx="146">
                  <c:v>0.25655185022231602</c:v>
                </c:pt>
                <c:pt idx="147">
                  <c:v>0.27228584358167701</c:v>
                </c:pt>
                <c:pt idx="148">
                  <c:v>0.24219428182070299</c:v>
                </c:pt>
                <c:pt idx="149">
                  <c:v>0.24833504370155701</c:v>
                </c:pt>
                <c:pt idx="150">
                  <c:v>0.233911521195865</c:v>
                </c:pt>
                <c:pt idx="151">
                  <c:v>0.25358225784864202</c:v>
                </c:pt>
                <c:pt idx="152">
                  <c:v>0.23276661229839199</c:v>
                </c:pt>
                <c:pt idx="153">
                  <c:v>0.266955175343349</c:v>
                </c:pt>
                <c:pt idx="154">
                  <c:v>0.25308932339110701</c:v>
                </c:pt>
                <c:pt idx="155">
                  <c:v>0.19027223533573701</c:v>
                </c:pt>
                <c:pt idx="156">
                  <c:v>0.240005303736543</c:v>
                </c:pt>
                <c:pt idx="157">
                  <c:v>0.31842187383305098</c:v>
                </c:pt>
                <c:pt idx="158">
                  <c:v>0.20048673810923801</c:v>
                </c:pt>
                <c:pt idx="159">
                  <c:v>0.36919065178409599</c:v>
                </c:pt>
                <c:pt idx="160">
                  <c:v>0.27272024194306499</c:v>
                </c:pt>
                <c:pt idx="161">
                  <c:v>0.39432904851661299</c:v>
                </c:pt>
                <c:pt idx="162">
                  <c:v>0.20436688584944701</c:v>
                </c:pt>
                <c:pt idx="163">
                  <c:v>0.20757485733138201</c:v>
                </c:pt>
                <c:pt idx="164">
                  <c:v>0.22060270519985301</c:v>
                </c:pt>
                <c:pt idx="165">
                  <c:v>0.250234864976356</c:v>
                </c:pt>
                <c:pt idx="166">
                  <c:v>0.208283845417918</c:v>
                </c:pt>
                <c:pt idx="167">
                  <c:v>0.19726195699173099</c:v>
                </c:pt>
                <c:pt idx="168">
                  <c:v>0.22754356569762901</c:v>
                </c:pt>
                <c:pt idx="169">
                  <c:v>0.25273308185478899</c:v>
                </c:pt>
                <c:pt idx="170">
                  <c:v>0.18670609569697599</c:v>
                </c:pt>
                <c:pt idx="171">
                  <c:v>0.30619414837325998</c:v>
                </c:pt>
                <c:pt idx="172">
                  <c:v>0.33172462292861299</c:v>
                </c:pt>
                <c:pt idx="173">
                  <c:v>0.28875737487182701</c:v>
                </c:pt>
                <c:pt idx="174">
                  <c:v>0.272912803831798</c:v>
                </c:pt>
                <c:pt idx="175">
                  <c:v>0.33050507284988001</c:v>
                </c:pt>
                <c:pt idx="176">
                  <c:v>0.23601114952666999</c:v>
                </c:pt>
                <c:pt idx="177">
                  <c:v>0.277554154449348</c:v>
                </c:pt>
                <c:pt idx="178">
                  <c:v>0.28015587958615101</c:v>
                </c:pt>
                <c:pt idx="179">
                  <c:v>0.22566449051714299</c:v>
                </c:pt>
                <c:pt idx="180">
                  <c:v>0.13255300854385099</c:v>
                </c:pt>
                <c:pt idx="181">
                  <c:v>0.350657864099854</c:v>
                </c:pt>
                <c:pt idx="182">
                  <c:v>0.32388639888417797</c:v>
                </c:pt>
                <c:pt idx="183">
                  <c:v>0.29633159025278399</c:v>
                </c:pt>
                <c:pt idx="184">
                  <c:v>0.32136299893195802</c:v>
                </c:pt>
                <c:pt idx="185">
                  <c:v>0.299962577612501</c:v>
                </c:pt>
                <c:pt idx="186">
                  <c:v>0.28703674663304002</c:v>
                </c:pt>
                <c:pt idx="187">
                  <c:v>0.236634081147334</c:v>
                </c:pt>
                <c:pt idx="188">
                  <c:v>0.30279184879354099</c:v>
                </c:pt>
                <c:pt idx="189">
                  <c:v>0.22233905308997801</c:v>
                </c:pt>
                <c:pt idx="190">
                  <c:v>0.27987900027776802</c:v>
                </c:pt>
                <c:pt idx="191">
                  <c:v>0.26318802164058802</c:v>
                </c:pt>
                <c:pt idx="192">
                  <c:v>0.23315942992035499</c:v>
                </c:pt>
                <c:pt idx="193">
                  <c:v>0.30322276342022703</c:v>
                </c:pt>
                <c:pt idx="194">
                  <c:v>0.12914997666952799</c:v>
                </c:pt>
                <c:pt idx="195">
                  <c:v>0.21536616305108999</c:v>
                </c:pt>
                <c:pt idx="196">
                  <c:v>0.35420033362403802</c:v>
                </c:pt>
                <c:pt idx="197">
                  <c:v>0.29882608484499701</c:v>
                </c:pt>
                <c:pt idx="198">
                  <c:v>0.328639920500224</c:v>
                </c:pt>
                <c:pt idx="199">
                  <c:v>0.28411471876146599</c:v>
                </c:pt>
                <c:pt idx="200">
                  <c:v>0.25651896317695799</c:v>
                </c:pt>
                <c:pt idx="201">
                  <c:v>0.279183599475049</c:v>
                </c:pt>
                <c:pt idx="202">
                  <c:v>0.153859567790427</c:v>
                </c:pt>
                <c:pt idx="203">
                  <c:v>0.20601887239927399</c:v>
                </c:pt>
                <c:pt idx="204">
                  <c:v>0.31324163056101501</c:v>
                </c:pt>
                <c:pt idx="205">
                  <c:v>0.37765811083087703</c:v>
                </c:pt>
                <c:pt idx="206">
                  <c:v>0.28245779335759302</c:v>
                </c:pt>
                <c:pt idx="207">
                  <c:v>0.36180611301858501</c:v>
                </c:pt>
                <c:pt idx="208">
                  <c:v>0.268449764687127</c:v>
                </c:pt>
                <c:pt idx="209">
                  <c:v>0.33622607510799402</c:v>
                </c:pt>
                <c:pt idx="210">
                  <c:v>0.28746093742954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F8-6D45-8E03-ABFF02E894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82232"/>
        <c:axId val="534882624"/>
      </c:scatterChart>
      <c:valAx>
        <c:axId val="534882232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FF</a:t>
                </a:r>
                <a:r>
                  <a:rPr lang="fr-FR" sz="1000" b="0" i="0" u="none" strike="noStrike" kern="120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sz="1000" b="0" i="0" u="none" strike="noStrike" kern="1200" baseline="-20000" dirty="0">
                  <a:solidFill>
                    <a:sysClr val="windowText" lastClr="000000">
                      <a:lumMod val="65000"/>
                      <a:lumOff val="35000"/>
                    </a:sysClr>
                  </a:solidFill>
                </a:endParaRPr>
              </a:p>
            </c:rich>
          </c:tx>
          <c:layout>
            <c:manualLayout>
              <c:xMode val="edge"/>
              <c:yMode val="edge"/>
              <c:x val="0.30154965107454701"/>
              <c:y val="0.907425207215486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2624"/>
        <c:crosses val="autoZero"/>
        <c:crossBetween val="midCat"/>
        <c:majorUnit val="20"/>
      </c:valAx>
      <c:valAx>
        <c:axId val="534882624"/>
        <c:scaling>
          <c:orientation val="minMax"/>
          <c:max val="0.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aseline="0" dirty="0"/>
                  <a:t> LossFF</a:t>
                </a:r>
                <a:r>
                  <a:rPr lang="fr-FR" baseline="-20000" dirty="0"/>
                  <a:t>T14</a:t>
                </a:r>
                <a:endParaRPr lang="fr-FR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2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82943362519511"/>
          <c:y val="0.18560185185185185"/>
          <c:w val="0.51398189432779939"/>
          <c:h val="0.62271617089530462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X$1</c:f>
              <c:strCache>
                <c:ptCount val="1"/>
                <c:pt idx="0">
                  <c:v>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T$2:$T$248</c:f>
              <c:numCache>
                <c:formatCode>General</c:formatCode>
                <c:ptCount val="247"/>
                <c:pt idx="0" formatCode="0.0">
                  <c:v>79.069858887726696</c:v>
                </c:pt>
                <c:pt idx="2" formatCode="0.0">
                  <c:v>166.31493731073101</c:v>
                </c:pt>
                <c:pt idx="3" formatCode="0.0">
                  <c:v>83.063532902103702</c:v>
                </c:pt>
                <c:pt idx="4" formatCode="0.0">
                  <c:v>104.757652726882</c:v>
                </c:pt>
                <c:pt idx="5" formatCode="0.0">
                  <c:v>96.544516157749598</c:v>
                </c:pt>
                <c:pt idx="7" formatCode="0.0">
                  <c:v>99.670372982697003</c:v>
                </c:pt>
                <c:pt idx="8" formatCode="0.0">
                  <c:v>78.758027179313203</c:v>
                </c:pt>
                <c:pt idx="9" formatCode="0.0">
                  <c:v>106.998434661343</c:v>
                </c:pt>
                <c:pt idx="10" formatCode="0.0">
                  <c:v>78.044516157749499</c:v>
                </c:pt>
                <c:pt idx="11" formatCode="0.0">
                  <c:v>106.03646507664899</c:v>
                </c:pt>
                <c:pt idx="12" formatCode="0.0">
                  <c:v>101.109499413393</c:v>
                </c:pt>
                <c:pt idx="13" formatCode="0.0">
                  <c:v>76.805934661341894</c:v>
                </c:pt>
                <c:pt idx="14" formatCode="0.0">
                  <c:v>73.131585184105205</c:v>
                </c:pt>
                <c:pt idx="15" formatCode="0.0">
                  <c:v>111.34910867571899</c:v>
                </c:pt>
                <c:pt idx="16" formatCode="0.0">
                  <c:v>126.835769019145</c:v>
                </c:pt>
                <c:pt idx="17" formatCode="0.0">
                  <c:v>73.790934661342902</c:v>
                </c:pt>
                <c:pt idx="18" formatCode="0.0">
                  <c:v>78.372128493478201</c:v>
                </c:pt>
                <c:pt idx="19" formatCode="0.0">
                  <c:v>83.284308230645195</c:v>
                </c:pt>
                <c:pt idx="20" formatCode="0.0">
                  <c:v>69.135835996563898</c:v>
                </c:pt>
                <c:pt idx="21" formatCode="0.0">
                  <c:v>84.625263296352799</c:v>
                </c:pt>
                <c:pt idx="22" formatCode="0.0">
                  <c:v>120.56562277068799</c:v>
                </c:pt>
                <c:pt idx="23" formatCode="0.0">
                  <c:v>89.966554945231906</c:v>
                </c:pt>
                <c:pt idx="24" formatCode="0.0">
                  <c:v>109.114319393549</c:v>
                </c:pt>
                <c:pt idx="25" formatCode="0.0">
                  <c:v>112.753769019144</c:v>
                </c:pt>
                <c:pt idx="26" formatCode="0.0">
                  <c:v>91.292903822019397</c:v>
                </c:pt>
                <c:pt idx="27" formatCode="0.0">
                  <c:v>99.050527179312198</c:v>
                </c:pt>
                <c:pt idx="28" formatCode="0.0">
                  <c:v>100.682128493479</c:v>
                </c:pt>
                <c:pt idx="29" formatCode="0.0">
                  <c:v>96.604993690602797</c:v>
                </c:pt>
                <c:pt idx="30" formatCode="0.0">
                  <c:v>122.184895025823</c:v>
                </c:pt>
                <c:pt idx="31" formatCode="0.0">
                  <c:v>88.791791486290506</c:v>
                </c:pt>
                <c:pt idx="32" formatCode="0.0">
                  <c:v>81.512465500666195</c:v>
                </c:pt>
                <c:pt idx="33" formatCode="0.0">
                  <c:v>104.915353164938</c:v>
                </c:pt>
                <c:pt idx="34" formatCode="0.0">
                  <c:v>59.894791062271302</c:v>
                </c:pt>
                <c:pt idx="35" formatCode="0.0">
                  <c:v>127.978398099228</c:v>
                </c:pt>
                <c:pt idx="36" formatCode="0.0">
                  <c:v>92.926577836395296</c:v>
                </c:pt>
                <c:pt idx="37" formatCode="0.0">
                  <c:v>50.280712215252102</c:v>
                </c:pt>
                <c:pt idx="38" formatCode="0.0">
                  <c:v>45.456304698130197</c:v>
                </c:pt>
                <c:pt idx="39" formatCode="0.0">
                  <c:v>107.913659332801</c:v>
                </c:pt>
                <c:pt idx="40" formatCode="0.0">
                  <c:v>85.341791486290205</c:v>
                </c:pt>
                <c:pt idx="41" formatCode="0.0">
                  <c:v>94.006768171107694</c:v>
                </c:pt>
                <c:pt idx="42" formatCode="0.0">
                  <c:v>100.691828931532</c:v>
                </c:pt>
                <c:pt idx="43" formatCode="0.0">
                  <c:v>94.852903822019201</c:v>
                </c:pt>
                <c:pt idx="44" formatCode="0.0">
                  <c:v>100.15370119368799</c:v>
                </c:pt>
                <c:pt idx="45" formatCode="0.0">
                  <c:v>77.879802507854293</c:v>
                </c:pt>
                <c:pt idx="46" formatCode="0.0">
                  <c:v>110.394634216269</c:v>
                </c:pt>
                <c:pt idx="47" formatCode="0.0">
                  <c:v>99.237589281977293</c:v>
                </c:pt>
                <c:pt idx="48" formatCode="0.0">
                  <c:v>107.59758928197699</c:v>
                </c:pt>
                <c:pt idx="49" formatCode="0.0">
                  <c:v>116.09762277068801</c:v>
                </c:pt>
                <c:pt idx="50" formatCode="0.0">
                  <c:v>106.01167915056099</c:v>
                </c:pt>
                <c:pt idx="51" formatCode="0.0">
                  <c:v>95.491884746049394</c:v>
                </c:pt>
                <c:pt idx="52" formatCode="0.0">
                  <c:v>88.917507361553405</c:v>
                </c:pt>
                <c:pt idx="53" formatCode="0.0">
                  <c:v>86.605312045839398</c:v>
                </c:pt>
                <c:pt idx="54" formatCode="0.0">
                  <c:v>80.346364610518904</c:v>
                </c:pt>
                <c:pt idx="55" formatCode="0.0">
                  <c:v>85.952821583824303</c:v>
                </c:pt>
                <c:pt idx="56" formatCode="0.0">
                  <c:v>112.11457783639599</c:v>
                </c:pt>
                <c:pt idx="57" formatCode="0.0">
                  <c:v>104.29490382202</c:v>
                </c:pt>
                <c:pt idx="58" formatCode="0.0">
                  <c:v>97.402813953436294</c:v>
                </c:pt>
                <c:pt idx="59" formatCode="0.0">
                  <c:v>124.35684744214601</c:v>
                </c:pt>
                <c:pt idx="60" formatCode="0.0">
                  <c:v>72.463083559186998</c:v>
                </c:pt>
                <c:pt idx="61" formatCode="0.0">
                  <c:v>94.640903822019993</c:v>
                </c:pt>
                <c:pt idx="62" formatCode="0.0">
                  <c:v>74.248546997072495</c:v>
                </c:pt>
                <c:pt idx="63" formatCode="0.0">
                  <c:v>117.326604260076</c:v>
                </c:pt>
                <c:pt idx="64" formatCode="0.0">
                  <c:v>115.06530250785499</c:v>
                </c:pt>
                <c:pt idx="65" formatCode="0.0">
                  <c:v>112.204965500667</c:v>
                </c:pt>
                <c:pt idx="66" formatCode="0.0">
                  <c:v>105.123083559186</c:v>
                </c:pt>
                <c:pt idx="67" formatCode="0.0">
                  <c:v>104.565761388757</c:v>
                </c:pt>
                <c:pt idx="68" formatCode="0.0">
                  <c:v>100.66585888772801</c:v>
                </c:pt>
                <c:pt idx="69" formatCode="0.0">
                  <c:v>70.077353164937406</c:v>
                </c:pt>
                <c:pt idx="70" formatCode="0.0">
                  <c:v>60.061679150561197</c:v>
                </c:pt>
                <c:pt idx="71" formatCode="0.0">
                  <c:v>90.291791486290606</c:v>
                </c:pt>
                <c:pt idx="72" formatCode="0.0">
                  <c:v>110.899787812437</c:v>
                </c:pt>
                <c:pt idx="73" formatCode="0.0">
                  <c:v>70.821083559186903</c:v>
                </c:pt>
                <c:pt idx="74" formatCode="0.0">
                  <c:v>98.939038200876297</c:v>
                </c:pt>
                <c:pt idx="75" formatCode="0.0">
                  <c:v>88.853679150561305</c:v>
                </c:pt>
                <c:pt idx="77" formatCode="0.0">
                  <c:v>109.668308230645</c:v>
                </c:pt>
                <c:pt idx="78" formatCode="0.0">
                  <c:v>96.240035975508604</c:v>
                </c:pt>
                <c:pt idx="79" formatCode="0.0">
                  <c:v>73.964066814831497</c:v>
                </c:pt>
                <c:pt idx="80" formatCode="0.0">
                  <c:v>76.802398099228498</c:v>
                </c:pt>
                <c:pt idx="81" formatCode="0.0">
                  <c:v>82.103996339989706</c:v>
                </c:pt>
                <c:pt idx="82" formatCode="0.0">
                  <c:v>104.84517342777001</c:v>
                </c:pt>
                <c:pt idx="83" formatCode="0.0">
                  <c:v>30.4810469970725</c:v>
                </c:pt>
                <c:pt idx="84" formatCode="0.0">
                  <c:v>66.696088857959097</c:v>
                </c:pt>
                <c:pt idx="85" formatCode="0.0">
                  <c:v>80.066454479102404</c:v>
                </c:pt>
                <c:pt idx="86" formatCode="0.0">
                  <c:v>79.605117047896201</c:v>
                </c:pt>
                <c:pt idx="87" formatCode="0.0">
                  <c:v>77.180742312786094</c:v>
                </c:pt>
                <c:pt idx="88" formatCode="0.0">
                  <c:v>67.296496339989503</c:v>
                </c:pt>
                <c:pt idx="89" formatCode="0.0">
                  <c:v>102.790667704979</c:v>
                </c:pt>
                <c:pt idx="90" formatCode="0.0">
                  <c:v>85.875148311237695</c:v>
                </c:pt>
                <c:pt idx="91" formatCode="0.0">
                  <c:v>93.809937593406801</c:v>
                </c:pt>
                <c:pt idx="92" formatCode="0.0">
                  <c:v>103.80336418650199</c:v>
                </c:pt>
                <c:pt idx="93" formatCode="0.0">
                  <c:v>84.043409544810302</c:v>
                </c:pt>
                <c:pt idx="94" formatCode="0.0">
                  <c:v>100.935769019144</c:v>
                </c:pt>
                <c:pt idx="95" formatCode="0.0">
                  <c:v>89.463622770688801</c:v>
                </c:pt>
                <c:pt idx="96" formatCode="0.0">
                  <c:v>83.531435403131198</c:v>
                </c:pt>
                <c:pt idx="97" formatCode="0.0">
                  <c:v>89.921791486290601</c:v>
                </c:pt>
                <c:pt idx="98" formatCode="0.0">
                  <c:v>78.034291486290599</c:v>
                </c:pt>
                <c:pt idx="99" formatCode="0.0">
                  <c:v>127.30490382201999</c:v>
                </c:pt>
                <c:pt idx="100" formatCode="0.0">
                  <c:v>90.1234994133941</c:v>
                </c:pt>
                <c:pt idx="101" formatCode="0.0">
                  <c:v>87.818795160144703</c:v>
                </c:pt>
                <c:pt idx="102" formatCode="0.0">
                  <c:v>121.018701193688</c:v>
                </c:pt>
                <c:pt idx="103" formatCode="0.0">
                  <c:v>116.23201615774801</c:v>
                </c:pt>
                <c:pt idx="104" formatCode="0.0">
                  <c:v>108.09848796781201</c:v>
                </c:pt>
                <c:pt idx="105" formatCode="0.0">
                  <c:v>149.993925865145</c:v>
                </c:pt>
                <c:pt idx="106" formatCode="0.0">
                  <c:v>99.309638031463606</c:v>
                </c:pt>
                <c:pt idx="107" formatCode="0.0">
                  <c:v>112.610038624895</c:v>
                </c:pt>
                <c:pt idx="108" formatCode="0.0">
                  <c:v>89.489263296353698</c:v>
                </c:pt>
                <c:pt idx="109" formatCode="0.0">
                  <c:v>82.171769019143895</c:v>
                </c:pt>
                <c:pt idx="110" formatCode="0.0">
                  <c:v>119.945083559187</c:v>
                </c:pt>
                <c:pt idx="111" formatCode="0.0">
                  <c:v>113.876184873352</c:v>
                </c:pt>
                <c:pt idx="112" formatCode="0.0">
                  <c:v>102.501769019145</c:v>
                </c:pt>
                <c:pt idx="113" formatCode="0.0">
                  <c:v>110.813121145769</c:v>
                </c:pt>
                <c:pt idx="114" formatCode="0.0">
                  <c:v>97.593996339989403</c:v>
                </c:pt>
                <c:pt idx="115" formatCode="0.0">
                  <c:v>103.061608675719</c:v>
                </c:pt>
                <c:pt idx="116" formatCode="0.0">
                  <c:v>70.254965500666302</c:v>
                </c:pt>
                <c:pt idx="117" formatCode="0.0">
                  <c:v>72.668993690603401</c:v>
                </c:pt>
                <c:pt idx="118" formatCode="0.0">
                  <c:v>67.534333347177295</c:v>
                </c:pt>
                <c:pt idx="119" formatCode="0.0">
                  <c:v>69.173270926741097</c:v>
                </c:pt>
                <c:pt idx="120" formatCode="0.0">
                  <c:v>85.871791486290107</c:v>
                </c:pt>
                <c:pt idx="121" formatCode="0.0">
                  <c:v>100.727263296354</c:v>
                </c:pt>
                <c:pt idx="122" formatCode="0.0">
                  <c:v>79.377029404680798</c:v>
                </c:pt>
                <c:pt idx="124" formatCode="0.0">
                  <c:v>75.069206916479502</c:v>
                </c:pt>
                <c:pt idx="125" formatCode="0.0">
                  <c:v>60.928251850772</c:v>
                </c:pt>
                <c:pt idx="126" formatCode="0.0">
                  <c:v>124.644791062271</c:v>
                </c:pt>
                <c:pt idx="127" formatCode="0.0">
                  <c:v>113.02758928197601</c:v>
                </c:pt>
                <c:pt idx="128" formatCode="0.0">
                  <c:v>119.870148311238</c:v>
                </c:pt>
                <c:pt idx="129" formatCode="0.0">
                  <c:v>71.732535975508299</c:v>
                </c:pt>
                <c:pt idx="130" formatCode="0.0">
                  <c:v>91.687016157749298</c:v>
                </c:pt>
                <c:pt idx="131" formatCode="0.0">
                  <c:v>119.603570488686</c:v>
                </c:pt>
                <c:pt idx="132" formatCode="0.0">
                  <c:v>59.742821583824302</c:v>
                </c:pt>
                <c:pt idx="133" formatCode="0.0">
                  <c:v>100.27138400426</c:v>
                </c:pt>
                <c:pt idx="134" formatCode="0.0">
                  <c:v>109.81679148629</c:v>
                </c:pt>
                <c:pt idx="135" formatCode="0.0">
                  <c:v>92.849221011447796</c:v>
                </c:pt>
                <c:pt idx="136" formatCode="0.0">
                  <c:v>107.91118402531499</c:v>
                </c:pt>
                <c:pt idx="137" formatCode="0.0">
                  <c:v>97.473251850770893</c:v>
                </c:pt>
                <c:pt idx="138" formatCode="0.0">
                  <c:v>94.875679150560799</c:v>
                </c:pt>
                <c:pt idx="139" formatCode="0.0">
                  <c:v>104.041769019144</c:v>
                </c:pt>
                <c:pt idx="140" formatCode="0.0">
                  <c:v>88.568884004260198</c:v>
                </c:pt>
                <c:pt idx="141" formatCode="0.0">
                  <c:v>95.626454479102406</c:v>
                </c:pt>
                <c:pt idx="142" formatCode="0.0">
                  <c:v>55.962847442146497</c:v>
                </c:pt>
                <c:pt idx="143" formatCode="0.0">
                  <c:v>87.253570488686293</c:v>
                </c:pt>
                <c:pt idx="144" formatCode="0.0">
                  <c:v>48.986364610519502</c:v>
                </c:pt>
                <c:pt idx="145" formatCode="0.0">
                  <c:v>94.965319676227494</c:v>
                </c:pt>
                <c:pt idx="146" formatCode="0.0">
                  <c:v>84.712016157748906</c:v>
                </c:pt>
                <c:pt idx="147" formatCode="0.0">
                  <c:v>84.255443033520294</c:v>
                </c:pt>
                <c:pt idx="148" formatCode="0.0">
                  <c:v>88.7516086757186</c:v>
                </c:pt>
                <c:pt idx="149" formatCode="0.0">
                  <c:v>70.277760646967096</c:v>
                </c:pt>
                <c:pt idx="150" formatCode="0.0">
                  <c:v>95.107712639271199</c:v>
                </c:pt>
                <c:pt idx="151" formatCode="0.0">
                  <c:v>82.304218362061704</c:v>
                </c:pt>
                <c:pt idx="152" formatCode="0.0">
                  <c:v>83.857016157748902</c:v>
                </c:pt>
                <c:pt idx="153" formatCode="0.0">
                  <c:v>85.985035975508595</c:v>
                </c:pt>
                <c:pt idx="155" formatCode="0.0">
                  <c:v>90.896667704979095</c:v>
                </c:pt>
                <c:pt idx="156" formatCode="0.0">
                  <c:v>80.681679150560896</c:v>
                </c:pt>
                <c:pt idx="157" formatCode="0.0">
                  <c:v>90.2417690191443</c:v>
                </c:pt>
                <c:pt idx="158" formatCode="0.0">
                  <c:v>91.777769019144699</c:v>
                </c:pt>
                <c:pt idx="159" formatCode="0.0">
                  <c:v>74.518027179312696</c:v>
                </c:pt>
                <c:pt idx="160" formatCode="0.0">
                  <c:v>89.976015733730407</c:v>
                </c:pt>
                <c:pt idx="161" formatCode="0.0">
                  <c:v>97.318884004260198</c:v>
                </c:pt>
                <c:pt idx="162" formatCode="0.0">
                  <c:v>115.073263296354</c:v>
                </c:pt>
                <c:pt idx="163" formatCode="0.0">
                  <c:v>110.20371263926999</c:v>
                </c:pt>
                <c:pt idx="164" formatCode="0.0">
                  <c:v>105.12917342777</c:v>
                </c:pt>
                <c:pt idx="165" formatCode="0.0">
                  <c:v>102.86325185077099</c:v>
                </c:pt>
                <c:pt idx="166" formatCode="0.0">
                  <c:v>85.691217514024999</c:v>
                </c:pt>
                <c:pt idx="168" formatCode="0.0">
                  <c:v>75.081884746049397</c:v>
                </c:pt>
                <c:pt idx="169" formatCode="0.0">
                  <c:v>68.440791062272197</c:v>
                </c:pt>
                <c:pt idx="170" formatCode="0.0">
                  <c:v>44.531435403132903</c:v>
                </c:pt>
                <c:pt idx="171" formatCode="0.0">
                  <c:v>67.162389903482904</c:v>
                </c:pt>
                <c:pt idx="173" formatCode="0.0">
                  <c:v>33.624431587938403</c:v>
                </c:pt>
                <c:pt idx="174" formatCode="0.0">
                  <c:v>86.041580061763597</c:v>
                </c:pt>
                <c:pt idx="175" formatCode="0.0">
                  <c:v>47.760644813814302</c:v>
                </c:pt>
                <c:pt idx="176" formatCode="0.0">
                  <c:v>66.243027179312705</c:v>
                </c:pt>
                <c:pt idx="177" formatCode="0.0">
                  <c:v>62.848701193688903</c:v>
                </c:pt>
                <c:pt idx="178" formatCode="0.0">
                  <c:v>45.276865670079097</c:v>
                </c:pt>
                <c:pt idx="179" formatCode="0.0">
                  <c:v>61.005218079382701</c:v>
                </c:pt>
                <c:pt idx="180" formatCode="0.0">
                  <c:v>54.7564544791028</c:v>
                </c:pt>
                <c:pt idx="181" formatCode="0.0">
                  <c:v>81.918401631743805</c:v>
                </c:pt>
                <c:pt idx="182" formatCode="0.0">
                  <c:v>62.9313421433733</c:v>
                </c:pt>
                <c:pt idx="183" formatCode="0.0">
                  <c:v>75.052611325105104</c:v>
                </c:pt>
                <c:pt idx="184" formatCode="0.0">
                  <c:v>52.4482518507712</c:v>
                </c:pt>
                <c:pt idx="185" formatCode="0.0">
                  <c:v>68.197764355913705</c:v>
                </c:pt>
                <c:pt idx="186" formatCode="0.0">
                  <c:v>70.066650536605906</c:v>
                </c:pt>
                <c:pt idx="187" formatCode="0.0">
                  <c:v>95.622757573562296</c:v>
                </c:pt>
                <c:pt idx="188" formatCode="0.0">
                  <c:v>99.767083559186801</c:v>
                </c:pt>
                <c:pt idx="189" formatCode="0.0">
                  <c:v>88.970847442145995</c:v>
                </c:pt>
                <c:pt idx="191" formatCode="0.0">
                  <c:v>73.855769019144503</c:v>
                </c:pt>
                <c:pt idx="192" formatCode="0.0">
                  <c:v>66.093319676226997</c:v>
                </c:pt>
                <c:pt idx="193" formatCode="0.0">
                  <c:v>92.105499413394099</c:v>
                </c:pt>
                <c:pt idx="194" formatCode="0.0">
                  <c:v>87.5981284934782</c:v>
                </c:pt>
                <c:pt idx="195" formatCode="0.0">
                  <c:v>67.958634216269402</c:v>
                </c:pt>
                <c:pt idx="196" formatCode="0.0">
                  <c:v>111.58989237643701</c:v>
                </c:pt>
                <c:pt idx="197" formatCode="0.0">
                  <c:v>73.582760646966904</c:v>
                </c:pt>
                <c:pt idx="198" formatCode="0.0">
                  <c:v>115.390285339481</c:v>
                </c:pt>
                <c:pt idx="199" formatCode="0.0">
                  <c:v>61.736229807643603</c:v>
                </c:pt>
                <c:pt idx="200" formatCode="0.0">
                  <c:v>61.733769019144503</c:v>
                </c:pt>
                <c:pt idx="201" formatCode="0.0">
                  <c:v>39.858102069798598</c:v>
                </c:pt>
                <c:pt idx="202" formatCode="0.0">
                  <c:v>116.20785888772799</c:v>
                </c:pt>
                <c:pt idx="203" formatCode="0.0">
                  <c:v>97.647532902104004</c:v>
                </c:pt>
                <c:pt idx="204" formatCode="0.0">
                  <c:v>67.714274741935597</c:v>
                </c:pt>
                <c:pt idx="205" formatCode="0.0">
                  <c:v>78.759179150560897</c:v>
                </c:pt>
                <c:pt idx="206" formatCode="0.0">
                  <c:v>114.34843466134301</c:v>
                </c:pt>
                <c:pt idx="207" formatCode="0.0">
                  <c:v>85.845035975508395</c:v>
                </c:pt>
                <c:pt idx="208" formatCode="0.0">
                  <c:v>86.398251850771302</c:v>
                </c:pt>
                <c:pt idx="209" formatCode="0.0">
                  <c:v>111.129179150561</c:v>
                </c:pt>
                <c:pt idx="210" formatCode="0.0">
                  <c:v>66.266679150561004</c:v>
                </c:pt>
                <c:pt idx="211" formatCode="0.0">
                  <c:v>73.2909038220197</c:v>
                </c:pt>
                <c:pt idx="212" formatCode="0.0">
                  <c:v>87.437872982696305</c:v>
                </c:pt>
                <c:pt idx="213" formatCode="0.0">
                  <c:v>94.284577836395499</c:v>
                </c:pt>
                <c:pt idx="214" formatCode="0.0">
                  <c:v>111.178903822019</c:v>
                </c:pt>
                <c:pt idx="215" formatCode="0.0">
                  <c:v>55.250634216269098</c:v>
                </c:pt>
                <c:pt idx="216" formatCode="0.0">
                  <c:v>84.208184873352096</c:v>
                </c:pt>
                <c:pt idx="217" formatCode="0.0">
                  <c:v>77.104291486290293</c:v>
                </c:pt>
                <c:pt idx="218" formatCode="0.0">
                  <c:v>76.457499413394103</c:v>
                </c:pt>
              </c:numCache>
            </c:numRef>
          </c:xVal>
          <c:yVal>
            <c:numRef>
              <c:f>Feuil1!$X$2:$X$248</c:f>
              <c:numCache>
                <c:formatCode>0.0</c:formatCode>
                <c:ptCount val="247"/>
                <c:pt idx="0">
                  <c:v>60.612119612554402</c:v>
                </c:pt>
                <c:pt idx="1">
                  <c:v>58.054085488961</c:v>
                </c:pt>
                <c:pt idx="2">
                  <c:v>78.375142007888499</c:v>
                </c:pt>
                <c:pt idx="3">
                  <c:v>72.089812247928094</c:v>
                </c:pt>
                <c:pt idx="4">
                  <c:v>55.783196557192703</c:v>
                </c:pt>
                <c:pt idx="5">
                  <c:v>63.2875527305549</c:v>
                </c:pt>
                <c:pt idx="6">
                  <c:v>68.5742413655001</c:v>
                </c:pt>
                <c:pt idx="7">
                  <c:v>67.683381174835901</c:v>
                </c:pt>
                <c:pt idx="8">
                  <c:v>64.699255389798907</c:v>
                </c:pt>
                <c:pt idx="9">
                  <c:v>57.173256677537303</c:v>
                </c:pt>
                <c:pt idx="10">
                  <c:v>64.122983875689002</c:v>
                </c:pt>
                <c:pt idx="11">
                  <c:v>74.521742330854593</c:v>
                </c:pt>
                <c:pt idx="12">
                  <c:v>69.329019877224795</c:v>
                </c:pt>
                <c:pt idx="13">
                  <c:v>70.996616588148896</c:v>
                </c:pt>
                <c:pt idx="14">
                  <c:v>59.928935265816001</c:v>
                </c:pt>
                <c:pt idx="15">
                  <c:v>75.701810477081295</c:v>
                </c:pt>
                <c:pt idx="16">
                  <c:v>63.947656516623802</c:v>
                </c:pt>
                <c:pt idx="17">
                  <c:v>54.230279685581898</c:v>
                </c:pt>
                <c:pt idx="18">
                  <c:v>72.144984233573297</c:v>
                </c:pt>
                <c:pt idx="19">
                  <c:v>63.344507028037903</c:v>
                </c:pt>
                <c:pt idx="20">
                  <c:v>53.079608540027699</c:v>
                </c:pt>
                <c:pt idx="21">
                  <c:v>71.007959128412693</c:v>
                </c:pt>
                <c:pt idx="22">
                  <c:v>66.128562759848293</c:v>
                </c:pt>
                <c:pt idx="23">
                  <c:v>61.989366400640698</c:v>
                </c:pt>
                <c:pt idx="24">
                  <c:v>69.021255917086506</c:v>
                </c:pt>
                <c:pt idx="25">
                  <c:v>56.561207688859902</c:v>
                </c:pt>
                <c:pt idx="26">
                  <c:v>61.570623298623403</c:v>
                </c:pt>
                <c:pt idx="27">
                  <c:v>60.633796553931703</c:v>
                </c:pt>
                <c:pt idx="28">
                  <c:v>44.941800379841503</c:v>
                </c:pt>
                <c:pt idx="29">
                  <c:v>59.166379966534699</c:v>
                </c:pt>
                <c:pt idx="30">
                  <c:v>67.464418154876199</c:v>
                </c:pt>
                <c:pt idx="31">
                  <c:v>71.928845325920094</c:v>
                </c:pt>
                <c:pt idx="32">
                  <c:v>66.152216945116606</c:v>
                </c:pt>
                <c:pt idx="33">
                  <c:v>70.799940907587995</c:v>
                </c:pt>
                <c:pt idx="34">
                  <c:v>61.769395354222098</c:v>
                </c:pt>
                <c:pt idx="35">
                  <c:v>64.339207512405096</c:v>
                </c:pt>
                <c:pt idx="36">
                  <c:v>63.5276974035744</c:v>
                </c:pt>
                <c:pt idx="37">
                  <c:v>65.749298850937294</c:v>
                </c:pt>
                <c:pt idx="38">
                  <c:v>65.497936454994104</c:v>
                </c:pt>
                <c:pt idx="39">
                  <c:v>66.536321332989203</c:v>
                </c:pt>
                <c:pt idx="40">
                  <c:v>54.634081765924499</c:v>
                </c:pt>
                <c:pt idx="41">
                  <c:v>57.275345827668502</c:v>
                </c:pt>
                <c:pt idx="42">
                  <c:v>56.473693862895203</c:v>
                </c:pt>
                <c:pt idx="43">
                  <c:v>71.790711628590202</c:v>
                </c:pt>
                <c:pt idx="44">
                  <c:v>62.233162843799803</c:v>
                </c:pt>
                <c:pt idx="45">
                  <c:v>66.499386917615695</c:v>
                </c:pt>
                <c:pt idx="46">
                  <c:v>76.369805792363806</c:v>
                </c:pt>
                <c:pt idx="47">
                  <c:v>65.247656128922699</c:v>
                </c:pt>
                <c:pt idx="48">
                  <c:v>58.720910255084398</c:v>
                </c:pt>
                <c:pt idx="49">
                  <c:v>63.563153563425502</c:v>
                </c:pt>
                <c:pt idx="50">
                  <c:v>61.436302001150104</c:v>
                </c:pt>
                <c:pt idx="51">
                  <c:v>71.788495549552906</c:v>
                </c:pt>
                <c:pt idx="52">
                  <c:v>58.472242050278197</c:v>
                </c:pt>
                <c:pt idx="53">
                  <c:v>58.496024816359601</c:v>
                </c:pt>
                <c:pt idx="54">
                  <c:v>63.084109620717101</c:v>
                </c:pt>
                <c:pt idx="55">
                  <c:v>59.671507573557598</c:v>
                </c:pt>
                <c:pt idx="56">
                  <c:v>60.403766290293703</c:v>
                </c:pt>
                <c:pt idx="57">
                  <c:v>64.426811575008898</c:v>
                </c:pt>
                <c:pt idx="58">
                  <c:v>57.347635644022397</c:v>
                </c:pt>
                <c:pt idx="59">
                  <c:v>70.881567444083601</c:v>
                </c:pt>
                <c:pt idx="60">
                  <c:v>61.505145335646702</c:v>
                </c:pt>
                <c:pt idx="61">
                  <c:v>61.867622220174297</c:v>
                </c:pt>
                <c:pt idx="62">
                  <c:v>69.670676615421002</c:v>
                </c:pt>
                <c:pt idx="63">
                  <c:v>58.087582458887603</c:v>
                </c:pt>
                <c:pt idx="64">
                  <c:v>74.821593514608296</c:v>
                </c:pt>
                <c:pt idx="65">
                  <c:v>80.241275224403196</c:v>
                </c:pt>
                <c:pt idx="66">
                  <c:v>74.933549981723502</c:v>
                </c:pt>
                <c:pt idx="67">
                  <c:v>74.106488824760007</c:v>
                </c:pt>
                <c:pt idx="68">
                  <c:v>62.2808809892787</c:v>
                </c:pt>
                <c:pt idx="69">
                  <c:v>64.291779113186195</c:v>
                </c:pt>
                <c:pt idx="70">
                  <c:v>76.469826205212499</c:v>
                </c:pt>
                <c:pt idx="71">
                  <c:v>50.182408226441197</c:v>
                </c:pt>
                <c:pt idx="72">
                  <c:v>56.967827487920999</c:v>
                </c:pt>
                <c:pt idx="73">
                  <c:v>69.699071515971994</c:v>
                </c:pt>
                <c:pt idx="74">
                  <c:v>47.862156353897198</c:v>
                </c:pt>
                <c:pt idx="75">
                  <c:v>61.341728020402698</c:v>
                </c:pt>
                <c:pt idx="76">
                  <c:v>63.928521997717802</c:v>
                </c:pt>
                <c:pt idx="77">
                  <c:v>72.429207192494204</c:v>
                </c:pt>
                <c:pt idx="78">
                  <c:v>66.939996061732899</c:v>
                </c:pt>
                <c:pt idx="79">
                  <c:v>76.917573523387702</c:v>
                </c:pt>
                <c:pt idx="80">
                  <c:v>60.148582621185597</c:v>
                </c:pt>
                <c:pt idx="81">
                  <c:v>57.100600541353799</c:v>
                </c:pt>
                <c:pt idx="82">
                  <c:v>71.601802546035202</c:v>
                </c:pt>
                <c:pt idx="83">
                  <c:v>54.704063901656703</c:v>
                </c:pt>
                <c:pt idx="84">
                  <c:v>64.411480721104198</c:v>
                </c:pt>
                <c:pt idx="85">
                  <c:v>65.2760842549134</c:v>
                </c:pt>
                <c:pt idx="86">
                  <c:v>69.057482885777404</c:v>
                </c:pt>
                <c:pt idx="87">
                  <c:v>67.692704720924596</c:v>
                </c:pt>
                <c:pt idx="88">
                  <c:v>58.508444377234198</c:v>
                </c:pt>
                <c:pt idx="89">
                  <c:v>71.0190561227176</c:v>
                </c:pt>
                <c:pt idx="90">
                  <c:v>63.5806327886079</c:v>
                </c:pt>
                <c:pt idx="91">
                  <c:v>67.643139191188695</c:v>
                </c:pt>
                <c:pt idx="92">
                  <c:v>64.900132484072401</c:v>
                </c:pt>
                <c:pt idx="93">
                  <c:v>56.733407914392799</c:v>
                </c:pt>
                <c:pt idx="94">
                  <c:v>68.267204570525706</c:v>
                </c:pt>
                <c:pt idx="95">
                  <c:v>66.735590734716197</c:v>
                </c:pt>
                <c:pt idx="96">
                  <c:v>67.535279940065195</c:v>
                </c:pt>
                <c:pt idx="97">
                  <c:v>63.211167045303696</c:v>
                </c:pt>
                <c:pt idx="98">
                  <c:v>60.953096729562603</c:v>
                </c:pt>
                <c:pt idx="99">
                  <c:v>63.198020959498002</c:v>
                </c:pt>
                <c:pt idx="100">
                  <c:v>64.654478364709902</c:v>
                </c:pt>
                <c:pt idx="101">
                  <c:v>56.304140216376801</c:v>
                </c:pt>
                <c:pt idx="102">
                  <c:v>71.132695665942407</c:v>
                </c:pt>
                <c:pt idx="103">
                  <c:v>62.820940328018203</c:v>
                </c:pt>
                <c:pt idx="104">
                  <c:v>70.154524990345493</c:v>
                </c:pt>
                <c:pt idx="105">
                  <c:v>80.627721834456807</c:v>
                </c:pt>
                <c:pt idx="106">
                  <c:v>66.587476018521997</c:v>
                </c:pt>
                <c:pt idx="107">
                  <c:v>65.754330621870594</c:v>
                </c:pt>
                <c:pt idx="108">
                  <c:v>69.150162981654105</c:v>
                </c:pt>
                <c:pt idx="109">
                  <c:v>78.906588758744206</c:v>
                </c:pt>
                <c:pt idx="110">
                  <c:v>69.243248930461704</c:v>
                </c:pt>
                <c:pt idx="111">
                  <c:v>68.362466685799305</c:v>
                </c:pt>
                <c:pt idx="112">
                  <c:v>57.665123129982298</c:v>
                </c:pt>
                <c:pt idx="113">
                  <c:v>39.920199068237203</c:v>
                </c:pt>
                <c:pt idx="114">
                  <c:v>49.754233794975697</c:v>
                </c:pt>
                <c:pt idx="115">
                  <c:v>63.3373113074042</c:v>
                </c:pt>
                <c:pt idx="116">
                  <c:v>77.551043226797503</c:v>
                </c:pt>
                <c:pt idx="117">
                  <c:v>71.206494543829606</c:v>
                </c:pt>
                <c:pt idx="118">
                  <c:v>67.066323473428596</c:v>
                </c:pt>
                <c:pt idx="119">
                  <c:v>72.441783756487993</c:v>
                </c:pt>
                <c:pt idx="120">
                  <c:v>69.812273992792697</c:v>
                </c:pt>
                <c:pt idx="121">
                  <c:v>68.073796671703306</c:v>
                </c:pt>
                <c:pt idx="122">
                  <c:v>72.311701540816898</c:v>
                </c:pt>
                <c:pt idx="123">
                  <c:v>68.306084741683307</c:v>
                </c:pt>
                <c:pt idx="124">
                  <c:v>65.675606450864706</c:v>
                </c:pt>
                <c:pt idx="125">
                  <c:v>65.342200202553897</c:v>
                </c:pt>
                <c:pt idx="126">
                  <c:v>77.230306914777501</c:v>
                </c:pt>
                <c:pt idx="127">
                  <c:v>64.395220332086595</c:v>
                </c:pt>
                <c:pt idx="128">
                  <c:v>57.812730478806003</c:v>
                </c:pt>
                <c:pt idx="129">
                  <c:v>61.000508522299199</c:v>
                </c:pt>
                <c:pt idx="130">
                  <c:v>67.410269128374907</c:v>
                </c:pt>
                <c:pt idx="131">
                  <c:v>49.007843789442603</c:v>
                </c:pt>
                <c:pt idx="132">
                  <c:v>75.318145164217299</c:v>
                </c:pt>
                <c:pt idx="133">
                  <c:v>74.949355349188906</c:v>
                </c:pt>
                <c:pt idx="134">
                  <c:v>64.282629494744</c:v>
                </c:pt>
                <c:pt idx="135">
                  <c:v>75.442343743735705</c:v>
                </c:pt>
                <c:pt idx="136">
                  <c:v>59.679468874073002</c:v>
                </c:pt>
                <c:pt idx="137">
                  <c:v>72.639795148172098</c:v>
                </c:pt>
                <c:pt idx="138">
                  <c:v>43.635654107099</c:v>
                </c:pt>
                <c:pt idx="139">
                  <c:v>67.405451714392797</c:v>
                </c:pt>
                <c:pt idx="140">
                  <c:v>57.6797208001678</c:v>
                </c:pt>
                <c:pt idx="141">
                  <c:v>68.439966909901301</c:v>
                </c:pt>
                <c:pt idx="142">
                  <c:v>73.869006116575093</c:v>
                </c:pt>
                <c:pt idx="143">
                  <c:v>65.838823991740796</c:v>
                </c:pt>
                <c:pt idx="144">
                  <c:v>72.849054966390398</c:v>
                </c:pt>
                <c:pt idx="145">
                  <c:v>69.854504943610493</c:v>
                </c:pt>
                <c:pt idx="146">
                  <c:v>58.2976864162288</c:v>
                </c:pt>
                <c:pt idx="147">
                  <c:v>63.762185367030902</c:v>
                </c:pt>
                <c:pt idx="148">
                  <c:v>65.754511019521004</c:v>
                </c:pt>
                <c:pt idx="149">
                  <c:v>56.699732381253803</c:v>
                </c:pt>
                <c:pt idx="150">
                  <c:v>66.740619808722997</c:v>
                </c:pt>
                <c:pt idx="151">
                  <c:v>64.684772782304705</c:v>
                </c:pt>
                <c:pt idx="152">
                  <c:v>69.344375354115797</c:v>
                </c:pt>
                <c:pt idx="153">
                  <c:v>68.756334295935801</c:v>
                </c:pt>
                <c:pt idx="154">
                  <c:v>67.197327897769796</c:v>
                </c:pt>
                <c:pt idx="155">
                  <c:v>71.581868079673797</c:v>
                </c:pt>
                <c:pt idx="156">
                  <c:v>65.171141793301601</c:v>
                </c:pt>
                <c:pt idx="157">
                  <c:v>67.834225146692305</c:v>
                </c:pt>
                <c:pt idx="158">
                  <c:v>62.939087822818202</c:v>
                </c:pt>
                <c:pt idx="159">
                  <c:v>70.675912707660302</c:v>
                </c:pt>
                <c:pt idx="160">
                  <c:v>71.236452625395003</c:v>
                </c:pt>
                <c:pt idx="161">
                  <c:v>71.051794974335195</c:v>
                </c:pt>
                <c:pt idx="162">
                  <c:v>52.548679785780401</c:v>
                </c:pt>
                <c:pt idx="163">
                  <c:v>71.130448294963401</c:v>
                </c:pt>
                <c:pt idx="164">
                  <c:v>54.565163634591798</c:v>
                </c:pt>
                <c:pt idx="165">
                  <c:v>62.950675120676202</c:v>
                </c:pt>
                <c:pt idx="166">
                  <c:v>52.019365933287602</c:v>
                </c:pt>
                <c:pt idx="167">
                  <c:v>59.9558838298232</c:v>
                </c:pt>
                <c:pt idx="168">
                  <c:v>70.419447029197798</c:v>
                </c:pt>
                <c:pt idx="169">
                  <c:v>72.076394334452402</c:v>
                </c:pt>
                <c:pt idx="170">
                  <c:v>66.9260432106651</c:v>
                </c:pt>
                <c:pt idx="171">
                  <c:v>64.074333180120206</c:v>
                </c:pt>
                <c:pt idx="172">
                  <c:v>52.431449539146101</c:v>
                </c:pt>
                <c:pt idx="173">
                  <c:v>76.715192110952401</c:v>
                </c:pt>
                <c:pt idx="174">
                  <c:v>71.281673559158605</c:v>
                </c:pt>
                <c:pt idx="175">
                  <c:v>67.129982906582697</c:v>
                </c:pt>
                <c:pt idx="176">
                  <c:v>64.530315212194196</c:v>
                </c:pt>
                <c:pt idx="177">
                  <c:v>76.949128438444205</c:v>
                </c:pt>
                <c:pt idx="178">
                  <c:v>63.050490248901298</c:v>
                </c:pt>
                <c:pt idx="179">
                  <c:v>58.145518012840398</c:v>
                </c:pt>
                <c:pt idx="180">
                  <c:v>66.095499822458194</c:v>
                </c:pt>
                <c:pt idx="181">
                  <c:v>63.634206655047997</c:v>
                </c:pt>
                <c:pt idx="182">
                  <c:v>60.968682865434097</c:v>
                </c:pt>
                <c:pt idx="183">
                  <c:v>71.949353880969895</c:v>
                </c:pt>
                <c:pt idx="184">
                  <c:v>70.430063253306898</c:v>
                </c:pt>
                <c:pt idx="185">
                  <c:v>52.406034723636701</c:v>
                </c:pt>
                <c:pt idx="186">
                  <c:v>64.033874313981201</c:v>
                </c:pt>
                <c:pt idx="187">
                  <c:v>79.859124693743098</c:v>
                </c:pt>
                <c:pt idx="188">
                  <c:v>52.333645247143501</c:v>
                </c:pt>
                <c:pt idx="189">
                  <c:v>57.079380697643899</c:v>
                </c:pt>
                <c:pt idx="190">
                  <c:v>50.534600594448598</c:v>
                </c:pt>
                <c:pt idx="191">
                  <c:v>62.066823287112697</c:v>
                </c:pt>
                <c:pt idx="192">
                  <c:v>60.103324977405698</c:v>
                </c:pt>
                <c:pt idx="193">
                  <c:v>60.041648687342096</c:v>
                </c:pt>
                <c:pt idx="194">
                  <c:v>60.881660358045302</c:v>
                </c:pt>
                <c:pt idx="195">
                  <c:v>66.843397666554296</c:v>
                </c:pt>
                <c:pt idx="196">
                  <c:v>60.251898942758103</c:v>
                </c:pt>
                <c:pt idx="197">
                  <c:v>71.960560774843401</c:v>
                </c:pt>
                <c:pt idx="198">
                  <c:v>61.986270328986599</c:v>
                </c:pt>
                <c:pt idx="199">
                  <c:v>66.981146852841604</c:v>
                </c:pt>
                <c:pt idx="200">
                  <c:v>65.277081962733902</c:v>
                </c:pt>
                <c:pt idx="201">
                  <c:v>67.126100102082404</c:v>
                </c:pt>
                <c:pt idx="202">
                  <c:v>75.405925153434296</c:v>
                </c:pt>
                <c:pt idx="203">
                  <c:v>61.076136624840601</c:v>
                </c:pt>
                <c:pt idx="204">
                  <c:v>57.9101165293376</c:v>
                </c:pt>
                <c:pt idx="205">
                  <c:v>56.175354611741398</c:v>
                </c:pt>
                <c:pt idx="206">
                  <c:v>57.429436050340499</c:v>
                </c:pt>
                <c:pt idx="207">
                  <c:v>58.846731355708798</c:v>
                </c:pt>
                <c:pt idx="208">
                  <c:v>59.367247948039399</c:v>
                </c:pt>
                <c:pt idx="209">
                  <c:v>60.810453904950599</c:v>
                </c:pt>
                <c:pt idx="210">
                  <c:v>74.761381630258299</c:v>
                </c:pt>
                <c:pt idx="211">
                  <c:v>65.241423622944794</c:v>
                </c:pt>
                <c:pt idx="212">
                  <c:v>59.556581883535401</c:v>
                </c:pt>
                <c:pt idx="213">
                  <c:v>52.824275727121403</c:v>
                </c:pt>
                <c:pt idx="214">
                  <c:v>57.353497816777903</c:v>
                </c:pt>
                <c:pt idx="215">
                  <c:v>46.569296352754598</c:v>
                </c:pt>
                <c:pt idx="216">
                  <c:v>63.6207708760735</c:v>
                </c:pt>
                <c:pt idx="217">
                  <c:v>56.333736080908302</c:v>
                </c:pt>
                <c:pt idx="218">
                  <c:v>58.698533217241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030-FB47-83D6-88D449E382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78704"/>
        <c:axId val="534881840"/>
      </c:scatterChart>
      <c:valAx>
        <c:axId val="534878704"/>
        <c:scaling>
          <c:orientation val="minMax"/>
          <c:max val="25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FW</a:t>
                </a:r>
                <a:r>
                  <a:rPr lang="fr-FR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  <a:r>
                  <a:rPr lang="fr-FR" sz="1000" b="0" i="0" u="none" strike="noStrike" baseline="0" dirty="0">
                    <a:effectLst/>
                  </a:rPr>
                  <a:t> (grams)</a:t>
                </a:r>
                <a:endParaRPr lang="fr-FR" sz="1000" b="0" i="0" u="none" strike="noStrike" kern="1200" spc="0" baseline="-20000" dirty="0">
                  <a:solidFill>
                    <a:sysClr val="windowText" lastClr="000000">
                      <a:lumMod val="65000"/>
                      <a:lumOff val="35000"/>
                    </a:sysClr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1840"/>
        <c:crosses val="autoZero"/>
        <c:crossBetween val="midCat"/>
        <c:majorUnit val="50"/>
      </c:valAx>
      <c:valAx>
        <c:axId val="534881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FF</a:t>
                </a:r>
                <a:r>
                  <a:rPr lang="fr-FR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sz="1000" b="0" i="0" u="none" strike="noStrike" kern="1200" spc="0" baseline="-20000" dirty="0">
                  <a:solidFill>
                    <a:sysClr val="windowText" lastClr="000000">
                      <a:lumMod val="65000"/>
                      <a:lumOff val="35000"/>
                    </a:sysClr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787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36119623770453"/>
          <c:y val="0.14393518518518519"/>
          <c:w val="0.63605372700524887"/>
          <c:h val="0.63197543015456403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I$1</c:f>
              <c:strCache>
                <c:ptCount val="1"/>
                <c:pt idx="0">
                  <c:v>Loss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F$2:$F$246</c:f>
              <c:numCache>
                <c:formatCode>0.0%</c:formatCode>
                <c:ptCount val="245"/>
                <c:pt idx="0">
                  <c:v>2.4191798934177333E-2</c:v>
                </c:pt>
                <c:pt idx="1">
                  <c:v>2.1934891026392588E-2</c:v>
                </c:pt>
                <c:pt idx="2">
                  <c:v>2.2023185301810667E-2</c:v>
                </c:pt>
                <c:pt idx="3">
                  <c:v>1.6368255093411044E-2</c:v>
                </c:pt>
                <c:pt idx="4">
                  <c:v>1.6989980301916209E-2</c:v>
                </c:pt>
                <c:pt idx="5">
                  <c:v>2.3982785204777101E-2</c:v>
                </c:pt>
                <c:pt idx="6">
                  <c:v>1.9540130679921643E-2</c:v>
                </c:pt>
                <c:pt idx="7">
                  <c:v>2.3040825212303419E-2</c:v>
                </c:pt>
                <c:pt idx="8">
                  <c:v>2.1050907273790574E-2</c:v>
                </c:pt>
                <c:pt idx="9">
                  <c:v>3.5992954860094531E-2</c:v>
                </c:pt>
                <c:pt idx="10">
                  <c:v>2.3341945779087679E-2</c:v>
                </c:pt>
                <c:pt idx="11">
                  <c:v>4.2613940961755546E-2</c:v>
                </c:pt>
                <c:pt idx="12">
                  <c:v>2.7266088001616961E-2</c:v>
                </c:pt>
                <c:pt idx="13">
                  <c:v>1.990719448828655E-2</c:v>
                </c:pt>
                <c:pt idx="14">
                  <c:v>2.4556247397660092E-2</c:v>
                </c:pt>
                <c:pt idx="15">
                  <c:v>4.8774076177098925E-2</c:v>
                </c:pt>
                <c:pt idx="16">
                  <c:v>2.395498089766792E-2</c:v>
                </c:pt>
                <c:pt idx="17">
                  <c:v>2.2086347757921933E-2</c:v>
                </c:pt>
                <c:pt idx="18">
                  <c:v>2.3583829104797126E-2</c:v>
                </c:pt>
                <c:pt idx="19">
                  <c:v>2.8361565719942351E-2</c:v>
                </c:pt>
                <c:pt idx="20">
                  <c:v>2.7889447337214945E-2</c:v>
                </c:pt>
                <c:pt idx="21">
                  <c:v>2.5558323156631403E-2</c:v>
                </c:pt>
                <c:pt idx="22">
                  <c:v>1.9208334585642195E-2</c:v>
                </c:pt>
                <c:pt idx="23">
                  <c:v>3.8217696976206292E-2</c:v>
                </c:pt>
                <c:pt idx="24">
                  <c:v>1.8956200233033994E-2</c:v>
                </c:pt>
                <c:pt idx="25">
                  <c:v>3.3679399832271396E-2</c:v>
                </c:pt>
                <c:pt idx="26">
                  <c:v>4.7072244156455431E-2</c:v>
                </c:pt>
                <c:pt idx="27">
                  <c:v>2.3297499076222916E-2</c:v>
                </c:pt>
                <c:pt idx="28">
                  <c:v>1.8205330289727751E-2</c:v>
                </c:pt>
                <c:pt idx="29">
                  <c:v>3.0200589545108646E-2</c:v>
                </c:pt>
                <c:pt idx="30">
                  <c:v>2.8169306602574461E-2</c:v>
                </c:pt>
                <c:pt idx="31">
                  <c:v>2.4284644267561495E-2</c:v>
                </c:pt>
                <c:pt idx="32">
                  <c:v>2.6647754054810992E-2</c:v>
                </c:pt>
                <c:pt idx="33">
                  <c:v>2.6075941625886334E-2</c:v>
                </c:pt>
                <c:pt idx="34">
                  <c:v>4.1349763362123773E-2</c:v>
                </c:pt>
                <c:pt idx="35">
                  <c:v>5.3717170365650754E-2</c:v>
                </c:pt>
                <c:pt idx="36">
                  <c:v>2.0984229354021243E-2</c:v>
                </c:pt>
                <c:pt idx="37">
                  <c:v>2.0828220942988196E-2</c:v>
                </c:pt>
                <c:pt idx="38">
                  <c:v>1.8357982615619738E-2</c:v>
                </c:pt>
                <c:pt idx="39">
                  <c:v>2.3315857961108889E-2</c:v>
                </c:pt>
                <c:pt idx="40">
                  <c:v>2.3103877856646183E-2</c:v>
                </c:pt>
                <c:pt idx="41">
                  <c:v>1.9106597295248905E-2</c:v>
                </c:pt>
                <c:pt idx="42">
                  <c:v>4.0613658316079305E-2</c:v>
                </c:pt>
                <c:pt idx="43">
                  <c:v>2.2025016086335603E-2</c:v>
                </c:pt>
                <c:pt idx="44">
                  <c:v>2.1360153245782887E-2</c:v>
                </c:pt>
                <c:pt idx="45">
                  <c:v>2.8230655427272943E-2</c:v>
                </c:pt>
                <c:pt idx="46">
                  <c:v>3.3003721144496609E-2</c:v>
                </c:pt>
                <c:pt idx="47">
                  <c:v>3.5077307337220809E-2</c:v>
                </c:pt>
                <c:pt idx="48">
                  <c:v>2.4890972438733637E-2</c:v>
                </c:pt>
                <c:pt idx="49">
                  <c:v>2.3411120067989132E-2</c:v>
                </c:pt>
                <c:pt idx="50">
                  <c:v>2.4827561303442592E-2</c:v>
                </c:pt>
                <c:pt idx="51">
                  <c:v>2.0303412788554697E-2</c:v>
                </c:pt>
                <c:pt idx="52">
                  <c:v>1.8825740805657399E-2</c:v>
                </c:pt>
                <c:pt idx="53">
                  <c:v>3.2197957147335796E-2</c:v>
                </c:pt>
                <c:pt idx="54">
                  <c:v>1.639081252223442E-2</c:v>
                </c:pt>
                <c:pt idx="55">
                  <c:v>1.6871299493005122E-2</c:v>
                </c:pt>
                <c:pt idx="56">
                  <c:v>1.6967026738989664E-2</c:v>
                </c:pt>
                <c:pt idx="57">
                  <c:v>3.0583905360308326E-2</c:v>
                </c:pt>
                <c:pt idx="58">
                  <c:v>2.2579082917833525E-2</c:v>
                </c:pt>
                <c:pt idx="59">
                  <c:v>2.3497961268631774E-2</c:v>
                </c:pt>
                <c:pt idx="60">
                  <c:v>2.0899369446986761E-2</c:v>
                </c:pt>
                <c:pt idx="61">
                  <c:v>2.0657703927090165E-2</c:v>
                </c:pt>
                <c:pt idx="62">
                  <c:v>2.3161861542298202E-2</c:v>
                </c:pt>
                <c:pt idx="63">
                  <c:v>2.0921200713923317E-2</c:v>
                </c:pt>
                <c:pt idx="64">
                  <c:v>1.7175440156774524E-2</c:v>
                </c:pt>
                <c:pt idx="65">
                  <c:v>2.3277065937944673E-2</c:v>
                </c:pt>
                <c:pt idx="66">
                  <c:v>1.6392671670856472E-2</c:v>
                </c:pt>
                <c:pt idx="67">
                  <c:v>1.9524594595089949E-2</c:v>
                </c:pt>
                <c:pt idx="68">
                  <c:v>2.3589219306213736E-2</c:v>
                </c:pt>
                <c:pt idx="69">
                  <c:v>4.3653945648611713E-2</c:v>
                </c:pt>
                <c:pt idx="70">
                  <c:v>4.2580813054753142E-2</c:v>
                </c:pt>
                <c:pt idx="71">
                  <c:v>4.8077938415226985E-2</c:v>
                </c:pt>
                <c:pt idx="72">
                  <c:v>4.9526096443264042E-2</c:v>
                </c:pt>
                <c:pt idx="73">
                  <c:v>1.8434679062297277E-2</c:v>
                </c:pt>
                <c:pt idx="74">
                  <c:v>2.5544152231607685E-2</c:v>
                </c:pt>
                <c:pt idx="75">
                  <c:v>2.5528941666102756E-2</c:v>
                </c:pt>
                <c:pt idx="76">
                  <c:v>3.034003298079424E-2</c:v>
                </c:pt>
                <c:pt idx="77">
                  <c:v>1.479561142450685E-2</c:v>
                </c:pt>
                <c:pt idx="78">
                  <c:v>2.3734764775950223E-2</c:v>
                </c:pt>
                <c:pt idx="79">
                  <c:v>2.8303275945784391E-2</c:v>
                </c:pt>
                <c:pt idx="80">
                  <c:v>4.0128520626043218E-2</c:v>
                </c:pt>
                <c:pt idx="81">
                  <c:v>1.8375825717181393E-2</c:v>
                </c:pt>
                <c:pt idx="82">
                  <c:v>3.1339111824532306E-2</c:v>
                </c:pt>
                <c:pt idx="83">
                  <c:v>3.1030356419708971E-2</c:v>
                </c:pt>
                <c:pt idx="84">
                  <c:v>2.8177054040520243E-2</c:v>
                </c:pt>
                <c:pt idx="85">
                  <c:v>3.0487563976510378E-2</c:v>
                </c:pt>
                <c:pt idx="86">
                  <c:v>1.6611624093017398E-2</c:v>
                </c:pt>
                <c:pt idx="87">
                  <c:v>2.9305046641732078E-2</c:v>
                </c:pt>
                <c:pt idx="88">
                  <c:v>4.3405913520435727E-2</c:v>
                </c:pt>
                <c:pt idx="89">
                  <c:v>2.2832621003916899E-2</c:v>
                </c:pt>
                <c:pt idx="90">
                  <c:v>2.159873337303737E-2</c:v>
                </c:pt>
                <c:pt idx="91">
                  <c:v>2.2483017699719832E-2</c:v>
                </c:pt>
                <c:pt idx="92">
                  <c:v>2.0464796553583176E-2</c:v>
                </c:pt>
                <c:pt idx="93">
                  <c:v>3.2636270974856885E-2</c:v>
                </c:pt>
                <c:pt idx="94">
                  <c:v>2.1243818473650887E-2</c:v>
                </c:pt>
                <c:pt idx="95">
                  <c:v>2.1029821346256306E-2</c:v>
                </c:pt>
                <c:pt idx="96">
                  <c:v>1.6046694745677971E-2</c:v>
                </c:pt>
                <c:pt idx="97">
                  <c:v>4.0719748056919157E-2</c:v>
                </c:pt>
                <c:pt idx="98">
                  <c:v>2.7046702987314264E-2</c:v>
                </c:pt>
                <c:pt idx="99">
                  <c:v>4.2938445724251983E-2</c:v>
                </c:pt>
                <c:pt idx="100">
                  <c:v>6.0468560067905977E-2</c:v>
                </c:pt>
                <c:pt idx="101">
                  <c:v>1.827227364752404E-2</c:v>
                </c:pt>
                <c:pt idx="102">
                  <c:v>2.1312277552664027E-2</c:v>
                </c:pt>
                <c:pt idx="103">
                  <c:v>1.9733940939761618E-2</c:v>
                </c:pt>
                <c:pt idx="104">
                  <c:v>3.184143127990393E-2</c:v>
                </c:pt>
                <c:pt idx="105">
                  <c:v>6.1234588082844502E-2</c:v>
                </c:pt>
                <c:pt idx="106">
                  <c:v>2.5193538412324766E-2</c:v>
                </c:pt>
                <c:pt idx="107">
                  <c:v>2.7876868792363174E-2</c:v>
                </c:pt>
                <c:pt idx="108">
                  <c:v>3.253434656242582E-2</c:v>
                </c:pt>
                <c:pt idx="109">
                  <c:v>2.436516145392149E-2</c:v>
                </c:pt>
                <c:pt idx="110">
                  <c:v>4.0603317913460987E-2</c:v>
                </c:pt>
                <c:pt idx="111">
                  <c:v>2.0403766529088218E-2</c:v>
                </c:pt>
                <c:pt idx="112">
                  <c:v>3.5916445305553976E-2</c:v>
                </c:pt>
                <c:pt idx="113">
                  <c:v>5.8392929831549714E-2</c:v>
                </c:pt>
                <c:pt idx="114">
                  <c:v>2.0255419404879516E-2</c:v>
                </c:pt>
                <c:pt idx="115">
                  <c:v>4.1795322861711573E-2</c:v>
                </c:pt>
                <c:pt idx="116">
                  <c:v>3.3929247357634897E-2</c:v>
                </c:pt>
                <c:pt idx="117">
                  <c:v>3.1136608078338623E-2</c:v>
                </c:pt>
                <c:pt idx="118">
                  <c:v>1.8208511192164822E-2</c:v>
                </c:pt>
                <c:pt idx="119">
                  <c:v>2.0623465096461402E-2</c:v>
                </c:pt>
                <c:pt idx="120">
                  <c:v>2.5218415871352651E-2</c:v>
                </c:pt>
                <c:pt idx="121">
                  <c:v>2.219161183943661E-2</c:v>
                </c:pt>
                <c:pt idx="122">
                  <c:v>1.956888936446375E-2</c:v>
                </c:pt>
                <c:pt idx="123">
                  <c:v>4.7518671960819069E-2</c:v>
                </c:pt>
                <c:pt idx="124">
                  <c:v>5.7407582838607807E-2</c:v>
                </c:pt>
                <c:pt idx="125">
                  <c:v>1.7597556254618008E-2</c:v>
                </c:pt>
                <c:pt idx="126">
                  <c:v>1.8258246823628265E-2</c:v>
                </c:pt>
                <c:pt idx="127">
                  <c:v>2.4427743199197584E-2</c:v>
                </c:pt>
                <c:pt idx="128">
                  <c:v>2.5351820152769888E-2</c:v>
                </c:pt>
                <c:pt idx="129">
                  <c:v>2.2809970562314864E-2</c:v>
                </c:pt>
                <c:pt idx="130">
                  <c:v>2.1346908640888042E-2</c:v>
                </c:pt>
                <c:pt idx="131">
                  <c:v>2.0717892483536126E-2</c:v>
                </c:pt>
                <c:pt idx="132">
                  <c:v>4.068903973336635E-2</c:v>
                </c:pt>
                <c:pt idx="133">
                  <c:v>3.3659992492053425E-2</c:v>
                </c:pt>
                <c:pt idx="134">
                  <c:v>2.9882522346979922E-2</c:v>
                </c:pt>
                <c:pt idx="135">
                  <c:v>3.0339294217743683E-2</c:v>
                </c:pt>
                <c:pt idx="136">
                  <c:v>2.2365236077981555E-2</c:v>
                </c:pt>
                <c:pt idx="137">
                  <c:v>3.3895849992871471E-2</c:v>
                </c:pt>
                <c:pt idx="138">
                  <c:v>2.8544736123782832E-2</c:v>
                </c:pt>
                <c:pt idx="139">
                  <c:v>4.8288562397720523E-2</c:v>
                </c:pt>
                <c:pt idx="140">
                  <c:v>2.2457779703007351E-2</c:v>
                </c:pt>
                <c:pt idx="141">
                  <c:v>2.3101368067781358E-2</c:v>
                </c:pt>
                <c:pt idx="142">
                  <c:v>2.2566061252443249E-2</c:v>
                </c:pt>
                <c:pt idx="143">
                  <c:v>1.9931905459290866E-2</c:v>
                </c:pt>
                <c:pt idx="144">
                  <c:v>2.4400085557815431E-2</c:v>
                </c:pt>
                <c:pt idx="145">
                  <c:v>2.6229785593652279E-2</c:v>
                </c:pt>
                <c:pt idx="146">
                  <c:v>2.6677804299450901E-2</c:v>
                </c:pt>
                <c:pt idx="147">
                  <c:v>3.8105729435905976E-2</c:v>
                </c:pt>
                <c:pt idx="148">
                  <c:v>2.3662119857438137E-2</c:v>
                </c:pt>
                <c:pt idx="149">
                  <c:v>2.2780063126479309E-2</c:v>
                </c:pt>
                <c:pt idx="150">
                  <c:v>1.764811909033661E-2</c:v>
                </c:pt>
                <c:pt idx="151">
                  <c:v>2.3485103066478552E-2</c:v>
                </c:pt>
                <c:pt idx="152">
                  <c:v>2.8025395922291363E-2</c:v>
                </c:pt>
                <c:pt idx="153">
                  <c:v>1.7467899540518063E-2</c:v>
                </c:pt>
                <c:pt idx="154">
                  <c:v>2.4775905304179457E-2</c:v>
                </c:pt>
                <c:pt idx="155">
                  <c:v>2.563260721999152E-2</c:v>
                </c:pt>
                <c:pt idx="156">
                  <c:v>2.2588819841454933E-2</c:v>
                </c:pt>
                <c:pt idx="157">
                  <c:v>2.6303578094930734E-2</c:v>
                </c:pt>
                <c:pt idx="158">
                  <c:v>2.4685682346016823E-2</c:v>
                </c:pt>
                <c:pt idx="159">
                  <c:v>1.9043097837567614E-2</c:v>
                </c:pt>
                <c:pt idx="160">
                  <c:v>2.9517136069113749E-2</c:v>
                </c:pt>
                <c:pt idx="161">
                  <c:v>1.8973044954248806E-2</c:v>
                </c:pt>
                <c:pt idx="162">
                  <c:v>3.5145668568897025E-2</c:v>
                </c:pt>
                <c:pt idx="163">
                  <c:v>2.7714476583584346E-2</c:v>
                </c:pt>
                <c:pt idx="164">
                  <c:v>2.036628552393982E-2</c:v>
                </c:pt>
                <c:pt idx="165">
                  <c:v>1.7787873039190116E-2</c:v>
                </c:pt>
                <c:pt idx="166">
                  <c:v>2.483370070743951E-2</c:v>
                </c:pt>
                <c:pt idx="167">
                  <c:v>2.3492076311842757E-2</c:v>
                </c:pt>
                <c:pt idx="168">
                  <c:v>2.5655349896131961E-2</c:v>
                </c:pt>
                <c:pt idx="169">
                  <c:v>2.7407042227607571E-2</c:v>
                </c:pt>
                <c:pt idx="170">
                  <c:v>2.003856178372989E-2</c:v>
                </c:pt>
                <c:pt idx="171">
                  <c:v>1.9850155460586348E-2</c:v>
                </c:pt>
                <c:pt idx="172">
                  <c:v>2.5613672912678288E-2</c:v>
                </c:pt>
                <c:pt idx="173">
                  <c:v>1.9317869077817761E-2</c:v>
                </c:pt>
                <c:pt idx="174">
                  <c:v>2.1839798329134519E-2</c:v>
                </c:pt>
                <c:pt idx="175">
                  <c:v>2.5550570909149427E-2</c:v>
                </c:pt>
                <c:pt idx="176">
                  <c:v>2.7273193790773486E-2</c:v>
                </c:pt>
                <c:pt idx="177">
                  <c:v>2.2117821231795731E-2</c:v>
                </c:pt>
                <c:pt idx="178">
                  <c:v>2.4790367008223659E-2</c:v>
                </c:pt>
                <c:pt idx="179">
                  <c:v>1.8690064441697806E-2</c:v>
                </c:pt>
                <c:pt idx="180">
                  <c:v>2.2823581090491853E-2</c:v>
                </c:pt>
                <c:pt idx="181">
                  <c:v>2.4311527016228695E-2</c:v>
                </c:pt>
                <c:pt idx="182">
                  <c:v>1.9655852821944396E-2</c:v>
                </c:pt>
                <c:pt idx="183">
                  <c:v>3.1729779657297286E-2</c:v>
                </c:pt>
                <c:pt idx="184">
                  <c:v>1.8225541551693248E-2</c:v>
                </c:pt>
                <c:pt idx="185">
                  <c:v>1.8634160895073238E-2</c:v>
                </c:pt>
                <c:pt idx="186">
                  <c:v>2.7395469352666679E-2</c:v>
                </c:pt>
                <c:pt idx="187">
                  <c:v>2.6631650177682008E-2</c:v>
                </c:pt>
                <c:pt idx="188">
                  <c:v>1.8242632806534865E-2</c:v>
                </c:pt>
                <c:pt idx="189">
                  <c:v>2.3391715647105359E-2</c:v>
                </c:pt>
                <c:pt idx="190">
                  <c:v>1.8084265023221156E-2</c:v>
                </c:pt>
                <c:pt idx="191">
                  <c:v>3.1949396265490114E-2</c:v>
                </c:pt>
                <c:pt idx="192">
                  <c:v>1.9168096113519505E-2</c:v>
                </c:pt>
                <c:pt idx="193">
                  <c:v>2.4131073458703689E-2</c:v>
                </c:pt>
                <c:pt idx="194">
                  <c:v>2.0848915094523579E-2</c:v>
                </c:pt>
                <c:pt idx="195">
                  <c:v>3.4882253259573906E-2</c:v>
                </c:pt>
                <c:pt idx="196">
                  <c:v>4.9224675823481688E-2</c:v>
                </c:pt>
                <c:pt idx="197">
                  <c:v>2.5111003137151443E-2</c:v>
                </c:pt>
                <c:pt idx="198">
                  <c:v>1.9256943495039501E-2</c:v>
                </c:pt>
                <c:pt idx="199">
                  <c:v>1.960292735363689E-2</c:v>
                </c:pt>
                <c:pt idx="200">
                  <c:v>3.1349100009579044E-2</c:v>
                </c:pt>
                <c:pt idx="201">
                  <c:v>2.2867577416564422E-2</c:v>
                </c:pt>
                <c:pt idx="202">
                  <c:v>3.5610078822238565E-2</c:v>
                </c:pt>
                <c:pt idx="203">
                  <c:v>2.3336980287997577E-2</c:v>
                </c:pt>
                <c:pt idx="204">
                  <c:v>1.7351650538181683E-2</c:v>
                </c:pt>
                <c:pt idx="205">
                  <c:v>2.0177665736236895E-2</c:v>
                </c:pt>
                <c:pt idx="206">
                  <c:v>2.2446148784074738E-2</c:v>
                </c:pt>
                <c:pt idx="207">
                  <c:v>1.8520393103206034E-2</c:v>
                </c:pt>
                <c:pt idx="208">
                  <c:v>2.4598388842822748E-2</c:v>
                </c:pt>
                <c:pt idx="209">
                  <c:v>2.7530226939379787E-2</c:v>
                </c:pt>
                <c:pt idx="210">
                  <c:v>4.4304022826641296E-2</c:v>
                </c:pt>
                <c:pt idx="211">
                  <c:v>2.4823938729412555E-2</c:v>
                </c:pt>
                <c:pt idx="212">
                  <c:v>3.9247947116407889E-2</c:v>
                </c:pt>
                <c:pt idx="213">
                  <c:v>3.1870788765713497E-2</c:v>
                </c:pt>
                <c:pt idx="214">
                  <c:v>2.4664680139871841E-2</c:v>
                </c:pt>
              </c:numCache>
            </c:numRef>
          </c:xVal>
          <c:yVal>
            <c:numRef>
              <c:f>Feuil1!$I$2:$I$246</c:f>
              <c:numCache>
                <c:formatCode>0.0%</c:formatCode>
                <c:ptCount val="245"/>
                <c:pt idx="0">
                  <c:v>0.29339676033982698</c:v>
                </c:pt>
                <c:pt idx="1">
                  <c:v>0.39723878785748967</c:v>
                </c:pt>
                <c:pt idx="2">
                  <c:v>0.36255380553315997</c:v>
                </c:pt>
                <c:pt idx="3">
                  <c:v>0.46448389904789733</c:v>
                </c:pt>
                <c:pt idx="4">
                  <c:v>0.31281501635129538</c:v>
                </c:pt>
                <c:pt idx="5">
                  <c:v>0.42424151632841822</c:v>
                </c:pt>
                <c:pt idx="6">
                  <c:v>0.34417764697752995</c:v>
                </c:pt>
                <c:pt idx="7">
                  <c:v>0.43769226285779206</c:v>
                </c:pt>
                <c:pt idx="8">
                  <c:v>0.39976623755919344</c:v>
                </c:pt>
                <c:pt idx="9">
                  <c:v>0.47700518439414452</c:v>
                </c:pt>
                <c:pt idx="10">
                  <c:v>0.32791990184941694</c:v>
                </c:pt>
                <c:pt idx="11">
                  <c:v>0.41683911096775006</c:v>
                </c:pt>
                <c:pt idx="12">
                  <c:v>0.39713068185506628</c:v>
                </c:pt>
                <c:pt idx="13">
                  <c:v>0.42447150384071308</c:v>
                </c:pt>
                <c:pt idx="14">
                  <c:v>0.4312840692330675</c:v>
                </c:pt>
                <c:pt idx="15">
                  <c:v>0.43729643474272234</c:v>
                </c:pt>
                <c:pt idx="16">
                  <c:v>0.37889937242165972</c:v>
                </c:pt>
                <c:pt idx="17">
                  <c:v>0.34742399265413282</c:v>
                </c:pt>
                <c:pt idx="18">
                  <c:v>0.34781866626849167</c:v>
                </c:pt>
                <c:pt idx="19">
                  <c:v>0.36943197922951321</c:v>
                </c:pt>
                <c:pt idx="20">
                  <c:v>0.42964834026324183</c:v>
                </c:pt>
                <c:pt idx="21">
                  <c:v>0.39336187983489024</c:v>
                </c:pt>
                <c:pt idx="22">
                  <c:v>0.35791853863414136</c:v>
                </c:pt>
                <c:pt idx="23">
                  <c:v>0.37320403165583638</c:v>
                </c:pt>
                <c:pt idx="24">
                  <c:v>0.28951701862695312</c:v>
                </c:pt>
                <c:pt idx="25">
                  <c:v>0.35783158285232231</c:v>
                </c:pt>
                <c:pt idx="26">
                  <c:v>0.48741407019551125</c:v>
                </c:pt>
                <c:pt idx="27">
                  <c:v>0.4166515282506042</c:v>
                </c:pt>
                <c:pt idx="28">
                  <c:v>0.38443674479421525</c:v>
                </c:pt>
                <c:pt idx="29">
                  <c:v>0.42746971239213305</c:v>
                </c:pt>
                <c:pt idx="30">
                  <c:v>0.34999438274266326</c:v>
                </c:pt>
                <c:pt idx="31">
                  <c:v>0.41179605780168105</c:v>
                </c:pt>
                <c:pt idx="32">
                  <c:v>0.30997987062572335</c:v>
                </c:pt>
                <c:pt idx="33">
                  <c:v>0.44477294513162591</c:v>
                </c:pt>
                <c:pt idx="34">
                  <c:v>0.41741317156063873</c:v>
                </c:pt>
                <c:pt idx="35">
                  <c:v>0.50482017656230338</c:v>
                </c:pt>
                <c:pt idx="36">
                  <c:v>0.45402228563139913</c:v>
                </c:pt>
                <c:pt idx="37">
                  <c:v>0.45413141583215089</c:v>
                </c:pt>
                <c:pt idx="38">
                  <c:v>0.28905852256554676</c:v>
                </c:pt>
                <c:pt idx="39">
                  <c:v>0.24954294188758458</c:v>
                </c:pt>
                <c:pt idx="40">
                  <c:v>0.35961026922363537</c:v>
                </c:pt>
                <c:pt idx="41">
                  <c:v>0.46874344264181655</c:v>
                </c:pt>
                <c:pt idx="42">
                  <c:v>0.57711933501027457</c:v>
                </c:pt>
                <c:pt idx="43">
                  <c:v>0.35642623797611661</c:v>
                </c:pt>
                <c:pt idx="44">
                  <c:v>0.3396127515846894</c:v>
                </c:pt>
                <c:pt idx="45">
                  <c:v>0.51646210132100945</c:v>
                </c:pt>
                <c:pt idx="46">
                  <c:v>0.16914590843633273</c:v>
                </c:pt>
                <c:pt idx="47">
                  <c:v>0.4300421182225822</c:v>
                </c:pt>
                <c:pt idx="48">
                  <c:v>0.44087028383581439</c:v>
                </c:pt>
                <c:pt idx="49">
                  <c:v>0.42721206450042892</c:v>
                </c:pt>
                <c:pt idx="50">
                  <c:v>0.49478989143996854</c:v>
                </c:pt>
                <c:pt idx="51">
                  <c:v>0.39736379307718295</c:v>
                </c:pt>
                <c:pt idx="52">
                  <c:v>0.42738216491364955</c:v>
                </c:pt>
                <c:pt idx="53">
                  <c:v>0.39603311525732937</c:v>
                </c:pt>
                <c:pt idx="54">
                  <c:v>0.37107258531665011</c:v>
                </c:pt>
                <c:pt idx="55">
                  <c:v>0.36689008785285282</c:v>
                </c:pt>
                <c:pt idx="56">
                  <c:v>0.30812032482201374</c:v>
                </c:pt>
                <c:pt idx="57">
                  <c:v>0.33090120796377825</c:v>
                </c:pt>
                <c:pt idx="58">
                  <c:v>0.39597725935471229</c:v>
                </c:pt>
                <c:pt idx="59">
                  <c:v>0.37372979636874454</c:v>
                </c:pt>
                <c:pt idx="60">
                  <c:v>0.46071635849337456</c:v>
                </c:pt>
                <c:pt idx="61">
                  <c:v>0.42405720672184205</c:v>
                </c:pt>
                <c:pt idx="62">
                  <c:v>0.56480557675550036</c:v>
                </c:pt>
                <c:pt idx="63">
                  <c:v>0.29060874832319994</c:v>
                </c:pt>
                <c:pt idx="64">
                  <c:v>0.33513397777587151</c:v>
                </c:pt>
                <c:pt idx="65">
                  <c:v>0.33693940743504813</c:v>
                </c:pt>
                <c:pt idx="66">
                  <c:v>0.28292540622531187</c:v>
                </c:pt>
                <c:pt idx="67">
                  <c:v>0.48514539037355497</c:v>
                </c:pt>
                <c:pt idx="68">
                  <c:v>0.31684290363020184</c:v>
                </c:pt>
                <c:pt idx="69">
                  <c:v>0.36533779178828685</c:v>
                </c:pt>
                <c:pt idx="70">
                  <c:v>0.3454353961028348</c:v>
                </c:pt>
                <c:pt idx="71">
                  <c:v>0.39929330719573786</c:v>
                </c:pt>
                <c:pt idx="72">
                  <c:v>0.40151248114692528</c:v>
                </c:pt>
                <c:pt idx="73">
                  <c:v>0.3279088991897855</c:v>
                </c:pt>
                <c:pt idx="74">
                  <c:v>0.31500434123424048</c:v>
                </c:pt>
                <c:pt idx="75">
                  <c:v>0.20414415603779265</c:v>
                </c:pt>
                <c:pt idx="76">
                  <c:v>0.37125749462057728</c:v>
                </c:pt>
                <c:pt idx="77">
                  <c:v>0.36822047326442769</c:v>
                </c:pt>
                <c:pt idx="78">
                  <c:v>0.36464257527663724</c:v>
                </c:pt>
                <c:pt idx="79">
                  <c:v>0.39599114526468571</c:v>
                </c:pt>
                <c:pt idx="80">
                  <c:v>0.40372037733579769</c:v>
                </c:pt>
                <c:pt idx="81">
                  <c:v>0.3197697486449928</c:v>
                </c:pt>
                <c:pt idx="82">
                  <c:v>0.53093507708842869</c:v>
                </c:pt>
                <c:pt idx="83">
                  <c:v>0.44960367533050649</c:v>
                </c:pt>
                <c:pt idx="84">
                  <c:v>0.36812481441527345</c:v>
                </c:pt>
                <c:pt idx="85">
                  <c:v>0.31970082389970395</c:v>
                </c:pt>
                <c:pt idx="86">
                  <c:v>0.3230656907650119</c:v>
                </c:pt>
                <c:pt idx="87">
                  <c:v>0.42874845616566787</c:v>
                </c:pt>
                <c:pt idx="88">
                  <c:v>0.3978981206600164</c:v>
                </c:pt>
                <c:pt idx="89">
                  <c:v>0.35958115494412196</c:v>
                </c:pt>
                <c:pt idx="90">
                  <c:v>0.33982879406337946</c:v>
                </c:pt>
                <c:pt idx="91">
                  <c:v>0.37216190121022252</c:v>
                </c:pt>
                <c:pt idx="92">
                  <c:v>0.39511823948182989</c:v>
                </c:pt>
                <c:pt idx="93">
                  <c:v>0.3934344294644575</c:v>
                </c:pt>
                <c:pt idx="94">
                  <c:v>0.391873416603637</c:v>
                </c:pt>
                <c:pt idx="95">
                  <c:v>0.39612113207872446</c:v>
                </c:pt>
                <c:pt idx="96">
                  <c:v>0.59656971665269665</c:v>
                </c:pt>
                <c:pt idx="97">
                  <c:v>0.45214088327420471</c:v>
                </c:pt>
                <c:pt idx="98">
                  <c:v>0.48425223665919648</c:v>
                </c:pt>
                <c:pt idx="99">
                  <c:v>0.40445884690260125</c:v>
                </c:pt>
                <c:pt idx="100">
                  <c:v>0.43912034038786779</c:v>
                </c:pt>
                <c:pt idx="101">
                  <c:v>0.45441369266041826</c:v>
                </c:pt>
                <c:pt idx="102">
                  <c:v>0.38077450985667027</c:v>
                </c:pt>
                <c:pt idx="103">
                  <c:v>0.39867287331916829</c:v>
                </c:pt>
                <c:pt idx="104">
                  <c:v>0.36128634160620116</c:v>
                </c:pt>
                <c:pt idx="105">
                  <c:v>0.46464651977841137</c:v>
                </c:pt>
                <c:pt idx="106">
                  <c:v>0.43039797624941867</c:v>
                </c:pt>
                <c:pt idx="107">
                  <c:v>0.35750697744940096</c:v>
                </c:pt>
                <c:pt idx="108">
                  <c:v>0.37955092206580882</c:v>
                </c:pt>
                <c:pt idx="109">
                  <c:v>0.41824987386759016</c:v>
                </c:pt>
                <c:pt idx="110">
                  <c:v>0.43787572190180979</c:v>
                </c:pt>
                <c:pt idx="111">
                  <c:v>0.44630232881224891</c:v>
                </c:pt>
                <c:pt idx="112">
                  <c:v>0.38362582484196661</c:v>
                </c:pt>
                <c:pt idx="113">
                  <c:v>0.47156421277729288</c:v>
                </c:pt>
                <c:pt idx="114">
                  <c:v>0.37053059788502135</c:v>
                </c:pt>
                <c:pt idx="115">
                  <c:v>0.40162472560704449</c:v>
                </c:pt>
                <c:pt idx="116">
                  <c:v>0.4994301581836883</c:v>
                </c:pt>
                <c:pt idx="117">
                  <c:v>0.40194162781011666</c:v>
                </c:pt>
                <c:pt idx="118">
                  <c:v>0.44803175051975402</c:v>
                </c:pt>
                <c:pt idx="119">
                  <c:v>0.40446607742574325</c:v>
                </c:pt>
                <c:pt idx="120">
                  <c:v>0.39088664783840033</c:v>
                </c:pt>
                <c:pt idx="121">
                  <c:v>0.52638058236668983</c:v>
                </c:pt>
                <c:pt idx="122">
                  <c:v>0.45481614717348834</c:v>
                </c:pt>
                <c:pt idx="123">
                  <c:v>0.41208307605089739</c:v>
                </c:pt>
                <c:pt idx="124">
                  <c:v>0.50106287271969385</c:v>
                </c:pt>
                <c:pt idx="125">
                  <c:v>0.46165152080068833</c:v>
                </c:pt>
                <c:pt idx="126">
                  <c:v>0.45108309319847989</c:v>
                </c:pt>
                <c:pt idx="127">
                  <c:v>0.43930875223477839</c:v>
                </c:pt>
                <c:pt idx="128">
                  <c:v>0.41306417800467277</c:v>
                </c:pt>
                <c:pt idx="129">
                  <c:v>0.50181073108273955</c:v>
                </c:pt>
                <c:pt idx="130">
                  <c:v>0.5049273184099945</c:v>
                </c:pt>
                <c:pt idx="131">
                  <c:v>0.49021412399101222</c:v>
                </c:pt>
                <c:pt idx="132">
                  <c:v>0.40255237714285086</c:v>
                </c:pt>
                <c:pt idx="133">
                  <c:v>0.40379789756131973</c:v>
                </c:pt>
                <c:pt idx="134">
                  <c:v>0.449555160452492</c:v>
                </c:pt>
                <c:pt idx="135">
                  <c:v>0.48131099194141258</c:v>
                </c:pt>
                <c:pt idx="136">
                  <c:v>0.52924066293372873</c:v>
                </c:pt>
                <c:pt idx="137">
                  <c:v>0.42858320807842387</c:v>
                </c:pt>
                <c:pt idx="138">
                  <c:v>0.43133796794794765</c:v>
                </c:pt>
                <c:pt idx="139">
                  <c:v>0.48551234084771577</c:v>
                </c:pt>
                <c:pt idx="140">
                  <c:v>0.43125436711479448</c:v>
                </c:pt>
                <c:pt idx="141">
                  <c:v>0.42841917519497585</c:v>
                </c:pt>
                <c:pt idx="142">
                  <c:v>0.45867265509668709</c:v>
                </c:pt>
                <c:pt idx="143">
                  <c:v>0.56271263827638462</c:v>
                </c:pt>
                <c:pt idx="144">
                  <c:v>0.38655089744686277</c:v>
                </c:pt>
                <c:pt idx="145">
                  <c:v>0.44568869418074009</c:v>
                </c:pt>
                <c:pt idx="146">
                  <c:v>0.38255186957136439</c:v>
                </c:pt>
                <c:pt idx="147">
                  <c:v>0.35230991928745514</c:v>
                </c:pt>
                <c:pt idx="148">
                  <c:v>0.35201029919720062</c:v>
                </c:pt>
                <c:pt idx="149">
                  <c:v>0.52276037941647135</c:v>
                </c:pt>
                <c:pt idx="150">
                  <c:v>0.42986402734005569</c:v>
                </c:pt>
                <c:pt idx="151">
                  <c:v>0.39542306884084877</c:v>
                </c:pt>
                <c:pt idx="152">
                  <c:v>0.38725662500584035</c:v>
                </c:pt>
                <c:pt idx="153">
                  <c:v>0.3923457306415421</c:v>
                </c:pt>
                <c:pt idx="154">
                  <c:v>0.48727251070499233</c:v>
                </c:pt>
                <c:pt idx="155">
                  <c:v>0.44415632013689449</c:v>
                </c:pt>
                <c:pt idx="156">
                  <c:v>0.40386338054323917</c:v>
                </c:pt>
                <c:pt idx="157">
                  <c:v>0.43982900565907601</c:v>
                </c:pt>
                <c:pt idx="158">
                  <c:v>0.40928392275025294</c:v>
                </c:pt>
                <c:pt idx="159">
                  <c:v>0.37810423251642078</c:v>
                </c:pt>
                <c:pt idx="160">
                  <c:v>0.4003606420652136</c:v>
                </c:pt>
                <c:pt idx="161">
                  <c:v>0.40350693377934765</c:v>
                </c:pt>
                <c:pt idx="162">
                  <c:v>0.42142565079150385</c:v>
                </c:pt>
                <c:pt idx="163">
                  <c:v>0.44912888520940841</c:v>
                </c:pt>
                <c:pt idx="164">
                  <c:v>0.35085688476352317</c:v>
                </c:pt>
                <c:pt idx="165">
                  <c:v>0.23768216622434757</c:v>
                </c:pt>
                <c:pt idx="166">
                  <c:v>0.39411174676282312</c:v>
                </c:pt>
                <c:pt idx="167">
                  <c:v>0.39658964078143921</c:v>
                </c:pt>
                <c:pt idx="168">
                  <c:v>0.34873356305262321</c:v>
                </c:pt>
                <c:pt idx="169">
                  <c:v>0.38222571419136964</c:v>
                </c:pt>
                <c:pt idx="170">
                  <c:v>0.4023792064995762</c:v>
                </c:pt>
                <c:pt idx="171">
                  <c:v>0.41955785172168608</c:v>
                </c:pt>
                <c:pt idx="172">
                  <c:v>0.44401526969091665</c:v>
                </c:pt>
                <c:pt idx="173">
                  <c:v>0.47116021352495174</c:v>
                </c:pt>
                <c:pt idx="174">
                  <c:v>0.30815561088998028</c:v>
                </c:pt>
                <c:pt idx="175">
                  <c:v>0.49968561762476327</c:v>
                </c:pt>
                <c:pt idx="176">
                  <c:v>0.37646554666090709</c:v>
                </c:pt>
                <c:pt idx="177">
                  <c:v>0.3210207722046502</c:v>
                </c:pt>
                <c:pt idx="178">
                  <c:v>0.55881003426978215</c:v>
                </c:pt>
                <c:pt idx="179">
                  <c:v>0.39349421840688514</c:v>
                </c:pt>
                <c:pt idx="180">
                  <c:v>0.29867944153111176</c:v>
                </c:pt>
                <c:pt idx="181">
                  <c:v>0.41134881706443593</c:v>
                </c:pt>
                <c:pt idx="182">
                  <c:v>0.31861170870156047</c:v>
                </c:pt>
                <c:pt idx="183">
                  <c:v>0.38693155432044068</c:v>
                </c:pt>
                <c:pt idx="184">
                  <c:v>0.27462962128726109</c:v>
                </c:pt>
                <c:pt idx="185">
                  <c:v>0.4378932604009812</c:v>
                </c:pt>
                <c:pt idx="186">
                  <c:v>0.46352525532093036</c:v>
                </c:pt>
                <c:pt idx="187">
                  <c:v>0.41672891959834091</c:v>
                </c:pt>
                <c:pt idx="188">
                  <c:v>0.43670768337837879</c:v>
                </c:pt>
                <c:pt idx="189">
                  <c:v>0.4136907390296079</c:v>
                </c:pt>
                <c:pt idx="190">
                  <c:v>0.47967032709893154</c:v>
                </c:pt>
                <c:pt idx="191">
                  <c:v>0.36896900287427475</c:v>
                </c:pt>
                <c:pt idx="192">
                  <c:v>0.52191823109670066</c:v>
                </c:pt>
                <c:pt idx="193">
                  <c:v>0.45290906530531638</c:v>
                </c:pt>
                <c:pt idx="194">
                  <c:v>0.32145272188083751</c:v>
                </c:pt>
                <c:pt idx="195">
                  <c:v>0.5083984688962323</c:v>
                </c:pt>
                <c:pt idx="196">
                  <c:v>0.42591608382295199</c:v>
                </c:pt>
                <c:pt idx="197">
                  <c:v>0.42262947181963495</c:v>
                </c:pt>
                <c:pt idx="198">
                  <c:v>0.44681534560846636</c:v>
                </c:pt>
                <c:pt idx="199">
                  <c:v>0.42077034728220514</c:v>
                </c:pt>
                <c:pt idx="200">
                  <c:v>0.46185100070436647</c:v>
                </c:pt>
                <c:pt idx="201">
                  <c:v>0.45286043067303189</c:v>
                </c:pt>
                <c:pt idx="202">
                  <c:v>0.31423555978484097</c:v>
                </c:pt>
                <c:pt idx="203">
                  <c:v>0.32884411078221554</c:v>
                </c:pt>
                <c:pt idx="204">
                  <c:v>0.44003173094560905</c:v>
                </c:pt>
                <c:pt idx="205">
                  <c:v>0.34238013811928403</c:v>
                </c:pt>
                <c:pt idx="206">
                  <c:v>0.37836573121381167</c:v>
                </c:pt>
                <c:pt idx="207">
                  <c:v>0.43633286524048465</c:v>
                </c:pt>
                <c:pt idx="208">
                  <c:v>0.46098085298143426</c:v>
                </c:pt>
                <c:pt idx="209">
                  <c:v>0.35973422554592915</c:v>
                </c:pt>
                <c:pt idx="210">
                  <c:v>0.28068160411515242</c:v>
                </c:pt>
                <c:pt idx="211">
                  <c:v>0.39636348130914473</c:v>
                </c:pt>
                <c:pt idx="212">
                  <c:v>0.42089839525174322</c:v>
                </c:pt>
                <c:pt idx="213">
                  <c:v>0.5101119965961326</c:v>
                </c:pt>
                <c:pt idx="214">
                  <c:v>0.430429738838028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BB8-054B-9271-6745C6CAA1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81056"/>
        <c:axId val="534883800"/>
      </c:scatterChart>
      <c:valAx>
        <c:axId val="534881056"/>
        <c:scaling>
          <c:orientation val="minMax"/>
          <c:max val="0.1200000000000000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Loss</a:t>
                </a:r>
                <a:r>
                  <a:rPr lang="fr-FR" baseline="0" dirty="0"/>
                  <a:t>FW</a:t>
                </a:r>
                <a:r>
                  <a:rPr lang="fr-FR" baseline="-20000" dirty="0"/>
                  <a:t>T14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3800"/>
        <c:crosses val="autoZero"/>
        <c:crossBetween val="midCat"/>
        <c:majorUnit val="2.0000000000000004E-2"/>
      </c:valAx>
      <c:valAx>
        <c:axId val="534883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LossFF</a:t>
                </a:r>
                <a:r>
                  <a:rPr lang="fr-FR" baseline="-20000" dirty="0"/>
                  <a:t>T14</a:t>
                </a:r>
              </a:p>
            </c:rich>
          </c:tx>
          <c:layout>
            <c:manualLayout>
              <c:xMode val="edge"/>
              <c:yMode val="edge"/>
              <c:x val="8.554675125044478E-2"/>
              <c:y val="0.372511665208515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10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b="1"/>
              <a:t>INRAE</a:t>
            </a:r>
          </a:p>
        </c:rich>
      </c:tx>
      <c:layout>
        <c:manualLayout>
          <c:xMode val="edge"/>
          <c:yMode val="edge"/>
          <c:x val="0.33667912953946388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701102339106659"/>
          <c:y val="0.17171296296296296"/>
          <c:w val="0.60680050928383333"/>
          <c:h val="0.62271617089530473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V$1</c:f>
              <c:strCache>
                <c:ptCount val="1"/>
                <c:pt idx="0">
                  <c:v>LossFW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R$2:$R$248</c:f>
              <c:numCache>
                <c:formatCode>General</c:formatCode>
                <c:ptCount val="247"/>
                <c:pt idx="0" formatCode="0.0">
                  <c:v>80.870874791313497</c:v>
                </c:pt>
                <c:pt idx="2" formatCode="0.0">
                  <c:v>169.73624070253899</c:v>
                </c:pt>
                <c:pt idx="3" formatCode="0.0">
                  <c:v>85.000228485830206</c:v>
                </c:pt>
                <c:pt idx="4" formatCode="0.0">
                  <c:v>106.788158031522</c:v>
                </c:pt>
                <c:pt idx="5" formatCode="0.0">
                  <c:v>98.721657320032705</c:v>
                </c:pt>
                <c:pt idx="7" formatCode="0.0">
                  <c:v>102.329700998231</c:v>
                </c:pt>
                <c:pt idx="8" formatCode="0.0">
                  <c:v>80.531687861810596</c:v>
                </c:pt>
                <c:pt idx="9" formatCode="0.0">
                  <c:v>109.042495743662</c:v>
                </c:pt>
                <c:pt idx="10" formatCode="0.0">
                  <c:v>79.801657320032504</c:v>
                </c:pt>
                <c:pt idx="11" formatCode="0.0">
                  <c:v>108.48984241011399</c:v>
                </c:pt>
                <c:pt idx="12" formatCode="0.0">
                  <c:v>102.849086154234</c:v>
                </c:pt>
                <c:pt idx="13" formatCode="0.0">
                  <c:v>78.502495743662195</c:v>
                </c:pt>
                <c:pt idx="14" formatCode="0.0">
                  <c:v>75.3111390933162</c:v>
                </c:pt>
                <c:pt idx="15" formatCode="0.0">
                  <c:v>113.74834943818099</c:v>
                </c:pt>
                <c:pt idx="16" formatCode="0.0">
                  <c:v>129.75642763203999</c:v>
                </c:pt>
                <c:pt idx="17" formatCode="0.0">
                  <c:v>76.627495743662493</c:v>
                </c:pt>
                <c:pt idx="18" formatCode="0.0">
                  <c:v>79.998882935785801</c:v>
                </c:pt>
                <c:pt idx="19" formatCode="0.0">
                  <c:v>85.173110587657405</c:v>
                </c:pt>
                <c:pt idx="20" formatCode="0.0">
                  <c:v>71.430712295231999</c:v>
                </c:pt>
                <c:pt idx="21" formatCode="0.0">
                  <c:v>86.290887008023006</c:v>
                </c:pt>
                <c:pt idx="22" formatCode="0.0">
                  <c:v>122.88667564510099</c:v>
                </c:pt>
                <c:pt idx="23" formatCode="0.0">
                  <c:v>92.514289569384403</c:v>
                </c:pt>
                <c:pt idx="24" formatCode="0.0">
                  <c:v>111.144824698189</c:v>
                </c:pt>
                <c:pt idx="25" formatCode="0.0">
                  <c:v>114.882427632044</c:v>
                </c:pt>
                <c:pt idx="26" formatCode="0.0">
                  <c:v>92.925098370946202</c:v>
                </c:pt>
                <c:pt idx="27" formatCode="0.0">
                  <c:v>101.04168786181</c:v>
                </c:pt>
                <c:pt idx="28" formatCode="0.0">
                  <c:v>102.31554960245199</c:v>
                </c:pt>
                <c:pt idx="29" formatCode="0.0">
                  <c:v>98.489545530215196</c:v>
                </c:pt>
                <c:pt idx="30" formatCode="0.0">
                  <c:v>124.917262081785</c:v>
                </c:pt>
                <c:pt idx="31" formatCode="0.0">
                  <c:v>90.458039421860605</c:v>
                </c:pt>
                <c:pt idx="32" formatCode="0.0">
                  <c:v>83.118893116378402</c:v>
                </c:pt>
                <c:pt idx="33" formatCode="0.0">
                  <c:v>106.873334167292</c:v>
                </c:pt>
                <c:pt idx="34" formatCode="0.0">
                  <c:v>61.584488715596997</c:v>
                </c:pt>
                <c:pt idx="35" formatCode="0.0">
                  <c:v>130.21355774692699</c:v>
                </c:pt>
                <c:pt idx="36" formatCode="0.0">
                  <c:v>94.646452065464601</c:v>
                </c:pt>
                <c:pt idx="37" formatCode="0.0">
                  <c:v>52.142572098105298</c:v>
                </c:pt>
                <c:pt idx="38" formatCode="0.0">
                  <c:v>46.371450642486202</c:v>
                </c:pt>
                <c:pt idx="39" formatCode="0.0">
                  <c:v>109.938613641835</c:v>
                </c:pt>
                <c:pt idx="40" formatCode="0.0">
                  <c:v>87.093039421860098</c:v>
                </c:pt>
                <c:pt idx="41" formatCode="0.0">
                  <c:v>96.904326219517102</c:v>
                </c:pt>
                <c:pt idx="42" formatCode="0.0">
                  <c:v>103.24739240488699</c:v>
                </c:pt>
                <c:pt idx="43" formatCode="0.0">
                  <c:v>97.207098370946895</c:v>
                </c:pt>
                <c:pt idx="44" formatCode="0.0">
                  <c:v>103.05254155632799</c:v>
                </c:pt>
                <c:pt idx="45" formatCode="0.0">
                  <c:v>79.387569963637404</c:v>
                </c:pt>
                <c:pt idx="46" formatCode="0.0">
                  <c:v>113.169756893138</c:v>
                </c:pt>
                <c:pt idx="47" formatCode="0.0">
                  <c:v>101.03953331350399</c:v>
                </c:pt>
                <c:pt idx="48" formatCode="0.0">
                  <c:v>109.889533313504</c:v>
                </c:pt>
                <c:pt idx="49" formatCode="0.0">
                  <c:v>118.6246756451</c:v>
                </c:pt>
                <c:pt idx="50" formatCode="0.0">
                  <c:v>109.211980472774</c:v>
                </c:pt>
                <c:pt idx="51" formatCode="0.0">
                  <c:v>97.565962957546702</c:v>
                </c:pt>
                <c:pt idx="52" formatCode="0.0">
                  <c:v>91.902821030871294</c:v>
                </c:pt>
                <c:pt idx="53" formatCode="0.0">
                  <c:v>88.994804337004396</c:v>
                </c:pt>
                <c:pt idx="54" formatCode="0.0">
                  <c:v>81.774415415332001</c:v>
                </c:pt>
                <c:pt idx="55" formatCode="0.0">
                  <c:v>88.527372043704304</c:v>
                </c:pt>
                <c:pt idx="56" formatCode="0.0">
                  <c:v>114.252452065464</c:v>
                </c:pt>
                <c:pt idx="57" formatCode="0.0">
                  <c:v>109.700539421861</c:v>
                </c:pt>
                <c:pt idx="58" formatCode="0.0">
                  <c:v>99.462651211677994</c:v>
                </c:pt>
                <c:pt idx="59" formatCode="0.0">
                  <c:v>126.15779354327201</c:v>
                </c:pt>
                <c:pt idx="60" formatCode="0.0">
                  <c:v>75.231992689485196</c:v>
                </c:pt>
                <c:pt idx="61" formatCode="0.0">
                  <c:v>96.775098370946907</c:v>
                </c:pt>
                <c:pt idx="62" formatCode="0.0">
                  <c:v>75.623054692748696</c:v>
                </c:pt>
                <c:pt idx="63" formatCode="0.0">
                  <c:v>119.12960784005099</c:v>
                </c:pt>
                <c:pt idx="64" formatCode="0.0">
                  <c:v>117.310569963638</c:v>
                </c:pt>
                <c:pt idx="65" formatCode="0.0">
                  <c:v>113.848893116379</c:v>
                </c:pt>
                <c:pt idx="66" formatCode="0.0">
                  <c:v>106.815992689485</c:v>
                </c:pt>
                <c:pt idx="67" formatCode="0.0">
                  <c:v>106.420373466684</c:v>
                </c:pt>
                <c:pt idx="68" formatCode="0.0">
                  <c:v>102.940874791312</c:v>
                </c:pt>
                <c:pt idx="69" formatCode="0.0">
                  <c:v>71.858334167291801</c:v>
                </c:pt>
                <c:pt idx="70" formatCode="0.0">
                  <c:v>61.253980472773598</c:v>
                </c:pt>
                <c:pt idx="71" formatCode="0.0">
                  <c:v>92.130539421860107</c:v>
                </c:pt>
                <c:pt idx="72" formatCode="0.0">
                  <c:v>113.07886257460299</c:v>
                </c:pt>
                <c:pt idx="73" formatCode="0.0">
                  <c:v>72.571992689484006</c:v>
                </c:pt>
                <c:pt idx="74" formatCode="0.0">
                  <c:v>101.336718403587</c:v>
                </c:pt>
                <c:pt idx="75" formatCode="0.0">
                  <c:v>90.551980472774204</c:v>
                </c:pt>
                <c:pt idx="77" formatCode="0.0">
                  <c:v>111.71511058765699</c:v>
                </c:pt>
                <c:pt idx="78" formatCode="0.0">
                  <c:v>98.103024150971706</c:v>
                </c:pt>
                <c:pt idx="79" formatCode="0.0">
                  <c:v>75.299421523688196</c:v>
                </c:pt>
                <c:pt idx="80" formatCode="0.0">
                  <c:v>78.463557746926199</c:v>
                </c:pt>
                <c:pt idx="81" formatCode="0.0">
                  <c:v>83.925290489094706</c:v>
                </c:pt>
                <c:pt idx="82" formatCode="0.0">
                  <c:v>107.37443984875399</c:v>
                </c:pt>
                <c:pt idx="83" formatCode="0.0">
                  <c:v>33.843098370946699</c:v>
                </c:pt>
                <c:pt idx="84" formatCode="0.0">
                  <c:v>68.591982607242201</c:v>
                </c:pt>
                <c:pt idx="85" formatCode="0.0">
                  <c:v>81.555529241267806</c:v>
                </c:pt>
                <c:pt idx="86" formatCode="0.0">
                  <c:v>81.359135021079297</c:v>
                </c:pt>
                <c:pt idx="87" formatCode="0.0">
                  <c:v>79.138571386616107</c:v>
                </c:pt>
                <c:pt idx="88" formatCode="0.0">
                  <c:v>68.980290489094301</c:v>
                </c:pt>
                <c:pt idx="89" formatCode="0.0">
                  <c:v>105.000899224734</c:v>
                </c:pt>
                <c:pt idx="90" formatCode="0.0">
                  <c:v>87.131083100058007</c:v>
                </c:pt>
                <c:pt idx="91" formatCode="0.0">
                  <c:v>95.789607840050806</c:v>
                </c:pt>
                <c:pt idx="92" formatCode="0.0">
                  <c:v>106.450864709071</c:v>
                </c:pt>
                <c:pt idx="93" formatCode="0.0">
                  <c:v>85.914638994967902</c:v>
                </c:pt>
                <c:pt idx="94" formatCode="0.0">
                  <c:v>103.27442763204201</c:v>
                </c:pt>
                <c:pt idx="95" formatCode="0.0">
                  <c:v>91.406675645099995</c:v>
                </c:pt>
                <c:pt idx="96" formatCode="0.0">
                  <c:v>85.033727161200801</c:v>
                </c:pt>
                <c:pt idx="97" formatCode="0.0">
                  <c:v>92.100539421860205</c:v>
                </c:pt>
                <c:pt idx="98" formatCode="0.0">
                  <c:v>79.925539421859995</c:v>
                </c:pt>
                <c:pt idx="99" formatCode="0.0">
                  <c:v>130.11109837094699</c:v>
                </c:pt>
                <c:pt idx="100" formatCode="0.0">
                  <c:v>92.4310861542358</c:v>
                </c:pt>
                <c:pt idx="101" formatCode="0.0">
                  <c:v>90.078882935785998</c:v>
                </c:pt>
                <c:pt idx="102" formatCode="0.0">
                  <c:v>123.205041556328</c:v>
                </c:pt>
                <c:pt idx="103" formatCode="0.0">
                  <c:v>118.35165732003099</c:v>
                </c:pt>
                <c:pt idx="104" formatCode="0.0">
                  <c:v>110.524004906195</c:v>
                </c:pt>
                <c:pt idx="105" formatCode="0.0">
                  <c:v>153.3786594545</c:v>
                </c:pt>
                <c:pt idx="106" formatCode="0.0">
                  <c:v>102.651450642486</c:v>
                </c:pt>
                <c:pt idx="107" formatCode="0.0">
                  <c:v>114.99576910985</c:v>
                </c:pt>
                <c:pt idx="108" formatCode="0.0">
                  <c:v>91.976887008022601</c:v>
                </c:pt>
                <c:pt idx="109" formatCode="0.0">
                  <c:v>84.114427632042407</c:v>
                </c:pt>
                <c:pt idx="110" formatCode="0.0">
                  <c:v>122.303992689485</c:v>
                </c:pt>
                <c:pt idx="111" formatCode="0.0">
                  <c:v>117.31952109679401</c:v>
                </c:pt>
                <c:pt idx="112" formatCode="0.0">
                  <c:v>104.708427632043</c:v>
                </c:pt>
                <c:pt idx="113" formatCode="0.0">
                  <c:v>123.246098370948</c:v>
                </c:pt>
                <c:pt idx="114" formatCode="0.0">
                  <c:v>102.558899224735</c:v>
                </c:pt>
                <c:pt idx="115" formatCode="0.0">
                  <c:v>105.10084943818001</c:v>
                </c:pt>
                <c:pt idx="116" formatCode="0.0">
                  <c:v>71.961393116378204</c:v>
                </c:pt>
                <c:pt idx="117" formatCode="0.0">
                  <c:v>74.947545530215393</c:v>
                </c:pt>
                <c:pt idx="118" formatCode="0.0">
                  <c:v>69.776967336353593</c:v>
                </c:pt>
                <c:pt idx="119" formatCode="0.0">
                  <c:v>70.842941173382499</c:v>
                </c:pt>
                <c:pt idx="120" formatCode="0.0">
                  <c:v>91.102439848753804</c:v>
                </c:pt>
                <c:pt idx="121" formatCode="0.0">
                  <c:v>103.098887008023</c:v>
                </c:pt>
                <c:pt idx="122" formatCode="0.0">
                  <c:v>81.685382114425806</c:v>
                </c:pt>
                <c:pt idx="124" formatCode="0.0">
                  <c:v>77.337582180348406</c:v>
                </c:pt>
                <c:pt idx="125" formatCode="0.0">
                  <c:v>62.337805759983098</c:v>
                </c:pt>
                <c:pt idx="126" formatCode="0.0">
                  <c:v>127.114488715596</c:v>
                </c:pt>
                <c:pt idx="127" formatCode="0.0">
                  <c:v>116.597533313504</c:v>
                </c:pt>
                <c:pt idx="128" formatCode="0.0">
                  <c:v>122.131083100057</c:v>
                </c:pt>
                <c:pt idx="129" formatCode="0.0">
                  <c:v>75.3755241509716</c:v>
                </c:pt>
                <c:pt idx="130" formatCode="0.0">
                  <c:v>93.581657320032804</c:v>
                </c:pt>
                <c:pt idx="131" formatCode="0.0">
                  <c:v>122.33776503761401</c:v>
                </c:pt>
                <c:pt idx="132" formatCode="0.0">
                  <c:v>61.027372043704403</c:v>
                </c:pt>
                <c:pt idx="133" formatCode="0.0">
                  <c:v>102.247231540008</c:v>
                </c:pt>
                <c:pt idx="134" formatCode="0.0">
                  <c:v>111.82803942186</c:v>
                </c:pt>
                <c:pt idx="135" formatCode="0.0">
                  <c:v>95.581408387267203</c:v>
                </c:pt>
                <c:pt idx="136" formatCode="0.0">
                  <c:v>110.549419684269</c:v>
                </c:pt>
                <c:pt idx="137" formatCode="0.0">
                  <c:v>99.355305759983096</c:v>
                </c:pt>
                <c:pt idx="138" formatCode="0.0">
                  <c:v>96.799980472774294</c:v>
                </c:pt>
                <c:pt idx="139" formatCode="0.0">
                  <c:v>106.290427632042</c:v>
                </c:pt>
                <c:pt idx="140" formatCode="0.0">
                  <c:v>90.752231540008097</c:v>
                </c:pt>
                <c:pt idx="141" formatCode="0.0">
                  <c:v>97.2421959079348</c:v>
                </c:pt>
                <c:pt idx="142" formatCode="0.0">
                  <c:v>57.219793543272601</c:v>
                </c:pt>
                <c:pt idx="143" formatCode="0.0">
                  <c:v>88.961098370946701</c:v>
                </c:pt>
                <c:pt idx="144" formatCode="0.0">
                  <c:v>51.758415415331697</c:v>
                </c:pt>
                <c:pt idx="145" formatCode="0.0">
                  <c:v>97.736191835697994</c:v>
                </c:pt>
                <c:pt idx="146" formatCode="0.0">
                  <c:v>86.366657320032999</c:v>
                </c:pt>
                <c:pt idx="147" formatCode="0.0">
                  <c:v>86.059781326561193</c:v>
                </c:pt>
                <c:pt idx="148" formatCode="0.0">
                  <c:v>91.028349438180697</c:v>
                </c:pt>
                <c:pt idx="149" formatCode="0.0">
                  <c:v>72.101642049144303</c:v>
                </c:pt>
                <c:pt idx="150" formatCode="0.0">
                  <c:v>97.065122804368499</c:v>
                </c:pt>
                <c:pt idx="151" formatCode="0.0">
                  <c:v>83.600663428388501</c:v>
                </c:pt>
                <c:pt idx="152" formatCode="0.0">
                  <c:v>85.799157320033004</c:v>
                </c:pt>
                <c:pt idx="153" formatCode="0.0">
                  <c:v>88.2505241509717</c:v>
                </c:pt>
                <c:pt idx="155" formatCode="0.0">
                  <c:v>92.994899224733601</c:v>
                </c:pt>
                <c:pt idx="156" formatCode="0.0">
                  <c:v>82.159980472773896</c:v>
                </c:pt>
                <c:pt idx="157" formatCode="0.0">
                  <c:v>92.218427632042804</c:v>
                </c:pt>
                <c:pt idx="158" formatCode="0.0">
                  <c:v>93.482427632043198</c:v>
                </c:pt>
                <c:pt idx="159" formatCode="0.0">
                  <c:v>76.266687861810198</c:v>
                </c:pt>
                <c:pt idx="160" formatCode="0.0">
                  <c:v>92.221606613770206</c:v>
                </c:pt>
                <c:pt idx="161" formatCode="0.0">
                  <c:v>99.542231540007805</c:v>
                </c:pt>
                <c:pt idx="162" formatCode="0.0">
                  <c:v>117.672887008023</c:v>
                </c:pt>
                <c:pt idx="163" formatCode="0.0">
                  <c:v>112.263122804368</c:v>
                </c:pt>
                <c:pt idx="164" formatCode="0.0">
                  <c:v>107.488439848754</c:v>
                </c:pt>
                <c:pt idx="165" formatCode="0.0">
                  <c:v>105.872805759983</c:v>
                </c:pt>
                <c:pt idx="166" formatCode="0.0">
                  <c:v>90.014562015862396</c:v>
                </c:pt>
                <c:pt idx="168" formatCode="0.0">
                  <c:v>76.472629624213099</c:v>
                </c:pt>
                <c:pt idx="169" formatCode="0.0">
                  <c:v>69.9944887155971</c:v>
                </c:pt>
                <c:pt idx="170" formatCode="0.0">
                  <c:v>45.510393827866999</c:v>
                </c:pt>
                <c:pt idx="171" formatCode="0.0">
                  <c:v>69.313435973215903</c:v>
                </c:pt>
                <c:pt idx="173" formatCode="0.0">
                  <c:v>34.616700078521497</c:v>
                </c:pt>
                <c:pt idx="174" formatCode="0.0">
                  <c:v>88.948146318080504</c:v>
                </c:pt>
                <c:pt idx="175" formatCode="0.0">
                  <c:v>49.450736728653403</c:v>
                </c:pt>
                <c:pt idx="176" formatCode="0.0">
                  <c:v>67.849187861810194</c:v>
                </c:pt>
                <c:pt idx="177" formatCode="0.0">
                  <c:v>64.326708222994895</c:v>
                </c:pt>
                <c:pt idx="178" formatCode="0.0">
                  <c:v>46.910827544146898</c:v>
                </c:pt>
                <c:pt idx="179" formatCode="0.0">
                  <c:v>66.8639236581554</c:v>
                </c:pt>
                <c:pt idx="180" formatCode="0.0">
                  <c:v>56.008862574601302</c:v>
                </c:pt>
                <c:pt idx="181" formatCode="0.0">
                  <c:v>83.461884358764706</c:v>
                </c:pt>
                <c:pt idx="182" formatCode="0.0">
                  <c:v>64.953303625514707</c:v>
                </c:pt>
                <c:pt idx="183" formatCode="0.0">
                  <c:v>76.543594397059195</c:v>
                </c:pt>
                <c:pt idx="184" formatCode="0.0">
                  <c:v>53.487805759982898</c:v>
                </c:pt>
                <c:pt idx="185" formatCode="0.0">
                  <c:v>70.718632470170306</c:v>
                </c:pt>
                <c:pt idx="186" formatCode="0.0">
                  <c:v>71.737277352673701</c:v>
                </c:pt>
                <c:pt idx="187" formatCode="0.0">
                  <c:v>97.5073463840031</c:v>
                </c:pt>
                <c:pt idx="188" formatCode="0.0">
                  <c:v>101.893992689485</c:v>
                </c:pt>
                <c:pt idx="189" formatCode="0.0">
                  <c:v>90.673793543271998</c:v>
                </c:pt>
                <c:pt idx="191" formatCode="0.0">
                  <c:v>75.394427632042905</c:v>
                </c:pt>
                <c:pt idx="192" formatCode="0.0">
                  <c:v>67.184191835697504</c:v>
                </c:pt>
                <c:pt idx="193" formatCode="0.0">
                  <c:v>93.667086154235704</c:v>
                </c:pt>
                <c:pt idx="194" formatCode="0.0">
                  <c:v>89.542216269119393</c:v>
                </c:pt>
                <c:pt idx="195" formatCode="0.0">
                  <c:v>69.579756893139304</c:v>
                </c:pt>
                <c:pt idx="196" formatCode="0.0">
                  <c:v>114.328017122907</c:v>
                </c:pt>
                <c:pt idx="197" formatCode="0.0">
                  <c:v>75.614142049144405</c:v>
                </c:pt>
                <c:pt idx="198" formatCode="0.0">
                  <c:v>117.34294809157799</c:v>
                </c:pt>
                <c:pt idx="199" formatCode="0.0">
                  <c:v>62.902744676428497</c:v>
                </c:pt>
                <c:pt idx="200" formatCode="0.0">
                  <c:v>63.182427632042803</c:v>
                </c:pt>
                <c:pt idx="201" formatCode="0.0">
                  <c:v>41.000393827867398</c:v>
                </c:pt>
                <c:pt idx="202" formatCode="0.0">
                  <c:v>119.072874791312</c:v>
                </c:pt>
                <c:pt idx="203" formatCode="0.0">
                  <c:v>99.522228485830198</c:v>
                </c:pt>
                <c:pt idx="204" formatCode="0.0">
                  <c:v>68.997465201885205</c:v>
                </c:pt>
                <c:pt idx="205" formatCode="0.0">
                  <c:v>80.572480472773805</c:v>
                </c:pt>
                <c:pt idx="206" formatCode="0.0">
                  <c:v>116.314995743662</c:v>
                </c:pt>
                <c:pt idx="207" formatCode="0.0">
                  <c:v>87.248024150971602</c:v>
                </c:pt>
                <c:pt idx="208" formatCode="0.0">
                  <c:v>93.486240702540996</c:v>
                </c:pt>
                <c:pt idx="209" formatCode="0.0">
                  <c:v>113.70748047277399</c:v>
                </c:pt>
                <c:pt idx="210" formatCode="0.0">
                  <c:v>67.532480472773798</c:v>
                </c:pt>
                <c:pt idx="211" formatCode="0.0">
                  <c:v>74.663098370946599</c:v>
                </c:pt>
                <c:pt idx="212" formatCode="0.0">
                  <c:v>92.818427632042898</c:v>
                </c:pt>
                <c:pt idx="213" formatCode="0.0">
                  <c:v>96.288452065464796</c:v>
                </c:pt>
                <c:pt idx="214" formatCode="0.0">
                  <c:v>113.753098370947</c:v>
                </c:pt>
                <c:pt idx="215" formatCode="0.0">
                  <c:v>56.441756893139498</c:v>
                </c:pt>
                <c:pt idx="216" formatCode="0.0">
                  <c:v>86.147521096793895</c:v>
                </c:pt>
                <c:pt idx="217" formatCode="0.0">
                  <c:v>78.931992689484701</c:v>
                </c:pt>
                <c:pt idx="218" formatCode="0.0">
                  <c:v>77.943086154235701</c:v>
                </c:pt>
              </c:numCache>
            </c:numRef>
          </c:xVal>
          <c:yVal>
            <c:numRef>
              <c:f>Feuil1!$V$2:$V$248</c:f>
              <c:numCache>
                <c:formatCode>General</c:formatCode>
                <c:ptCount val="247"/>
                <c:pt idx="0" formatCode="0.0">
                  <c:v>2.2270266127754099E-2</c:v>
                </c:pt>
                <c:pt idx="2" formatCode="0.0">
                  <c:v>2.0156587524542E-2</c:v>
                </c:pt>
                <c:pt idx="3" formatCode="0.0">
                  <c:v>2.27845926796457E-2</c:v>
                </c:pt>
                <c:pt idx="4" formatCode="0.0">
                  <c:v>1.9014330259735E-2</c:v>
                </c:pt>
                <c:pt idx="5" formatCode="0.0">
                  <c:v>2.2053328736422999E-2</c:v>
                </c:pt>
                <c:pt idx="7" formatCode="0.0">
                  <c:v>2.5987841160405499E-2</c:v>
                </c:pt>
                <c:pt idx="8" formatCode="0.0">
                  <c:v>2.2024382321912301E-2</c:v>
                </c:pt>
                <c:pt idx="9" formatCode="0.0">
                  <c:v>1.8745545655199598E-2</c:v>
                </c:pt>
                <c:pt idx="10" formatCode="0.0">
                  <c:v>2.2018855513693002E-2</c:v>
                </c:pt>
                <c:pt idx="11" formatCode="0.0">
                  <c:v>2.2613889733488102E-2</c:v>
                </c:pt>
                <c:pt idx="12" formatCode="0.0">
                  <c:v>1.6913973724886299E-2</c:v>
                </c:pt>
                <c:pt idx="13" formatCode="0.0">
                  <c:v>2.1611555992566402E-2</c:v>
                </c:pt>
                <c:pt idx="14" formatCode="0.0">
                  <c:v>2.8940657855545001E-2</c:v>
                </c:pt>
                <c:pt idx="15" formatCode="0.0">
                  <c:v>2.1092532544973799E-2</c:v>
                </c:pt>
                <c:pt idx="16" formatCode="0.0">
                  <c:v>2.2508777917170798E-2</c:v>
                </c:pt>
                <c:pt idx="17" formatCode="0.0">
                  <c:v>3.7017536000505301E-2</c:v>
                </c:pt>
                <c:pt idx="18" formatCode="0.0">
                  <c:v>2.0334714468618599E-2</c:v>
                </c:pt>
                <c:pt idx="19" formatCode="0.0">
                  <c:v>2.2176040583469999E-2</c:v>
                </c:pt>
                <c:pt idx="20" formatCode="0.0">
                  <c:v>3.2127305257478797E-2</c:v>
                </c:pt>
                <c:pt idx="21" formatCode="0.0">
                  <c:v>1.9302428905561698E-2</c:v>
                </c:pt>
                <c:pt idx="22" formatCode="0.0">
                  <c:v>1.8887750541124099E-2</c:v>
                </c:pt>
                <c:pt idx="23" formatCode="0.0">
                  <c:v>2.7538822770095301E-2</c:v>
                </c:pt>
                <c:pt idx="24" formatCode="0.0">
                  <c:v>1.8269004518683601E-2</c:v>
                </c:pt>
                <c:pt idx="25" formatCode="0.0">
                  <c:v>1.8529018377970299E-2</c:v>
                </c:pt>
                <c:pt idx="26" formatCode="0.0">
                  <c:v>1.7564625462233401E-2</c:v>
                </c:pt>
                <c:pt idx="27" formatCode="0.0">
                  <c:v>1.9706328394089E-2</c:v>
                </c:pt>
                <c:pt idx="28" formatCode="0.0">
                  <c:v>1.5964544151108501E-2</c:v>
                </c:pt>
                <c:pt idx="29" formatCode="0.0">
                  <c:v>1.91345368634506E-2</c:v>
                </c:pt>
                <c:pt idx="30" formatCode="0.0">
                  <c:v>2.1873414533952001E-2</c:v>
                </c:pt>
                <c:pt idx="31" formatCode="0.0">
                  <c:v>1.84201199386975E-2</c:v>
                </c:pt>
                <c:pt idx="32" formatCode="0.0">
                  <c:v>1.9326864873706301E-2</c:v>
                </c:pt>
                <c:pt idx="33" formatCode="0.0">
                  <c:v>1.8320575638535699E-2</c:v>
                </c:pt>
                <c:pt idx="34" formatCode="0.0">
                  <c:v>2.7437065543061599E-2</c:v>
                </c:pt>
                <c:pt idx="35" formatCode="0.0">
                  <c:v>1.7165337360974701E-2</c:v>
                </c:pt>
                <c:pt idx="36" formatCode="0.0">
                  <c:v>1.8171565774909301E-2</c:v>
                </c:pt>
                <c:pt idx="37" formatCode="0.0">
                  <c:v>3.5707097059771598E-2</c:v>
                </c:pt>
                <c:pt idx="38" formatCode="0.0">
                  <c:v>1.9735115716167501E-2</c:v>
                </c:pt>
                <c:pt idx="39" formatCode="0.0">
                  <c:v>1.8418954377853802E-2</c:v>
                </c:pt>
                <c:pt idx="40" formatCode="0.0">
                  <c:v>2.0107782977779001E-2</c:v>
                </c:pt>
                <c:pt idx="41" formatCode="0.0">
                  <c:v>2.99012248621962E-2</c:v>
                </c:pt>
                <c:pt idx="42" formatCode="0.0">
                  <c:v>2.47518451926984E-2</c:v>
                </c:pt>
                <c:pt idx="43" formatCode="0.0">
                  <c:v>2.4218339898840702E-2</c:v>
                </c:pt>
                <c:pt idx="44" formatCode="0.0">
                  <c:v>2.8129731871342701E-2</c:v>
                </c:pt>
                <c:pt idx="45" formatCode="0.0">
                  <c:v>1.89924878223845E-2</c:v>
                </c:pt>
                <c:pt idx="46" formatCode="0.0">
                  <c:v>2.4521769358310401E-2</c:v>
                </c:pt>
                <c:pt idx="47" formatCode="0.0">
                  <c:v>1.7834049430294499E-2</c:v>
                </c:pt>
                <c:pt idx="48" formatCode="0.0">
                  <c:v>2.08568001193375E-2</c:v>
                </c:pt>
                <c:pt idx="49" formatCode="0.0">
                  <c:v>2.1302927579524601E-2</c:v>
                </c:pt>
                <c:pt idx="50" formatCode="0.0">
                  <c:v>2.93035737321059E-2</c:v>
                </c:pt>
                <c:pt idx="51" formatCode="0.0">
                  <c:v>2.1258214941206801E-2</c:v>
                </c:pt>
                <c:pt idx="52" formatCode="0.0">
                  <c:v>3.2483373587793997E-2</c:v>
                </c:pt>
                <c:pt idx="53" formatCode="0.0">
                  <c:v>2.68497954343093E-2</c:v>
                </c:pt>
                <c:pt idx="54" formatCode="0.0">
                  <c:v>1.7463295794412699E-2</c:v>
                </c:pt>
                <c:pt idx="55" formatCode="0.0">
                  <c:v>2.9081970925432701E-2</c:v>
                </c:pt>
                <c:pt idx="56" formatCode="0.0">
                  <c:v>1.87118454826996E-2</c:v>
                </c:pt>
                <c:pt idx="57" formatCode="0.0">
                  <c:v>4.9276290055906398E-2</c:v>
                </c:pt>
                <c:pt idx="58" formatCode="0.0">
                  <c:v>2.07096556662048E-2</c:v>
                </c:pt>
                <c:pt idx="59" formatCode="0.0">
                  <c:v>1.4275345585434401E-2</c:v>
                </c:pt>
                <c:pt idx="60" formatCode="0.0">
                  <c:v>3.6804942037448003E-2</c:v>
                </c:pt>
                <c:pt idx="61" formatCode="0.0">
                  <c:v>2.2053137479089699E-2</c:v>
                </c:pt>
                <c:pt idx="62" formatCode="0.0">
                  <c:v>1.8175775909353702E-2</c:v>
                </c:pt>
                <c:pt idx="63" formatCode="0.0">
                  <c:v>1.5134806641823401E-2</c:v>
                </c:pt>
                <c:pt idx="64" formatCode="0.0">
                  <c:v>1.9139515360634601E-2</c:v>
                </c:pt>
                <c:pt idx="65" formatCode="0.0">
                  <c:v>1.44395573001488E-2</c:v>
                </c:pt>
                <c:pt idx="66" formatCode="0.0">
                  <c:v>1.5848835812627499E-2</c:v>
                </c:pt>
                <c:pt idx="67" formatCode="0.0">
                  <c:v>1.7427227677486199E-2</c:v>
                </c:pt>
                <c:pt idx="68" formatCode="0.0">
                  <c:v>2.2100219258833199E-2</c:v>
                </c:pt>
                <c:pt idx="69" formatCode="0.0">
                  <c:v>2.4784612988774799E-2</c:v>
                </c:pt>
                <c:pt idx="70" formatCode="0.0">
                  <c:v>1.9464879065980201E-2</c:v>
                </c:pt>
                <c:pt idx="71" formatCode="0.0">
                  <c:v>1.9958071960808E-2</c:v>
                </c:pt>
                <c:pt idx="72" formatCode="0.0">
                  <c:v>1.9270398662953901E-2</c:v>
                </c:pt>
                <c:pt idx="73" formatCode="0.0">
                  <c:v>2.4126513072181201E-2</c:v>
                </c:pt>
                <c:pt idx="74" formatCode="0.0">
                  <c:v>2.3660527402927501E-2</c:v>
                </c:pt>
                <c:pt idx="75" formatCode="0.0">
                  <c:v>1.8754988166421401E-2</c:v>
                </c:pt>
                <c:pt idx="77" formatCode="0.0">
                  <c:v>1.8321624946216801E-2</c:v>
                </c:pt>
                <c:pt idx="78" formatCode="0.0">
                  <c:v>1.8990119739795999E-2</c:v>
                </c:pt>
                <c:pt idx="79" formatCode="0.0">
                  <c:v>1.7733930511493301E-2</c:v>
                </c:pt>
                <c:pt idx="80" formatCode="0.0">
                  <c:v>2.1171097709532599E-2</c:v>
                </c:pt>
                <c:pt idx="81" formatCode="0.0">
                  <c:v>2.1701374382989198E-2</c:v>
                </c:pt>
                <c:pt idx="82" formatCode="0.0">
                  <c:v>2.3555572672103401E-2</c:v>
                </c:pt>
                <c:pt idx="83" formatCode="0.0">
                  <c:v>9.9342304212914095E-2</c:v>
                </c:pt>
                <c:pt idx="84" formatCode="0.0">
                  <c:v>2.7640165471509499E-2</c:v>
                </c:pt>
                <c:pt idx="85" formatCode="0.0">
                  <c:v>1.8258415781475901E-2</c:v>
                </c:pt>
                <c:pt idx="86" formatCode="0.0">
                  <c:v>2.1558955521449399E-2</c:v>
                </c:pt>
                <c:pt idx="87" formatCode="0.0">
                  <c:v>2.4739252169026501E-2</c:v>
                </c:pt>
                <c:pt idx="88" formatCode="0.0">
                  <c:v>2.4409786290636601E-2</c:v>
                </c:pt>
                <c:pt idx="89" formatCode="0.0">
                  <c:v>2.1049643727568301E-2</c:v>
                </c:pt>
                <c:pt idx="90" formatCode="0.0">
                  <c:v>1.44143139753932E-2</c:v>
                </c:pt>
                <c:pt idx="91" formatCode="0.0">
                  <c:v>2.0666858245725801E-2</c:v>
                </c:pt>
                <c:pt idx="92" formatCode="0.0">
                  <c:v>2.4870634257453599E-2</c:v>
                </c:pt>
                <c:pt idx="93" formatCode="0.0">
                  <c:v>2.17801002488901E-2</c:v>
                </c:pt>
                <c:pt idx="94" formatCode="0.0">
                  <c:v>2.2645089075008999E-2</c:v>
                </c:pt>
                <c:pt idx="95" formatCode="0.0">
                  <c:v>2.1257231604782999E-2</c:v>
                </c:pt>
                <c:pt idx="96" formatCode="0.0">
                  <c:v>1.7667010587712102E-2</c:v>
                </c:pt>
                <c:pt idx="97" formatCode="0.0">
                  <c:v>2.3656190824138602E-2</c:v>
                </c:pt>
                <c:pt idx="98" formatCode="0.0">
                  <c:v>2.3662623352306299E-2</c:v>
                </c:pt>
                <c:pt idx="99" formatCode="0.0">
                  <c:v>2.1567680113858099E-2</c:v>
                </c:pt>
                <c:pt idx="100" formatCode="0.0">
                  <c:v>2.4965483333076501E-2</c:v>
                </c:pt>
                <c:pt idx="101" formatCode="0.0">
                  <c:v>2.50900955027662E-2</c:v>
                </c:pt>
                <c:pt idx="102" formatCode="0.0">
                  <c:v>1.7745542999069198E-2</c:v>
                </c:pt>
                <c:pt idx="103" formatCode="0.0">
                  <c:v>1.7909687200673301E-2</c:v>
                </c:pt>
                <c:pt idx="104" formatCode="0.0">
                  <c:v>2.1945612090708399E-2</c:v>
                </c:pt>
                <c:pt idx="105" formatCode="0.0">
                  <c:v>2.2067826133004498E-2</c:v>
                </c:pt>
                <c:pt idx="106" formatCode="0.0">
                  <c:v>3.25549477392343E-2</c:v>
                </c:pt>
                <c:pt idx="107" formatCode="0.0">
                  <c:v>2.0746245739500499E-2</c:v>
                </c:pt>
                <c:pt idx="108" formatCode="0.0">
                  <c:v>2.7046182933457601E-2</c:v>
                </c:pt>
                <c:pt idx="109" formatCode="0.0">
                  <c:v>2.3095426879638802E-2</c:v>
                </c:pt>
                <c:pt idx="110" formatCode="0.0">
                  <c:v>1.9287261833612301E-2</c:v>
                </c:pt>
                <c:pt idx="111" formatCode="0.0">
                  <c:v>2.9350070570099501E-2</c:v>
                </c:pt>
                <c:pt idx="112" formatCode="0.0">
                  <c:v>2.1074317156712302E-2</c:v>
                </c:pt>
                <c:pt idx="113" formatCode="0.0">
                  <c:v>0.100879276419426</c:v>
                </c:pt>
                <c:pt idx="114" formatCode="0.0">
                  <c:v>4.8410259102586797E-2</c:v>
                </c:pt>
                <c:pt idx="115" formatCode="0.0">
                  <c:v>1.94027048626371E-2</c:v>
                </c:pt>
                <c:pt idx="116" formatCode="0.0">
                  <c:v>2.3713098674343101E-2</c:v>
                </c:pt>
                <c:pt idx="117" formatCode="0.0">
                  <c:v>3.0401954106601799E-2</c:v>
                </c:pt>
                <c:pt idx="118" formatCode="0.0">
                  <c:v>3.2140032374377202E-2</c:v>
                </c:pt>
                <c:pt idx="119" formatCode="0.0">
                  <c:v>2.35686183970681E-2</c:v>
                </c:pt>
                <c:pt idx="120" formatCode="0.0">
                  <c:v>5.7415019522500797E-2</c:v>
                </c:pt>
                <c:pt idx="121" formatCode="0.0">
                  <c:v>2.3003388111114399E-2</c:v>
                </c:pt>
                <c:pt idx="122" formatCode="0.0">
                  <c:v>2.82590672895611E-2</c:v>
                </c:pt>
                <c:pt idx="124" formatCode="0.0">
                  <c:v>2.93308272629869E-2</c:v>
                </c:pt>
                <c:pt idx="125" formatCode="0.0">
                  <c:v>2.2611541937139198E-2</c:v>
                </c:pt>
                <c:pt idx="126" formatCode="0.0">
                  <c:v>1.9428923313771398E-2</c:v>
                </c:pt>
                <c:pt idx="127" formatCode="0.0">
                  <c:v>3.06176634279961E-2</c:v>
                </c:pt>
                <c:pt idx="128" formatCode="0.0">
                  <c:v>1.8512361729950199E-2</c:v>
                </c:pt>
                <c:pt idx="129" formatCode="0.0">
                  <c:v>4.8331181991738699E-2</c:v>
                </c:pt>
                <c:pt idx="130" formatCode="0.0">
                  <c:v>2.0245860316453E-2</c:v>
                </c:pt>
                <c:pt idx="131" formatCode="0.0">
                  <c:v>2.2349554514814799E-2</c:v>
                </c:pt>
                <c:pt idx="132" formatCode="0.0">
                  <c:v>2.10487592184074E-2</c:v>
                </c:pt>
                <c:pt idx="133" formatCode="0.0">
                  <c:v>1.9324215492078599E-2</c:v>
                </c:pt>
                <c:pt idx="134" formatCode="0.0">
                  <c:v>1.79851846278299E-2</c:v>
                </c:pt>
                <c:pt idx="135" formatCode="0.0">
                  <c:v>2.8584924850127098E-2</c:v>
                </c:pt>
                <c:pt idx="136" formatCode="0.0">
                  <c:v>2.3864762623703299E-2</c:v>
                </c:pt>
                <c:pt idx="137" formatCode="0.0">
                  <c:v>1.8942661338678099E-2</c:v>
                </c:pt>
                <c:pt idx="138" formatCode="0.0">
                  <c:v>1.9879149900807001E-2</c:v>
                </c:pt>
                <c:pt idx="139" formatCode="0.0">
                  <c:v>2.11557960861956E-2</c:v>
                </c:pt>
                <c:pt idx="140" formatCode="0.0">
                  <c:v>2.4058334419967901E-2</c:v>
                </c:pt>
                <c:pt idx="141" formatCode="0.0">
                  <c:v>1.6615641119027101E-2</c:v>
                </c:pt>
                <c:pt idx="142" formatCode="0.0">
                  <c:v>2.1966980712286501E-2</c:v>
                </c:pt>
                <c:pt idx="143" formatCode="0.0">
                  <c:v>1.91940962232772E-2</c:v>
                </c:pt>
                <c:pt idx="144" formatCode="0.0">
                  <c:v>5.3557489783411197E-2</c:v>
                </c:pt>
                <c:pt idx="145" formatCode="0.0">
                  <c:v>2.83505230501363E-2</c:v>
                </c:pt>
                <c:pt idx="146" formatCode="0.0">
                  <c:v>1.9158332782902399E-2</c:v>
                </c:pt>
                <c:pt idx="147" formatCode="0.0">
                  <c:v>2.0966103622715601E-2</c:v>
                </c:pt>
                <c:pt idx="148" formatCode="0.0">
                  <c:v>2.50113374186605E-2</c:v>
                </c:pt>
                <c:pt idx="149" formatCode="0.0">
                  <c:v>2.5295975935389702E-2</c:v>
                </c:pt>
                <c:pt idx="150" formatCode="0.0">
                  <c:v>2.01659474437841E-2</c:v>
                </c:pt>
                <c:pt idx="151" formatCode="0.0">
                  <c:v>1.55075930400633E-2</c:v>
                </c:pt>
                <c:pt idx="152" formatCode="0.0">
                  <c:v>2.2635900199343899E-2</c:v>
                </c:pt>
                <c:pt idx="153" formatCode="0.0">
                  <c:v>2.56711016422689E-2</c:v>
                </c:pt>
                <c:pt idx="155" formatCode="0.0">
                  <c:v>2.2562866751259798E-2</c:v>
                </c:pt>
                <c:pt idx="156" formatCode="0.0">
                  <c:v>1.7992960973292099E-2</c:v>
                </c:pt>
                <c:pt idx="157" formatCode="0.0">
                  <c:v>2.14345295582943E-2</c:v>
                </c:pt>
                <c:pt idx="158" formatCode="0.0">
                  <c:v>1.8235070013460399E-2</c:v>
                </c:pt>
                <c:pt idx="159" formatCode="0.0">
                  <c:v>2.2928236842616499E-2</c:v>
                </c:pt>
                <c:pt idx="160" formatCode="0.0">
                  <c:v>2.4349943169440499E-2</c:v>
                </c:pt>
                <c:pt idx="161" formatCode="0.0">
                  <c:v>2.2335721244646601E-2</c:v>
                </c:pt>
                <c:pt idx="162" formatCode="0.0">
                  <c:v>2.20919514916952E-2</c:v>
                </c:pt>
                <c:pt idx="163" formatCode="0.0">
                  <c:v>1.8344493843157301E-2</c:v>
                </c:pt>
                <c:pt idx="164" formatCode="0.0">
                  <c:v>2.19490246979419E-2</c:v>
                </c:pt>
                <c:pt idx="165" formatCode="0.0">
                  <c:v>2.84261278201559E-2</c:v>
                </c:pt>
                <c:pt idx="166" formatCode="0.0">
                  <c:v>4.8029389967764499E-2</c:v>
                </c:pt>
                <c:pt idx="168" formatCode="0.0">
                  <c:v>1.8186178309780001E-2</c:v>
                </c:pt>
                <c:pt idx="169" formatCode="0.0">
                  <c:v>2.2197428423799501E-2</c:v>
                </c:pt>
                <c:pt idx="170" formatCode="0.0">
                  <c:v>2.1510655970958199E-2</c:v>
                </c:pt>
                <c:pt idx="171" formatCode="0.0">
                  <c:v>3.10336089898096E-2</c:v>
                </c:pt>
                <c:pt idx="173" formatCode="0.0">
                  <c:v>2.86644448584721E-2</c:v>
                </c:pt>
                <c:pt idx="174" formatCode="0.0">
                  <c:v>3.2677086332108599E-2</c:v>
                </c:pt>
                <c:pt idx="175" formatCode="0.0">
                  <c:v>3.41772848423465E-2</c:v>
                </c:pt>
                <c:pt idx="176" formatCode="0.0">
                  <c:v>2.3672511537924001E-2</c:v>
                </c:pt>
                <c:pt idx="177" formatCode="0.0">
                  <c:v>2.2976568677854001E-2</c:v>
                </c:pt>
                <c:pt idx="178" formatCode="0.0">
                  <c:v>3.4831231074107898E-2</c:v>
                </c:pt>
                <c:pt idx="179" formatCode="0.0">
                  <c:v>8.7621324897496994E-2</c:v>
                </c:pt>
                <c:pt idx="180" formatCode="0.0">
                  <c:v>2.2360891436249902E-2</c:v>
                </c:pt>
                <c:pt idx="181" formatCode="0.0">
                  <c:v>1.84932647864294E-2</c:v>
                </c:pt>
                <c:pt idx="182" formatCode="0.0">
                  <c:v>3.11294633110413E-2</c:v>
                </c:pt>
                <c:pt idx="183" formatCode="0.0">
                  <c:v>1.94788745380816E-2</c:v>
                </c:pt>
                <c:pt idx="184" formatCode="0.0">
                  <c:v>1.9435344083407E-2</c:v>
                </c:pt>
                <c:pt idx="185" formatCode="0.0">
                  <c:v>3.5646448838216702E-2</c:v>
                </c:pt>
                <c:pt idx="186" formatCode="0.0">
                  <c:v>2.32881268667979E-2</c:v>
                </c:pt>
                <c:pt idx="187" formatCode="0.0">
                  <c:v>1.93276597131345E-2</c:v>
                </c:pt>
                <c:pt idx="188" formatCode="0.0">
                  <c:v>2.0873744115415899E-2</c:v>
                </c:pt>
                <c:pt idx="189" formatCode="0.0">
                  <c:v>1.8781017475720502E-2</c:v>
                </c:pt>
                <c:pt idx="191" formatCode="0.0">
                  <c:v>2.0408121146667998E-2</c:v>
                </c:pt>
                <c:pt idx="192" formatCode="0.0">
                  <c:v>1.6237036267969698E-2</c:v>
                </c:pt>
                <c:pt idx="193" formatCode="0.0">
                  <c:v>1.66716698998223E-2</c:v>
                </c:pt>
                <c:pt idx="194" formatCode="0.0">
                  <c:v>2.17114100660434E-2</c:v>
                </c:pt>
                <c:pt idx="195" formatCode="0.0">
                  <c:v>2.3298768912913201E-2</c:v>
                </c:pt>
                <c:pt idx="196" formatCode="0.0">
                  <c:v>2.3949726544507399E-2</c:v>
                </c:pt>
                <c:pt idx="197" formatCode="0.0">
                  <c:v>2.68650988707533E-2</c:v>
                </c:pt>
                <c:pt idx="198" formatCode="0.0">
                  <c:v>1.66406484910629E-2</c:v>
                </c:pt>
                <c:pt idx="199" formatCode="0.0">
                  <c:v>1.85447371936708E-2</c:v>
                </c:pt>
                <c:pt idx="200" formatCode="0.0">
                  <c:v>2.29281885358209E-2</c:v>
                </c:pt>
                <c:pt idx="201" formatCode="0.0">
                  <c:v>2.78605069713357E-2</c:v>
                </c:pt>
                <c:pt idx="202" formatCode="0.0">
                  <c:v>2.4061029084969199E-2</c:v>
                </c:pt>
                <c:pt idx="203" formatCode="0.0">
                  <c:v>1.8836953434911399E-2</c:v>
                </c:pt>
                <c:pt idx="204" formatCode="0.0">
                  <c:v>1.8597646394618299E-2</c:v>
                </c:pt>
                <c:pt idx="205" formatCode="0.0">
                  <c:v>2.25052190471614E-2</c:v>
                </c:pt>
                <c:pt idx="206" formatCode="0.0">
                  <c:v>1.6907201601534499E-2</c:v>
                </c:pt>
                <c:pt idx="207" formatCode="0.0">
                  <c:v>1.6080457856966102E-2</c:v>
                </c:pt>
                <c:pt idx="208" formatCode="0.0">
                  <c:v>7.5818524720900698E-2</c:v>
                </c:pt>
                <c:pt idx="209" formatCode="0.0">
                  <c:v>2.2674861068881801E-2</c:v>
                </c:pt>
                <c:pt idx="210" formatCode="0.0">
                  <c:v>1.8743592910424298E-2</c:v>
                </c:pt>
                <c:pt idx="211" formatCode="0.0">
                  <c:v>1.8378483867752999E-2</c:v>
                </c:pt>
                <c:pt idx="212" formatCode="0.0">
                  <c:v>5.7968603720336E-2</c:v>
                </c:pt>
                <c:pt idx="213" formatCode="0.0">
                  <c:v>2.0811158410844001E-2</c:v>
                </c:pt>
                <c:pt idx="214" formatCode="0.0">
                  <c:v>2.26296653523477E-2</c:v>
                </c:pt>
                <c:pt idx="215" formatCode="0.0">
                  <c:v>2.1103571937448402E-2</c:v>
                </c:pt>
                <c:pt idx="216" formatCode="0.0">
                  <c:v>2.25118053166363E-2</c:v>
                </c:pt>
                <c:pt idx="217" formatCode="0.0">
                  <c:v>2.3155391634220202E-2</c:v>
                </c:pt>
                <c:pt idx="218" formatCode="0.0">
                  <c:v>1.90598911865232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EC6-3D48-9F1A-691387C01A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84584"/>
        <c:axId val="534879096"/>
      </c:scatterChart>
      <c:valAx>
        <c:axId val="534884584"/>
        <c:scaling>
          <c:orientation val="minMax"/>
          <c:max val="25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FW</a:t>
                </a:r>
                <a:r>
                  <a:rPr lang="fr-FR" baseline="-20000" dirty="0"/>
                  <a:t>T0</a:t>
                </a:r>
                <a:r>
                  <a:rPr lang="fr-FR" sz="1000" b="0" i="0" u="none" strike="noStrike" baseline="0" dirty="0">
                    <a:effectLst/>
                  </a:rPr>
                  <a:t> (grams)</a:t>
                </a:r>
                <a:endParaRPr lang="fr-FR" baseline="-20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79096"/>
        <c:crosses val="autoZero"/>
        <c:crossBetween val="midCat"/>
        <c:majorUnit val="50"/>
      </c:valAx>
      <c:valAx>
        <c:axId val="534879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W</a:t>
                </a:r>
                <a:r>
                  <a:rPr lang="fr-FR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</a:p>
            </c:rich>
          </c:tx>
          <c:layout>
            <c:manualLayout>
              <c:xMode val="edge"/>
              <c:yMode val="edge"/>
              <c:x val="2.3377497757102884E-2"/>
              <c:y val="0.374737532808398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45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07661310290394"/>
          <c:y val="0.15782407407407409"/>
          <c:w val="0.66036199585849631"/>
          <c:h val="0.62734580052493438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Y$1</c:f>
              <c:strCache>
                <c:ptCount val="1"/>
                <c:pt idx="0">
                  <c:v>Loss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V$2:$V$248</c:f>
              <c:numCache>
                <c:formatCode>General</c:formatCode>
                <c:ptCount val="247"/>
                <c:pt idx="0" formatCode="0.0">
                  <c:v>2.2270266127754099E-2</c:v>
                </c:pt>
                <c:pt idx="2" formatCode="0.0">
                  <c:v>2.0156587524542E-2</c:v>
                </c:pt>
                <c:pt idx="3" formatCode="0.0">
                  <c:v>2.27845926796457E-2</c:v>
                </c:pt>
                <c:pt idx="4" formatCode="0.0">
                  <c:v>1.9014330259735E-2</c:v>
                </c:pt>
                <c:pt idx="5" formatCode="0.0">
                  <c:v>2.2053328736422999E-2</c:v>
                </c:pt>
                <c:pt idx="7" formatCode="0.0">
                  <c:v>2.5987841160405499E-2</c:v>
                </c:pt>
                <c:pt idx="8" formatCode="0.0">
                  <c:v>2.2024382321912301E-2</c:v>
                </c:pt>
                <c:pt idx="9" formatCode="0.0">
                  <c:v>1.8745545655199598E-2</c:v>
                </c:pt>
                <c:pt idx="10" formatCode="0.0">
                  <c:v>2.2018855513693002E-2</c:v>
                </c:pt>
                <c:pt idx="11" formatCode="0.0">
                  <c:v>2.2613889733488102E-2</c:v>
                </c:pt>
                <c:pt idx="12" formatCode="0.0">
                  <c:v>1.6913973724886299E-2</c:v>
                </c:pt>
                <c:pt idx="13" formatCode="0.0">
                  <c:v>2.1611555992566402E-2</c:v>
                </c:pt>
                <c:pt idx="14" formatCode="0.0">
                  <c:v>2.8940657855545001E-2</c:v>
                </c:pt>
                <c:pt idx="15" formatCode="0.0">
                  <c:v>2.1092532544973799E-2</c:v>
                </c:pt>
                <c:pt idx="16" formatCode="0.0">
                  <c:v>2.2508777917170798E-2</c:v>
                </c:pt>
                <c:pt idx="17" formatCode="0.0">
                  <c:v>3.7017536000505301E-2</c:v>
                </c:pt>
                <c:pt idx="18" formatCode="0.0">
                  <c:v>2.0334714468618599E-2</c:v>
                </c:pt>
                <c:pt idx="19" formatCode="0.0">
                  <c:v>2.2176040583469999E-2</c:v>
                </c:pt>
                <c:pt idx="20" formatCode="0.0">
                  <c:v>3.2127305257478797E-2</c:v>
                </c:pt>
                <c:pt idx="21" formatCode="0.0">
                  <c:v>1.9302428905561698E-2</c:v>
                </c:pt>
                <c:pt idx="22" formatCode="0.0">
                  <c:v>1.8887750541124099E-2</c:v>
                </c:pt>
                <c:pt idx="23" formatCode="0.0">
                  <c:v>2.7538822770095301E-2</c:v>
                </c:pt>
                <c:pt idx="24" formatCode="0.0">
                  <c:v>1.8269004518683601E-2</c:v>
                </c:pt>
                <c:pt idx="25" formatCode="0.0">
                  <c:v>1.8529018377970299E-2</c:v>
                </c:pt>
                <c:pt idx="26" formatCode="0.0">
                  <c:v>1.7564625462233401E-2</c:v>
                </c:pt>
                <c:pt idx="27" formatCode="0.0">
                  <c:v>1.9706328394089E-2</c:v>
                </c:pt>
                <c:pt idx="28" formatCode="0.0">
                  <c:v>1.5964544151108501E-2</c:v>
                </c:pt>
                <c:pt idx="29" formatCode="0.0">
                  <c:v>1.91345368634506E-2</c:v>
                </c:pt>
                <c:pt idx="30" formatCode="0.0">
                  <c:v>2.1873414533952001E-2</c:v>
                </c:pt>
                <c:pt idx="31" formatCode="0.0">
                  <c:v>1.84201199386975E-2</c:v>
                </c:pt>
                <c:pt idx="32" formatCode="0.0">
                  <c:v>1.9326864873706301E-2</c:v>
                </c:pt>
                <c:pt idx="33" formatCode="0.0">
                  <c:v>1.8320575638535699E-2</c:v>
                </c:pt>
                <c:pt idx="34" formatCode="0.0">
                  <c:v>2.7437065543061599E-2</c:v>
                </c:pt>
                <c:pt idx="35" formatCode="0.0">
                  <c:v>1.7165337360974701E-2</c:v>
                </c:pt>
                <c:pt idx="36" formatCode="0.0">
                  <c:v>1.8171565774909301E-2</c:v>
                </c:pt>
                <c:pt idx="37" formatCode="0.0">
                  <c:v>3.5707097059771598E-2</c:v>
                </c:pt>
                <c:pt idx="38" formatCode="0.0">
                  <c:v>1.9735115716167501E-2</c:v>
                </c:pt>
                <c:pt idx="39" formatCode="0.0">
                  <c:v>1.8418954377853802E-2</c:v>
                </c:pt>
                <c:pt idx="40" formatCode="0.0">
                  <c:v>2.0107782977779001E-2</c:v>
                </c:pt>
                <c:pt idx="41" formatCode="0.0">
                  <c:v>2.99012248621962E-2</c:v>
                </c:pt>
                <c:pt idx="42" formatCode="0.0">
                  <c:v>2.47518451926984E-2</c:v>
                </c:pt>
                <c:pt idx="43" formatCode="0.0">
                  <c:v>2.4218339898840702E-2</c:v>
                </c:pt>
                <c:pt idx="44" formatCode="0.0">
                  <c:v>2.8129731871342701E-2</c:v>
                </c:pt>
                <c:pt idx="45" formatCode="0.0">
                  <c:v>1.89924878223845E-2</c:v>
                </c:pt>
                <c:pt idx="46" formatCode="0.0">
                  <c:v>2.4521769358310401E-2</c:v>
                </c:pt>
                <c:pt idx="47" formatCode="0.0">
                  <c:v>1.7834049430294499E-2</c:v>
                </c:pt>
                <c:pt idx="48" formatCode="0.0">
                  <c:v>2.08568001193375E-2</c:v>
                </c:pt>
                <c:pt idx="49" formatCode="0.0">
                  <c:v>2.1302927579524601E-2</c:v>
                </c:pt>
                <c:pt idx="50" formatCode="0.0">
                  <c:v>2.93035737321059E-2</c:v>
                </c:pt>
                <c:pt idx="51" formatCode="0.0">
                  <c:v>2.1258214941206801E-2</c:v>
                </c:pt>
                <c:pt idx="52" formatCode="0.0">
                  <c:v>3.2483373587793997E-2</c:v>
                </c:pt>
                <c:pt idx="53" formatCode="0.0">
                  <c:v>2.68497954343093E-2</c:v>
                </c:pt>
                <c:pt idx="54" formatCode="0.0">
                  <c:v>1.7463295794412699E-2</c:v>
                </c:pt>
                <c:pt idx="55" formatCode="0.0">
                  <c:v>2.9081970925432701E-2</c:v>
                </c:pt>
                <c:pt idx="56" formatCode="0.0">
                  <c:v>1.87118454826996E-2</c:v>
                </c:pt>
                <c:pt idx="57" formatCode="0.0">
                  <c:v>4.9276290055906398E-2</c:v>
                </c:pt>
                <c:pt idx="58" formatCode="0.0">
                  <c:v>2.07096556662048E-2</c:v>
                </c:pt>
                <c:pt idx="59" formatCode="0.0">
                  <c:v>1.4275345585434401E-2</c:v>
                </c:pt>
                <c:pt idx="60" formatCode="0.0">
                  <c:v>3.6804942037448003E-2</c:v>
                </c:pt>
                <c:pt idx="61" formatCode="0.0">
                  <c:v>2.2053137479089699E-2</c:v>
                </c:pt>
                <c:pt idx="62" formatCode="0.0">
                  <c:v>1.8175775909353702E-2</c:v>
                </c:pt>
                <c:pt idx="63" formatCode="0.0">
                  <c:v>1.5134806641823401E-2</c:v>
                </c:pt>
                <c:pt idx="64" formatCode="0.0">
                  <c:v>1.9139515360634601E-2</c:v>
                </c:pt>
                <c:pt idx="65" formatCode="0.0">
                  <c:v>1.44395573001488E-2</c:v>
                </c:pt>
                <c:pt idx="66" formatCode="0.0">
                  <c:v>1.5848835812627499E-2</c:v>
                </c:pt>
                <c:pt idx="67" formatCode="0.0">
                  <c:v>1.7427227677486199E-2</c:v>
                </c:pt>
                <c:pt idx="68" formatCode="0.0">
                  <c:v>2.2100219258833199E-2</c:v>
                </c:pt>
                <c:pt idx="69" formatCode="0.0">
                  <c:v>2.4784612988774799E-2</c:v>
                </c:pt>
                <c:pt idx="70" formatCode="0.0">
                  <c:v>1.9464879065980201E-2</c:v>
                </c:pt>
                <c:pt idx="71" formatCode="0.0">
                  <c:v>1.9958071960808E-2</c:v>
                </c:pt>
                <c:pt idx="72" formatCode="0.0">
                  <c:v>1.9270398662953901E-2</c:v>
                </c:pt>
                <c:pt idx="73" formatCode="0.0">
                  <c:v>2.4126513072181201E-2</c:v>
                </c:pt>
                <c:pt idx="74" formatCode="0.0">
                  <c:v>2.3660527402927501E-2</c:v>
                </c:pt>
                <c:pt idx="75" formatCode="0.0">
                  <c:v>1.8754988166421401E-2</c:v>
                </c:pt>
                <c:pt idx="77" formatCode="0.0">
                  <c:v>1.8321624946216801E-2</c:v>
                </c:pt>
                <c:pt idx="78" formatCode="0.0">
                  <c:v>1.8990119739795999E-2</c:v>
                </c:pt>
                <c:pt idx="79" formatCode="0.0">
                  <c:v>1.7733930511493301E-2</c:v>
                </c:pt>
                <c:pt idx="80" formatCode="0.0">
                  <c:v>2.1171097709532599E-2</c:v>
                </c:pt>
                <c:pt idx="81" formatCode="0.0">
                  <c:v>2.1701374382989198E-2</c:v>
                </c:pt>
                <c:pt idx="82" formatCode="0.0">
                  <c:v>2.3555572672103401E-2</c:v>
                </c:pt>
                <c:pt idx="83" formatCode="0.0">
                  <c:v>9.9342304212914095E-2</c:v>
                </c:pt>
                <c:pt idx="84" formatCode="0.0">
                  <c:v>2.7640165471509499E-2</c:v>
                </c:pt>
                <c:pt idx="85" formatCode="0.0">
                  <c:v>1.8258415781475901E-2</c:v>
                </c:pt>
                <c:pt idx="86" formatCode="0.0">
                  <c:v>2.1558955521449399E-2</c:v>
                </c:pt>
                <c:pt idx="87" formatCode="0.0">
                  <c:v>2.4739252169026501E-2</c:v>
                </c:pt>
                <c:pt idx="88" formatCode="0.0">
                  <c:v>2.4409786290636601E-2</c:v>
                </c:pt>
                <c:pt idx="89" formatCode="0.0">
                  <c:v>2.1049643727568301E-2</c:v>
                </c:pt>
                <c:pt idx="90" formatCode="0.0">
                  <c:v>1.44143139753932E-2</c:v>
                </c:pt>
                <c:pt idx="91" formatCode="0.0">
                  <c:v>2.0666858245725801E-2</c:v>
                </c:pt>
                <c:pt idx="92" formatCode="0.0">
                  <c:v>2.4870634257453599E-2</c:v>
                </c:pt>
                <c:pt idx="93" formatCode="0.0">
                  <c:v>2.17801002488901E-2</c:v>
                </c:pt>
                <c:pt idx="94" formatCode="0.0">
                  <c:v>2.2645089075008999E-2</c:v>
                </c:pt>
                <c:pt idx="95" formatCode="0.0">
                  <c:v>2.1257231604782999E-2</c:v>
                </c:pt>
                <c:pt idx="96" formatCode="0.0">
                  <c:v>1.7667010587712102E-2</c:v>
                </c:pt>
                <c:pt idx="97" formatCode="0.0">
                  <c:v>2.3656190824138602E-2</c:v>
                </c:pt>
                <c:pt idx="98" formatCode="0.0">
                  <c:v>2.3662623352306299E-2</c:v>
                </c:pt>
                <c:pt idx="99" formatCode="0.0">
                  <c:v>2.1567680113858099E-2</c:v>
                </c:pt>
                <c:pt idx="100" formatCode="0.0">
                  <c:v>2.4965483333076501E-2</c:v>
                </c:pt>
                <c:pt idx="101" formatCode="0.0">
                  <c:v>2.50900955027662E-2</c:v>
                </c:pt>
                <c:pt idx="102" formatCode="0.0">
                  <c:v>1.7745542999069198E-2</c:v>
                </c:pt>
                <c:pt idx="103" formatCode="0.0">
                  <c:v>1.7909687200673301E-2</c:v>
                </c:pt>
                <c:pt idx="104" formatCode="0.0">
                  <c:v>2.1945612090708399E-2</c:v>
                </c:pt>
                <c:pt idx="105" formatCode="0.0">
                  <c:v>2.2067826133004498E-2</c:v>
                </c:pt>
                <c:pt idx="106" formatCode="0.0">
                  <c:v>3.25549477392343E-2</c:v>
                </c:pt>
                <c:pt idx="107" formatCode="0.0">
                  <c:v>2.0746245739500499E-2</c:v>
                </c:pt>
                <c:pt idx="108" formatCode="0.0">
                  <c:v>2.7046182933457601E-2</c:v>
                </c:pt>
                <c:pt idx="109" formatCode="0.0">
                  <c:v>2.3095426879638802E-2</c:v>
                </c:pt>
                <c:pt idx="110" formatCode="0.0">
                  <c:v>1.9287261833612301E-2</c:v>
                </c:pt>
                <c:pt idx="111" formatCode="0.0">
                  <c:v>2.9350070570099501E-2</c:v>
                </c:pt>
                <c:pt idx="112" formatCode="0.0">
                  <c:v>2.1074317156712302E-2</c:v>
                </c:pt>
                <c:pt idx="113" formatCode="0.0">
                  <c:v>0.100879276419426</c:v>
                </c:pt>
                <c:pt idx="114" formatCode="0.0">
                  <c:v>4.8410259102586797E-2</c:v>
                </c:pt>
                <c:pt idx="115" formatCode="0.0">
                  <c:v>1.94027048626371E-2</c:v>
                </c:pt>
                <c:pt idx="116" formatCode="0.0">
                  <c:v>2.3713098674343101E-2</c:v>
                </c:pt>
                <c:pt idx="117" formatCode="0.0">
                  <c:v>3.0401954106601799E-2</c:v>
                </c:pt>
                <c:pt idx="118" formatCode="0.0">
                  <c:v>3.2140032374377202E-2</c:v>
                </c:pt>
                <c:pt idx="119" formatCode="0.0">
                  <c:v>2.35686183970681E-2</c:v>
                </c:pt>
                <c:pt idx="120" formatCode="0.0">
                  <c:v>5.7415019522500797E-2</c:v>
                </c:pt>
                <c:pt idx="121" formatCode="0.0">
                  <c:v>2.3003388111114399E-2</c:v>
                </c:pt>
                <c:pt idx="122" formatCode="0.0">
                  <c:v>2.82590672895611E-2</c:v>
                </c:pt>
                <c:pt idx="124" formatCode="0.0">
                  <c:v>2.93308272629869E-2</c:v>
                </c:pt>
                <c:pt idx="125" formatCode="0.0">
                  <c:v>2.2611541937139198E-2</c:v>
                </c:pt>
                <c:pt idx="126" formatCode="0.0">
                  <c:v>1.9428923313771398E-2</c:v>
                </c:pt>
                <c:pt idx="127" formatCode="0.0">
                  <c:v>3.06176634279961E-2</c:v>
                </c:pt>
                <c:pt idx="128" formatCode="0.0">
                  <c:v>1.8512361729950199E-2</c:v>
                </c:pt>
                <c:pt idx="129" formatCode="0.0">
                  <c:v>4.8331181991738699E-2</c:v>
                </c:pt>
                <c:pt idx="130" formatCode="0.0">
                  <c:v>2.0245860316453E-2</c:v>
                </c:pt>
                <c:pt idx="131" formatCode="0.0">
                  <c:v>2.2349554514814799E-2</c:v>
                </c:pt>
                <c:pt idx="132" formatCode="0.0">
                  <c:v>2.10487592184074E-2</c:v>
                </c:pt>
                <c:pt idx="133" formatCode="0.0">
                  <c:v>1.9324215492078599E-2</c:v>
                </c:pt>
                <c:pt idx="134" formatCode="0.0">
                  <c:v>1.79851846278299E-2</c:v>
                </c:pt>
                <c:pt idx="135" formatCode="0.0">
                  <c:v>2.8584924850127098E-2</c:v>
                </c:pt>
                <c:pt idx="136" formatCode="0.0">
                  <c:v>2.3864762623703299E-2</c:v>
                </c:pt>
                <c:pt idx="137" formatCode="0.0">
                  <c:v>1.8942661338678099E-2</c:v>
                </c:pt>
                <c:pt idx="138" formatCode="0.0">
                  <c:v>1.9879149900807001E-2</c:v>
                </c:pt>
                <c:pt idx="139" formatCode="0.0">
                  <c:v>2.11557960861956E-2</c:v>
                </c:pt>
                <c:pt idx="140" formatCode="0.0">
                  <c:v>2.4058334419967901E-2</c:v>
                </c:pt>
                <c:pt idx="141" formatCode="0.0">
                  <c:v>1.6615641119027101E-2</c:v>
                </c:pt>
                <c:pt idx="142" formatCode="0.0">
                  <c:v>2.1966980712286501E-2</c:v>
                </c:pt>
                <c:pt idx="143" formatCode="0.0">
                  <c:v>1.91940962232772E-2</c:v>
                </c:pt>
                <c:pt idx="144" formatCode="0.0">
                  <c:v>5.3557489783411197E-2</c:v>
                </c:pt>
                <c:pt idx="145" formatCode="0.0">
                  <c:v>2.83505230501363E-2</c:v>
                </c:pt>
                <c:pt idx="146" formatCode="0.0">
                  <c:v>1.9158332782902399E-2</c:v>
                </c:pt>
                <c:pt idx="147" formatCode="0.0">
                  <c:v>2.0966103622715601E-2</c:v>
                </c:pt>
                <c:pt idx="148" formatCode="0.0">
                  <c:v>2.50113374186605E-2</c:v>
                </c:pt>
                <c:pt idx="149" formatCode="0.0">
                  <c:v>2.5295975935389702E-2</c:v>
                </c:pt>
                <c:pt idx="150" formatCode="0.0">
                  <c:v>2.01659474437841E-2</c:v>
                </c:pt>
                <c:pt idx="151" formatCode="0.0">
                  <c:v>1.55075930400633E-2</c:v>
                </c:pt>
                <c:pt idx="152" formatCode="0.0">
                  <c:v>2.2635900199343899E-2</c:v>
                </c:pt>
                <c:pt idx="153" formatCode="0.0">
                  <c:v>2.56711016422689E-2</c:v>
                </c:pt>
                <c:pt idx="155" formatCode="0.0">
                  <c:v>2.2562866751259798E-2</c:v>
                </c:pt>
                <c:pt idx="156" formatCode="0.0">
                  <c:v>1.7992960973292099E-2</c:v>
                </c:pt>
                <c:pt idx="157" formatCode="0.0">
                  <c:v>2.14345295582943E-2</c:v>
                </c:pt>
                <c:pt idx="158" formatCode="0.0">
                  <c:v>1.8235070013460399E-2</c:v>
                </c:pt>
                <c:pt idx="159" formatCode="0.0">
                  <c:v>2.2928236842616499E-2</c:v>
                </c:pt>
                <c:pt idx="160" formatCode="0.0">
                  <c:v>2.4349943169440499E-2</c:v>
                </c:pt>
                <c:pt idx="161" formatCode="0.0">
                  <c:v>2.2335721244646601E-2</c:v>
                </c:pt>
                <c:pt idx="162" formatCode="0.0">
                  <c:v>2.20919514916952E-2</c:v>
                </c:pt>
                <c:pt idx="163" formatCode="0.0">
                  <c:v>1.8344493843157301E-2</c:v>
                </c:pt>
                <c:pt idx="164" formatCode="0.0">
                  <c:v>2.19490246979419E-2</c:v>
                </c:pt>
                <c:pt idx="165" formatCode="0.0">
                  <c:v>2.84261278201559E-2</c:v>
                </c:pt>
                <c:pt idx="166" formatCode="0.0">
                  <c:v>4.8029389967764499E-2</c:v>
                </c:pt>
                <c:pt idx="168" formatCode="0.0">
                  <c:v>1.8186178309780001E-2</c:v>
                </c:pt>
                <c:pt idx="169" formatCode="0.0">
                  <c:v>2.2197428423799501E-2</c:v>
                </c:pt>
                <c:pt idx="170" formatCode="0.0">
                  <c:v>2.1510655970958199E-2</c:v>
                </c:pt>
                <c:pt idx="171" formatCode="0.0">
                  <c:v>3.10336089898096E-2</c:v>
                </c:pt>
                <c:pt idx="173" formatCode="0.0">
                  <c:v>2.86644448584721E-2</c:v>
                </c:pt>
                <c:pt idx="174" formatCode="0.0">
                  <c:v>3.2677086332108599E-2</c:v>
                </c:pt>
                <c:pt idx="175" formatCode="0.0">
                  <c:v>3.41772848423465E-2</c:v>
                </c:pt>
                <c:pt idx="176" formatCode="0.0">
                  <c:v>2.3672511537924001E-2</c:v>
                </c:pt>
                <c:pt idx="177" formatCode="0.0">
                  <c:v>2.2976568677854001E-2</c:v>
                </c:pt>
                <c:pt idx="178" formatCode="0.0">
                  <c:v>3.4831231074107898E-2</c:v>
                </c:pt>
                <c:pt idx="179" formatCode="0.0">
                  <c:v>8.7621324897496994E-2</c:v>
                </c:pt>
                <c:pt idx="180" formatCode="0.0">
                  <c:v>2.2360891436249902E-2</c:v>
                </c:pt>
                <c:pt idx="181" formatCode="0.0">
                  <c:v>1.84932647864294E-2</c:v>
                </c:pt>
                <c:pt idx="182" formatCode="0.0">
                  <c:v>3.11294633110413E-2</c:v>
                </c:pt>
                <c:pt idx="183" formatCode="0.0">
                  <c:v>1.94788745380816E-2</c:v>
                </c:pt>
                <c:pt idx="184" formatCode="0.0">
                  <c:v>1.9435344083407E-2</c:v>
                </c:pt>
                <c:pt idx="185" formatCode="0.0">
                  <c:v>3.5646448838216702E-2</c:v>
                </c:pt>
                <c:pt idx="186" formatCode="0.0">
                  <c:v>2.32881268667979E-2</c:v>
                </c:pt>
                <c:pt idx="187" formatCode="0.0">
                  <c:v>1.93276597131345E-2</c:v>
                </c:pt>
                <c:pt idx="188" formatCode="0.0">
                  <c:v>2.0873744115415899E-2</c:v>
                </c:pt>
                <c:pt idx="189" formatCode="0.0">
                  <c:v>1.8781017475720502E-2</c:v>
                </c:pt>
                <c:pt idx="191" formatCode="0.0">
                  <c:v>2.0408121146667998E-2</c:v>
                </c:pt>
                <c:pt idx="192" formatCode="0.0">
                  <c:v>1.6237036267969698E-2</c:v>
                </c:pt>
                <c:pt idx="193" formatCode="0.0">
                  <c:v>1.66716698998223E-2</c:v>
                </c:pt>
                <c:pt idx="194" formatCode="0.0">
                  <c:v>2.17114100660434E-2</c:v>
                </c:pt>
                <c:pt idx="195" formatCode="0.0">
                  <c:v>2.3298768912913201E-2</c:v>
                </c:pt>
                <c:pt idx="196" formatCode="0.0">
                  <c:v>2.3949726544507399E-2</c:v>
                </c:pt>
                <c:pt idx="197" formatCode="0.0">
                  <c:v>2.68650988707533E-2</c:v>
                </c:pt>
                <c:pt idx="198" formatCode="0.0">
                  <c:v>1.66406484910629E-2</c:v>
                </c:pt>
                <c:pt idx="199" formatCode="0.0">
                  <c:v>1.85447371936708E-2</c:v>
                </c:pt>
                <c:pt idx="200" formatCode="0.0">
                  <c:v>2.29281885358209E-2</c:v>
                </c:pt>
                <c:pt idx="201" formatCode="0.0">
                  <c:v>2.78605069713357E-2</c:v>
                </c:pt>
                <c:pt idx="202" formatCode="0.0">
                  <c:v>2.4061029084969199E-2</c:v>
                </c:pt>
                <c:pt idx="203" formatCode="0.0">
                  <c:v>1.8836953434911399E-2</c:v>
                </c:pt>
                <c:pt idx="204" formatCode="0.0">
                  <c:v>1.8597646394618299E-2</c:v>
                </c:pt>
                <c:pt idx="205" formatCode="0.0">
                  <c:v>2.25052190471614E-2</c:v>
                </c:pt>
                <c:pt idx="206" formatCode="0.0">
                  <c:v>1.6907201601534499E-2</c:v>
                </c:pt>
                <c:pt idx="207" formatCode="0.0">
                  <c:v>1.6080457856966102E-2</c:v>
                </c:pt>
                <c:pt idx="208" formatCode="0.0">
                  <c:v>7.5818524720900698E-2</c:v>
                </c:pt>
                <c:pt idx="209" formatCode="0.0">
                  <c:v>2.2674861068881801E-2</c:v>
                </c:pt>
                <c:pt idx="210" formatCode="0.0">
                  <c:v>1.8743592910424298E-2</c:v>
                </c:pt>
                <c:pt idx="211" formatCode="0.0">
                  <c:v>1.8378483867752999E-2</c:v>
                </c:pt>
                <c:pt idx="212" formatCode="0.0">
                  <c:v>5.7968603720336E-2</c:v>
                </c:pt>
                <c:pt idx="213" formatCode="0.0">
                  <c:v>2.0811158410844001E-2</c:v>
                </c:pt>
                <c:pt idx="214" formatCode="0.0">
                  <c:v>2.26296653523477E-2</c:v>
                </c:pt>
                <c:pt idx="215" formatCode="0.0">
                  <c:v>2.1103571937448402E-2</c:v>
                </c:pt>
                <c:pt idx="216" formatCode="0.0">
                  <c:v>2.25118053166363E-2</c:v>
                </c:pt>
                <c:pt idx="217" formatCode="0.0">
                  <c:v>2.3155391634220202E-2</c:v>
                </c:pt>
                <c:pt idx="218" formatCode="0.0">
                  <c:v>1.9059891186523299E-2</c:v>
                </c:pt>
              </c:numCache>
            </c:numRef>
          </c:xVal>
          <c:yVal>
            <c:numRef>
              <c:f>Feuil1!$Y$2:$Y$248</c:f>
              <c:numCache>
                <c:formatCode>0.00</c:formatCode>
                <c:ptCount val="247"/>
                <c:pt idx="0">
                  <c:v>0.28682948240786599</c:v>
                </c:pt>
                <c:pt idx="1">
                  <c:v>0.334973467391461</c:v>
                </c:pt>
                <c:pt idx="2">
                  <c:v>0.17885900308307001</c:v>
                </c:pt>
                <c:pt idx="3">
                  <c:v>0.23797154658929201</c:v>
                </c:pt>
                <c:pt idx="4">
                  <c:v>0.30189691870441798</c:v>
                </c:pt>
                <c:pt idx="5">
                  <c:v>0.29087988465132503</c:v>
                </c:pt>
                <c:pt idx="6">
                  <c:v>0.208544517756902</c:v>
                </c:pt>
                <c:pt idx="7">
                  <c:v>0.24366201946028401</c:v>
                </c:pt>
                <c:pt idx="8">
                  <c:v>0.33803630137979201</c:v>
                </c:pt>
                <c:pt idx="9">
                  <c:v>0.32783144229219902</c:v>
                </c:pt>
                <c:pt idx="10">
                  <c:v>0.30335674513432498</c:v>
                </c:pt>
                <c:pt idx="11">
                  <c:v>0.115062140277499</c:v>
                </c:pt>
                <c:pt idx="12">
                  <c:v>0.25184870215552002</c:v>
                </c:pt>
                <c:pt idx="13">
                  <c:v>0.20680293273295799</c:v>
                </c:pt>
                <c:pt idx="14">
                  <c:v>0.35987518197034601</c:v>
                </c:pt>
                <c:pt idx="15">
                  <c:v>0.20238602656629301</c:v>
                </c:pt>
                <c:pt idx="16">
                  <c:v>0.27968285137697702</c:v>
                </c:pt>
                <c:pt idx="17">
                  <c:v>0.37775929545981501</c:v>
                </c:pt>
                <c:pt idx="18">
                  <c:v>0.20515170767942301</c:v>
                </c:pt>
                <c:pt idx="19">
                  <c:v>0.29768892542949599</c:v>
                </c:pt>
                <c:pt idx="20">
                  <c:v>0.33785678322047102</c:v>
                </c:pt>
                <c:pt idx="21">
                  <c:v>0.238260343502811</c:v>
                </c:pt>
                <c:pt idx="22">
                  <c:v>0.245430865500505</c:v>
                </c:pt>
                <c:pt idx="23">
                  <c:v>0.26770821033324199</c:v>
                </c:pt>
                <c:pt idx="24">
                  <c:v>0.23093887084704201</c:v>
                </c:pt>
                <c:pt idx="25">
                  <c:v>0.34677137432128302</c:v>
                </c:pt>
                <c:pt idx="26">
                  <c:v>0.27962533794418898</c:v>
                </c:pt>
                <c:pt idx="27">
                  <c:v>0.33158001793867498</c:v>
                </c:pt>
                <c:pt idx="28">
                  <c:v>0.47018820835040898</c:v>
                </c:pt>
                <c:pt idx="29">
                  <c:v>0.31271610234362202</c:v>
                </c:pt>
                <c:pt idx="30">
                  <c:v>0.24399009180773201</c:v>
                </c:pt>
                <c:pt idx="31">
                  <c:v>0.21747325940571499</c:v>
                </c:pt>
                <c:pt idx="32">
                  <c:v>0.23710563429950199</c:v>
                </c:pt>
                <c:pt idx="33">
                  <c:v>0.19786124568501201</c:v>
                </c:pt>
                <c:pt idx="34">
                  <c:v>0.32822300969594498</c:v>
                </c:pt>
                <c:pt idx="35">
                  <c:v>0.248642132402809</c:v>
                </c:pt>
                <c:pt idx="36">
                  <c:v>0.28880517064658101</c:v>
                </c:pt>
                <c:pt idx="37">
                  <c:v>0.283348704072589</c:v>
                </c:pt>
                <c:pt idx="38">
                  <c:v>0.32913309450358802</c:v>
                </c:pt>
                <c:pt idx="39">
                  <c:v>0.24316349230415399</c:v>
                </c:pt>
                <c:pt idx="40">
                  <c:v>0.29604238900923902</c:v>
                </c:pt>
                <c:pt idx="41">
                  <c:v>0.34244859023204299</c:v>
                </c:pt>
                <c:pt idx="42">
                  <c:v>0.33752823439185897</c:v>
                </c:pt>
                <c:pt idx="43">
                  <c:v>0.22137643944663499</c:v>
                </c:pt>
                <c:pt idx="44">
                  <c:v>0.26833662789240398</c:v>
                </c:pt>
                <c:pt idx="45">
                  <c:v>0.23315170804650501</c:v>
                </c:pt>
                <c:pt idx="46">
                  <c:v>0.173702752109197</c:v>
                </c:pt>
                <c:pt idx="47">
                  <c:v>0.26656325629260502</c:v>
                </c:pt>
                <c:pt idx="48">
                  <c:v>0.30337663411780602</c:v>
                </c:pt>
                <c:pt idx="49">
                  <c:v>0.28818745487615999</c:v>
                </c:pt>
                <c:pt idx="50">
                  <c:v>0.27126204722724401</c:v>
                </c:pt>
                <c:pt idx="51">
                  <c:v>0.20193523391285501</c:v>
                </c:pt>
                <c:pt idx="52">
                  <c:v>0.347776165490296</c:v>
                </c:pt>
                <c:pt idx="53">
                  <c:v>0.347882758933651</c:v>
                </c:pt>
                <c:pt idx="54">
                  <c:v>0.28319058687801402</c:v>
                </c:pt>
                <c:pt idx="55">
                  <c:v>0.31895809525725799</c:v>
                </c:pt>
                <c:pt idx="56">
                  <c:v>0.256763624738306</c:v>
                </c:pt>
                <c:pt idx="57">
                  <c:v>0.27510530479783402</c:v>
                </c:pt>
                <c:pt idx="58">
                  <c:v>0.351320909544169</c:v>
                </c:pt>
                <c:pt idx="59">
                  <c:v>0.16934541775638101</c:v>
                </c:pt>
                <c:pt idx="60">
                  <c:v>0.30341574237992902</c:v>
                </c:pt>
                <c:pt idx="61">
                  <c:v>0.27742948604526002</c:v>
                </c:pt>
                <c:pt idx="62">
                  <c:v>0.24690893706691699</c:v>
                </c:pt>
                <c:pt idx="63">
                  <c:v>0.318447295134896</c:v>
                </c:pt>
                <c:pt idx="64">
                  <c:v>0.18274635885823601</c:v>
                </c:pt>
                <c:pt idx="65">
                  <c:v>0.110898726139144</c:v>
                </c:pt>
                <c:pt idx="66">
                  <c:v>0.19626525315610899</c:v>
                </c:pt>
                <c:pt idx="67">
                  <c:v>0.19321697412039299</c:v>
                </c:pt>
                <c:pt idx="68">
                  <c:v>0.29415082648815499</c:v>
                </c:pt>
                <c:pt idx="69">
                  <c:v>0.28293628792543402</c:v>
                </c:pt>
                <c:pt idx="70">
                  <c:v>0.19985444477214601</c:v>
                </c:pt>
                <c:pt idx="71">
                  <c:v>0.42663500109760599</c:v>
                </c:pt>
                <c:pt idx="72">
                  <c:v>0.36161741432252598</c:v>
                </c:pt>
                <c:pt idx="73">
                  <c:v>0.240569140278936</c:v>
                </c:pt>
                <c:pt idx="74">
                  <c:v>0.35021294180275397</c:v>
                </c:pt>
                <c:pt idx="75">
                  <c:v>0.26602673094024598</c:v>
                </c:pt>
                <c:pt idx="76">
                  <c:v>0.25121864378122899</c:v>
                </c:pt>
                <c:pt idx="77">
                  <c:v>0.210844824839068</c:v>
                </c:pt>
                <c:pt idx="78">
                  <c:v>0.25407293454364199</c:v>
                </c:pt>
                <c:pt idx="79">
                  <c:v>0.167743408479686</c:v>
                </c:pt>
                <c:pt idx="80">
                  <c:v>0.34243762125767901</c:v>
                </c:pt>
                <c:pt idx="81">
                  <c:v>0.33739367917294799</c:v>
                </c:pt>
                <c:pt idx="82">
                  <c:v>0.188979842689145</c:v>
                </c:pt>
                <c:pt idx="83">
                  <c:v>0.34732201024679898</c:v>
                </c:pt>
                <c:pt idx="84">
                  <c:v>0.31164490033626802</c:v>
                </c:pt>
                <c:pt idx="85">
                  <c:v>0.303386538666162</c:v>
                </c:pt>
                <c:pt idx="86">
                  <c:v>0.19924030806423901</c:v>
                </c:pt>
                <c:pt idx="87">
                  <c:v>8.8682351814771895E-2</c:v>
                </c:pt>
                <c:pt idx="88">
                  <c:v>0.33726637858026398</c:v>
                </c:pt>
                <c:pt idx="89">
                  <c:v>0.19392996085465899</c:v>
                </c:pt>
                <c:pt idx="90">
                  <c:v>0.27704849905578099</c:v>
                </c:pt>
                <c:pt idx="91">
                  <c:v>0.238849989405062</c:v>
                </c:pt>
                <c:pt idx="92">
                  <c:v>0.28680235891115902</c:v>
                </c:pt>
                <c:pt idx="93">
                  <c:v>0.37303685887766203</c:v>
                </c:pt>
                <c:pt idx="94">
                  <c:v>0.241205952980896</c:v>
                </c:pt>
                <c:pt idx="95">
                  <c:v>0.24425733897702301</c:v>
                </c:pt>
                <c:pt idx="96">
                  <c:v>0.19177432588524501</c:v>
                </c:pt>
                <c:pt idx="97">
                  <c:v>0.26514086746131399</c:v>
                </c:pt>
                <c:pt idx="98">
                  <c:v>0.271466092002276</c:v>
                </c:pt>
                <c:pt idx="99">
                  <c:v>0.28349146222247001</c:v>
                </c:pt>
                <c:pt idx="100">
                  <c:v>0.29639301661928802</c:v>
                </c:pt>
                <c:pt idx="101">
                  <c:v>0.34768909539182902</c:v>
                </c:pt>
                <c:pt idx="102">
                  <c:v>0.21290520272664301</c:v>
                </c:pt>
                <c:pt idx="103">
                  <c:v>0.28532312080965</c:v>
                </c:pt>
                <c:pt idx="104">
                  <c:v>0.22994653062468501</c:v>
                </c:pt>
                <c:pt idx="105">
                  <c:v>0.14620240395751799</c:v>
                </c:pt>
                <c:pt idx="106">
                  <c:v>0.26202975010151502</c:v>
                </c:pt>
                <c:pt idx="107">
                  <c:v>0.26652847101577998</c:v>
                </c:pt>
                <c:pt idx="108">
                  <c:v>0.27743494367064903</c:v>
                </c:pt>
                <c:pt idx="109">
                  <c:v>0.17251567232715601</c:v>
                </c:pt>
                <c:pt idx="110">
                  <c:v>0.168531211447281</c:v>
                </c:pt>
                <c:pt idx="111">
                  <c:v>0.24670287932871901</c:v>
                </c:pt>
                <c:pt idx="112">
                  <c:v>0.362741150497638</c:v>
                </c:pt>
                <c:pt idx="113">
                  <c:v>0.54917630373298998</c:v>
                </c:pt>
                <c:pt idx="114">
                  <c:v>0.41246199427543101</c:v>
                </c:pt>
                <c:pt idx="115">
                  <c:v>0.230321902211298</c:v>
                </c:pt>
                <c:pt idx="116">
                  <c:v>0.15459481786353199</c:v>
                </c:pt>
                <c:pt idx="117">
                  <c:v>0.22665119963604599</c:v>
                </c:pt>
                <c:pt idx="118">
                  <c:v>0.26697078896443999</c:v>
                </c:pt>
                <c:pt idx="119">
                  <c:v>0.195216217079591</c:v>
                </c:pt>
                <c:pt idx="120">
                  <c:v>0.22656459654480501</c:v>
                </c:pt>
                <c:pt idx="121">
                  <c:v>0.21453791006284101</c:v>
                </c:pt>
                <c:pt idx="122">
                  <c:v>0.23225388798026</c:v>
                </c:pt>
                <c:pt idx="123">
                  <c:v>0.277481412364462</c:v>
                </c:pt>
                <c:pt idx="124">
                  <c:v>0.29072156810115302</c:v>
                </c:pt>
                <c:pt idx="125">
                  <c:v>0.26967186608216498</c:v>
                </c:pt>
                <c:pt idx="126">
                  <c:v>0.18423806723848399</c:v>
                </c:pt>
                <c:pt idx="127">
                  <c:v>0.24909523586093299</c:v>
                </c:pt>
                <c:pt idx="128">
                  <c:v>0.30276841516702002</c:v>
                </c:pt>
                <c:pt idx="129">
                  <c:v>0.33852469737444402</c:v>
                </c:pt>
                <c:pt idx="130">
                  <c:v>0.25138029246877402</c:v>
                </c:pt>
                <c:pt idx="131">
                  <c:v>0.43444733600771501</c:v>
                </c:pt>
                <c:pt idx="132">
                  <c:v>0.20343504220870001</c:v>
                </c:pt>
                <c:pt idx="133">
                  <c:v>0.14707491955231</c:v>
                </c:pt>
                <c:pt idx="134">
                  <c:v>0.25676582928910002</c:v>
                </c:pt>
                <c:pt idx="135">
                  <c:v>0.19649340776145299</c:v>
                </c:pt>
                <c:pt idx="136">
                  <c:v>0.28529454883737898</c:v>
                </c:pt>
                <c:pt idx="137">
                  <c:v>0.18268164856756999</c:v>
                </c:pt>
                <c:pt idx="138">
                  <c:v>0.46889659264415801</c:v>
                </c:pt>
                <c:pt idx="139">
                  <c:v>0.23150417112451299</c:v>
                </c:pt>
                <c:pt idx="140">
                  <c:v>0.34118325236417002</c:v>
                </c:pt>
                <c:pt idx="141">
                  <c:v>0.26842494004203699</c:v>
                </c:pt>
                <c:pt idx="142">
                  <c:v>0.209670383518198</c:v>
                </c:pt>
                <c:pt idx="143">
                  <c:v>0.29251899062001202</c:v>
                </c:pt>
                <c:pt idx="144">
                  <c:v>0.26230126700471101</c:v>
                </c:pt>
                <c:pt idx="145">
                  <c:v>0.17603926249843499</c:v>
                </c:pt>
                <c:pt idx="146">
                  <c:v>0.33927677762458203</c:v>
                </c:pt>
                <c:pt idx="147">
                  <c:v>0.33416490193582998</c:v>
                </c:pt>
                <c:pt idx="148">
                  <c:v>0.248864404753739</c:v>
                </c:pt>
                <c:pt idx="149">
                  <c:v>0.305030649992029</c:v>
                </c:pt>
                <c:pt idx="150">
                  <c:v>0.25655185022231602</c:v>
                </c:pt>
                <c:pt idx="151">
                  <c:v>0.27228584358167701</c:v>
                </c:pt>
                <c:pt idx="152">
                  <c:v>0.24219428182070299</c:v>
                </c:pt>
                <c:pt idx="153">
                  <c:v>0.24833504370155701</c:v>
                </c:pt>
                <c:pt idx="154">
                  <c:v>0.275336412602668</c:v>
                </c:pt>
                <c:pt idx="155">
                  <c:v>0.233911521195865</c:v>
                </c:pt>
                <c:pt idx="156">
                  <c:v>0.25358225784864202</c:v>
                </c:pt>
                <c:pt idx="157">
                  <c:v>0.23276661229839199</c:v>
                </c:pt>
                <c:pt idx="158">
                  <c:v>0.266955175343349</c:v>
                </c:pt>
                <c:pt idx="159">
                  <c:v>0.25308932339110701</c:v>
                </c:pt>
                <c:pt idx="160">
                  <c:v>0.19027223533573701</c:v>
                </c:pt>
                <c:pt idx="161">
                  <c:v>0.240005303736543</c:v>
                </c:pt>
                <c:pt idx="162">
                  <c:v>0.31842187383305098</c:v>
                </c:pt>
                <c:pt idx="163">
                  <c:v>0.20048673810923801</c:v>
                </c:pt>
                <c:pt idx="164">
                  <c:v>0.36919065178409599</c:v>
                </c:pt>
                <c:pt idx="165">
                  <c:v>0.27272024194306499</c:v>
                </c:pt>
                <c:pt idx="166">
                  <c:v>0.39432904851661299</c:v>
                </c:pt>
                <c:pt idx="167">
                  <c:v>0.33901286153697502</c:v>
                </c:pt>
                <c:pt idx="168">
                  <c:v>0.20436688584944701</c:v>
                </c:pt>
                <c:pt idx="169">
                  <c:v>0.20757485733138201</c:v>
                </c:pt>
                <c:pt idx="170">
                  <c:v>0.22060270519985301</c:v>
                </c:pt>
                <c:pt idx="171">
                  <c:v>0.250234864976356</c:v>
                </c:pt>
                <c:pt idx="172">
                  <c:v>0.243531169535813</c:v>
                </c:pt>
                <c:pt idx="173">
                  <c:v>0.208283845417918</c:v>
                </c:pt>
                <c:pt idx="174">
                  <c:v>0.19726195699173099</c:v>
                </c:pt>
                <c:pt idx="175">
                  <c:v>0.22754356569762901</c:v>
                </c:pt>
                <c:pt idx="176">
                  <c:v>0.25273308185478899</c:v>
                </c:pt>
                <c:pt idx="177">
                  <c:v>0.18670609569697599</c:v>
                </c:pt>
                <c:pt idx="178">
                  <c:v>0.30619414837325998</c:v>
                </c:pt>
                <c:pt idx="179">
                  <c:v>0.33172462292861299</c:v>
                </c:pt>
                <c:pt idx="180">
                  <c:v>0.28875737487182701</c:v>
                </c:pt>
                <c:pt idx="181">
                  <c:v>0.272912803831798</c:v>
                </c:pt>
                <c:pt idx="182">
                  <c:v>0.33050507284988001</c:v>
                </c:pt>
                <c:pt idx="183">
                  <c:v>0.23601114952666999</c:v>
                </c:pt>
                <c:pt idx="184">
                  <c:v>0.277554154449348</c:v>
                </c:pt>
                <c:pt idx="185">
                  <c:v>0.28015587958615101</c:v>
                </c:pt>
                <c:pt idx="186">
                  <c:v>0.22566449051714299</c:v>
                </c:pt>
                <c:pt idx="187">
                  <c:v>0.13255300854385099</c:v>
                </c:pt>
                <c:pt idx="188">
                  <c:v>0.350657864099854</c:v>
                </c:pt>
                <c:pt idx="189">
                  <c:v>0.32388639888417797</c:v>
                </c:pt>
                <c:pt idx="190">
                  <c:v>0.35247206303448703</c:v>
                </c:pt>
                <c:pt idx="191">
                  <c:v>0.29633159025278399</c:v>
                </c:pt>
                <c:pt idx="192">
                  <c:v>0.32136299893195802</c:v>
                </c:pt>
                <c:pt idx="193">
                  <c:v>0.299962577612501</c:v>
                </c:pt>
                <c:pt idx="194">
                  <c:v>0.28703674663304002</c:v>
                </c:pt>
                <c:pt idx="195">
                  <c:v>0.236634081147334</c:v>
                </c:pt>
                <c:pt idx="196">
                  <c:v>0.30279184879354099</c:v>
                </c:pt>
                <c:pt idx="197">
                  <c:v>0.22233905308997801</c:v>
                </c:pt>
                <c:pt idx="198">
                  <c:v>0.27987900027776802</c:v>
                </c:pt>
                <c:pt idx="199">
                  <c:v>0.26318802164058802</c:v>
                </c:pt>
                <c:pt idx="200">
                  <c:v>0.23315942992035499</c:v>
                </c:pt>
                <c:pt idx="201">
                  <c:v>0.30322276342022703</c:v>
                </c:pt>
                <c:pt idx="202">
                  <c:v>0.12914997666952799</c:v>
                </c:pt>
                <c:pt idx="203">
                  <c:v>0.21536616305108999</c:v>
                </c:pt>
                <c:pt idx="204">
                  <c:v>0.35420033362403802</c:v>
                </c:pt>
                <c:pt idx="205">
                  <c:v>0.29882608484499701</c:v>
                </c:pt>
                <c:pt idx="206">
                  <c:v>0.328639920500224</c:v>
                </c:pt>
                <c:pt idx="207">
                  <c:v>0.28411471876146599</c:v>
                </c:pt>
                <c:pt idx="208">
                  <c:v>0.25651896317695799</c:v>
                </c:pt>
                <c:pt idx="209">
                  <c:v>0.279183599475049</c:v>
                </c:pt>
                <c:pt idx="210">
                  <c:v>0.153859567790427</c:v>
                </c:pt>
                <c:pt idx="211">
                  <c:v>0.20601887239927399</c:v>
                </c:pt>
                <c:pt idx="212">
                  <c:v>0.31324163056101501</c:v>
                </c:pt>
                <c:pt idx="213">
                  <c:v>0.37765811083087703</c:v>
                </c:pt>
                <c:pt idx="214">
                  <c:v>0.28245779335759302</c:v>
                </c:pt>
                <c:pt idx="215">
                  <c:v>0.36180611301858501</c:v>
                </c:pt>
                <c:pt idx="216">
                  <c:v>0.268449764687127</c:v>
                </c:pt>
                <c:pt idx="217">
                  <c:v>0.33622607510799402</c:v>
                </c:pt>
                <c:pt idx="218">
                  <c:v>0.28746093742954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BDE-D243-BB94-1B163814AC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84976"/>
        <c:axId val="534879488"/>
      </c:scatterChart>
      <c:valAx>
        <c:axId val="5348849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W</a:t>
                </a:r>
                <a:r>
                  <a:rPr lang="en-US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79488"/>
        <c:crosses val="autoZero"/>
        <c:crossBetween val="midCat"/>
        <c:majorUnit val="2.0000000000000004E-2"/>
      </c:valAx>
      <c:valAx>
        <c:axId val="534879488"/>
        <c:scaling>
          <c:orientation val="minMax"/>
          <c:max val="0.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F</a:t>
                </a:r>
                <a:r>
                  <a:rPr lang="en-US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</a:p>
            </c:rich>
          </c:tx>
          <c:layout>
            <c:manualLayout>
              <c:xMode val="edge"/>
              <c:yMode val="edge"/>
              <c:x val="5.4418294572285475E-2"/>
              <c:y val="0.368343175853018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49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66527274320278"/>
          <c:y val="0.16017312814168422"/>
          <c:w val="0.53058884851328858"/>
          <c:h val="0.64059336233600905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G$1</c:f>
              <c:strCache>
                <c:ptCount val="1"/>
                <c:pt idx="0">
                  <c:v>Δ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F$2:$F$249</c:f>
              <c:numCache>
                <c:formatCode>0.0</c:formatCode>
                <c:ptCount val="248"/>
                <c:pt idx="0">
                  <c:v>45.14</c:v>
                </c:pt>
                <c:pt idx="1">
                  <c:v>45.21</c:v>
                </c:pt>
                <c:pt idx="2">
                  <c:v>49.480000000000004</c:v>
                </c:pt>
                <c:pt idx="3">
                  <c:v>38.33</c:v>
                </c:pt>
                <c:pt idx="4">
                  <c:v>57.489999999999995</c:v>
                </c:pt>
                <c:pt idx="5">
                  <c:v>40.619999999999997</c:v>
                </c:pt>
                <c:pt idx="6">
                  <c:v>41.86</c:v>
                </c:pt>
                <c:pt idx="7">
                  <c:v>41.47</c:v>
                </c:pt>
                <c:pt idx="8">
                  <c:v>35.71</c:v>
                </c:pt>
                <c:pt idx="9">
                  <c:v>36.679999999999993</c:v>
                </c:pt>
                <c:pt idx="10">
                  <c:v>46.599999999999994</c:v>
                </c:pt>
                <c:pt idx="11">
                  <c:v>40.320000000000007</c:v>
                </c:pt>
                <c:pt idx="12">
                  <c:v>34.510000000000005</c:v>
                </c:pt>
                <c:pt idx="13">
                  <c:v>38.770000000000003</c:v>
                </c:pt>
                <c:pt idx="14">
                  <c:v>36.94</c:v>
                </c:pt>
                <c:pt idx="15">
                  <c:v>34.89</c:v>
                </c:pt>
                <c:pt idx="16">
                  <c:v>40.39</c:v>
                </c:pt>
                <c:pt idx="17">
                  <c:v>54.519999999999996</c:v>
                </c:pt>
                <c:pt idx="18">
                  <c:v>50.68</c:v>
                </c:pt>
                <c:pt idx="19">
                  <c:v>50.69</c:v>
                </c:pt>
                <c:pt idx="20">
                  <c:v>44.750000000000007</c:v>
                </c:pt>
                <c:pt idx="21">
                  <c:v>37.379999999999995</c:v>
                </c:pt>
                <c:pt idx="22">
                  <c:v>37.71</c:v>
                </c:pt>
                <c:pt idx="23">
                  <c:v>44.15</c:v>
                </c:pt>
                <c:pt idx="24">
                  <c:v>40.11</c:v>
                </c:pt>
                <c:pt idx="25">
                  <c:v>45.94</c:v>
                </c:pt>
                <c:pt idx="26">
                  <c:v>37.96</c:v>
                </c:pt>
                <c:pt idx="27">
                  <c:v>45.13</c:v>
                </c:pt>
                <c:pt idx="28">
                  <c:v>43.96</c:v>
                </c:pt>
                <c:pt idx="29">
                  <c:v>37.15</c:v>
                </c:pt>
                <c:pt idx="30">
                  <c:v>49.789999999999992</c:v>
                </c:pt>
                <c:pt idx="31">
                  <c:v>40.81</c:v>
                </c:pt>
                <c:pt idx="32">
                  <c:v>38.480000000000004</c:v>
                </c:pt>
                <c:pt idx="33">
                  <c:v>38.429999999999993</c:v>
                </c:pt>
                <c:pt idx="34">
                  <c:v>48.56</c:v>
                </c:pt>
                <c:pt idx="35">
                  <c:v>37.269999999999996</c:v>
                </c:pt>
                <c:pt idx="36">
                  <c:v>46.36</c:v>
                </c:pt>
                <c:pt idx="37">
                  <c:v>35.279999999999994</c:v>
                </c:pt>
                <c:pt idx="38">
                  <c:v>49.730000000000004</c:v>
                </c:pt>
                <c:pt idx="39">
                  <c:v>42.66</c:v>
                </c:pt>
                <c:pt idx="40">
                  <c:v>48.239999999999995</c:v>
                </c:pt>
                <c:pt idx="41">
                  <c:v>40.910000000000004</c:v>
                </c:pt>
                <c:pt idx="42">
                  <c:v>32.120000000000005</c:v>
                </c:pt>
                <c:pt idx="43">
                  <c:v>40.159999999999997</c:v>
                </c:pt>
                <c:pt idx="44">
                  <c:v>43.199999999999996</c:v>
                </c:pt>
                <c:pt idx="45">
                  <c:v>37.799999999999997</c:v>
                </c:pt>
                <c:pt idx="46">
                  <c:v>52.1</c:v>
                </c:pt>
                <c:pt idx="47">
                  <c:v>37.659999999999997</c:v>
                </c:pt>
                <c:pt idx="48">
                  <c:v>41.309999999999995</c:v>
                </c:pt>
                <c:pt idx="49">
                  <c:v>43.33</c:v>
                </c:pt>
                <c:pt idx="50">
                  <c:v>38.01</c:v>
                </c:pt>
                <c:pt idx="51">
                  <c:v>43.730000000000004</c:v>
                </c:pt>
                <c:pt idx="52">
                  <c:v>40.58</c:v>
                </c:pt>
                <c:pt idx="53">
                  <c:v>47.73</c:v>
                </c:pt>
                <c:pt idx="54">
                  <c:v>46.41</c:v>
                </c:pt>
                <c:pt idx="55">
                  <c:v>46.92</c:v>
                </c:pt>
                <c:pt idx="56">
                  <c:v>35.250000000000007</c:v>
                </c:pt>
                <c:pt idx="57">
                  <c:v>42.5</c:v>
                </c:pt>
                <c:pt idx="58">
                  <c:v>44.17</c:v>
                </c:pt>
                <c:pt idx="59">
                  <c:v>33</c:v>
                </c:pt>
                <c:pt idx="60">
                  <c:v>39.730000000000004</c:v>
                </c:pt>
                <c:pt idx="61">
                  <c:v>39.750000000000007</c:v>
                </c:pt>
                <c:pt idx="62">
                  <c:v>31.880000000000003</c:v>
                </c:pt>
                <c:pt idx="63">
                  <c:v>51.489999999999995</c:v>
                </c:pt>
                <c:pt idx="64">
                  <c:v>40.730000000000004</c:v>
                </c:pt>
                <c:pt idx="65">
                  <c:v>54.879999999999995</c:v>
                </c:pt>
                <c:pt idx="66">
                  <c:v>43.06</c:v>
                </c:pt>
                <c:pt idx="67">
                  <c:v>42.559999999999995</c:v>
                </c:pt>
                <c:pt idx="68">
                  <c:v>51.760000000000005</c:v>
                </c:pt>
                <c:pt idx="69">
                  <c:v>41.35</c:v>
                </c:pt>
                <c:pt idx="70">
                  <c:v>46.05</c:v>
                </c:pt>
                <c:pt idx="71">
                  <c:v>45.69</c:v>
                </c:pt>
                <c:pt idx="72">
                  <c:v>43.379999999999995</c:v>
                </c:pt>
                <c:pt idx="73">
                  <c:v>38.14</c:v>
                </c:pt>
                <c:pt idx="74">
                  <c:v>42.67</c:v>
                </c:pt>
                <c:pt idx="75">
                  <c:v>44.8</c:v>
                </c:pt>
                <c:pt idx="76">
                  <c:v>45.589999999999996</c:v>
                </c:pt>
                <c:pt idx="77">
                  <c:v>36.44</c:v>
                </c:pt>
                <c:pt idx="78">
                  <c:v>46.27</c:v>
                </c:pt>
                <c:pt idx="79">
                  <c:v>46.239999999999995</c:v>
                </c:pt>
                <c:pt idx="80">
                  <c:v>39.370000000000005</c:v>
                </c:pt>
                <c:pt idx="81">
                  <c:v>54.820000000000007</c:v>
                </c:pt>
                <c:pt idx="82">
                  <c:v>33.79</c:v>
                </c:pt>
                <c:pt idx="83">
                  <c:v>45.22</c:v>
                </c:pt>
                <c:pt idx="84">
                  <c:v>47.540000000000006</c:v>
                </c:pt>
                <c:pt idx="85">
                  <c:v>36.79</c:v>
                </c:pt>
                <c:pt idx="86">
                  <c:v>45.18</c:v>
                </c:pt>
                <c:pt idx="87">
                  <c:v>38.019999999999996</c:v>
                </c:pt>
                <c:pt idx="88">
                  <c:v>38.160000000000004</c:v>
                </c:pt>
                <c:pt idx="89">
                  <c:v>52.279999999999994</c:v>
                </c:pt>
                <c:pt idx="90">
                  <c:v>46.279999999999994</c:v>
                </c:pt>
                <c:pt idx="91">
                  <c:v>42.75</c:v>
                </c:pt>
                <c:pt idx="92">
                  <c:v>45.19</c:v>
                </c:pt>
                <c:pt idx="93">
                  <c:v>44.83</c:v>
                </c:pt>
                <c:pt idx="94">
                  <c:v>47.730000000000004</c:v>
                </c:pt>
                <c:pt idx="95">
                  <c:v>44.11</c:v>
                </c:pt>
                <c:pt idx="96">
                  <c:v>29.910000000000004</c:v>
                </c:pt>
                <c:pt idx="97">
                  <c:v>39.39</c:v>
                </c:pt>
                <c:pt idx="98">
                  <c:v>36.4</c:v>
                </c:pt>
                <c:pt idx="99">
                  <c:v>47.150000000000006</c:v>
                </c:pt>
                <c:pt idx="100">
                  <c:v>46.739999999999995</c:v>
                </c:pt>
                <c:pt idx="101">
                  <c:v>41.739999999999995</c:v>
                </c:pt>
                <c:pt idx="102">
                  <c:v>39.120000000000005</c:v>
                </c:pt>
                <c:pt idx="103">
                  <c:v>36.510000000000005</c:v>
                </c:pt>
                <c:pt idx="104">
                  <c:v>47.790000000000006</c:v>
                </c:pt>
                <c:pt idx="105">
                  <c:v>31.5</c:v>
                </c:pt>
                <c:pt idx="106">
                  <c:v>41.41</c:v>
                </c:pt>
                <c:pt idx="107">
                  <c:v>46.599999999999994</c:v>
                </c:pt>
                <c:pt idx="108">
                  <c:v>47.3</c:v>
                </c:pt>
                <c:pt idx="109">
                  <c:v>39.28</c:v>
                </c:pt>
                <c:pt idx="110">
                  <c:v>34.779999999999994</c:v>
                </c:pt>
                <c:pt idx="111">
                  <c:v>40.56</c:v>
                </c:pt>
                <c:pt idx="112">
                  <c:v>36.88000000000001</c:v>
                </c:pt>
                <c:pt idx="113">
                  <c:v>36.11</c:v>
                </c:pt>
                <c:pt idx="114">
                  <c:v>35.479999999999997</c:v>
                </c:pt>
                <c:pt idx="115">
                  <c:v>45.71</c:v>
                </c:pt>
                <c:pt idx="116">
                  <c:v>33.760000000000005</c:v>
                </c:pt>
                <c:pt idx="117">
                  <c:v>38.200000000000003</c:v>
                </c:pt>
                <c:pt idx="118">
                  <c:v>40.64</c:v>
                </c:pt>
                <c:pt idx="119">
                  <c:v>48.320000000000007</c:v>
                </c:pt>
                <c:pt idx="120">
                  <c:v>43.3</c:v>
                </c:pt>
                <c:pt idx="121">
                  <c:v>34.78</c:v>
                </c:pt>
                <c:pt idx="122">
                  <c:v>44.690000000000005</c:v>
                </c:pt>
                <c:pt idx="123">
                  <c:v>41.4</c:v>
                </c:pt>
                <c:pt idx="124">
                  <c:v>35.86</c:v>
                </c:pt>
                <c:pt idx="125">
                  <c:v>36.799999999999997</c:v>
                </c:pt>
                <c:pt idx="126">
                  <c:v>43.570000000000007</c:v>
                </c:pt>
                <c:pt idx="127">
                  <c:v>35.78</c:v>
                </c:pt>
                <c:pt idx="128">
                  <c:v>49.629999999999995</c:v>
                </c:pt>
                <c:pt idx="129">
                  <c:v>36.75</c:v>
                </c:pt>
                <c:pt idx="130">
                  <c:v>36.92</c:v>
                </c:pt>
                <c:pt idx="131">
                  <c:v>35.18</c:v>
                </c:pt>
                <c:pt idx="132">
                  <c:v>45.53</c:v>
                </c:pt>
                <c:pt idx="133">
                  <c:v>43.69</c:v>
                </c:pt>
                <c:pt idx="134">
                  <c:v>40.700000000000003</c:v>
                </c:pt>
                <c:pt idx="135">
                  <c:v>37.15</c:v>
                </c:pt>
                <c:pt idx="136">
                  <c:v>35.350000000000009</c:v>
                </c:pt>
                <c:pt idx="137">
                  <c:v>37.819999999999993</c:v>
                </c:pt>
                <c:pt idx="138">
                  <c:v>34.17</c:v>
                </c:pt>
                <c:pt idx="139">
                  <c:v>36.339999999999996</c:v>
                </c:pt>
                <c:pt idx="140">
                  <c:v>43.04</c:v>
                </c:pt>
                <c:pt idx="141">
                  <c:v>42.879999999999995</c:v>
                </c:pt>
                <c:pt idx="142">
                  <c:v>35.459999999999994</c:v>
                </c:pt>
                <c:pt idx="143">
                  <c:v>32.790000000000006</c:v>
                </c:pt>
                <c:pt idx="144">
                  <c:v>42.7</c:v>
                </c:pt>
                <c:pt idx="145">
                  <c:v>48.09</c:v>
                </c:pt>
                <c:pt idx="146">
                  <c:v>41.64</c:v>
                </c:pt>
                <c:pt idx="147">
                  <c:v>44.489999999999995</c:v>
                </c:pt>
                <c:pt idx="148">
                  <c:v>36.340000000000003</c:v>
                </c:pt>
                <c:pt idx="149">
                  <c:v>38.81</c:v>
                </c:pt>
                <c:pt idx="150">
                  <c:v>44.65</c:v>
                </c:pt>
                <c:pt idx="151">
                  <c:v>40.449999999999996</c:v>
                </c:pt>
                <c:pt idx="152">
                  <c:v>38.489999999999995</c:v>
                </c:pt>
                <c:pt idx="153">
                  <c:v>37.479999999999997</c:v>
                </c:pt>
                <c:pt idx="154">
                  <c:v>34.29</c:v>
                </c:pt>
                <c:pt idx="155">
                  <c:v>37.660000000000004</c:v>
                </c:pt>
                <c:pt idx="156">
                  <c:v>44.769999999999996</c:v>
                </c:pt>
                <c:pt idx="157">
                  <c:v>35.739999999999995</c:v>
                </c:pt>
                <c:pt idx="158">
                  <c:v>44.489999999999995</c:v>
                </c:pt>
                <c:pt idx="159">
                  <c:v>48.49</c:v>
                </c:pt>
                <c:pt idx="160">
                  <c:v>33.799999999999997</c:v>
                </c:pt>
                <c:pt idx="161">
                  <c:v>42.280000000000008</c:v>
                </c:pt>
                <c:pt idx="162">
                  <c:v>39.979999999999997</c:v>
                </c:pt>
                <c:pt idx="163">
                  <c:v>41.81</c:v>
                </c:pt>
                <c:pt idx="164">
                  <c:v>38.589999999999996</c:v>
                </c:pt>
                <c:pt idx="165">
                  <c:v>48.62</c:v>
                </c:pt>
                <c:pt idx="166">
                  <c:v>38.019999999999996</c:v>
                </c:pt>
                <c:pt idx="167">
                  <c:v>35.809999999999995</c:v>
                </c:pt>
                <c:pt idx="168">
                  <c:v>50.879999999999995</c:v>
                </c:pt>
                <c:pt idx="169">
                  <c:v>37.280000000000008</c:v>
                </c:pt>
                <c:pt idx="170">
                  <c:v>44.46</c:v>
                </c:pt>
                <c:pt idx="171">
                  <c:v>31.76</c:v>
                </c:pt>
                <c:pt idx="172">
                  <c:v>34.049999999999997</c:v>
                </c:pt>
                <c:pt idx="173">
                  <c:v>41.010000000000005</c:v>
                </c:pt>
                <c:pt idx="174">
                  <c:v>32.15</c:v>
                </c:pt>
                <c:pt idx="175">
                  <c:v>35.950000000000003</c:v>
                </c:pt>
                <c:pt idx="176">
                  <c:v>45.74</c:v>
                </c:pt>
                <c:pt idx="177">
                  <c:v>43.480000000000004</c:v>
                </c:pt>
                <c:pt idx="178">
                  <c:v>35.989999999999995</c:v>
                </c:pt>
                <c:pt idx="179">
                  <c:v>45.69</c:v>
                </c:pt>
                <c:pt idx="180">
                  <c:v>48.529999999999994</c:v>
                </c:pt>
                <c:pt idx="181">
                  <c:v>43.839999999999996</c:v>
                </c:pt>
                <c:pt idx="182">
                  <c:v>41.06</c:v>
                </c:pt>
                <c:pt idx="183">
                  <c:v>39.36</c:v>
                </c:pt>
                <c:pt idx="184">
                  <c:v>39.61</c:v>
                </c:pt>
                <c:pt idx="185">
                  <c:v>40.179999999999993</c:v>
                </c:pt>
                <c:pt idx="186">
                  <c:v>31.639999999999997</c:v>
                </c:pt>
                <c:pt idx="187">
                  <c:v>44.75</c:v>
                </c:pt>
                <c:pt idx="188">
                  <c:v>41.32</c:v>
                </c:pt>
                <c:pt idx="189">
                  <c:v>40.4</c:v>
                </c:pt>
                <c:pt idx="190">
                  <c:v>42.7</c:v>
                </c:pt>
                <c:pt idx="191">
                  <c:v>31.839999999999996</c:v>
                </c:pt>
                <c:pt idx="192">
                  <c:v>34.81</c:v>
                </c:pt>
                <c:pt idx="193">
                  <c:v>44.499999999999993</c:v>
                </c:pt>
                <c:pt idx="194">
                  <c:v>46.15</c:v>
                </c:pt>
                <c:pt idx="195">
                  <c:v>38.769999999999996</c:v>
                </c:pt>
                <c:pt idx="196">
                  <c:v>40.489999999999995</c:v>
                </c:pt>
                <c:pt idx="197">
                  <c:v>41.4</c:v>
                </c:pt>
                <c:pt idx="198">
                  <c:v>43.029999999999994</c:v>
                </c:pt>
                <c:pt idx="199">
                  <c:v>36.870000000000005</c:v>
                </c:pt>
                <c:pt idx="200">
                  <c:v>44.23</c:v>
                </c:pt>
                <c:pt idx="201">
                  <c:v>34.4</c:v>
                </c:pt>
                <c:pt idx="202">
                  <c:v>45.5</c:v>
                </c:pt>
                <c:pt idx="203">
                  <c:v>45.4</c:v>
                </c:pt>
                <c:pt idx="204">
                  <c:v>45.89</c:v>
                </c:pt>
                <c:pt idx="205">
                  <c:v>42.26</c:v>
                </c:pt>
                <c:pt idx="206">
                  <c:v>37.42</c:v>
                </c:pt>
                <c:pt idx="207">
                  <c:v>37.320000000000007</c:v>
                </c:pt>
                <c:pt idx="208">
                  <c:v>44.31</c:v>
                </c:pt>
                <c:pt idx="209">
                  <c:v>46.769999999999996</c:v>
                </c:pt>
                <c:pt idx="210">
                  <c:v>45.160000000000004</c:v>
                </c:pt>
                <c:pt idx="211">
                  <c:v>39.31</c:v>
                </c:pt>
                <c:pt idx="212">
                  <c:v>29.220000000000006</c:v>
                </c:pt>
                <c:pt idx="213">
                  <c:v>40.14</c:v>
                </c:pt>
                <c:pt idx="214">
                  <c:v>42.55</c:v>
                </c:pt>
              </c:numCache>
            </c:numRef>
          </c:xVal>
          <c:yVal>
            <c:numRef>
              <c:f>Feuil1!$G$2:$G$249</c:f>
              <c:numCache>
                <c:formatCode>0.0%</c:formatCode>
                <c:ptCount val="248"/>
                <c:pt idx="0">
                  <c:v>0.29339676033982698</c:v>
                </c:pt>
                <c:pt idx="1">
                  <c:v>0.39723878785748967</c:v>
                </c:pt>
                <c:pt idx="2">
                  <c:v>0.36255380553315997</c:v>
                </c:pt>
                <c:pt idx="3">
                  <c:v>0.46448389904789733</c:v>
                </c:pt>
                <c:pt idx="4">
                  <c:v>0.31281501635129538</c:v>
                </c:pt>
                <c:pt idx="5">
                  <c:v>0.42424151632841822</c:v>
                </c:pt>
                <c:pt idx="6">
                  <c:v>0.34417764697752995</c:v>
                </c:pt>
                <c:pt idx="7">
                  <c:v>0.43769226285779206</c:v>
                </c:pt>
                <c:pt idx="8">
                  <c:v>0.39976623755919344</c:v>
                </c:pt>
                <c:pt idx="9">
                  <c:v>0.47700518439414452</c:v>
                </c:pt>
                <c:pt idx="10">
                  <c:v>0.32791990184941694</c:v>
                </c:pt>
                <c:pt idx="11">
                  <c:v>0.41683911096775006</c:v>
                </c:pt>
                <c:pt idx="12">
                  <c:v>0.39713068185506628</c:v>
                </c:pt>
                <c:pt idx="13">
                  <c:v>0.42447150384071308</c:v>
                </c:pt>
                <c:pt idx="14">
                  <c:v>0.4312840692330675</c:v>
                </c:pt>
                <c:pt idx="15">
                  <c:v>0.43729643474272234</c:v>
                </c:pt>
                <c:pt idx="16">
                  <c:v>0.37889937242165972</c:v>
                </c:pt>
                <c:pt idx="17">
                  <c:v>0.34742399265413282</c:v>
                </c:pt>
                <c:pt idx="18">
                  <c:v>0.34781866626849167</c:v>
                </c:pt>
                <c:pt idx="19">
                  <c:v>0.36943197922951321</c:v>
                </c:pt>
                <c:pt idx="20">
                  <c:v>0.42964834026324183</c:v>
                </c:pt>
                <c:pt idx="21">
                  <c:v>0.39336187983489024</c:v>
                </c:pt>
                <c:pt idx="22">
                  <c:v>0.35791853863414136</c:v>
                </c:pt>
                <c:pt idx="23">
                  <c:v>0.37320403165583638</c:v>
                </c:pt>
                <c:pt idx="24">
                  <c:v>0.28951701862695312</c:v>
                </c:pt>
                <c:pt idx="25">
                  <c:v>0.35783158285232231</c:v>
                </c:pt>
                <c:pt idx="26">
                  <c:v>0.48741407019551125</c:v>
                </c:pt>
                <c:pt idx="27">
                  <c:v>0.4166515282506042</c:v>
                </c:pt>
                <c:pt idx="28">
                  <c:v>0.38443674479421525</c:v>
                </c:pt>
                <c:pt idx="29">
                  <c:v>0.42746971239213305</c:v>
                </c:pt>
                <c:pt idx="30">
                  <c:v>0.34999438274266326</c:v>
                </c:pt>
                <c:pt idx="31">
                  <c:v>0.41179605780168105</c:v>
                </c:pt>
                <c:pt idx="32">
                  <c:v>0.30997987062572335</c:v>
                </c:pt>
                <c:pt idx="33">
                  <c:v>0.44477294513162591</c:v>
                </c:pt>
                <c:pt idx="34">
                  <c:v>0.41741317156063873</c:v>
                </c:pt>
                <c:pt idx="35">
                  <c:v>0.50482017656230338</c:v>
                </c:pt>
                <c:pt idx="36">
                  <c:v>0.45402228563139913</c:v>
                </c:pt>
                <c:pt idx="37">
                  <c:v>0.45413141583215089</c:v>
                </c:pt>
                <c:pt idx="38">
                  <c:v>0.28905852256554676</c:v>
                </c:pt>
                <c:pt idx="39">
                  <c:v>0.24954294188758458</c:v>
                </c:pt>
                <c:pt idx="40">
                  <c:v>0.35961026922363537</c:v>
                </c:pt>
                <c:pt idx="41">
                  <c:v>0.46874344264181655</c:v>
                </c:pt>
                <c:pt idx="42">
                  <c:v>0.57711933501027457</c:v>
                </c:pt>
                <c:pt idx="43">
                  <c:v>0.35642623797611661</c:v>
                </c:pt>
                <c:pt idx="44">
                  <c:v>0.3396127515846894</c:v>
                </c:pt>
                <c:pt idx="45">
                  <c:v>0.51646210132100945</c:v>
                </c:pt>
                <c:pt idx="46">
                  <c:v>0.16914590843633273</c:v>
                </c:pt>
                <c:pt idx="47">
                  <c:v>0.4300421182225822</c:v>
                </c:pt>
                <c:pt idx="48">
                  <c:v>0.44087028383581439</c:v>
                </c:pt>
                <c:pt idx="49">
                  <c:v>0.42721206450042892</c:v>
                </c:pt>
                <c:pt idx="50">
                  <c:v>0.49478989143996854</c:v>
                </c:pt>
                <c:pt idx="51">
                  <c:v>0.39736379307718295</c:v>
                </c:pt>
                <c:pt idx="52">
                  <c:v>0.42738216491364955</c:v>
                </c:pt>
                <c:pt idx="53">
                  <c:v>0.39603311525732937</c:v>
                </c:pt>
                <c:pt idx="54">
                  <c:v>0.37107258531665011</c:v>
                </c:pt>
                <c:pt idx="55">
                  <c:v>0.36689008785285282</c:v>
                </c:pt>
                <c:pt idx="56">
                  <c:v>0.30812032482201374</c:v>
                </c:pt>
                <c:pt idx="57">
                  <c:v>0.33090120796377825</c:v>
                </c:pt>
                <c:pt idx="58">
                  <c:v>0.39597725935471229</c:v>
                </c:pt>
                <c:pt idx="59">
                  <c:v>0.37372979636874454</c:v>
                </c:pt>
                <c:pt idx="60">
                  <c:v>0.46071635849337456</c:v>
                </c:pt>
                <c:pt idx="61">
                  <c:v>0.42405720672184205</c:v>
                </c:pt>
                <c:pt idx="62">
                  <c:v>0.56480557675550036</c:v>
                </c:pt>
                <c:pt idx="63">
                  <c:v>0.29060874832319994</c:v>
                </c:pt>
                <c:pt idx="64">
                  <c:v>0.33513397777587151</c:v>
                </c:pt>
                <c:pt idx="65">
                  <c:v>0.33693940743504813</c:v>
                </c:pt>
                <c:pt idx="66">
                  <c:v>0.28292540622531187</c:v>
                </c:pt>
                <c:pt idx="67">
                  <c:v>0.48514539037355497</c:v>
                </c:pt>
                <c:pt idx="68">
                  <c:v>0.31684290363020184</c:v>
                </c:pt>
                <c:pt idx="69">
                  <c:v>0.36533779178828685</c:v>
                </c:pt>
                <c:pt idx="70">
                  <c:v>0.3454353961028348</c:v>
                </c:pt>
                <c:pt idx="71">
                  <c:v>0.39929330719573786</c:v>
                </c:pt>
                <c:pt idx="72">
                  <c:v>0.40151248114692528</c:v>
                </c:pt>
                <c:pt idx="73">
                  <c:v>0.3279088991897855</c:v>
                </c:pt>
                <c:pt idx="74">
                  <c:v>0.31500434123424048</c:v>
                </c:pt>
                <c:pt idx="75">
                  <c:v>0.20414415603779265</c:v>
                </c:pt>
                <c:pt idx="76">
                  <c:v>0.37125749462057728</c:v>
                </c:pt>
                <c:pt idx="77">
                  <c:v>0.36822047326442769</c:v>
                </c:pt>
                <c:pt idx="78">
                  <c:v>0.36464257527663724</c:v>
                </c:pt>
                <c:pt idx="79">
                  <c:v>0.39599114526468571</c:v>
                </c:pt>
                <c:pt idx="80">
                  <c:v>0.40372037733579769</c:v>
                </c:pt>
                <c:pt idx="81">
                  <c:v>0.3197697486449928</c:v>
                </c:pt>
                <c:pt idx="82">
                  <c:v>0.53093507708842869</c:v>
                </c:pt>
                <c:pt idx="83">
                  <c:v>0.44960367533050649</c:v>
                </c:pt>
                <c:pt idx="84">
                  <c:v>0.36812481441527345</c:v>
                </c:pt>
                <c:pt idx="85">
                  <c:v>0.31970082389970395</c:v>
                </c:pt>
                <c:pt idx="86">
                  <c:v>0.3230656907650119</c:v>
                </c:pt>
                <c:pt idx="87">
                  <c:v>0.42874845616566787</c:v>
                </c:pt>
                <c:pt idx="88">
                  <c:v>0.3978981206600164</c:v>
                </c:pt>
                <c:pt idx="89">
                  <c:v>0.35958115494412196</c:v>
                </c:pt>
                <c:pt idx="90">
                  <c:v>0.33982879406337946</c:v>
                </c:pt>
                <c:pt idx="91">
                  <c:v>0.37216190121022252</c:v>
                </c:pt>
                <c:pt idx="92">
                  <c:v>0.39511823948182989</c:v>
                </c:pt>
                <c:pt idx="93">
                  <c:v>0.3934344294644575</c:v>
                </c:pt>
                <c:pt idx="94">
                  <c:v>0.391873416603637</c:v>
                </c:pt>
                <c:pt idx="95">
                  <c:v>0.39612113207872446</c:v>
                </c:pt>
                <c:pt idx="96">
                  <c:v>0.59656971665269665</c:v>
                </c:pt>
                <c:pt idx="97">
                  <c:v>0.45214088327420471</c:v>
                </c:pt>
                <c:pt idx="98">
                  <c:v>0.48425223665919648</c:v>
                </c:pt>
                <c:pt idx="99">
                  <c:v>0.40445884690260125</c:v>
                </c:pt>
                <c:pt idx="100">
                  <c:v>0.43912034038786779</c:v>
                </c:pt>
                <c:pt idx="101">
                  <c:v>0.45441369266041826</c:v>
                </c:pt>
                <c:pt idx="102">
                  <c:v>0.38077450985667027</c:v>
                </c:pt>
                <c:pt idx="103">
                  <c:v>0.39867287331916829</c:v>
                </c:pt>
                <c:pt idx="104">
                  <c:v>0.36128634160620116</c:v>
                </c:pt>
                <c:pt idx="105">
                  <c:v>0.46464651977841137</c:v>
                </c:pt>
                <c:pt idx="106">
                  <c:v>0.43039797624941867</c:v>
                </c:pt>
                <c:pt idx="107">
                  <c:v>0.35750697744940096</c:v>
                </c:pt>
                <c:pt idx="108">
                  <c:v>0.37955092206580882</c:v>
                </c:pt>
                <c:pt idx="109">
                  <c:v>0.41824987386759016</c:v>
                </c:pt>
                <c:pt idx="110">
                  <c:v>0.43787572190180979</c:v>
                </c:pt>
                <c:pt idx="111">
                  <c:v>0.44630232881224891</c:v>
                </c:pt>
                <c:pt idx="112">
                  <c:v>0.38362582484196661</c:v>
                </c:pt>
                <c:pt idx="113">
                  <c:v>0.47156421277729288</c:v>
                </c:pt>
                <c:pt idx="114">
                  <c:v>0.37053059788502135</c:v>
                </c:pt>
                <c:pt idx="115">
                  <c:v>0.40162472560704449</c:v>
                </c:pt>
                <c:pt idx="116">
                  <c:v>0.4994301581836883</c:v>
                </c:pt>
                <c:pt idx="117">
                  <c:v>0.40194162781011666</c:v>
                </c:pt>
                <c:pt idx="118">
                  <c:v>0.44803175051975402</c:v>
                </c:pt>
                <c:pt idx="119">
                  <c:v>0.40446607742574325</c:v>
                </c:pt>
                <c:pt idx="120">
                  <c:v>0.39088664783840033</c:v>
                </c:pt>
                <c:pt idx="121">
                  <c:v>0.52638058236668983</c:v>
                </c:pt>
                <c:pt idx="122">
                  <c:v>0.45481614717348834</c:v>
                </c:pt>
                <c:pt idx="123">
                  <c:v>0.41208307605089739</c:v>
                </c:pt>
                <c:pt idx="124">
                  <c:v>0.50106287271969385</c:v>
                </c:pt>
                <c:pt idx="125">
                  <c:v>0.46165152080068833</c:v>
                </c:pt>
                <c:pt idx="126">
                  <c:v>0.45108309319847989</c:v>
                </c:pt>
                <c:pt idx="127">
                  <c:v>0.43930875223477839</c:v>
                </c:pt>
                <c:pt idx="128">
                  <c:v>0.41306417800467277</c:v>
                </c:pt>
                <c:pt idx="129">
                  <c:v>0.50181073108273955</c:v>
                </c:pt>
                <c:pt idx="130">
                  <c:v>0.5049273184099945</c:v>
                </c:pt>
                <c:pt idx="131">
                  <c:v>0.49021412399101222</c:v>
                </c:pt>
                <c:pt idx="132">
                  <c:v>0.40255237714285086</c:v>
                </c:pt>
                <c:pt idx="133">
                  <c:v>0.40379789756131973</c:v>
                </c:pt>
                <c:pt idx="134">
                  <c:v>0.449555160452492</c:v>
                </c:pt>
                <c:pt idx="135">
                  <c:v>0.48131099194141258</c:v>
                </c:pt>
                <c:pt idx="136">
                  <c:v>0.52924066293372873</c:v>
                </c:pt>
                <c:pt idx="137">
                  <c:v>0.42858320807842387</c:v>
                </c:pt>
                <c:pt idx="138">
                  <c:v>0.43133796794794765</c:v>
                </c:pt>
                <c:pt idx="139">
                  <c:v>0.48551234084771577</c:v>
                </c:pt>
                <c:pt idx="140">
                  <c:v>0.43125436711479448</c:v>
                </c:pt>
                <c:pt idx="141">
                  <c:v>0.42841917519497585</c:v>
                </c:pt>
                <c:pt idx="142">
                  <c:v>0.45867265509668709</c:v>
                </c:pt>
                <c:pt idx="143">
                  <c:v>0.56271263827638462</c:v>
                </c:pt>
                <c:pt idx="144">
                  <c:v>0.38655089744686277</c:v>
                </c:pt>
                <c:pt idx="145">
                  <c:v>0.44568869418074009</c:v>
                </c:pt>
                <c:pt idx="146">
                  <c:v>0.38255186957136439</c:v>
                </c:pt>
                <c:pt idx="147">
                  <c:v>0.35230991928745514</c:v>
                </c:pt>
                <c:pt idx="148">
                  <c:v>0.35201029919720062</c:v>
                </c:pt>
                <c:pt idx="149">
                  <c:v>0.52276037941647135</c:v>
                </c:pt>
                <c:pt idx="150">
                  <c:v>0.42986402734005569</c:v>
                </c:pt>
                <c:pt idx="151">
                  <c:v>0.39542306884084877</c:v>
                </c:pt>
                <c:pt idx="152">
                  <c:v>0.38725662500584035</c:v>
                </c:pt>
                <c:pt idx="153">
                  <c:v>0.3923457306415421</c:v>
                </c:pt>
                <c:pt idx="154">
                  <c:v>0.48727251070499233</c:v>
                </c:pt>
                <c:pt idx="155">
                  <c:v>0.44415632013689449</c:v>
                </c:pt>
                <c:pt idx="156">
                  <c:v>0.40386338054323917</c:v>
                </c:pt>
                <c:pt idx="157">
                  <c:v>0.43982900565907601</c:v>
                </c:pt>
                <c:pt idx="158">
                  <c:v>0.40928392275025294</c:v>
                </c:pt>
                <c:pt idx="159">
                  <c:v>0.37810423251642078</c:v>
                </c:pt>
                <c:pt idx="160">
                  <c:v>0.4003606420652136</c:v>
                </c:pt>
                <c:pt idx="161">
                  <c:v>0.40350693377934765</c:v>
                </c:pt>
                <c:pt idx="162">
                  <c:v>0.42142565079150385</c:v>
                </c:pt>
                <c:pt idx="163">
                  <c:v>0.44912888520940841</c:v>
                </c:pt>
                <c:pt idx="164">
                  <c:v>0.35085688476352317</c:v>
                </c:pt>
                <c:pt idx="165">
                  <c:v>0.23768216622434757</c:v>
                </c:pt>
                <c:pt idx="166">
                  <c:v>0.39411174676282312</c:v>
                </c:pt>
                <c:pt idx="167">
                  <c:v>0.39658964078143921</c:v>
                </c:pt>
                <c:pt idx="168">
                  <c:v>0.34873356305262321</c:v>
                </c:pt>
                <c:pt idx="169">
                  <c:v>0.38222571419136964</c:v>
                </c:pt>
                <c:pt idx="170">
                  <c:v>0.4023792064995762</c:v>
                </c:pt>
                <c:pt idx="171">
                  <c:v>0.41955785172168608</c:v>
                </c:pt>
                <c:pt idx="172">
                  <c:v>0.44401526969091665</c:v>
                </c:pt>
                <c:pt idx="173">
                  <c:v>0.47116021352495174</c:v>
                </c:pt>
                <c:pt idx="174">
                  <c:v>0.30815561088998028</c:v>
                </c:pt>
                <c:pt idx="175">
                  <c:v>0.49968561762476327</c:v>
                </c:pt>
                <c:pt idx="176">
                  <c:v>0.37646554666090709</c:v>
                </c:pt>
                <c:pt idx="177">
                  <c:v>0.3210207722046502</c:v>
                </c:pt>
                <c:pt idx="178">
                  <c:v>0.55881003426978215</c:v>
                </c:pt>
                <c:pt idx="179">
                  <c:v>0.39349421840688514</c:v>
                </c:pt>
                <c:pt idx="180">
                  <c:v>0.29867944153111176</c:v>
                </c:pt>
                <c:pt idx="181">
                  <c:v>0.41134881706443593</c:v>
                </c:pt>
                <c:pt idx="182">
                  <c:v>0.31861170870156047</c:v>
                </c:pt>
                <c:pt idx="183">
                  <c:v>0.38693155432044068</c:v>
                </c:pt>
                <c:pt idx="184">
                  <c:v>0.27462962128726109</c:v>
                </c:pt>
                <c:pt idx="185">
                  <c:v>0.4378932604009812</c:v>
                </c:pt>
                <c:pt idx="186">
                  <c:v>0.46352525532093036</c:v>
                </c:pt>
                <c:pt idx="187">
                  <c:v>0.41672891959834091</c:v>
                </c:pt>
                <c:pt idx="188">
                  <c:v>0.43670768337837879</c:v>
                </c:pt>
                <c:pt idx="189">
                  <c:v>0.4136907390296079</c:v>
                </c:pt>
                <c:pt idx="190">
                  <c:v>0.47967032709893154</c:v>
                </c:pt>
                <c:pt idx="191">
                  <c:v>0.36896900287427475</c:v>
                </c:pt>
                <c:pt idx="192">
                  <c:v>0.52191823109670066</c:v>
                </c:pt>
                <c:pt idx="193">
                  <c:v>0.45290906530531638</c:v>
                </c:pt>
                <c:pt idx="194">
                  <c:v>0.32145272188083751</c:v>
                </c:pt>
                <c:pt idx="195">
                  <c:v>0.5083984688962323</c:v>
                </c:pt>
                <c:pt idx="196">
                  <c:v>0.42591608382295199</c:v>
                </c:pt>
                <c:pt idx="197">
                  <c:v>0.42262947181963495</c:v>
                </c:pt>
                <c:pt idx="198">
                  <c:v>0.44681534560846636</c:v>
                </c:pt>
                <c:pt idx="199">
                  <c:v>0.42077034728220514</c:v>
                </c:pt>
                <c:pt idx="200">
                  <c:v>0.46185100070436647</c:v>
                </c:pt>
                <c:pt idx="201">
                  <c:v>0.45286043067303189</c:v>
                </c:pt>
                <c:pt idx="202">
                  <c:v>0.31423555978484097</c:v>
                </c:pt>
                <c:pt idx="203">
                  <c:v>0.32884411078221554</c:v>
                </c:pt>
                <c:pt idx="204">
                  <c:v>0.44003173094560905</c:v>
                </c:pt>
                <c:pt idx="205">
                  <c:v>0.34238013811928403</c:v>
                </c:pt>
                <c:pt idx="206">
                  <c:v>0.37836573121381167</c:v>
                </c:pt>
                <c:pt idx="207">
                  <c:v>0.43633286524048465</c:v>
                </c:pt>
                <c:pt idx="208">
                  <c:v>0.46098085298143426</c:v>
                </c:pt>
                <c:pt idx="209">
                  <c:v>0.35973422554592915</c:v>
                </c:pt>
                <c:pt idx="210">
                  <c:v>0.28068160411515242</c:v>
                </c:pt>
                <c:pt idx="211">
                  <c:v>0.39636348130914473</c:v>
                </c:pt>
                <c:pt idx="212">
                  <c:v>0.42089839525174322</c:v>
                </c:pt>
                <c:pt idx="213">
                  <c:v>0.5101119965961326</c:v>
                </c:pt>
                <c:pt idx="214">
                  <c:v>0.430429738838028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F72-C549-A8B5-3B656EDB2A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81448"/>
        <c:axId val="534883408"/>
      </c:scatterChart>
      <c:valAx>
        <c:axId val="534881448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FF</a:t>
                </a:r>
                <a:r>
                  <a:rPr lang="fr-FR" baseline="-20000" dirty="0"/>
                  <a:t>T14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baseline="-20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3408"/>
        <c:crosses val="autoZero"/>
        <c:crossBetween val="midCat"/>
        <c:majorUnit val="20"/>
      </c:valAx>
      <c:valAx>
        <c:axId val="534883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 LossFF</a:t>
                </a:r>
                <a:r>
                  <a:rPr lang="fr-FR" baseline="-20000" dirty="0"/>
                  <a:t>T14</a:t>
                </a:r>
              </a:p>
            </c:rich>
          </c:tx>
          <c:layout>
            <c:manualLayout>
              <c:xMode val="edge"/>
              <c:yMode val="edge"/>
              <c:x val="4.5262912478337511E-2"/>
              <c:y val="0.377665818586894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14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19758264486639"/>
          <c:y val="5.7454860714118268E-2"/>
          <c:w val="0.68533440463787731"/>
          <c:h val="0.73187525890096283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2!$I$1</c:f>
              <c:strCache>
                <c:ptCount val="1"/>
                <c:pt idx="0">
                  <c:v>Loss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2!$G$2:$G$246</c:f>
              <c:numCache>
                <c:formatCode>0.0</c:formatCode>
                <c:ptCount val="245"/>
                <c:pt idx="0">
                  <c:v>64.2</c:v>
                </c:pt>
                <c:pt idx="1">
                  <c:v>75.599999999999994</c:v>
                </c:pt>
                <c:pt idx="2">
                  <c:v>78.099999999999994</c:v>
                </c:pt>
                <c:pt idx="3">
                  <c:v>71.5</c:v>
                </c:pt>
                <c:pt idx="4">
                  <c:v>84.1</c:v>
                </c:pt>
                <c:pt idx="5">
                  <c:v>71.5</c:v>
                </c:pt>
                <c:pt idx="6">
                  <c:v>66.2</c:v>
                </c:pt>
                <c:pt idx="7">
                  <c:v>74.7</c:v>
                </c:pt>
                <c:pt idx="8">
                  <c:v>60.4</c:v>
                </c:pt>
                <c:pt idx="9">
                  <c:v>71.599999999999994</c:v>
                </c:pt>
                <c:pt idx="10">
                  <c:v>69.5</c:v>
                </c:pt>
                <c:pt idx="11">
                  <c:v>69.7</c:v>
                </c:pt>
                <c:pt idx="12">
                  <c:v>57.3</c:v>
                </c:pt>
                <c:pt idx="13">
                  <c:v>67.599999999999994</c:v>
                </c:pt>
                <c:pt idx="14">
                  <c:v>65.3</c:v>
                </c:pt>
                <c:pt idx="15">
                  <c:v>63.9</c:v>
                </c:pt>
                <c:pt idx="16">
                  <c:v>65.400000000000006</c:v>
                </c:pt>
                <c:pt idx="17">
                  <c:v>83.9</c:v>
                </c:pt>
                <c:pt idx="18">
                  <c:v>77.8</c:v>
                </c:pt>
                <c:pt idx="19">
                  <c:v>80.5</c:v>
                </c:pt>
                <c:pt idx="20">
                  <c:v>79</c:v>
                </c:pt>
                <c:pt idx="21">
                  <c:v>61.7</c:v>
                </c:pt>
                <c:pt idx="22">
                  <c:v>59.9</c:v>
                </c:pt>
                <c:pt idx="23">
                  <c:v>70.599999999999994</c:v>
                </c:pt>
                <c:pt idx="24">
                  <c:v>57.2</c:v>
                </c:pt>
                <c:pt idx="25">
                  <c:v>72.5</c:v>
                </c:pt>
                <c:pt idx="26">
                  <c:v>74.2</c:v>
                </c:pt>
                <c:pt idx="27">
                  <c:v>77.599999999999994</c:v>
                </c:pt>
                <c:pt idx="28">
                  <c:v>73.3</c:v>
                </c:pt>
                <c:pt idx="29">
                  <c:v>65.3</c:v>
                </c:pt>
                <c:pt idx="30">
                  <c:v>77.3</c:v>
                </c:pt>
                <c:pt idx="31">
                  <c:v>69.3</c:v>
                </c:pt>
                <c:pt idx="32">
                  <c:v>56.1</c:v>
                </c:pt>
                <c:pt idx="33">
                  <c:v>69.3</c:v>
                </c:pt>
                <c:pt idx="34">
                  <c:v>83.7</c:v>
                </c:pt>
                <c:pt idx="35">
                  <c:v>75.8</c:v>
                </c:pt>
                <c:pt idx="36">
                  <c:v>85.3</c:v>
                </c:pt>
                <c:pt idx="37">
                  <c:v>65.2</c:v>
                </c:pt>
                <c:pt idx="38">
                  <c:v>71.5</c:v>
                </c:pt>
                <c:pt idx="39">
                  <c:v>56.9</c:v>
                </c:pt>
                <c:pt idx="40">
                  <c:v>76</c:v>
                </c:pt>
                <c:pt idx="41">
                  <c:v>77.2</c:v>
                </c:pt>
                <c:pt idx="42">
                  <c:v>76.7</c:v>
                </c:pt>
                <c:pt idx="43">
                  <c:v>63.9</c:v>
                </c:pt>
                <c:pt idx="44">
                  <c:v>67</c:v>
                </c:pt>
                <c:pt idx="45">
                  <c:v>78.7</c:v>
                </c:pt>
                <c:pt idx="46">
                  <c:v>63</c:v>
                </c:pt>
                <c:pt idx="47">
                  <c:v>66.900000000000006</c:v>
                </c:pt>
                <c:pt idx="48">
                  <c:v>74.599999999999994</c:v>
                </c:pt>
                <c:pt idx="49">
                  <c:v>75.7</c:v>
                </c:pt>
                <c:pt idx="50">
                  <c:v>75.400000000000006</c:v>
                </c:pt>
                <c:pt idx="51">
                  <c:v>73.2</c:v>
                </c:pt>
                <c:pt idx="52">
                  <c:v>71.599999999999994</c:v>
                </c:pt>
                <c:pt idx="53">
                  <c:v>79.5</c:v>
                </c:pt>
                <c:pt idx="54">
                  <c:v>73.7</c:v>
                </c:pt>
                <c:pt idx="55">
                  <c:v>74.7</c:v>
                </c:pt>
                <c:pt idx="56">
                  <c:v>51</c:v>
                </c:pt>
                <c:pt idx="57">
                  <c:v>64.099999999999994</c:v>
                </c:pt>
                <c:pt idx="58">
                  <c:v>73.400000000000006</c:v>
                </c:pt>
                <c:pt idx="59">
                  <c:v>52.8</c:v>
                </c:pt>
                <c:pt idx="60">
                  <c:v>74.900000000000006</c:v>
                </c:pt>
                <c:pt idx="61">
                  <c:v>70.099999999999994</c:v>
                </c:pt>
                <c:pt idx="62">
                  <c:v>72.5</c:v>
                </c:pt>
                <c:pt idx="63">
                  <c:v>72.599999999999994</c:v>
                </c:pt>
                <c:pt idx="64">
                  <c:v>62.3</c:v>
                </c:pt>
                <c:pt idx="65">
                  <c:v>83.1</c:v>
                </c:pt>
                <c:pt idx="66">
                  <c:v>61.5</c:v>
                </c:pt>
                <c:pt idx="67">
                  <c:v>82.4</c:v>
                </c:pt>
                <c:pt idx="68">
                  <c:v>75.900000000000006</c:v>
                </c:pt>
                <c:pt idx="69">
                  <c:v>66.400000000000006</c:v>
                </c:pt>
                <c:pt idx="70">
                  <c:v>70.2</c:v>
                </c:pt>
                <c:pt idx="71">
                  <c:v>77.099999999999994</c:v>
                </c:pt>
                <c:pt idx="72">
                  <c:v>72.599999999999994</c:v>
                </c:pt>
                <c:pt idx="73">
                  <c:v>56.7</c:v>
                </c:pt>
                <c:pt idx="74">
                  <c:v>63</c:v>
                </c:pt>
                <c:pt idx="75">
                  <c:v>57.2</c:v>
                </c:pt>
                <c:pt idx="76">
                  <c:v>73.3</c:v>
                </c:pt>
                <c:pt idx="77">
                  <c:v>58.5</c:v>
                </c:pt>
                <c:pt idx="78">
                  <c:v>73.3</c:v>
                </c:pt>
                <c:pt idx="79">
                  <c:v>76.8</c:v>
                </c:pt>
                <c:pt idx="80">
                  <c:v>66.2</c:v>
                </c:pt>
                <c:pt idx="81">
                  <c:v>80.8</c:v>
                </c:pt>
                <c:pt idx="82">
                  <c:v>73</c:v>
                </c:pt>
                <c:pt idx="83">
                  <c:v>82.4</c:v>
                </c:pt>
                <c:pt idx="84">
                  <c:v>76.099999999999994</c:v>
                </c:pt>
                <c:pt idx="85">
                  <c:v>54.5</c:v>
                </c:pt>
                <c:pt idx="86">
                  <c:v>67.599999999999994</c:v>
                </c:pt>
                <c:pt idx="87">
                  <c:v>67.2</c:v>
                </c:pt>
                <c:pt idx="88">
                  <c:v>64.099999999999994</c:v>
                </c:pt>
                <c:pt idx="89">
                  <c:v>82.2</c:v>
                </c:pt>
                <c:pt idx="90">
                  <c:v>70.8</c:v>
                </c:pt>
                <c:pt idx="91">
                  <c:v>68.8</c:v>
                </c:pt>
                <c:pt idx="92">
                  <c:v>76.099999999999994</c:v>
                </c:pt>
                <c:pt idx="93">
                  <c:v>75</c:v>
                </c:pt>
                <c:pt idx="94">
                  <c:v>78.8</c:v>
                </c:pt>
                <c:pt idx="95">
                  <c:v>73.5</c:v>
                </c:pt>
                <c:pt idx="96">
                  <c:v>75.5</c:v>
                </c:pt>
                <c:pt idx="97">
                  <c:v>72.3</c:v>
                </c:pt>
                <c:pt idx="98">
                  <c:v>70.599999999999994</c:v>
                </c:pt>
                <c:pt idx="99">
                  <c:v>79.099999999999994</c:v>
                </c:pt>
                <c:pt idx="100">
                  <c:v>83.7</c:v>
                </c:pt>
                <c:pt idx="101">
                  <c:v>77</c:v>
                </c:pt>
                <c:pt idx="102">
                  <c:v>65</c:v>
                </c:pt>
                <c:pt idx="103">
                  <c:v>62.9</c:v>
                </c:pt>
                <c:pt idx="104">
                  <c:v>75.599999999999994</c:v>
                </c:pt>
                <c:pt idx="105">
                  <c:v>59.8</c:v>
                </c:pt>
                <c:pt idx="106">
                  <c:v>73.599999999999994</c:v>
                </c:pt>
                <c:pt idx="107">
                  <c:v>72.8</c:v>
                </c:pt>
                <c:pt idx="108">
                  <c:v>76.900000000000006</c:v>
                </c:pt>
                <c:pt idx="109">
                  <c:v>68.400000000000006</c:v>
                </c:pt>
                <c:pt idx="110">
                  <c:v>62.7</c:v>
                </c:pt>
                <c:pt idx="111">
                  <c:v>74.7</c:v>
                </c:pt>
                <c:pt idx="112">
                  <c:v>61</c:v>
                </c:pt>
                <c:pt idx="113">
                  <c:v>68.3</c:v>
                </c:pt>
                <c:pt idx="114">
                  <c:v>58.1</c:v>
                </c:pt>
                <c:pt idx="115">
                  <c:v>76.5</c:v>
                </c:pt>
                <c:pt idx="116">
                  <c:v>68.400000000000006</c:v>
                </c:pt>
                <c:pt idx="117">
                  <c:v>64.400000000000006</c:v>
                </c:pt>
                <c:pt idx="118">
                  <c:v>74.8</c:v>
                </c:pt>
                <c:pt idx="119">
                  <c:v>81.599999999999994</c:v>
                </c:pt>
                <c:pt idx="120">
                  <c:v>71.2</c:v>
                </c:pt>
                <c:pt idx="121">
                  <c:v>74</c:v>
                </c:pt>
                <c:pt idx="122">
                  <c:v>82.2</c:v>
                </c:pt>
                <c:pt idx="123">
                  <c:v>71.2</c:v>
                </c:pt>
                <c:pt idx="124">
                  <c:v>72.5</c:v>
                </c:pt>
                <c:pt idx="125">
                  <c:v>69.400000000000006</c:v>
                </c:pt>
                <c:pt idx="126">
                  <c:v>79.7</c:v>
                </c:pt>
                <c:pt idx="127">
                  <c:v>65.5</c:v>
                </c:pt>
                <c:pt idx="128">
                  <c:v>84.5</c:v>
                </c:pt>
                <c:pt idx="129">
                  <c:v>73.900000000000006</c:v>
                </c:pt>
                <c:pt idx="130">
                  <c:v>75.7</c:v>
                </c:pt>
                <c:pt idx="131">
                  <c:v>69.8</c:v>
                </c:pt>
                <c:pt idx="132">
                  <c:v>77.400000000000006</c:v>
                </c:pt>
                <c:pt idx="133">
                  <c:v>73</c:v>
                </c:pt>
                <c:pt idx="134">
                  <c:v>74.5</c:v>
                </c:pt>
                <c:pt idx="135">
                  <c:v>72.2</c:v>
                </c:pt>
                <c:pt idx="136">
                  <c:v>76.8</c:v>
                </c:pt>
                <c:pt idx="137">
                  <c:v>68</c:v>
                </c:pt>
                <c:pt idx="138">
                  <c:v>60.5</c:v>
                </c:pt>
                <c:pt idx="139">
                  <c:v>70.900000000000006</c:v>
                </c:pt>
                <c:pt idx="140">
                  <c:v>77</c:v>
                </c:pt>
                <c:pt idx="141">
                  <c:v>75.400000000000006</c:v>
                </c:pt>
                <c:pt idx="142">
                  <c:v>66.7</c:v>
                </c:pt>
                <c:pt idx="143">
                  <c:v>76.3</c:v>
                </c:pt>
                <c:pt idx="144">
                  <c:v>69.7</c:v>
                </c:pt>
                <c:pt idx="145">
                  <c:v>86.8</c:v>
                </c:pt>
                <c:pt idx="146">
                  <c:v>68.7</c:v>
                </c:pt>
                <c:pt idx="147">
                  <c:v>69</c:v>
                </c:pt>
                <c:pt idx="148">
                  <c:v>56.8</c:v>
                </c:pt>
                <c:pt idx="149">
                  <c:v>81.3</c:v>
                </c:pt>
                <c:pt idx="150">
                  <c:v>79</c:v>
                </c:pt>
                <c:pt idx="151">
                  <c:v>68.599999999999994</c:v>
                </c:pt>
                <c:pt idx="152">
                  <c:v>62.9</c:v>
                </c:pt>
                <c:pt idx="153">
                  <c:v>63.7</c:v>
                </c:pt>
                <c:pt idx="154">
                  <c:v>67.3</c:v>
                </c:pt>
                <c:pt idx="155">
                  <c:v>67.900000000000006</c:v>
                </c:pt>
                <c:pt idx="156">
                  <c:v>75.5</c:v>
                </c:pt>
                <c:pt idx="157">
                  <c:v>64.400000000000006</c:v>
                </c:pt>
                <c:pt idx="158">
                  <c:v>76.2</c:v>
                </c:pt>
                <c:pt idx="159">
                  <c:v>78.400000000000006</c:v>
                </c:pt>
                <c:pt idx="160">
                  <c:v>56.7</c:v>
                </c:pt>
                <c:pt idx="161">
                  <c:v>71.900000000000006</c:v>
                </c:pt>
                <c:pt idx="162">
                  <c:v>70.2</c:v>
                </c:pt>
                <c:pt idx="163">
                  <c:v>76.099999999999994</c:v>
                </c:pt>
                <c:pt idx="164">
                  <c:v>61.6</c:v>
                </c:pt>
                <c:pt idx="165">
                  <c:v>64.099999999999994</c:v>
                </c:pt>
                <c:pt idx="166">
                  <c:v>64</c:v>
                </c:pt>
                <c:pt idx="167">
                  <c:v>60.6</c:v>
                </c:pt>
                <c:pt idx="168">
                  <c:v>78.099999999999994</c:v>
                </c:pt>
                <c:pt idx="169">
                  <c:v>63.5</c:v>
                </c:pt>
                <c:pt idx="170">
                  <c:v>75.3</c:v>
                </c:pt>
                <c:pt idx="171">
                  <c:v>56.2</c:v>
                </c:pt>
                <c:pt idx="172">
                  <c:v>61.2</c:v>
                </c:pt>
                <c:pt idx="173">
                  <c:v>77.599999999999994</c:v>
                </c:pt>
                <c:pt idx="174">
                  <c:v>48.4</c:v>
                </c:pt>
                <c:pt idx="175">
                  <c:v>72.099999999999994</c:v>
                </c:pt>
                <c:pt idx="176">
                  <c:v>73.400000000000006</c:v>
                </c:pt>
                <c:pt idx="177">
                  <c:v>66.8</c:v>
                </c:pt>
                <c:pt idx="178">
                  <c:v>83.6</c:v>
                </c:pt>
                <c:pt idx="179">
                  <c:v>75.900000000000006</c:v>
                </c:pt>
                <c:pt idx="180">
                  <c:v>70.7</c:v>
                </c:pt>
                <c:pt idx="181">
                  <c:v>74.5</c:v>
                </c:pt>
                <c:pt idx="182">
                  <c:v>61.5</c:v>
                </c:pt>
                <c:pt idx="183">
                  <c:v>65.2</c:v>
                </c:pt>
                <c:pt idx="184">
                  <c:v>55.5</c:v>
                </c:pt>
                <c:pt idx="185">
                  <c:v>71.599999999999994</c:v>
                </c:pt>
                <c:pt idx="186">
                  <c:v>61.2</c:v>
                </c:pt>
                <c:pt idx="187">
                  <c:v>77</c:v>
                </c:pt>
                <c:pt idx="188">
                  <c:v>74.8</c:v>
                </c:pt>
                <c:pt idx="189">
                  <c:v>69.900000000000006</c:v>
                </c:pt>
                <c:pt idx="190">
                  <c:v>82.1</c:v>
                </c:pt>
                <c:pt idx="191">
                  <c:v>51.1</c:v>
                </c:pt>
                <c:pt idx="192">
                  <c:v>72.8</c:v>
                </c:pt>
                <c:pt idx="193">
                  <c:v>81.7</c:v>
                </c:pt>
                <c:pt idx="194">
                  <c:v>69.2</c:v>
                </c:pt>
                <c:pt idx="195">
                  <c:v>78.3</c:v>
                </c:pt>
                <c:pt idx="196">
                  <c:v>70.7</c:v>
                </c:pt>
                <c:pt idx="197">
                  <c:v>72.099999999999994</c:v>
                </c:pt>
                <c:pt idx="198">
                  <c:v>77.900000000000006</c:v>
                </c:pt>
                <c:pt idx="199">
                  <c:v>64.099999999999994</c:v>
                </c:pt>
                <c:pt idx="200">
                  <c:v>82.5</c:v>
                </c:pt>
                <c:pt idx="201">
                  <c:v>62.8</c:v>
                </c:pt>
                <c:pt idx="202">
                  <c:v>66.5</c:v>
                </c:pt>
                <c:pt idx="203">
                  <c:v>68.900000000000006</c:v>
                </c:pt>
                <c:pt idx="204">
                  <c:v>82.2</c:v>
                </c:pt>
                <c:pt idx="205">
                  <c:v>64.900000000000006</c:v>
                </c:pt>
                <c:pt idx="206">
                  <c:v>62.1</c:v>
                </c:pt>
                <c:pt idx="207">
                  <c:v>67.2</c:v>
                </c:pt>
                <c:pt idx="208">
                  <c:v>82.3</c:v>
                </c:pt>
                <c:pt idx="209">
                  <c:v>73.400000000000006</c:v>
                </c:pt>
                <c:pt idx="210">
                  <c:v>63.3</c:v>
                </c:pt>
                <c:pt idx="211">
                  <c:v>66.400000000000006</c:v>
                </c:pt>
                <c:pt idx="212">
                  <c:v>50.6</c:v>
                </c:pt>
                <c:pt idx="213">
                  <c:v>82.2</c:v>
                </c:pt>
                <c:pt idx="214">
                  <c:v>74.8</c:v>
                </c:pt>
              </c:numCache>
            </c:numRef>
          </c:xVal>
          <c:yVal>
            <c:numRef>
              <c:f>Feuil2!$I$2:$I$246</c:f>
              <c:numCache>
                <c:formatCode>0.0%</c:formatCode>
                <c:ptCount val="245"/>
                <c:pt idx="0">
                  <c:v>0.29299999999999998</c:v>
                </c:pt>
                <c:pt idx="1">
                  <c:v>0.39700000000000002</c:v>
                </c:pt>
                <c:pt idx="2">
                  <c:v>0.36299999999999999</c:v>
                </c:pt>
                <c:pt idx="3">
                  <c:v>0.46400000000000002</c:v>
                </c:pt>
                <c:pt idx="4">
                  <c:v>0.313</c:v>
                </c:pt>
                <c:pt idx="5">
                  <c:v>0.42399999999999999</c:v>
                </c:pt>
                <c:pt idx="6">
                  <c:v>0.34399999999999997</c:v>
                </c:pt>
                <c:pt idx="7">
                  <c:v>0.438</c:v>
                </c:pt>
                <c:pt idx="8">
                  <c:v>0.4</c:v>
                </c:pt>
                <c:pt idx="9">
                  <c:v>0.47699999999999998</c:v>
                </c:pt>
                <c:pt idx="10">
                  <c:v>0.32800000000000001</c:v>
                </c:pt>
                <c:pt idx="11">
                  <c:v>0.41699999999999998</c:v>
                </c:pt>
                <c:pt idx="12">
                  <c:v>0.39700000000000002</c:v>
                </c:pt>
                <c:pt idx="13">
                  <c:v>0.42399999999999999</c:v>
                </c:pt>
                <c:pt idx="14">
                  <c:v>0.43099999999999999</c:v>
                </c:pt>
                <c:pt idx="15">
                  <c:v>0.437</c:v>
                </c:pt>
                <c:pt idx="16">
                  <c:v>0.379</c:v>
                </c:pt>
                <c:pt idx="17">
                  <c:v>0.34699999999999998</c:v>
                </c:pt>
                <c:pt idx="18">
                  <c:v>0.34799999999999998</c:v>
                </c:pt>
                <c:pt idx="19">
                  <c:v>0.36899999999999999</c:v>
                </c:pt>
                <c:pt idx="20">
                  <c:v>0.43</c:v>
                </c:pt>
                <c:pt idx="21">
                  <c:v>0.39300000000000002</c:v>
                </c:pt>
                <c:pt idx="22">
                  <c:v>0.35799999999999998</c:v>
                </c:pt>
                <c:pt idx="23">
                  <c:v>0.373</c:v>
                </c:pt>
                <c:pt idx="24">
                  <c:v>0.28999999999999998</c:v>
                </c:pt>
                <c:pt idx="25">
                  <c:v>0.35799999999999998</c:v>
                </c:pt>
                <c:pt idx="26">
                  <c:v>0.48699999999999999</c:v>
                </c:pt>
                <c:pt idx="27">
                  <c:v>0.41699999999999998</c:v>
                </c:pt>
                <c:pt idx="28">
                  <c:v>0.38400000000000001</c:v>
                </c:pt>
                <c:pt idx="29">
                  <c:v>0.42699999999999999</c:v>
                </c:pt>
                <c:pt idx="30">
                  <c:v>0.35</c:v>
                </c:pt>
                <c:pt idx="31">
                  <c:v>0.41199999999999998</c:v>
                </c:pt>
                <c:pt idx="32">
                  <c:v>0.31</c:v>
                </c:pt>
                <c:pt idx="33">
                  <c:v>0.44500000000000001</c:v>
                </c:pt>
                <c:pt idx="34">
                  <c:v>0.41699999999999998</c:v>
                </c:pt>
                <c:pt idx="35">
                  <c:v>0.505</c:v>
                </c:pt>
                <c:pt idx="36">
                  <c:v>0.45400000000000001</c:v>
                </c:pt>
                <c:pt idx="37">
                  <c:v>0.45400000000000001</c:v>
                </c:pt>
                <c:pt idx="38">
                  <c:v>0.28899999999999998</c:v>
                </c:pt>
                <c:pt idx="39">
                  <c:v>0.25</c:v>
                </c:pt>
                <c:pt idx="40">
                  <c:v>0.36</c:v>
                </c:pt>
                <c:pt idx="41">
                  <c:v>0.46899999999999997</c:v>
                </c:pt>
                <c:pt idx="42">
                  <c:v>0.57699999999999996</c:v>
                </c:pt>
                <c:pt idx="43">
                  <c:v>0.35599999999999998</c:v>
                </c:pt>
                <c:pt idx="44">
                  <c:v>0.34</c:v>
                </c:pt>
                <c:pt idx="45">
                  <c:v>0.51600000000000001</c:v>
                </c:pt>
                <c:pt idx="46">
                  <c:v>0.16900000000000001</c:v>
                </c:pt>
                <c:pt idx="47">
                  <c:v>0.43</c:v>
                </c:pt>
                <c:pt idx="48">
                  <c:v>0.441</c:v>
                </c:pt>
                <c:pt idx="49">
                  <c:v>0.42699999999999999</c:v>
                </c:pt>
                <c:pt idx="50">
                  <c:v>0.495</c:v>
                </c:pt>
                <c:pt idx="51">
                  <c:v>0.39700000000000002</c:v>
                </c:pt>
                <c:pt idx="52">
                  <c:v>0.42699999999999999</c:v>
                </c:pt>
                <c:pt idx="53">
                  <c:v>0.39600000000000002</c:v>
                </c:pt>
                <c:pt idx="54">
                  <c:v>0.371</c:v>
                </c:pt>
                <c:pt idx="55">
                  <c:v>0.36699999999999999</c:v>
                </c:pt>
                <c:pt idx="56">
                  <c:v>0.308</c:v>
                </c:pt>
                <c:pt idx="57">
                  <c:v>0.33100000000000002</c:v>
                </c:pt>
                <c:pt idx="58">
                  <c:v>0.39600000000000002</c:v>
                </c:pt>
                <c:pt idx="59">
                  <c:v>0.374</c:v>
                </c:pt>
                <c:pt idx="60">
                  <c:v>0.46100000000000002</c:v>
                </c:pt>
                <c:pt idx="61">
                  <c:v>0.42399999999999999</c:v>
                </c:pt>
                <c:pt idx="62">
                  <c:v>0.56499999999999995</c:v>
                </c:pt>
                <c:pt idx="63">
                  <c:v>0.29099999999999998</c:v>
                </c:pt>
                <c:pt idx="64">
                  <c:v>0.33500000000000002</c:v>
                </c:pt>
                <c:pt idx="65">
                  <c:v>0.33700000000000002</c:v>
                </c:pt>
                <c:pt idx="66">
                  <c:v>0.28299999999999997</c:v>
                </c:pt>
                <c:pt idx="67">
                  <c:v>0.48499999999999999</c:v>
                </c:pt>
                <c:pt idx="68">
                  <c:v>0.317</c:v>
                </c:pt>
                <c:pt idx="69">
                  <c:v>0.36499999999999999</c:v>
                </c:pt>
                <c:pt idx="70">
                  <c:v>0.34499999999999997</c:v>
                </c:pt>
                <c:pt idx="71">
                  <c:v>0.39900000000000002</c:v>
                </c:pt>
                <c:pt idx="72">
                  <c:v>0.40200000000000002</c:v>
                </c:pt>
                <c:pt idx="73">
                  <c:v>0.32800000000000001</c:v>
                </c:pt>
                <c:pt idx="74">
                  <c:v>0.315</c:v>
                </c:pt>
                <c:pt idx="75">
                  <c:v>0.20399999999999999</c:v>
                </c:pt>
                <c:pt idx="76">
                  <c:v>0.371</c:v>
                </c:pt>
                <c:pt idx="77">
                  <c:v>0.36799999999999999</c:v>
                </c:pt>
                <c:pt idx="78">
                  <c:v>0.36499999999999999</c:v>
                </c:pt>
                <c:pt idx="79">
                  <c:v>0.39600000000000002</c:v>
                </c:pt>
                <c:pt idx="80">
                  <c:v>0.40400000000000003</c:v>
                </c:pt>
                <c:pt idx="81">
                  <c:v>0.32</c:v>
                </c:pt>
                <c:pt idx="82">
                  <c:v>0.53100000000000003</c:v>
                </c:pt>
                <c:pt idx="83">
                  <c:v>0.45</c:v>
                </c:pt>
                <c:pt idx="84">
                  <c:v>0.36799999999999999</c:v>
                </c:pt>
                <c:pt idx="85">
                  <c:v>0.32</c:v>
                </c:pt>
                <c:pt idx="86">
                  <c:v>0.32300000000000001</c:v>
                </c:pt>
                <c:pt idx="87">
                  <c:v>0.42899999999999999</c:v>
                </c:pt>
                <c:pt idx="88">
                  <c:v>0.39800000000000002</c:v>
                </c:pt>
                <c:pt idx="89">
                  <c:v>0.36</c:v>
                </c:pt>
                <c:pt idx="90">
                  <c:v>0.34</c:v>
                </c:pt>
                <c:pt idx="91">
                  <c:v>0.372</c:v>
                </c:pt>
                <c:pt idx="92">
                  <c:v>0.39500000000000002</c:v>
                </c:pt>
                <c:pt idx="93">
                  <c:v>0.39300000000000002</c:v>
                </c:pt>
                <c:pt idx="94">
                  <c:v>0.39200000000000002</c:v>
                </c:pt>
                <c:pt idx="95">
                  <c:v>0.39600000000000002</c:v>
                </c:pt>
                <c:pt idx="96">
                  <c:v>0.59699999999999998</c:v>
                </c:pt>
                <c:pt idx="97">
                  <c:v>0.45200000000000001</c:v>
                </c:pt>
                <c:pt idx="98">
                  <c:v>0.48399999999999999</c:v>
                </c:pt>
                <c:pt idx="99">
                  <c:v>0.40400000000000003</c:v>
                </c:pt>
                <c:pt idx="100">
                  <c:v>0.439</c:v>
                </c:pt>
                <c:pt idx="101">
                  <c:v>0.45400000000000001</c:v>
                </c:pt>
                <c:pt idx="102">
                  <c:v>0.38100000000000001</c:v>
                </c:pt>
                <c:pt idx="103">
                  <c:v>0.39900000000000002</c:v>
                </c:pt>
                <c:pt idx="104">
                  <c:v>0.36099999999999999</c:v>
                </c:pt>
                <c:pt idx="105">
                  <c:v>0.46500000000000002</c:v>
                </c:pt>
                <c:pt idx="106">
                  <c:v>0.43</c:v>
                </c:pt>
                <c:pt idx="107">
                  <c:v>0.35799999999999998</c:v>
                </c:pt>
                <c:pt idx="108">
                  <c:v>0.38</c:v>
                </c:pt>
                <c:pt idx="109">
                  <c:v>0.41799999999999998</c:v>
                </c:pt>
                <c:pt idx="110">
                  <c:v>0.438</c:v>
                </c:pt>
                <c:pt idx="111">
                  <c:v>0.44600000000000001</c:v>
                </c:pt>
                <c:pt idx="112">
                  <c:v>0.38400000000000001</c:v>
                </c:pt>
                <c:pt idx="113">
                  <c:v>0.47199999999999998</c:v>
                </c:pt>
                <c:pt idx="114">
                  <c:v>0.371</c:v>
                </c:pt>
                <c:pt idx="115">
                  <c:v>0.40200000000000002</c:v>
                </c:pt>
                <c:pt idx="116">
                  <c:v>0.499</c:v>
                </c:pt>
                <c:pt idx="117">
                  <c:v>0.40200000000000002</c:v>
                </c:pt>
                <c:pt idx="118">
                  <c:v>0.44800000000000001</c:v>
                </c:pt>
                <c:pt idx="119">
                  <c:v>0.40400000000000003</c:v>
                </c:pt>
                <c:pt idx="120">
                  <c:v>0.39100000000000001</c:v>
                </c:pt>
                <c:pt idx="121">
                  <c:v>0.52600000000000002</c:v>
                </c:pt>
                <c:pt idx="122">
                  <c:v>0.45500000000000002</c:v>
                </c:pt>
                <c:pt idx="123">
                  <c:v>0.41199999999999998</c:v>
                </c:pt>
                <c:pt idx="124">
                  <c:v>0.501</c:v>
                </c:pt>
                <c:pt idx="125">
                  <c:v>0.46200000000000002</c:v>
                </c:pt>
                <c:pt idx="126">
                  <c:v>0.45100000000000001</c:v>
                </c:pt>
                <c:pt idx="127">
                  <c:v>0.439</c:v>
                </c:pt>
                <c:pt idx="128">
                  <c:v>0.41299999999999998</c:v>
                </c:pt>
                <c:pt idx="129">
                  <c:v>0.502</c:v>
                </c:pt>
                <c:pt idx="130">
                  <c:v>0.505</c:v>
                </c:pt>
                <c:pt idx="131">
                  <c:v>0.49</c:v>
                </c:pt>
                <c:pt idx="132">
                  <c:v>0.40300000000000002</c:v>
                </c:pt>
                <c:pt idx="133">
                  <c:v>0.40400000000000003</c:v>
                </c:pt>
                <c:pt idx="134">
                  <c:v>0.45</c:v>
                </c:pt>
                <c:pt idx="135">
                  <c:v>0.48099999999999998</c:v>
                </c:pt>
                <c:pt idx="136">
                  <c:v>0.52900000000000003</c:v>
                </c:pt>
                <c:pt idx="137">
                  <c:v>0.42899999999999999</c:v>
                </c:pt>
                <c:pt idx="138">
                  <c:v>0.43099999999999999</c:v>
                </c:pt>
                <c:pt idx="139">
                  <c:v>0.48599999999999999</c:v>
                </c:pt>
                <c:pt idx="140">
                  <c:v>0.43099999999999999</c:v>
                </c:pt>
                <c:pt idx="141">
                  <c:v>0.42799999999999999</c:v>
                </c:pt>
                <c:pt idx="142">
                  <c:v>0.45900000000000002</c:v>
                </c:pt>
                <c:pt idx="143">
                  <c:v>0.56299999999999994</c:v>
                </c:pt>
                <c:pt idx="144">
                  <c:v>0.38700000000000001</c:v>
                </c:pt>
                <c:pt idx="145">
                  <c:v>0.44600000000000001</c:v>
                </c:pt>
                <c:pt idx="146">
                  <c:v>0.38300000000000001</c:v>
                </c:pt>
                <c:pt idx="147">
                  <c:v>0.35199999999999998</c:v>
                </c:pt>
                <c:pt idx="148">
                  <c:v>0.35199999999999998</c:v>
                </c:pt>
                <c:pt idx="149">
                  <c:v>0.52300000000000002</c:v>
                </c:pt>
                <c:pt idx="150">
                  <c:v>0.43</c:v>
                </c:pt>
                <c:pt idx="151">
                  <c:v>0.39500000000000002</c:v>
                </c:pt>
                <c:pt idx="152">
                  <c:v>0.38700000000000001</c:v>
                </c:pt>
                <c:pt idx="153">
                  <c:v>0.39200000000000002</c:v>
                </c:pt>
                <c:pt idx="154">
                  <c:v>0.48699999999999999</c:v>
                </c:pt>
                <c:pt idx="155">
                  <c:v>0.44400000000000001</c:v>
                </c:pt>
                <c:pt idx="156">
                  <c:v>0.40400000000000003</c:v>
                </c:pt>
                <c:pt idx="157">
                  <c:v>0.44</c:v>
                </c:pt>
                <c:pt idx="158">
                  <c:v>0.40899999999999997</c:v>
                </c:pt>
                <c:pt idx="159">
                  <c:v>0.378</c:v>
                </c:pt>
                <c:pt idx="160">
                  <c:v>0.4</c:v>
                </c:pt>
                <c:pt idx="161">
                  <c:v>0.40400000000000003</c:v>
                </c:pt>
                <c:pt idx="162">
                  <c:v>0.42099999999999999</c:v>
                </c:pt>
                <c:pt idx="163">
                  <c:v>0.44900000000000001</c:v>
                </c:pt>
                <c:pt idx="164">
                  <c:v>0.35099999999999998</c:v>
                </c:pt>
                <c:pt idx="165">
                  <c:v>0.23799999999999999</c:v>
                </c:pt>
                <c:pt idx="166">
                  <c:v>0.39400000000000002</c:v>
                </c:pt>
                <c:pt idx="167">
                  <c:v>0.39700000000000002</c:v>
                </c:pt>
                <c:pt idx="168">
                  <c:v>0.34899999999999998</c:v>
                </c:pt>
                <c:pt idx="169">
                  <c:v>0.38200000000000001</c:v>
                </c:pt>
                <c:pt idx="170">
                  <c:v>0.40200000000000002</c:v>
                </c:pt>
                <c:pt idx="171">
                  <c:v>0.42</c:v>
                </c:pt>
                <c:pt idx="172">
                  <c:v>0.44400000000000001</c:v>
                </c:pt>
                <c:pt idx="173">
                  <c:v>0.47099999999999997</c:v>
                </c:pt>
                <c:pt idx="174">
                  <c:v>0.308</c:v>
                </c:pt>
                <c:pt idx="175">
                  <c:v>0.5</c:v>
                </c:pt>
                <c:pt idx="176">
                  <c:v>0.376</c:v>
                </c:pt>
                <c:pt idx="177">
                  <c:v>0.32100000000000001</c:v>
                </c:pt>
                <c:pt idx="178">
                  <c:v>0.55900000000000005</c:v>
                </c:pt>
                <c:pt idx="179">
                  <c:v>0.39300000000000002</c:v>
                </c:pt>
                <c:pt idx="180">
                  <c:v>0.29899999999999999</c:v>
                </c:pt>
                <c:pt idx="181">
                  <c:v>0.41099999999999998</c:v>
                </c:pt>
                <c:pt idx="182">
                  <c:v>0.31900000000000001</c:v>
                </c:pt>
                <c:pt idx="183">
                  <c:v>0.38700000000000001</c:v>
                </c:pt>
                <c:pt idx="184">
                  <c:v>0.27500000000000002</c:v>
                </c:pt>
                <c:pt idx="185">
                  <c:v>0.438</c:v>
                </c:pt>
                <c:pt idx="186">
                  <c:v>0.46400000000000002</c:v>
                </c:pt>
                <c:pt idx="187">
                  <c:v>0.41699999999999998</c:v>
                </c:pt>
                <c:pt idx="188">
                  <c:v>0.437</c:v>
                </c:pt>
                <c:pt idx="189">
                  <c:v>0.41399999999999998</c:v>
                </c:pt>
                <c:pt idx="190">
                  <c:v>0.48</c:v>
                </c:pt>
                <c:pt idx="191">
                  <c:v>0.36899999999999999</c:v>
                </c:pt>
                <c:pt idx="192">
                  <c:v>0.52200000000000002</c:v>
                </c:pt>
                <c:pt idx="193">
                  <c:v>0.45300000000000001</c:v>
                </c:pt>
                <c:pt idx="194">
                  <c:v>0.32100000000000001</c:v>
                </c:pt>
                <c:pt idx="195">
                  <c:v>0.50800000000000001</c:v>
                </c:pt>
                <c:pt idx="196">
                  <c:v>0.42599999999999999</c:v>
                </c:pt>
                <c:pt idx="197">
                  <c:v>0.42299999999999999</c:v>
                </c:pt>
                <c:pt idx="198">
                  <c:v>0.44700000000000001</c:v>
                </c:pt>
                <c:pt idx="199">
                  <c:v>0.42099999999999999</c:v>
                </c:pt>
                <c:pt idx="200">
                  <c:v>0.46200000000000002</c:v>
                </c:pt>
                <c:pt idx="201">
                  <c:v>0.45300000000000001</c:v>
                </c:pt>
                <c:pt idx="202">
                  <c:v>0.314</c:v>
                </c:pt>
                <c:pt idx="203">
                  <c:v>0.32900000000000001</c:v>
                </c:pt>
                <c:pt idx="204">
                  <c:v>0.44</c:v>
                </c:pt>
                <c:pt idx="205">
                  <c:v>0.34200000000000003</c:v>
                </c:pt>
                <c:pt idx="206">
                  <c:v>0.378</c:v>
                </c:pt>
                <c:pt idx="207">
                  <c:v>0.436</c:v>
                </c:pt>
                <c:pt idx="208">
                  <c:v>0.46100000000000002</c:v>
                </c:pt>
                <c:pt idx="209">
                  <c:v>0.36</c:v>
                </c:pt>
                <c:pt idx="210">
                  <c:v>0.28100000000000003</c:v>
                </c:pt>
                <c:pt idx="211">
                  <c:v>0.39600000000000002</c:v>
                </c:pt>
                <c:pt idx="212">
                  <c:v>0.42099999999999999</c:v>
                </c:pt>
                <c:pt idx="213">
                  <c:v>0.51</c:v>
                </c:pt>
                <c:pt idx="214">
                  <c:v>0.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7AA-EC4E-AE5D-BC95E1692E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4878312"/>
        <c:axId val="534880272"/>
      </c:scatterChart>
      <c:valAx>
        <c:axId val="534878312"/>
        <c:scaling>
          <c:orientation val="minMax"/>
          <c:max val="100"/>
          <c:min val="4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FF</a:t>
                </a:r>
                <a:r>
                  <a:rPr lang="fr-FR" baseline="-20000" dirty="0"/>
                  <a:t>T0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baseline="-20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80272"/>
        <c:crosses val="autoZero"/>
        <c:crossBetween val="midCat"/>
        <c:majorUnit val="10"/>
      </c:valAx>
      <c:valAx>
        <c:axId val="534880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F</a:t>
                </a:r>
                <a:r>
                  <a:rPr lang="en-US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</a:p>
            </c:rich>
          </c:tx>
          <c:layout>
            <c:manualLayout>
              <c:xMode val="edge"/>
              <c:yMode val="edge"/>
              <c:x val="6.4577296728629011E-2"/>
              <c:y val="0.302498838868409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8783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68865536984992"/>
          <c:y val="7.376978102656169E-2"/>
          <c:w val="0.62911109083284555"/>
          <c:h val="0.70806501200522265"/>
        </c:manualLayout>
      </c:layout>
      <c:scatterChart>
        <c:scatterStyle val="lineMarker"/>
        <c:varyColors val="0"/>
        <c:ser>
          <c:idx val="0"/>
          <c:order val="0"/>
          <c:tx>
            <c:strRef>
              <c:f>inrae!$I$1</c:f>
              <c:strCache>
                <c:ptCount val="1"/>
                <c:pt idx="0">
                  <c:v>Loss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inrae!$G$2:$G$248</c:f>
              <c:numCache>
                <c:formatCode>0.0</c:formatCode>
                <c:ptCount val="247"/>
                <c:pt idx="0">
                  <c:v>90.259897616297295</c:v>
                </c:pt>
                <c:pt idx="1">
                  <c:v>89.842732356514205</c:v>
                </c:pt>
                <c:pt idx="2">
                  <c:v>86.533478408701001</c:v>
                </c:pt>
                <c:pt idx="3">
                  <c:v>87.011741980167201</c:v>
                </c:pt>
                <c:pt idx="4">
                  <c:v>98.2236841176626</c:v>
                </c:pt>
                <c:pt idx="5">
                  <c:v>90.333149971756299</c:v>
                </c:pt>
                <c:pt idx="6">
                  <c:v>91.784023547111502</c:v>
                </c:pt>
                <c:pt idx="7">
                  <c:v>94.805249352187701</c:v>
                </c:pt>
                <c:pt idx="8">
                  <c:v>91.340672099289307</c:v>
                </c:pt>
                <c:pt idx="9">
                  <c:v>94.285794313613593</c:v>
                </c:pt>
                <c:pt idx="10">
                  <c:v>90.599734123967096</c:v>
                </c:pt>
                <c:pt idx="11">
                  <c:v>89.301497590288704</c:v>
                </c:pt>
                <c:pt idx="12">
                  <c:v>95.8091312221799</c:v>
                </c:pt>
                <c:pt idx="13">
                  <c:v>93.108522406665699</c:v>
                </c:pt>
                <c:pt idx="14">
                  <c:v>83.692403340060594</c:v>
                </c:pt>
                <c:pt idx="15">
                  <c:v>90.516906316453898</c:v>
                </c:pt>
                <c:pt idx="16">
                  <c:v>86.559566839384999</c:v>
                </c:pt>
                <c:pt idx="17">
                  <c:v>87.118140979582904</c:v>
                </c:pt>
                <c:pt idx="18">
                  <c:v>90.903862294673402</c:v>
                </c:pt>
                <c:pt idx="19">
                  <c:v>87.765157782987103</c:v>
                </c:pt>
                <c:pt idx="20">
                  <c:v>88.224575326742595</c:v>
                </c:pt>
                <c:pt idx="21">
                  <c:v>91.018380744620103</c:v>
                </c:pt>
                <c:pt idx="22">
                  <c:v>89.908999039175598</c:v>
                </c:pt>
                <c:pt idx="23">
                  <c:v>84.9896597200879</c:v>
                </c:pt>
                <c:pt idx="24">
                  <c:v>95.446631336344495</c:v>
                </c:pt>
                <c:pt idx="25">
                  <c:v>94.602520319637094</c:v>
                </c:pt>
                <c:pt idx="26">
                  <c:v>79.906818995365001</c:v>
                </c:pt>
                <c:pt idx="27">
                  <c:v>89.248000953176202</c:v>
                </c:pt>
                <c:pt idx="28">
                  <c:v>89.488274972701504</c:v>
                </c:pt>
                <c:pt idx="29">
                  <c:v>97.738373757741599</c:v>
                </c:pt>
                <c:pt idx="30">
                  <c:v>85.057915937792501</c:v>
                </c:pt>
                <c:pt idx="31">
                  <c:v>92.045653823280105</c:v>
                </c:pt>
                <c:pt idx="32">
                  <c:v>84.211271460600798</c:v>
                </c:pt>
                <c:pt idx="33">
                  <c:v>92.667111688465397</c:v>
                </c:pt>
                <c:pt idx="34">
                  <c:v>89.506907574390695</c:v>
                </c:pt>
                <c:pt idx="35">
                  <c:v>93.620702678395105</c:v>
                </c:pt>
                <c:pt idx="36">
                  <c:v>94.910336326214306</c:v>
                </c:pt>
                <c:pt idx="37">
                  <c:v>88.777084703408406</c:v>
                </c:pt>
                <c:pt idx="38">
                  <c:v>87.153217862300295</c:v>
                </c:pt>
                <c:pt idx="39">
                  <c:v>90.765728417110196</c:v>
                </c:pt>
                <c:pt idx="40">
                  <c:v>90.194373008821003</c:v>
                </c:pt>
                <c:pt idx="41">
                  <c:v>80.163335053391293</c:v>
                </c:pt>
                <c:pt idx="42">
                  <c:v>93.218146807451504</c:v>
                </c:pt>
                <c:pt idx="43">
                  <c:v>87.637513564229394</c:v>
                </c:pt>
                <c:pt idx="44">
                  <c:v>84.651183142241806</c:v>
                </c:pt>
                <c:pt idx="45">
                  <c:v>89.747424880394604</c:v>
                </c:pt>
                <c:pt idx="46">
                  <c:v>86.587154122481607</c:v>
                </c:pt>
                <c:pt idx="47">
                  <c:v>85.470278928068595</c:v>
                </c:pt>
                <c:pt idx="48">
                  <c:v>90.712124384648902</c:v>
                </c:pt>
                <c:pt idx="49">
                  <c:v>84.825972332388702</c:v>
                </c:pt>
                <c:pt idx="50">
                  <c:v>86.087248905860605</c:v>
                </c:pt>
                <c:pt idx="51">
                  <c:v>89.237478799971797</c:v>
                </c:pt>
                <c:pt idx="52">
                  <c:v>91.918705897889495</c:v>
                </c:pt>
                <c:pt idx="53">
                  <c:v>86.712158221767694</c:v>
                </c:pt>
                <c:pt idx="54">
                  <c:v>88.263957484575002</c:v>
                </c:pt>
                <c:pt idx="55">
                  <c:v>91.949257336522507</c:v>
                </c:pt>
                <c:pt idx="56">
                  <c:v>85.630576702629099</c:v>
                </c:pt>
                <c:pt idx="57">
                  <c:v>89.325308314362204</c:v>
                </c:pt>
                <c:pt idx="58">
                  <c:v>91.745175407590295</c:v>
                </c:pt>
                <c:pt idx="59">
                  <c:v>97.631789433000193</c:v>
                </c:pt>
                <c:pt idx="60">
                  <c:v>87.913731243694897</c:v>
                </c:pt>
                <c:pt idx="61">
                  <c:v>77.6099028022889</c:v>
                </c:pt>
                <c:pt idx="62">
                  <c:v>87.103981493827803</c:v>
                </c:pt>
                <c:pt idx="63">
                  <c:v>85.246944541180696</c:v>
                </c:pt>
                <c:pt idx="64">
                  <c:v>92.202079754135298</c:v>
                </c:pt>
                <c:pt idx="65">
                  <c:v>85.057097589201106</c:v>
                </c:pt>
                <c:pt idx="66">
                  <c:v>86.717787097383905</c:v>
                </c:pt>
                <c:pt idx="67">
                  <c:v>92.424131857275995</c:v>
                </c:pt>
                <c:pt idx="68">
                  <c:v>88.961531704980004</c:v>
                </c:pt>
                <c:pt idx="69">
                  <c:v>84.293627131959596</c:v>
                </c:pt>
                <c:pt idx="70">
                  <c:v>89.297602295512903</c:v>
                </c:pt>
                <c:pt idx="71">
                  <c:v>84.305067092214301</c:v>
                </c:pt>
                <c:pt idx="72">
                  <c:v>89.953220089550797</c:v>
                </c:pt>
                <c:pt idx="73">
                  <c:v>89.650575395229893</c:v>
                </c:pt>
                <c:pt idx="74">
                  <c:v>89.701699529836404</c:v>
                </c:pt>
                <c:pt idx="75">
                  <c:v>88.006809712446497</c:v>
                </c:pt>
                <c:pt idx="76">
                  <c:v>87.617967643412499</c:v>
                </c:pt>
                <c:pt idx="77">
                  <c:v>81.271272909678899</c:v>
                </c:pt>
                <c:pt idx="78">
                  <c:v>88.877476965176299</c:v>
                </c:pt>
                <c:pt idx="79">
                  <c:v>88.406789254951804</c:v>
                </c:pt>
                <c:pt idx="80">
                  <c:v>85.332181341407505</c:v>
                </c:pt>
                <c:pt idx="81">
                  <c:v>88.295342110921894</c:v>
                </c:pt>
                <c:pt idx="82">
                  <c:v>85.621570525433199</c:v>
                </c:pt>
                <c:pt idx="83">
                  <c:v>92.512951015608806</c:v>
                </c:pt>
                <c:pt idx="84">
                  <c:v>85.228305961142894</c:v>
                </c:pt>
                <c:pt idx="85">
                  <c:v>91.552474957562794</c:v>
                </c:pt>
                <c:pt idx="86">
                  <c:v>90.249870946603707</c:v>
                </c:pt>
                <c:pt idx="87">
                  <c:v>93.231691520085406</c:v>
                </c:pt>
                <c:pt idx="88">
                  <c:v>91.854298426722906</c:v>
                </c:pt>
                <c:pt idx="89">
                  <c:v>88.235395501576704</c:v>
                </c:pt>
                <c:pt idx="90">
                  <c:v>89.659786195540505</c:v>
                </c:pt>
                <c:pt idx="91">
                  <c:v>95.569894384324201</c:v>
                </c:pt>
                <c:pt idx="92">
                  <c:v>87.522622278141498</c:v>
                </c:pt>
                <c:pt idx="93">
                  <c:v>89.237752980784705</c:v>
                </c:pt>
                <c:pt idx="94">
                  <c:v>91.778034331620702</c:v>
                </c:pt>
                <c:pt idx="95">
                  <c:v>73.658217334590802</c:v>
                </c:pt>
                <c:pt idx="96">
                  <c:v>83.5748801846471</c:v>
                </c:pt>
                <c:pt idx="97">
                  <c:v>91.780690885951302</c:v>
                </c:pt>
                <c:pt idx="98">
                  <c:v>89.740671925852496</c:v>
                </c:pt>
                <c:pt idx="99">
                  <c:v>92.420503853119996</c:v>
                </c:pt>
                <c:pt idx="100">
                  <c:v>91.472055831764607</c:v>
                </c:pt>
                <c:pt idx="101">
                  <c:v>86.175755869762895</c:v>
                </c:pt>
                <c:pt idx="102">
                  <c:v>88.286094865322795</c:v>
                </c:pt>
                <c:pt idx="103">
                  <c:v>83.814782726688904</c:v>
                </c:pt>
                <c:pt idx="104">
                  <c:v>93.5730421007556</c:v>
                </c:pt>
                <c:pt idx="105">
                  <c:v>93.704884958619999</c:v>
                </c:pt>
                <c:pt idx="106">
                  <c:v>86.239958855618099</c:v>
                </c:pt>
                <c:pt idx="107">
                  <c:v>74.280032714965998</c:v>
                </c:pt>
                <c:pt idx="108">
                  <c:v>88.283501072263306</c:v>
                </c:pt>
                <c:pt idx="109">
                  <c:v>88.105316751404899</c:v>
                </c:pt>
                <c:pt idx="110">
                  <c:v>87.945917126622902</c:v>
                </c:pt>
                <c:pt idx="111">
                  <c:v>88.869655455061704</c:v>
                </c:pt>
                <c:pt idx="112">
                  <c:v>90.998804181389701</c:v>
                </c:pt>
                <c:pt idx="113">
                  <c:v>90.489223677221801</c:v>
                </c:pt>
                <c:pt idx="114">
                  <c:v>89.968028661678403</c:v>
                </c:pt>
                <c:pt idx="115">
                  <c:v>88.304649421778805</c:v>
                </c:pt>
                <c:pt idx="116">
                  <c:v>83.5599289938868</c:v>
                </c:pt>
                <c:pt idx="117">
                  <c:v>86.018073731942096</c:v>
                </c:pt>
                <c:pt idx="118">
                  <c:v>83.665421829278898</c:v>
                </c:pt>
                <c:pt idx="119">
                  <c:v>88.202746551389396</c:v>
                </c:pt>
                <c:pt idx="120">
                  <c:v>91.890046420597002</c:v>
                </c:pt>
                <c:pt idx="121">
                  <c:v>86.314884234838004</c:v>
                </c:pt>
                <c:pt idx="122">
                  <c:v>90.373733776870793</c:v>
                </c:pt>
                <c:pt idx="123">
                  <c:v>87.901179060371206</c:v>
                </c:pt>
                <c:pt idx="124">
                  <c:v>91.103446423345702</c:v>
                </c:pt>
                <c:pt idx="125">
                  <c:v>94.434233837366094</c:v>
                </c:pt>
                <c:pt idx="126">
                  <c:v>90.230569630255104</c:v>
                </c:pt>
                <c:pt idx="127">
                  <c:v>89.648102241859903</c:v>
                </c:pt>
                <c:pt idx="128">
                  <c:v>95.700950905291094</c:v>
                </c:pt>
                <c:pt idx="129">
                  <c:v>95.357200275508902</c:v>
                </c:pt>
                <c:pt idx="130">
                  <c:v>83.278229903239804</c:v>
                </c:pt>
                <c:pt idx="131">
                  <c:v>90.7509995855021</c:v>
                </c:pt>
                <c:pt idx="132">
                  <c:v>90.489324981541102</c:v>
                </c:pt>
                <c:pt idx="133">
                  <c:v>88.5494693353331</c:v>
                </c:pt>
                <c:pt idx="134">
                  <c:v>84.682579356917302</c:v>
                </c:pt>
                <c:pt idx="135">
                  <c:v>82.290650454226594</c:v>
                </c:pt>
                <c:pt idx="136">
                  <c:v>91.732396329549601</c:v>
                </c:pt>
                <c:pt idx="137">
                  <c:v>92.075522080487403</c:v>
                </c:pt>
                <c:pt idx="138">
                  <c:v>91.492020323014302</c:v>
                </c:pt>
                <c:pt idx="139">
                  <c:v>90.013970576805605</c:v>
                </c:pt>
                <c:pt idx="140">
                  <c:v>90.262578724632803</c:v>
                </c:pt>
                <c:pt idx="141">
                  <c:v>86.667195710425204</c:v>
                </c:pt>
                <c:pt idx="142">
                  <c:v>94.186998030616707</c:v>
                </c:pt>
                <c:pt idx="143">
                  <c:v>92.594957772846897</c:v>
                </c:pt>
                <c:pt idx="144">
                  <c:v>89.469646817556594</c:v>
                </c:pt>
                <c:pt idx="145">
                  <c:v>94.672604608231197</c:v>
                </c:pt>
                <c:pt idx="146">
                  <c:v>85.756840823772706</c:v>
                </c:pt>
                <c:pt idx="147">
                  <c:v>82.917543806703605</c:v>
                </c:pt>
                <c:pt idx="148">
                  <c:v>92.218875414053102</c:v>
                </c:pt>
                <c:pt idx="149">
                  <c:v>90.046078736930795</c:v>
                </c:pt>
                <c:pt idx="150">
                  <c:v>86.654783735774402</c:v>
                </c:pt>
                <c:pt idx="151">
                  <c:v>94.553676291583301</c:v>
                </c:pt>
                <c:pt idx="152">
                  <c:v>87.8733162704618</c:v>
                </c:pt>
                <c:pt idx="153">
                  <c:v>86.490411808243394</c:v>
                </c:pt>
                <c:pt idx="154">
                  <c:v>93.891381193968101</c:v>
                </c:pt>
                <c:pt idx="155">
                  <c:v>83.502187897114297</c:v>
                </c:pt>
                <c:pt idx="156">
                  <c:v>88.875766732588104</c:v>
                </c:pt>
                <c:pt idx="157">
                  <c:v>82.160373107647601</c:v>
                </c:pt>
                <c:pt idx="158">
                  <c:v>87.710888181429397</c:v>
                </c:pt>
                <c:pt idx="159">
                  <c:v>87.5504774387597</c:v>
                </c:pt>
                <c:pt idx="160">
                  <c:v>93.551531012872402</c:v>
                </c:pt>
                <c:pt idx="161">
                  <c:v>93.466073618001701</c:v>
                </c:pt>
                <c:pt idx="162">
                  <c:v>93.060906397246796</c:v>
                </c:pt>
                <c:pt idx="163">
                  <c:v>98.751769127486895</c:v>
                </c:pt>
                <c:pt idx="164">
                  <c:v>84.778924242707305</c:v>
                </c:pt>
                <c:pt idx="165">
                  <c:v>88.2331427774525</c:v>
                </c:pt>
                <c:pt idx="166">
                  <c:v>95.762727967347004</c:v>
                </c:pt>
                <c:pt idx="167">
                  <c:v>87.540134478599995</c:v>
                </c:pt>
                <c:pt idx="168">
                  <c:v>81.585946748016198</c:v>
                </c:pt>
                <c:pt idx="169">
                  <c:v>89.771720904384097</c:v>
                </c:pt>
                <c:pt idx="170">
                  <c:v>88.887610900235003</c:v>
                </c:pt>
                <c:pt idx="171">
                  <c:v>91.506798761986801</c:v>
                </c:pt>
                <c:pt idx="172">
                  <c:v>91.472049774043995</c:v>
                </c:pt>
                <c:pt idx="173">
                  <c:v>93.438121131142907</c:v>
                </c:pt>
                <c:pt idx="174">
                  <c:v>87.311887315891695</c:v>
                </c:pt>
                <c:pt idx="175">
                  <c:v>88.414068305737501</c:v>
                </c:pt>
                <c:pt idx="176">
                  <c:v>85.8598078941463</c:v>
                </c:pt>
                <c:pt idx="177">
                  <c:v>94.624317098453403</c:v>
                </c:pt>
                <c:pt idx="178">
                  <c:v>87.975805862272395</c:v>
                </c:pt>
                <c:pt idx="179">
                  <c:v>93.489856341977202</c:v>
                </c:pt>
                <c:pt idx="180">
                  <c:v>77.098541998850607</c:v>
                </c:pt>
                <c:pt idx="181">
                  <c:v>88.9671900210231</c:v>
                </c:pt>
                <c:pt idx="182">
                  <c:v>86.500245738140194</c:v>
                </c:pt>
                <c:pt idx="183">
                  <c:v>86.556341522361095</c:v>
                </c:pt>
                <c:pt idx="184">
                  <c:v>85.887173234713799</c:v>
                </c:pt>
                <c:pt idx="185">
                  <c:v>88.507436124475902</c:v>
                </c:pt>
                <c:pt idx="186">
                  <c:v>90.956723169741593</c:v>
                </c:pt>
                <c:pt idx="187">
                  <c:v>85.868970366167702</c:v>
                </c:pt>
                <c:pt idx="188">
                  <c:v>85.459206072711893</c:v>
                </c:pt>
                <c:pt idx="189">
                  <c:v>96.897343406422706</c:v>
                </c:pt>
                <c:pt idx="190">
                  <c:v>88.798175419754301</c:v>
                </c:pt>
                <c:pt idx="191">
                  <c:v>86.904555293412599</c:v>
                </c:pt>
                <c:pt idx="192">
                  <c:v>86.355107720230293</c:v>
                </c:pt>
                <c:pt idx="193">
                  <c:v>94.614170881297994</c:v>
                </c:pt>
                <c:pt idx="194">
                  <c:v>90.876273385514395</c:v>
                </c:pt>
                <c:pt idx="195">
                  <c:v>87.008320234173695</c:v>
                </c:pt>
                <c:pt idx="196">
                  <c:v>92.929610075812207</c:v>
                </c:pt>
                <c:pt idx="197">
                  <c:v>87.519360800746497</c:v>
                </c:pt>
                <c:pt idx="198">
                  <c:v>91.066683843241705</c:v>
                </c:pt>
                <c:pt idx="199">
                  <c:v>94.175921332351393</c:v>
                </c:pt>
                <c:pt idx="200">
                  <c:v>97.488363573638793</c:v>
                </c:pt>
                <c:pt idx="201">
                  <c:v>72.801920912415994</c:v>
                </c:pt>
                <c:pt idx="202">
                  <c:v>82.695257455965702</c:v>
                </c:pt>
                <c:pt idx="203">
                  <c:v>92.062253348399807</c:v>
                </c:pt>
                <c:pt idx="204">
                  <c:v>80.594870336877705</c:v>
                </c:pt>
                <c:pt idx="205">
                  <c:v>84.422766534267495</c:v>
                </c:pt>
                <c:pt idx="206">
                  <c:v>88.204646431988394</c:v>
                </c:pt>
                <c:pt idx="207">
                  <c:v>88.5647627270762</c:v>
                </c:pt>
                <c:pt idx="208">
                  <c:v>85.769198570225299</c:v>
                </c:pt>
                <c:pt idx="209">
                  <c:v>85.392423901978802</c:v>
                </c:pt>
                <c:pt idx="210">
                  <c:v>87.564031895764302</c:v>
                </c:pt>
                <c:pt idx="211">
                  <c:v>86.418810277099297</c:v>
                </c:pt>
                <c:pt idx="212">
                  <c:v>92.534620724845894</c:v>
                </c:pt>
                <c:pt idx="213">
                  <c:v>86.077576341887294</c:v>
                </c:pt>
                <c:pt idx="214">
                  <c:v>90.906701872548297</c:v>
                </c:pt>
                <c:pt idx="215">
                  <c:v>85.1247110673267</c:v>
                </c:pt>
                <c:pt idx="216">
                  <c:v>96.337963667670905</c:v>
                </c:pt>
                <c:pt idx="217">
                  <c:v>86.588876538180997</c:v>
                </c:pt>
                <c:pt idx="218">
                  <c:v>77.840304290646401</c:v>
                </c:pt>
                <c:pt idx="219">
                  <c:v>89.671951759145699</c:v>
                </c:pt>
                <c:pt idx="220">
                  <c:v>80.1161500700197</c:v>
                </c:pt>
                <c:pt idx="221">
                  <c:v>85.541928696640099</c:v>
                </c:pt>
                <c:pt idx="222">
                  <c:v>82.201342726169202</c:v>
                </c:pt>
                <c:pt idx="223">
                  <c:v>79.850386234087097</c:v>
                </c:pt>
                <c:pt idx="224">
                  <c:v>84.363305081105295</c:v>
                </c:pt>
                <c:pt idx="225">
                  <c:v>88.355760798511596</c:v>
                </c:pt>
                <c:pt idx="226">
                  <c:v>82.169992906623804</c:v>
                </c:pt>
                <c:pt idx="227">
                  <c:v>86.721304805047197</c:v>
                </c:pt>
                <c:pt idx="228">
                  <c:v>84.879833169587997</c:v>
                </c:pt>
                <c:pt idx="229">
                  <c:v>79.930486716805206</c:v>
                </c:pt>
                <c:pt idx="230">
                  <c:v>72.970451931186801</c:v>
                </c:pt>
                <c:pt idx="231">
                  <c:v>86.967056813075601</c:v>
                </c:pt>
                <c:pt idx="232">
                  <c:v>84.868859664943301</c:v>
                </c:pt>
                <c:pt idx="233">
                  <c:v>82.379389847749295</c:v>
                </c:pt>
              </c:numCache>
            </c:numRef>
          </c:xVal>
          <c:yVal>
            <c:numRef>
              <c:f>inrae!$I$2:$I$248</c:f>
              <c:numCache>
                <c:formatCode>0.00</c:formatCode>
                <c:ptCount val="247"/>
                <c:pt idx="0">
                  <c:v>0.470334050037444</c:v>
                </c:pt>
                <c:pt idx="1">
                  <c:v>0.383184574598536</c:v>
                </c:pt>
                <c:pt idx="2">
                  <c:v>0.33525162267395697</c:v>
                </c:pt>
                <c:pt idx="3">
                  <c:v>0.400327637121831</c:v>
                </c:pt>
                <c:pt idx="4">
                  <c:v>0.177943019497631</c:v>
                </c:pt>
                <c:pt idx="5">
                  <c:v>0.16395216670716101</c:v>
                </c:pt>
                <c:pt idx="6">
                  <c:v>5.2850061707337602E-2</c:v>
                </c:pt>
                <c:pt idx="7">
                  <c:v>0.17081130408207601</c:v>
                </c:pt>
                <c:pt idx="8">
                  <c:v>9.6142437781944506E-2</c:v>
                </c:pt>
                <c:pt idx="9">
                  <c:v>0.14784971516457099</c:v>
                </c:pt>
                <c:pt idx="10">
                  <c:v>0.15721557300726899</c:v>
                </c:pt>
                <c:pt idx="11">
                  <c:v>0.124974486442199</c:v>
                </c:pt>
                <c:pt idx="12">
                  <c:v>0.197640512799242</c:v>
                </c:pt>
                <c:pt idx="13">
                  <c:v>0.22797206623744901</c:v>
                </c:pt>
                <c:pt idx="14">
                  <c:v>0.23654573424244699</c:v>
                </c:pt>
                <c:pt idx="15">
                  <c:v>0.24704067112435599</c:v>
                </c:pt>
                <c:pt idx="16">
                  <c:v>0.55377586113852995</c:v>
                </c:pt>
                <c:pt idx="17">
                  <c:v>0.36433998446044602</c:v>
                </c:pt>
                <c:pt idx="18">
                  <c:v>0.33468918095442102</c:v>
                </c:pt>
                <c:pt idx="19">
                  <c:v>0.30860317172810903</c:v>
                </c:pt>
                <c:pt idx="20">
                  <c:v>0.26890957135896698</c:v>
                </c:pt>
                <c:pt idx="21">
                  <c:v>0.30372696944731897</c:v>
                </c:pt>
                <c:pt idx="22">
                  <c:v>0.247016055846428</c:v>
                </c:pt>
                <c:pt idx="23">
                  <c:v>0.28682948240786599</c:v>
                </c:pt>
                <c:pt idx="24">
                  <c:v>0.17885900308307001</c:v>
                </c:pt>
                <c:pt idx="25">
                  <c:v>0.23797154658929201</c:v>
                </c:pt>
                <c:pt idx="26">
                  <c:v>0.30189691870441798</c:v>
                </c:pt>
                <c:pt idx="27">
                  <c:v>0.29087988465132503</c:v>
                </c:pt>
                <c:pt idx="28">
                  <c:v>0.24366201946028401</c:v>
                </c:pt>
                <c:pt idx="29">
                  <c:v>0.33803630137979201</c:v>
                </c:pt>
                <c:pt idx="30">
                  <c:v>0.32783144229219902</c:v>
                </c:pt>
                <c:pt idx="31">
                  <c:v>0.30335674513432498</c:v>
                </c:pt>
                <c:pt idx="32">
                  <c:v>0.115062140277499</c:v>
                </c:pt>
                <c:pt idx="33">
                  <c:v>0.25184870215552002</c:v>
                </c:pt>
                <c:pt idx="34">
                  <c:v>0.20680293273295799</c:v>
                </c:pt>
                <c:pt idx="35">
                  <c:v>0.35987518197034601</c:v>
                </c:pt>
                <c:pt idx="36">
                  <c:v>0.20238602656629301</c:v>
                </c:pt>
                <c:pt idx="37">
                  <c:v>0.27968285137697702</c:v>
                </c:pt>
                <c:pt idx="38">
                  <c:v>0.37775929545981501</c:v>
                </c:pt>
                <c:pt idx="39">
                  <c:v>0.20515170767942301</c:v>
                </c:pt>
                <c:pt idx="40">
                  <c:v>0.29768892542949599</c:v>
                </c:pt>
                <c:pt idx="41">
                  <c:v>0.33785678322047102</c:v>
                </c:pt>
                <c:pt idx="42">
                  <c:v>0.238260343502811</c:v>
                </c:pt>
                <c:pt idx="43">
                  <c:v>0.245430865500505</c:v>
                </c:pt>
                <c:pt idx="44">
                  <c:v>0.26770821033324199</c:v>
                </c:pt>
                <c:pt idx="45">
                  <c:v>0.23093887084704201</c:v>
                </c:pt>
                <c:pt idx="46">
                  <c:v>0.34677137432128302</c:v>
                </c:pt>
                <c:pt idx="47">
                  <c:v>0.27962533794418898</c:v>
                </c:pt>
                <c:pt idx="48">
                  <c:v>0.33158001793867498</c:v>
                </c:pt>
                <c:pt idx="49">
                  <c:v>0.47018820835040898</c:v>
                </c:pt>
                <c:pt idx="50">
                  <c:v>0.31271610234362202</c:v>
                </c:pt>
                <c:pt idx="51">
                  <c:v>0.24399009180773201</c:v>
                </c:pt>
                <c:pt idx="52">
                  <c:v>0.21747325940571499</c:v>
                </c:pt>
                <c:pt idx="53">
                  <c:v>0.23710563429950199</c:v>
                </c:pt>
                <c:pt idx="54">
                  <c:v>0.19786124568501201</c:v>
                </c:pt>
                <c:pt idx="55">
                  <c:v>0.32822300969594498</c:v>
                </c:pt>
                <c:pt idx="56">
                  <c:v>0.248642132402809</c:v>
                </c:pt>
                <c:pt idx="57">
                  <c:v>0.28880517064658101</c:v>
                </c:pt>
                <c:pt idx="58">
                  <c:v>0.283348704072589</c:v>
                </c:pt>
                <c:pt idx="59">
                  <c:v>0.32913309450358802</c:v>
                </c:pt>
                <c:pt idx="60">
                  <c:v>0.24316349230415399</c:v>
                </c:pt>
                <c:pt idx="61">
                  <c:v>0.29604238900923902</c:v>
                </c:pt>
                <c:pt idx="62">
                  <c:v>0.34244859023204299</c:v>
                </c:pt>
                <c:pt idx="63">
                  <c:v>0.33752823439185897</c:v>
                </c:pt>
                <c:pt idx="64">
                  <c:v>0.22137643944663499</c:v>
                </c:pt>
                <c:pt idx="65">
                  <c:v>0.26833662789240398</c:v>
                </c:pt>
                <c:pt idx="66">
                  <c:v>0.23315170804650501</c:v>
                </c:pt>
                <c:pt idx="67">
                  <c:v>0.173702752109197</c:v>
                </c:pt>
                <c:pt idx="68">
                  <c:v>0.26656325629260502</c:v>
                </c:pt>
                <c:pt idx="69">
                  <c:v>0.30337663411780602</c:v>
                </c:pt>
                <c:pt idx="70">
                  <c:v>0.28818745487615999</c:v>
                </c:pt>
                <c:pt idx="71">
                  <c:v>0.27126204722724401</c:v>
                </c:pt>
                <c:pt idx="72">
                  <c:v>0.20193523391285501</c:v>
                </c:pt>
                <c:pt idx="73">
                  <c:v>0.347776165490296</c:v>
                </c:pt>
                <c:pt idx="74">
                  <c:v>0.347882758933651</c:v>
                </c:pt>
                <c:pt idx="75">
                  <c:v>0.28319058687801402</c:v>
                </c:pt>
                <c:pt idx="76">
                  <c:v>0.31895809525725799</c:v>
                </c:pt>
                <c:pt idx="77">
                  <c:v>0.256763624738306</c:v>
                </c:pt>
                <c:pt idx="78">
                  <c:v>0.27510530479783402</c:v>
                </c:pt>
                <c:pt idx="79">
                  <c:v>0.351320909544169</c:v>
                </c:pt>
                <c:pt idx="80">
                  <c:v>0.16934541775638101</c:v>
                </c:pt>
                <c:pt idx="81">
                  <c:v>0.30341574237992902</c:v>
                </c:pt>
                <c:pt idx="82">
                  <c:v>0.27742948604526002</c:v>
                </c:pt>
                <c:pt idx="83">
                  <c:v>0.24690893706691699</c:v>
                </c:pt>
                <c:pt idx="84">
                  <c:v>0.318447295134896</c:v>
                </c:pt>
                <c:pt idx="85">
                  <c:v>0.18274635885823601</c:v>
                </c:pt>
                <c:pt idx="86">
                  <c:v>0.110898726139144</c:v>
                </c:pt>
                <c:pt idx="87">
                  <c:v>0.19626525315610899</c:v>
                </c:pt>
                <c:pt idx="88">
                  <c:v>0.19321697412039299</c:v>
                </c:pt>
                <c:pt idx="89">
                  <c:v>0.29415082648815499</c:v>
                </c:pt>
                <c:pt idx="90">
                  <c:v>0.28293628792543402</c:v>
                </c:pt>
                <c:pt idx="91">
                  <c:v>0.19985444477214601</c:v>
                </c:pt>
                <c:pt idx="92">
                  <c:v>0.42663500109760599</c:v>
                </c:pt>
                <c:pt idx="93">
                  <c:v>0.36161741432252598</c:v>
                </c:pt>
                <c:pt idx="94">
                  <c:v>0.240569140278936</c:v>
                </c:pt>
                <c:pt idx="95">
                  <c:v>0.35021294180275397</c:v>
                </c:pt>
                <c:pt idx="96">
                  <c:v>0.26602673094024598</c:v>
                </c:pt>
                <c:pt idx="97">
                  <c:v>0.210844824839068</c:v>
                </c:pt>
                <c:pt idx="98">
                  <c:v>0.25407293454364199</c:v>
                </c:pt>
                <c:pt idx="99">
                  <c:v>0.167743408479686</c:v>
                </c:pt>
                <c:pt idx="100">
                  <c:v>0.34243762125767901</c:v>
                </c:pt>
                <c:pt idx="101">
                  <c:v>0.33739367917294799</c:v>
                </c:pt>
                <c:pt idx="102">
                  <c:v>0.188979842689145</c:v>
                </c:pt>
                <c:pt idx="103">
                  <c:v>0.34732201024679898</c:v>
                </c:pt>
                <c:pt idx="104">
                  <c:v>0.31164490033626802</c:v>
                </c:pt>
                <c:pt idx="105">
                  <c:v>0.303386538666162</c:v>
                </c:pt>
                <c:pt idx="106">
                  <c:v>0.19924030806423901</c:v>
                </c:pt>
                <c:pt idx="107">
                  <c:v>8.8682351814771895E-2</c:v>
                </c:pt>
                <c:pt idx="108">
                  <c:v>0.33726637858026398</c:v>
                </c:pt>
                <c:pt idx="109">
                  <c:v>0.19392996085465899</c:v>
                </c:pt>
                <c:pt idx="110">
                  <c:v>0.27704849905578099</c:v>
                </c:pt>
                <c:pt idx="111">
                  <c:v>0.238849989405062</c:v>
                </c:pt>
                <c:pt idx="112">
                  <c:v>0.28680235891115902</c:v>
                </c:pt>
                <c:pt idx="113">
                  <c:v>0.37303685887766203</c:v>
                </c:pt>
                <c:pt idx="114">
                  <c:v>0.241205952980896</c:v>
                </c:pt>
                <c:pt idx="115">
                  <c:v>0.24425733897702301</c:v>
                </c:pt>
                <c:pt idx="116">
                  <c:v>0.19177432588524501</c:v>
                </c:pt>
                <c:pt idx="117">
                  <c:v>0.26514086746131399</c:v>
                </c:pt>
                <c:pt idx="118">
                  <c:v>0.271466092002276</c:v>
                </c:pt>
                <c:pt idx="119">
                  <c:v>0.28349146222247001</c:v>
                </c:pt>
                <c:pt idx="120">
                  <c:v>0.29639301661928802</c:v>
                </c:pt>
                <c:pt idx="121">
                  <c:v>0.34768909539182902</c:v>
                </c:pt>
                <c:pt idx="122">
                  <c:v>0.21290520272664301</c:v>
                </c:pt>
                <c:pt idx="123">
                  <c:v>0.28532312080965</c:v>
                </c:pt>
                <c:pt idx="124">
                  <c:v>0.22994653062468501</c:v>
                </c:pt>
                <c:pt idx="125">
                  <c:v>0.14620240395751799</c:v>
                </c:pt>
                <c:pt idx="126">
                  <c:v>0.26202975010151502</c:v>
                </c:pt>
                <c:pt idx="127">
                  <c:v>0.26652847101577998</c:v>
                </c:pt>
                <c:pt idx="128">
                  <c:v>0.27743494367064903</c:v>
                </c:pt>
                <c:pt idx="129">
                  <c:v>0.17251567232715601</c:v>
                </c:pt>
                <c:pt idx="130">
                  <c:v>0.168531211447281</c:v>
                </c:pt>
                <c:pt idx="131">
                  <c:v>0.24670287932871901</c:v>
                </c:pt>
                <c:pt idx="132">
                  <c:v>0.362741150497638</c:v>
                </c:pt>
                <c:pt idx="133">
                  <c:v>0.54917630373298998</c:v>
                </c:pt>
                <c:pt idx="134">
                  <c:v>0.41246199427543101</c:v>
                </c:pt>
                <c:pt idx="135">
                  <c:v>0.230321902211298</c:v>
                </c:pt>
                <c:pt idx="136">
                  <c:v>0.15459481786353199</c:v>
                </c:pt>
                <c:pt idx="137">
                  <c:v>0.22665119963604599</c:v>
                </c:pt>
                <c:pt idx="138">
                  <c:v>0.26697078896443999</c:v>
                </c:pt>
                <c:pt idx="139">
                  <c:v>0.195216217079591</c:v>
                </c:pt>
                <c:pt idx="140">
                  <c:v>0.22656459654480501</c:v>
                </c:pt>
                <c:pt idx="141">
                  <c:v>0.21453791006284101</c:v>
                </c:pt>
                <c:pt idx="142">
                  <c:v>0.23225388798026</c:v>
                </c:pt>
                <c:pt idx="143">
                  <c:v>0.29072156810115302</c:v>
                </c:pt>
                <c:pt idx="144">
                  <c:v>0.26967186608216498</c:v>
                </c:pt>
                <c:pt idx="145">
                  <c:v>0.18423806723848399</c:v>
                </c:pt>
                <c:pt idx="146">
                  <c:v>0.24909523586093299</c:v>
                </c:pt>
                <c:pt idx="147">
                  <c:v>0.30276841516702002</c:v>
                </c:pt>
                <c:pt idx="148">
                  <c:v>0.33852469737444402</c:v>
                </c:pt>
                <c:pt idx="149">
                  <c:v>0.25138029246877402</c:v>
                </c:pt>
                <c:pt idx="150">
                  <c:v>0.43444733600771501</c:v>
                </c:pt>
                <c:pt idx="151">
                  <c:v>0.20343504220870001</c:v>
                </c:pt>
                <c:pt idx="152">
                  <c:v>0.14707491955231</c:v>
                </c:pt>
                <c:pt idx="153">
                  <c:v>0.25676582928910002</c:v>
                </c:pt>
                <c:pt idx="154">
                  <c:v>0.19649340776145299</c:v>
                </c:pt>
                <c:pt idx="155">
                  <c:v>0.28529454883737898</c:v>
                </c:pt>
                <c:pt idx="156">
                  <c:v>0.18268164856756999</c:v>
                </c:pt>
                <c:pt idx="157">
                  <c:v>0.46889659264415801</c:v>
                </c:pt>
                <c:pt idx="158">
                  <c:v>0.23150417112451299</c:v>
                </c:pt>
                <c:pt idx="159">
                  <c:v>0.34118325236417002</c:v>
                </c:pt>
                <c:pt idx="160">
                  <c:v>0.26842494004203699</c:v>
                </c:pt>
                <c:pt idx="161">
                  <c:v>0.209670383518198</c:v>
                </c:pt>
                <c:pt idx="162">
                  <c:v>0.29251899062001202</c:v>
                </c:pt>
                <c:pt idx="163">
                  <c:v>0.26230126700471101</c:v>
                </c:pt>
                <c:pt idx="164">
                  <c:v>0.17603926249843499</c:v>
                </c:pt>
                <c:pt idx="165">
                  <c:v>0.33927677762458203</c:v>
                </c:pt>
                <c:pt idx="166">
                  <c:v>0.33416490193582998</c:v>
                </c:pt>
                <c:pt idx="167">
                  <c:v>0.248864404753739</c:v>
                </c:pt>
                <c:pt idx="168">
                  <c:v>0.305030649992029</c:v>
                </c:pt>
                <c:pt idx="169">
                  <c:v>0.25655185022231602</c:v>
                </c:pt>
                <c:pt idx="170">
                  <c:v>0.27228584358167701</c:v>
                </c:pt>
                <c:pt idx="171">
                  <c:v>0.24219428182070299</c:v>
                </c:pt>
                <c:pt idx="172">
                  <c:v>0.24833504370155701</c:v>
                </c:pt>
                <c:pt idx="173">
                  <c:v>0.233911521195865</c:v>
                </c:pt>
                <c:pt idx="174">
                  <c:v>0.25358225784864202</c:v>
                </c:pt>
                <c:pt idx="175">
                  <c:v>0.23276661229839199</c:v>
                </c:pt>
                <c:pt idx="176">
                  <c:v>0.266955175343349</c:v>
                </c:pt>
                <c:pt idx="177">
                  <c:v>0.25308932339110701</c:v>
                </c:pt>
                <c:pt idx="178">
                  <c:v>0.19027223533573701</c:v>
                </c:pt>
                <c:pt idx="179">
                  <c:v>0.240005303736543</c:v>
                </c:pt>
                <c:pt idx="180">
                  <c:v>0.31842187383305098</c:v>
                </c:pt>
                <c:pt idx="181">
                  <c:v>0.20048673810923801</c:v>
                </c:pt>
                <c:pt idx="182">
                  <c:v>0.36919065178409599</c:v>
                </c:pt>
                <c:pt idx="183">
                  <c:v>0.27272024194306499</c:v>
                </c:pt>
                <c:pt idx="184">
                  <c:v>0.39432904851661299</c:v>
                </c:pt>
                <c:pt idx="185">
                  <c:v>0.20436688584944701</c:v>
                </c:pt>
                <c:pt idx="186">
                  <c:v>0.20757485733138201</c:v>
                </c:pt>
                <c:pt idx="187">
                  <c:v>0.22060270519985301</c:v>
                </c:pt>
                <c:pt idx="188">
                  <c:v>0.250234864976356</c:v>
                </c:pt>
                <c:pt idx="189">
                  <c:v>0.208283845417918</c:v>
                </c:pt>
                <c:pt idx="190">
                  <c:v>0.19726195699173099</c:v>
                </c:pt>
                <c:pt idx="191">
                  <c:v>0.22754356569762901</c:v>
                </c:pt>
                <c:pt idx="192">
                  <c:v>0.25273308185478899</c:v>
                </c:pt>
                <c:pt idx="193">
                  <c:v>0.18670609569697599</c:v>
                </c:pt>
                <c:pt idx="194">
                  <c:v>0.30619414837325998</c:v>
                </c:pt>
                <c:pt idx="195">
                  <c:v>0.33172462292861299</c:v>
                </c:pt>
                <c:pt idx="196">
                  <c:v>0.28875737487182701</c:v>
                </c:pt>
                <c:pt idx="197">
                  <c:v>0.272912803831798</c:v>
                </c:pt>
                <c:pt idx="198">
                  <c:v>0.33050507284988001</c:v>
                </c:pt>
                <c:pt idx="199">
                  <c:v>0.23601114952666999</c:v>
                </c:pt>
                <c:pt idx="200">
                  <c:v>0.277554154449348</c:v>
                </c:pt>
                <c:pt idx="201">
                  <c:v>0.28015587958615101</c:v>
                </c:pt>
                <c:pt idx="202">
                  <c:v>0.22566449051714299</c:v>
                </c:pt>
                <c:pt idx="203">
                  <c:v>0.13255300854385099</c:v>
                </c:pt>
                <c:pt idx="204">
                  <c:v>0.350657864099854</c:v>
                </c:pt>
                <c:pt idx="205">
                  <c:v>0.32388639888417797</c:v>
                </c:pt>
                <c:pt idx="206">
                  <c:v>0.29633159025278399</c:v>
                </c:pt>
                <c:pt idx="207">
                  <c:v>0.32136299893195802</c:v>
                </c:pt>
                <c:pt idx="208">
                  <c:v>0.299962577612501</c:v>
                </c:pt>
                <c:pt idx="209">
                  <c:v>0.28703674663304002</c:v>
                </c:pt>
                <c:pt idx="210">
                  <c:v>0.236634081147334</c:v>
                </c:pt>
                <c:pt idx="211">
                  <c:v>0.30279184879354099</c:v>
                </c:pt>
                <c:pt idx="212">
                  <c:v>0.22233905308997801</c:v>
                </c:pt>
                <c:pt idx="213">
                  <c:v>0.27987900027776802</c:v>
                </c:pt>
                <c:pt idx="214">
                  <c:v>0.26318802164058802</c:v>
                </c:pt>
                <c:pt idx="215">
                  <c:v>0.23315942992035499</c:v>
                </c:pt>
                <c:pt idx="216">
                  <c:v>0.30322276342022703</c:v>
                </c:pt>
                <c:pt idx="217">
                  <c:v>0.12914997666952799</c:v>
                </c:pt>
                <c:pt idx="218">
                  <c:v>0.21536616305108999</c:v>
                </c:pt>
                <c:pt idx="219">
                  <c:v>0.35420033362403802</c:v>
                </c:pt>
                <c:pt idx="220">
                  <c:v>0.29882608484499701</c:v>
                </c:pt>
                <c:pt idx="221">
                  <c:v>0.328639920500224</c:v>
                </c:pt>
                <c:pt idx="222">
                  <c:v>0.28411471876146599</c:v>
                </c:pt>
                <c:pt idx="223">
                  <c:v>0.25651896317695799</c:v>
                </c:pt>
                <c:pt idx="224">
                  <c:v>0.279183599475049</c:v>
                </c:pt>
                <c:pt idx="225">
                  <c:v>0.153859567790427</c:v>
                </c:pt>
                <c:pt idx="226">
                  <c:v>0.20601887239927399</c:v>
                </c:pt>
                <c:pt idx="227">
                  <c:v>0.31324163056101501</c:v>
                </c:pt>
                <c:pt idx="228">
                  <c:v>0.37765811083087703</c:v>
                </c:pt>
                <c:pt idx="229">
                  <c:v>0.28245779335759302</c:v>
                </c:pt>
                <c:pt idx="230">
                  <c:v>0.36180611301858501</c:v>
                </c:pt>
                <c:pt idx="231">
                  <c:v>0.268449764687127</c:v>
                </c:pt>
                <c:pt idx="232">
                  <c:v>0.33622607510799402</c:v>
                </c:pt>
                <c:pt idx="233">
                  <c:v>0.28746093742954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C9F-1F42-ACEE-296D2155E8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5328240"/>
        <c:axId val="535332160"/>
      </c:scatterChart>
      <c:valAx>
        <c:axId val="535328240"/>
        <c:scaling>
          <c:orientation val="minMax"/>
          <c:max val="100"/>
          <c:min val="4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/>
                  <a:t>FF</a:t>
                </a:r>
                <a:r>
                  <a:rPr lang="fr-FR" baseline="-20000" dirty="0"/>
                  <a:t>T0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baseline="-20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32160"/>
        <c:crosses val="autoZero"/>
        <c:crossBetween val="midCat"/>
        <c:majorUnit val="10"/>
      </c:valAx>
      <c:valAx>
        <c:axId val="535332160"/>
        <c:scaling>
          <c:orientation val="minMax"/>
          <c:max val="0.7000000000000000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F</a:t>
                </a:r>
                <a:r>
                  <a:rPr lang="en-US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</a:p>
            </c:rich>
          </c:tx>
          <c:layout>
            <c:manualLayout>
              <c:xMode val="edge"/>
              <c:yMode val="edge"/>
              <c:x val="6.5106903484911091E-2"/>
              <c:y val="0.2973876452627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82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82943362519511"/>
          <c:y val="0.17171296296296296"/>
          <c:w val="0.5176085115277882"/>
          <c:h val="0.63197543015456403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H$1</c:f>
              <c:strCache>
                <c:ptCount val="1"/>
                <c:pt idx="0">
                  <c:v>FF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D$2:$D$248</c:f>
              <c:numCache>
                <c:formatCode>0.0</c:formatCode>
                <c:ptCount val="247"/>
                <c:pt idx="0">
                  <c:v>54.091999999999999</c:v>
                </c:pt>
                <c:pt idx="1">
                  <c:v>54.888000000000012</c:v>
                </c:pt>
                <c:pt idx="2">
                  <c:v>44.072000000000003</c:v>
                </c:pt>
                <c:pt idx="3">
                  <c:v>65.307999999999993</c:v>
                </c:pt>
                <c:pt idx="4">
                  <c:v>78.906000000000006</c:v>
                </c:pt>
                <c:pt idx="5">
                  <c:v>62.288000000000011</c:v>
                </c:pt>
                <c:pt idx="6">
                  <c:v>60.125999999999998</c:v>
                </c:pt>
                <c:pt idx="7">
                  <c:v>150.57</c:v>
                </c:pt>
                <c:pt idx="8">
                  <c:v>196.09200000000001</c:v>
                </c:pt>
                <c:pt idx="9">
                  <c:v>58.048000000000002</c:v>
                </c:pt>
                <c:pt idx="10">
                  <c:v>51.660000000000004</c:v>
                </c:pt>
                <c:pt idx="11">
                  <c:v>64.462000000000003</c:v>
                </c:pt>
                <c:pt idx="12">
                  <c:v>85.156000000000006</c:v>
                </c:pt>
                <c:pt idx="13">
                  <c:v>77.543999999999997</c:v>
                </c:pt>
                <c:pt idx="14">
                  <c:v>61.605999999999995</c:v>
                </c:pt>
                <c:pt idx="15">
                  <c:v>53.775999999999996</c:v>
                </c:pt>
                <c:pt idx="16">
                  <c:v>88.957999999999998</c:v>
                </c:pt>
                <c:pt idx="17">
                  <c:v>49.134</c:v>
                </c:pt>
                <c:pt idx="18">
                  <c:v>61.370000000000005</c:v>
                </c:pt>
                <c:pt idx="19">
                  <c:v>71.242000000000004</c:v>
                </c:pt>
                <c:pt idx="20">
                  <c:v>61.905999999999992</c:v>
                </c:pt>
                <c:pt idx="21">
                  <c:v>69.05</c:v>
                </c:pt>
                <c:pt idx="22">
                  <c:v>63.059999999999988</c:v>
                </c:pt>
                <c:pt idx="23">
                  <c:v>72.664000000000001</c:v>
                </c:pt>
                <c:pt idx="24">
                  <c:v>74.731999999999999</c:v>
                </c:pt>
                <c:pt idx="25">
                  <c:v>75.186000000000007</c:v>
                </c:pt>
                <c:pt idx="26">
                  <c:v>45.003999999999998</c:v>
                </c:pt>
                <c:pt idx="27">
                  <c:v>60.96</c:v>
                </c:pt>
                <c:pt idx="28">
                  <c:v>92.722000000000008</c:v>
                </c:pt>
                <c:pt idx="29">
                  <c:v>80.16</c:v>
                </c:pt>
                <c:pt idx="30">
                  <c:v>49.847999999999999</c:v>
                </c:pt>
                <c:pt idx="31">
                  <c:v>79.945999999999998</c:v>
                </c:pt>
                <c:pt idx="32">
                  <c:v>74.916000000000011</c:v>
                </c:pt>
                <c:pt idx="33">
                  <c:v>79.986000000000004</c:v>
                </c:pt>
                <c:pt idx="34">
                  <c:v>68.647999999999996</c:v>
                </c:pt>
                <c:pt idx="35">
                  <c:v>48.089999999999996</c:v>
                </c:pt>
                <c:pt idx="36">
                  <c:v>59.157999999999994</c:v>
                </c:pt>
                <c:pt idx="37">
                  <c:v>62.211999999999989</c:v>
                </c:pt>
                <c:pt idx="38">
                  <c:v>136.91800000000001</c:v>
                </c:pt>
                <c:pt idx="39">
                  <c:v>85.388000000000005</c:v>
                </c:pt>
                <c:pt idx="40">
                  <c:v>62.327999999999996</c:v>
                </c:pt>
                <c:pt idx="41">
                  <c:v>53.958000000000006</c:v>
                </c:pt>
                <c:pt idx="42">
                  <c:v>71.513999999999996</c:v>
                </c:pt>
                <c:pt idx="43">
                  <c:v>55.576000000000001</c:v>
                </c:pt>
                <c:pt idx="44">
                  <c:v>76.914000000000016</c:v>
                </c:pt>
                <c:pt idx="45">
                  <c:v>40.681999999999995</c:v>
                </c:pt>
                <c:pt idx="46">
                  <c:v>56.61</c:v>
                </c:pt>
                <c:pt idx="47">
                  <c:v>53.342000000000006</c:v>
                </c:pt>
                <c:pt idx="48">
                  <c:v>71.13</c:v>
                </c:pt>
                <c:pt idx="49">
                  <c:v>47.482000000000006</c:v>
                </c:pt>
                <c:pt idx="50">
                  <c:v>48.834000000000003</c:v>
                </c:pt>
                <c:pt idx="51">
                  <c:v>129.35599999999999</c:v>
                </c:pt>
                <c:pt idx="52">
                  <c:v>83.686000000000007</c:v>
                </c:pt>
                <c:pt idx="53">
                  <c:v>41.792000000000002</c:v>
                </c:pt>
                <c:pt idx="54">
                  <c:v>58.577999999999996</c:v>
                </c:pt>
                <c:pt idx="55">
                  <c:v>91.311999999999998</c:v>
                </c:pt>
                <c:pt idx="56">
                  <c:v>62.272000000000006</c:v>
                </c:pt>
                <c:pt idx="57">
                  <c:v>72.210000000000008</c:v>
                </c:pt>
                <c:pt idx="58">
                  <c:v>81.227999999999994</c:v>
                </c:pt>
                <c:pt idx="59">
                  <c:v>172.988</c:v>
                </c:pt>
                <c:pt idx="60">
                  <c:v>66.510000000000005</c:v>
                </c:pt>
                <c:pt idx="61">
                  <c:v>224.81399999999994</c:v>
                </c:pt>
                <c:pt idx="62">
                  <c:v>62.855999999999995</c:v>
                </c:pt>
                <c:pt idx="63">
                  <c:v>48.031999999999996</c:v>
                </c:pt>
                <c:pt idx="64">
                  <c:v>96.27</c:v>
                </c:pt>
                <c:pt idx="65">
                  <c:v>65.037999999999997</c:v>
                </c:pt>
                <c:pt idx="66">
                  <c:v>160.21199999999999</c:v>
                </c:pt>
                <c:pt idx="67">
                  <c:v>49.339999999999996</c:v>
                </c:pt>
                <c:pt idx="68">
                  <c:v>49.51</c:v>
                </c:pt>
                <c:pt idx="69">
                  <c:v>60.903999999999996</c:v>
                </c:pt>
                <c:pt idx="70">
                  <c:v>77.11</c:v>
                </c:pt>
                <c:pt idx="71">
                  <c:v>55.946000000000005</c:v>
                </c:pt>
                <c:pt idx="72">
                  <c:v>52.489999999999995</c:v>
                </c:pt>
                <c:pt idx="73">
                  <c:v>143.26799999999997</c:v>
                </c:pt>
                <c:pt idx="74">
                  <c:v>70.227999999999994</c:v>
                </c:pt>
                <c:pt idx="75">
                  <c:v>59.760000000000005</c:v>
                </c:pt>
                <c:pt idx="76">
                  <c:v>57.351999999999997</c:v>
                </c:pt>
                <c:pt idx="77">
                  <c:v>84.645999999999987</c:v>
                </c:pt>
                <c:pt idx="78">
                  <c:v>56.944000000000003</c:v>
                </c:pt>
                <c:pt idx="79">
                  <c:v>147.20599999999999</c:v>
                </c:pt>
                <c:pt idx="80">
                  <c:v>51.311999999999998</c:v>
                </c:pt>
                <c:pt idx="81">
                  <c:v>67.511999999999986</c:v>
                </c:pt>
                <c:pt idx="82">
                  <c:v>64.796000000000006</c:v>
                </c:pt>
                <c:pt idx="83">
                  <c:v>66.216000000000008</c:v>
                </c:pt>
                <c:pt idx="84">
                  <c:v>63.442000000000007</c:v>
                </c:pt>
                <c:pt idx="85">
                  <c:v>66.854000000000013</c:v>
                </c:pt>
                <c:pt idx="86">
                  <c:v>127.08600000000001</c:v>
                </c:pt>
                <c:pt idx="87">
                  <c:v>68.705999999999989</c:v>
                </c:pt>
                <c:pt idx="88">
                  <c:v>58.448</c:v>
                </c:pt>
                <c:pt idx="89">
                  <c:v>100.648</c:v>
                </c:pt>
                <c:pt idx="90">
                  <c:v>67.26400000000001</c:v>
                </c:pt>
                <c:pt idx="91">
                  <c:v>57.775999999999996</c:v>
                </c:pt>
                <c:pt idx="92">
                  <c:v>93.6</c:v>
                </c:pt>
                <c:pt idx="93">
                  <c:v>68.06</c:v>
                </c:pt>
                <c:pt idx="94">
                  <c:v>56.863999999999997</c:v>
                </c:pt>
                <c:pt idx="95">
                  <c:v>82.872</c:v>
                </c:pt>
                <c:pt idx="96">
                  <c:v>99.018000000000001</c:v>
                </c:pt>
                <c:pt idx="97">
                  <c:v>48.495999999999995</c:v>
                </c:pt>
                <c:pt idx="98">
                  <c:v>62.705999999999996</c:v>
                </c:pt>
                <c:pt idx="99">
                  <c:v>53.567999999999998</c:v>
                </c:pt>
                <c:pt idx="100">
                  <c:v>40.936</c:v>
                </c:pt>
                <c:pt idx="101">
                  <c:v>115.61800000000001</c:v>
                </c:pt>
                <c:pt idx="102">
                  <c:v>73.328000000000003</c:v>
                </c:pt>
                <c:pt idx="103">
                  <c:v>98.207999999999998</c:v>
                </c:pt>
                <c:pt idx="104">
                  <c:v>86.328000000000003</c:v>
                </c:pt>
                <c:pt idx="105">
                  <c:v>49.962000000000003</c:v>
                </c:pt>
                <c:pt idx="106">
                  <c:v>71.349999999999994</c:v>
                </c:pt>
                <c:pt idx="107">
                  <c:v>67.256</c:v>
                </c:pt>
                <c:pt idx="108">
                  <c:v>46.403999999999996</c:v>
                </c:pt>
                <c:pt idx="109">
                  <c:v>62.263999999999996</c:v>
                </c:pt>
                <c:pt idx="110">
                  <c:v>55.942000000000007</c:v>
                </c:pt>
                <c:pt idx="111">
                  <c:v>60.844000000000008</c:v>
                </c:pt>
                <c:pt idx="112">
                  <c:v>84.38</c:v>
                </c:pt>
                <c:pt idx="113">
                  <c:v>49.224000000000004</c:v>
                </c:pt>
                <c:pt idx="114">
                  <c:v>47.707999999999998</c:v>
                </c:pt>
                <c:pt idx="115">
                  <c:v>64.72999999999999</c:v>
                </c:pt>
                <c:pt idx="116">
                  <c:v>64.231999999999999</c:v>
                </c:pt>
                <c:pt idx="117">
                  <c:v>54.856000000000009</c:v>
                </c:pt>
                <c:pt idx="118">
                  <c:v>65.481999999999999</c:v>
                </c:pt>
                <c:pt idx="119">
                  <c:v>64.110000000000014</c:v>
                </c:pt>
                <c:pt idx="120">
                  <c:v>50.944000000000003</c:v>
                </c:pt>
                <c:pt idx="121">
                  <c:v>53.640000000000008</c:v>
                </c:pt>
                <c:pt idx="122">
                  <c:v>53.768000000000008</c:v>
                </c:pt>
                <c:pt idx="123">
                  <c:v>54.712000000000003</c:v>
                </c:pt>
                <c:pt idx="124">
                  <c:v>43.131999999999998</c:v>
                </c:pt>
                <c:pt idx="125">
                  <c:v>57.494000000000007</c:v>
                </c:pt>
                <c:pt idx="126">
                  <c:v>46.498000000000005</c:v>
                </c:pt>
                <c:pt idx="127">
                  <c:v>93.474000000000004</c:v>
                </c:pt>
                <c:pt idx="128">
                  <c:v>60.838000000000001</c:v>
                </c:pt>
                <c:pt idx="129">
                  <c:v>69.016000000000005</c:v>
                </c:pt>
                <c:pt idx="130">
                  <c:v>73.45</c:v>
                </c:pt>
                <c:pt idx="131">
                  <c:v>110.36800000000001</c:v>
                </c:pt>
                <c:pt idx="132">
                  <c:v>50.991999999999997</c:v>
                </c:pt>
                <c:pt idx="133">
                  <c:v>66.535999999999987</c:v>
                </c:pt>
                <c:pt idx="134">
                  <c:v>49.282000000000004</c:v>
                </c:pt>
                <c:pt idx="135">
                  <c:v>61.505999999999993</c:v>
                </c:pt>
                <c:pt idx="136">
                  <c:v>73.846000000000004</c:v>
                </c:pt>
                <c:pt idx="137">
                  <c:v>51.265999999999998</c:v>
                </c:pt>
                <c:pt idx="138">
                  <c:v>68.945999999999998</c:v>
                </c:pt>
                <c:pt idx="139">
                  <c:v>42.708000000000006</c:v>
                </c:pt>
                <c:pt idx="140">
                  <c:v>62.940000000000012</c:v>
                </c:pt>
                <c:pt idx="141">
                  <c:v>63.948</c:v>
                </c:pt>
                <c:pt idx="142">
                  <c:v>69.424000000000007</c:v>
                </c:pt>
                <c:pt idx="143">
                  <c:v>54.646000000000001</c:v>
                </c:pt>
                <c:pt idx="144">
                  <c:v>65.774000000000001</c:v>
                </c:pt>
                <c:pt idx="145">
                  <c:v>54.886000000000003</c:v>
                </c:pt>
                <c:pt idx="146">
                  <c:v>54.46</c:v>
                </c:pt>
                <c:pt idx="147">
                  <c:v>48.975999999999999</c:v>
                </c:pt>
                <c:pt idx="148">
                  <c:v>82.964000000000013</c:v>
                </c:pt>
                <c:pt idx="149">
                  <c:v>61.213999999999999</c:v>
                </c:pt>
                <c:pt idx="150">
                  <c:v>86.49199999999999</c:v>
                </c:pt>
                <c:pt idx="151">
                  <c:v>49.08</c:v>
                </c:pt>
                <c:pt idx="152">
                  <c:v>46.262</c:v>
                </c:pt>
                <c:pt idx="153">
                  <c:v>129.714</c:v>
                </c:pt>
                <c:pt idx="154">
                  <c:v>74.8</c:v>
                </c:pt>
                <c:pt idx="155">
                  <c:v>62.251999999999995</c:v>
                </c:pt>
                <c:pt idx="156">
                  <c:v>53.822000000000003</c:v>
                </c:pt>
                <c:pt idx="157">
                  <c:v>63.525999999999996</c:v>
                </c:pt>
                <c:pt idx="158">
                  <c:v>62.284000000000006</c:v>
                </c:pt>
                <c:pt idx="159">
                  <c:v>61.3</c:v>
                </c:pt>
                <c:pt idx="160">
                  <c:v>48.672000000000004</c:v>
                </c:pt>
                <c:pt idx="161">
                  <c:v>91.347999999999999</c:v>
                </c:pt>
                <c:pt idx="162">
                  <c:v>59.851999999999997</c:v>
                </c:pt>
                <c:pt idx="163">
                  <c:v>68.658000000000001</c:v>
                </c:pt>
                <c:pt idx="164">
                  <c:v>118.852</c:v>
                </c:pt>
                <c:pt idx="165">
                  <c:v>77.623999999999995</c:v>
                </c:pt>
                <c:pt idx="166">
                  <c:v>65.929999999999993</c:v>
                </c:pt>
                <c:pt idx="167">
                  <c:v>73.332000000000008</c:v>
                </c:pt>
                <c:pt idx="168">
                  <c:v>54.911999999999999</c:v>
                </c:pt>
                <c:pt idx="169">
                  <c:v>64.816000000000003</c:v>
                </c:pt>
                <c:pt idx="170">
                  <c:v>74.227999999999994</c:v>
                </c:pt>
                <c:pt idx="171">
                  <c:v>59.083999999999989</c:v>
                </c:pt>
                <c:pt idx="172">
                  <c:v>47.148000000000003</c:v>
                </c:pt>
                <c:pt idx="173">
                  <c:v>78.431999999999988</c:v>
                </c:pt>
                <c:pt idx="174">
                  <c:v>66.438000000000002</c:v>
                </c:pt>
                <c:pt idx="175">
                  <c:v>59.613999999999997</c:v>
                </c:pt>
                <c:pt idx="176">
                  <c:v>61.96</c:v>
                </c:pt>
                <c:pt idx="177">
                  <c:v>111.226</c:v>
                </c:pt>
                <c:pt idx="178">
                  <c:v>67.49199999999999</c:v>
                </c:pt>
                <c:pt idx="179">
                  <c:v>62.355999999999995</c:v>
                </c:pt>
                <c:pt idx="180">
                  <c:v>109.922</c:v>
                </c:pt>
                <c:pt idx="181">
                  <c:v>71.02000000000001</c:v>
                </c:pt>
                <c:pt idx="182">
                  <c:v>55.739999999999995</c:v>
                </c:pt>
                <c:pt idx="183">
                  <c:v>40.269999999999996</c:v>
                </c:pt>
                <c:pt idx="184">
                  <c:v>87.310000000000016</c:v>
                </c:pt>
                <c:pt idx="185">
                  <c:v>78.860000000000014</c:v>
                </c:pt>
                <c:pt idx="186">
                  <c:v>106.07000000000001</c:v>
                </c:pt>
                <c:pt idx="187">
                  <c:v>59.246000000000002</c:v>
                </c:pt>
                <c:pt idx="188">
                  <c:v>88.475999999999999</c:v>
                </c:pt>
                <c:pt idx="189">
                  <c:v>49.287999999999997</c:v>
                </c:pt>
                <c:pt idx="190">
                  <c:v>62.873999999999988</c:v>
                </c:pt>
                <c:pt idx="191">
                  <c:v>50</c:v>
                </c:pt>
                <c:pt idx="192">
                  <c:v>50.86</c:v>
                </c:pt>
                <c:pt idx="193">
                  <c:v>44.052</c:v>
                </c:pt>
                <c:pt idx="194">
                  <c:v>57.179999999999993</c:v>
                </c:pt>
                <c:pt idx="195">
                  <c:v>81.453999999999994</c:v>
                </c:pt>
                <c:pt idx="196">
                  <c:v>50.073999999999998</c:v>
                </c:pt>
                <c:pt idx="197">
                  <c:v>36.72</c:v>
                </c:pt>
                <c:pt idx="198">
                  <c:v>66.8</c:v>
                </c:pt>
                <c:pt idx="199">
                  <c:v>88.277999999999992</c:v>
                </c:pt>
                <c:pt idx="200">
                  <c:v>72.054000000000002</c:v>
                </c:pt>
                <c:pt idx="201">
                  <c:v>56.363999999999997</c:v>
                </c:pt>
                <c:pt idx="202">
                  <c:v>64.147999999999996</c:v>
                </c:pt>
                <c:pt idx="203">
                  <c:v>75.564000000000007</c:v>
                </c:pt>
                <c:pt idx="204">
                  <c:v>59.129999999999995</c:v>
                </c:pt>
                <c:pt idx="205">
                  <c:v>60.753999999999998</c:v>
                </c:pt>
                <c:pt idx="206">
                  <c:v>65.25800000000001</c:v>
                </c:pt>
                <c:pt idx="207">
                  <c:v>80.349999999999994</c:v>
                </c:pt>
                <c:pt idx="208">
                  <c:v>66.006</c:v>
                </c:pt>
                <c:pt idx="209">
                  <c:v>63.739999999999995</c:v>
                </c:pt>
                <c:pt idx="210">
                  <c:v>48.426000000000002</c:v>
                </c:pt>
                <c:pt idx="211">
                  <c:v>60.398000000000003</c:v>
                </c:pt>
                <c:pt idx="212">
                  <c:v>52.239999999999995</c:v>
                </c:pt>
                <c:pt idx="213">
                  <c:v>58.879999999999995</c:v>
                </c:pt>
                <c:pt idx="214">
                  <c:v>56.326000000000001</c:v>
                </c:pt>
              </c:numCache>
            </c:numRef>
          </c:xVal>
          <c:yVal>
            <c:numRef>
              <c:f>Feuil1!$H$2:$H$248</c:f>
              <c:numCache>
                <c:formatCode>0.0</c:formatCode>
                <c:ptCount val="247"/>
                <c:pt idx="0">
                  <c:v>45.14</c:v>
                </c:pt>
                <c:pt idx="1">
                  <c:v>45.21</c:v>
                </c:pt>
                <c:pt idx="2">
                  <c:v>49.480000000000004</c:v>
                </c:pt>
                <c:pt idx="3">
                  <c:v>38.33</c:v>
                </c:pt>
                <c:pt idx="4">
                  <c:v>57.489999999999995</c:v>
                </c:pt>
                <c:pt idx="5">
                  <c:v>40.619999999999997</c:v>
                </c:pt>
                <c:pt idx="6">
                  <c:v>41.86</c:v>
                </c:pt>
                <c:pt idx="7">
                  <c:v>41.47</c:v>
                </c:pt>
                <c:pt idx="8">
                  <c:v>35.71</c:v>
                </c:pt>
                <c:pt idx="9">
                  <c:v>36.679999999999993</c:v>
                </c:pt>
                <c:pt idx="10">
                  <c:v>46.599999999999994</c:v>
                </c:pt>
                <c:pt idx="11">
                  <c:v>40.320000000000007</c:v>
                </c:pt>
                <c:pt idx="12">
                  <c:v>34.510000000000005</c:v>
                </c:pt>
                <c:pt idx="13">
                  <c:v>38.770000000000003</c:v>
                </c:pt>
                <c:pt idx="14">
                  <c:v>36.94</c:v>
                </c:pt>
                <c:pt idx="15">
                  <c:v>34.89</c:v>
                </c:pt>
                <c:pt idx="16">
                  <c:v>40.39</c:v>
                </c:pt>
                <c:pt idx="17">
                  <c:v>54.519999999999996</c:v>
                </c:pt>
                <c:pt idx="18">
                  <c:v>50.68</c:v>
                </c:pt>
                <c:pt idx="19">
                  <c:v>50.69</c:v>
                </c:pt>
                <c:pt idx="20">
                  <c:v>44.750000000000007</c:v>
                </c:pt>
                <c:pt idx="21">
                  <c:v>37.379999999999995</c:v>
                </c:pt>
                <c:pt idx="22">
                  <c:v>37.71</c:v>
                </c:pt>
                <c:pt idx="23">
                  <c:v>44.15</c:v>
                </c:pt>
                <c:pt idx="24">
                  <c:v>40.11</c:v>
                </c:pt>
                <c:pt idx="25">
                  <c:v>45.94</c:v>
                </c:pt>
                <c:pt idx="26">
                  <c:v>37.96</c:v>
                </c:pt>
                <c:pt idx="27">
                  <c:v>45.13</c:v>
                </c:pt>
                <c:pt idx="28">
                  <c:v>43.96</c:v>
                </c:pt>
                <c:pt idx="29">
                  <c:v>37.15</c:v>
                </c:pt>
                <c:pt idx="30">
                  <c:v>49.789999999999992</c:v>
                </c:pt>
                <c:pt idx="31">
                  <c:v>40.81</c:v>
                </c:pt>
                <c:pt idx="32">
                  <c:v>38.480000000000004</c:v>
                </c:pt>
                <c:pt idx="33">
                  <c:v>38.429999999999993</c:v>
                </c:pt>
                <c:pt idx="34">
                  <c:v>48.56</c:v>
                </c:pt>
                <c:pt idx="35">
                  <c:v>37.269999999999996</c:v>
                </c:pt>
                <c:pt idx="36">
                  <c:v>46.36</c:v>
                </c:pt>
                <c:pt idx="37">
                  <c:v>35.279999999999994</c:v>
                </c:pt>
                <c:pt idx="38">
                  <c:v>49.730000000000004</c:v>
                </c:pt>
                <c:pt idx="39">
                  <c:v>42.66</c:v>
                </c:pt>
                <c:pt idx="40">
                  <c:v>48.239999999999995</c:v>
                </c:pt>
                <c:pt idx="41">
                  <c:v>40.910000000000004</c:v>
                </c:pt>
                <c:pt idx="42">
                  <c:v>32.120000000000005</c:v>
                </c:pt>
                <c:pt idx="43">
                  <c:v>40.159999999999997</c:v>
                </c:pt>
                <c:pt idx="44">
                  <c:v>43.199999999999996</c:v>
                </c:pt>
                <c:pt idx="45">
                  <c:v>37.799999999999997</c:v>
                </c:pt>
                <c:pt idx="46">
                  <c:v>52.1</c:v>
                </c:pt>
                <c:pt idx="47">
                  <c:v>37.659999999999997</c:v>
                </c:pt>
                <c:pt idx="48">
                  <c:v>41.309999999999995</c:v>
                </c:pt>
                <c:pt idx="49">
                  <c:v>43.33</c:v>
                </c:pt>
                <c:pt idx="50">
                  <c:v>38.01</c:v>
                </c:pt>
                <c:pt idx="51">
                  <c:v>43.730000000000004</c:v>
                </c:pt>
                <c:pt idx="52">
                  <c:v>40.58</c:v>
                </c:pt>
                <c:pt idx="53">
                  <c:v>47.73</c:v>
                </c:pt>
                <c:pt idx="54">
                  <c:v>46.41</c:v>
                </c:pt>
                <c:pt idx="55">
                  <c:v>46.92</c:v>
                </c:pt>
                <c:pt idx="56">
                  <c:v>35.250000000000007</c:v>
                </c:pt>
                <c:pt idx="57">
                  <c:v>42.5</c:v>
                </c:pt>
                <c:pt idx="58">
                  <c:v>44.17</c:v>
                </c:pt>
                <c:pt idx="59">
                  <c:v>33</c:v>
                </c:pt>
                <c:pt idx="60">
                  <c:v>39.730000000000004</c:v>
                </c:pt>
                <c:pt idx="61">
                  <c:v>39.750000000000007</c:v>
                </c:pt>
                <c:pt idx="62">
                  <c:v>31.880000000000003</c:v>
                </c:pt>
                <c:pt idx="63">
                  <c:v>51.489999999999995</c:v>
                </c:pt>
                <c:pt idx="64">
                  <c:v>40.730000000000004</c:v>
                </c:pt>
                <c:pt idx="65">
                  <c:v>54.879999999999995</c:v>
                </c:pt>
                <c:pt idx="66">
                  <c:v>43.06</c:v>
                </c:pt>
                <c:pt idx="67">
                  <c:v>42.559999999999995</c:v>
                </c:pt>
                <c:pt idx="68">
                  <c:v>51.760000000000005</c:v>
                </c:pt>
                <c:pt idx="69">
                  <c:v>41.35</c:v>
                </c:pt>
                <c:pt idx="70">
                  <c:v>46.05</c:v>
                </c:pt>
                <c:pt idx="71">
                  <c:v>45.69</c:v>
                </c:pt>
                <c:pt idx="72">
                  <c:v>43.379999999999995</c:v>
                </c:pt>
                <c:pt idx="73">
                  <c:v>38.14</c:v>
                </c:pt>
                <c:pt idx="74">
                  <c:v>42.67</c:v>
                </c:pt>
                <c:pt idx="75">
                  <c:v>44.8</c:v>
                </c:pt>
                <c:pt idx="76">
                  <c:v>45.589999999999996</c:v>
                </c:pt>
                <c:pt idx="77">
                  <c:v>36.44</c:v>
                </c:pt>
                <c:pt idx="78">
                  <c:v>46.27</c:v>
                </c:pt>
                <c:pt idx="79">
                  <c:v>46.239999999999995</c:v>
                </c:pt>
                <c:pt idx="80">
                  <c:v>39.370000000000005</c:v>
                </c:pt>
                <c:pt idx="81">
                  <c:v>54.820000000000007</c:v>
                </c:pt>
                <c:pt idx="82">
                  <c:v>33.79</c:v>
                </c:pt>
                <c:pt idx="83">
                  <c:v>45.22</c:v>
                </c:pt>
                <c:pt idx="84">
                  <c:v>47.540000000000006</c:v>
                </c:pt>
                <c:pt idx="85">
                  <c:v>36.79</c:v>
                </c:pt>
                <c:pt idx="86">
                  <c:v>45.18</c:v>
                </c:pt>
                <c:pt idx="87">
                  <c:v>38.019999999999996</c:v>
                </c:pt>
                <c:pt idx="88">
                  <c:v>38.160000000000004</c:v>
                </c:pt>
                <c:pt idx="89">
                  <c:v>52.279999999999994</c:v>
                </c:pt>
                <c:pt idx="90">
                  <c:v>46.279999999999994</c:v>
                </c:pt>
                <c:pt idx="91">
                  <c:v>42.75</c:v>
                </c:pt>
                <c:pt idx="92">
                  <c:v>45.19</c:v>
                </c:pt>
                <c:pt idx="93">
                  <c:v>44.83</c:v>
                </c:pt>
                <c:pt idx="94">
                  <c:v>47.730000000000004</c:v>
                </c:pt>
                <c:pt idx="95">
                  <c:v>44.11</c:v>
                </c:pt>
                <c:pt idx="96">
                  <c:v>29.910000000000004</c:v>
                </c:pt>
                <c:pt idx="97">
                  <c:v>39.39</c:v>
                </c:pt>
                <c:pt idx="98">
                  <c:v>36.4</c:v>
                </c:pt>
                <c:pt idx="99">
                  <c:v>47.150000000000006</c:v>
                </c:pt>
                <c:pt idx="100">
                  <c:v>46.739999999999995</c:v>
                </c:pt>
                <c:pt idx="101">
                  <c:v>41.739999999999995</c:v>
                </c:pt>
                <c:pt idx="102">
                  <c:v>39.120000000000005</c:v>
                </c:pt>
                <c:pt idx="103">
                  <c:v>36.510000000000005</c:v>
                </c:pt>
                <c:pt idx="104">
                  <c:v>47.790000000000006</c:v>
                </c:pt>
                <c:pt idx="105">
                  <c:v>31.5</c:v>
                </c:pt>
                <c:pt idx="106">
                  <c:v>41.41</c:v>
                </c:pt>
                <c:pt idx="107">
                  <c:v>46.599999999999994</c:v>
                </c:pt>
                <c:pt idx="108">
                  <c:v>47.3</c:v>
                </c:pt>
                <c:pt idx="109">
                  <c:v>39.28</c:v>
                </c:pt>
                <c:pt idx="110">
                  <c:v>34.779999999999994</c:v>
                </c:pt>
                <c:pt idx="111">
                  <c:v>40.56</c:v>
                </c:pt>
                <c:pt idx="112">
                  <c:v>36.88000000000001</c:v>
                </c:pt>
                <c:pt idx="113">
                  <c:v>36.11</c:v>
                </c:pt>
                <c:pt idx="114">
                  <c:v>35.479999999999997</c:v>
                </c:pt>
                <c:pt idx="115">
                  <c:v>45.71</c:v>
                </c:pt>
                <c:pt idx="116">
                  <c:v>33.760000000000005</c:v>
                </c:pt>
                <c:pt idx="117">
                  <c:v>38.200000000000003</c:v>
                </c:pt>
                <c:pt idx="118">
                  <c:v>40.64</c:v>
                </c:pt>
                <c:pt idx="119">
                  <c:v>48.320000000000007</c:v>
                </c:pt>
                <c:pt idx="120">
                  <c:v>43.3</c:v>
                </c:pt>
                <c:pt idx="121">
                  <c:v>34.78</c:v>
                </c:pt>
                <c:pt idx="122">
                  <c:v>44.690000000000005</c:v>
                </c:pt>
                <c:pt idx="123">
                  <c:v>41.4</c:v>
                </c:pt>
                <c:pt idx="124">
                  <c:v>35.86</c:v>
                </c:pt>
                <c:pt idx="125">
                  <c:v>36.799999999999997</c:v>
                </c:pt>
                <c:pt idx="126">
                  <c:v>43.570000000000007</c:v>
                </c:pt>
                <c:pt idx="127">
                  <c:v>35.78</c:v>
                </c:pt>
                <c:pt idx="128">
                  <c:v>49.629999999999995</c:v>
                </c:pt>
                <c:pt idx="129">
                  <c:v>36.75</c:v>
                </c:pt>
                <c:pt idx="130">
                  <c:v>36.92</c:v>
                </c:pt>
                <c:pt idx="131">
                  <c:v>35.18</c:v>
                </c:pt>
                <c:pt idx="132">
                  <c:v>45.53</c:v>
                </c:pt>
                <c:pt idx="133">
                  <c:v>43.69</c:v>
                </c:pt>
                <c:pt idx="134">
                  <c:v>40.700000000000003</c:v>
                </c:pt>
                <c:pt idx="135">
                  <c:v>37.15</c:v>
                </c:pt>
                <c:pt idx="136">
                  <c:v>35.350000000000009</c:v>
                </c:pt>
                <c:pt idx="137">
                  <c:v>37.819999999999993</c:v>
                </c:pt>
                <c:pt idx="138">
                  <c:v>34.17</c:v>
                </c:pt>
                <c:pt idx="139">
                  <c:v>36.339999999999996</c:v>
                </c:pt>
                <c:pt idx="140">
                  <c:v>43.04</c:v>
                </c:pt>
                <c:pt idx="141">
                  <c:v>42.879999999999995</c:v>
                </c:pt>
                <c:pt idx="142">
                  <c:v>35.459999999999994</c:v>
                </c:pt>
                <c:pt idx="143">
                  <c:v>32.790000000000006</c:v>
                </c:pt>
                <c:pt idx="144">
                  <c:v>42.7</c:v>
                </c:pt>
                <c:pt idx="145">
                  <c:v>48.09</c:v>
                </c:pt>
                <c:pt idx="146">
                  <c:v>41.64</c:v>
                </c:pt>
                <c:pt idx="147">
                  <c:v>44.489999999999995</c:v>
                </c:pt>
                <c:pt idx="148">
                  <c:v>36.340000000000003</c:v>
                </c:pt>
                <c:pt idx="149">
                  <c:v>38.81</c:v>
                </c:pt>
                <c:pt idx="150">
                  <c:v>44.65</c:v>
                </c:pt>
                <c:pt idx="151">
                  <c:v>40.449999999999996</c:v>
                </c:pt>
                <c:pt idx="152">
                  <c:v>38.489999999999995</c:v>
                </c:pt>
                <c:pt idx="153">
                  <c:v>37.479999999999997</c:v>
                </c:pt>
                <c:pt idx="154">
                  <c:v>34.29</c:v>
                </c:pt>
                <c:pt idx="155">
                  <c:v>37.660000000000004</c:v>
                </c:pt>
                <c:pt idx="156">
                  <c:v>44.769999999999996</c:v>
                </c:pt>
                <c:pt idx="157">
                  <c:v>35.739999999999995</c:v>
                </c:pt>
                <c:pt idx="158">
                  <c:v>44.489999999999995</c:v>
                </c:pt>
                <c:pt idx="159">
                  <c:v>48.49</c:v>
                </c:pt>
                <c:pt idx="160">
                  <c:v>33.799999999999997</c:v>
                </c:pt>
                <c:pt idx="161">
                  <c:v>42.280000000000008</c:v>
                </c:pt>
                <c:pt idx="162">
                  <c:v>39.979999999999997</c:v>
                </c:pt>
                <c:pt idx="163">
                  <c:v>41.81</c:v>
                </c:pt>
                <c:pt idx="164">
                  <c:v>38.589999999999996</c:v>
                </c:pt>
                <c:pt idx="165">
                  <c:v>48.62</c:v>
                </c:pt>
                <c:pt idx="166">
                  <c:v>38.019999999999996</c:v>
                </c:pt>
                <c:pt idx="167">
                  <c:v>35.809999999999995</c:v>
                </c:pt>
                <c:pt idx="168">
                  <c:v>50.879999999999995</c:v>
                </c:pt>
                <c:pt idx="169">
                  <c:v>37.280000000000008</c:v>
                </c:pt>
                <c:pt idx="170">
                  <c:v>44.46</c:v>
                </c:pt>
                <c:pt idx="171">
                  <c:v>31.76</c:v>
                </c:pt>
                <c:pt idx="172">
                  <c:v>34.049999999999997</c:v>
                </c:pt>
                <c:pt idx="173">
                  <c:v>41.010000000000005</c:v>
                </c:pt>
                <c:pt idx="174">
                  <c:v>32.15</c:v>
                </c:pt>
                <c:pt idx="175">
                  <c:v>35.950000000000003</c:v>
                </c:pt>
                <c:pt idx="176">
                  <c:v>45.74</c:v>
                </c:pt>
                <c:pt idx="177">
                  <c:v>43.480000000000004</c:v>
                </c:pt>
                <c:pt idx="178">
                  <c:v>35.989999999999995</c:v>
                </c:pt>
                <c:pt idx="179">
                  <c:v>45.69</c:v>
                </c:pt>
                <c:pt idx="180">
                  <c:v>48.529999999999994</c:v>
                </c:pt>
                <c:pt idx="181">
                  <c:v>43.839999999999996</c:v>
                </c:pt>
                <c:pt idx="182">
                  <c:v>41.06</c:v>
                </c:pt>
                <c:pt idx="183">
                  <c:v>39.36</c:v>
                </c:pt>
                <c:pt idx="184">
                  <c:v>39.61</c:v>
                </c:pt>
                <c:pt idx="185">
                  <c:v>40.179999999999993</c:v>
                </c:pt>
                <c:pt idx="186">
                  <c:v>31.639999999999997</c:v>
                </c:pt>
                <c:pt idx="187">
                  <c:v>44.75</c:v>
                </c:pt>
                <c:pt idx="188">
                  <c:v>41.32</c:v>
                </c:pt>
                <c:pt idx="189">
                  <c:v>40.4</c:v>
                </c:pt>
                <c:pt idx="190">
                  <c:v>42.7</c:v>
                </c:pt>
                <c:pt idx="191">
                  <c:v>31.839999999999996</c:v>
                </c:pt>
                <c:pt idx="192">
                  <c:v>34.81</c:v>
                </c:pt>
                <c:pt idx="193">
                  <c:v>44.499999999999993</c:v>
                </c:pt>
                <c:pt idx="194">
                  <c:v>46.15</c:v>
                </c:pt>
                <c:pt idx="195">
                  <c:v>38.769999999999996</c:v>
                </c:pt>
                <c:pt idx="196">
                  <c:v>40.489999999999995</c:v>
                </c:pt>
                <c:pt idx="197">
                  <c:v>41.4</c:v>
                </c:pt>
                <c:pt idx="198">
                  <c:v>43.029999999999994</c:v>
                </c:pt>
                <c:pt idx="199">
                  <c:v>36.870000000000005</c:v>
                </c:pt>
                <c:pt idx="200">
                  <c:v>44.23</c:v>
                </c:pt>
                <c:pt idx="201">
                  <c:v>34.4</c:v>
                </c:pt>
                <c:pt idx="202">
                  <c:v>45.5</c:v>
                </c:pt>
                <c:pt idx="203">
                  <c:v>45.4</c:v>
                </c:pt>
                <c:pt idx="204">
                  <c:v>45.89</c:v>
                </c:pt>
                <c:pt idx="205">
                  <c:v>42.26</c:v>
                </c:pt>
                <c:pt idx="206">
                  <c:v>37.42</c:v>
                </c:pt>
                <c:pt idx="207">
                  <c:v>37.320000000000007</c:v>
                </c:pt>
                <c:pt idx="208">
                  <c:v>44.31</c:v>
                </c:pt>
                <c:pt idx="209">
                  <c:v>46.769999999999996</c:v>
                </c:pt>
                <c:pt idx="210">
                  <c:v>45.160000000000004</c:v>
                </c:pt>
                <c:pt idx="211">
                  <c:v>39.31</c:v>
                </c:pt>
                <c:pt idx="212">
                  <c:v>29.220000000000006</c:v>
                </c:pt>
                <c:pt idx="213">
                  <c:v>40.14</c:v>
                </c:pt>
                <c:pt idx="214">
                  <c:v>42.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F8-F548-ACAE-6A355CE96E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5323536"/>
        <c:axId val="535330200"/>
      </c:scatterChart>
      <c:valAx>
        <c:axId val="535323536"/>
        <c:scaling>
          <c:orientation val="minMax"/>
          <c:max val="2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FW</a:t>
                </a:r>
                <a:r>
                  <a:rPr lang="fr-FR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  <a:r>
                  <a:rPr lang="fr-FR" sz="1000" b="0" i="0" u="none" strike="noStrike" baseline="0" dirty="0">
                    <a:effectLst/>
                  </a:rPr>
                  <a:t> (grams)</a:t>
                </a:r>
                <a:endParaRPr lang="fr-FR" sz="1000" b="0" i="0" u="none" strike="noStrike" kern="1200" spc="0" baseline="-20000" dirty="0">
                  <a:solidFill>
                    <a:sysClr val="windowText" lastClr="000000">
                      <a:lumMod val="65000"/>
                      <a:lumOff val="35000"/>
                    </a:sysClr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30200"/>
        <c:crosses val="autoZero"/>
        <c:crossBetween val="midCat"/>
        <c:majorUnit val="50"/>
      </c:valAx>
      <c:valAx>
        <c:axId val="535330200"/>
        <c:scaling>
          <c:orientation val="minMax"/>
          <c:max val="9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00" b="0" i="0" u="none" strike="noStrike" kern="1200" spc="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FF</a:t>
                </a:r>
                <a:r>
                  <a:rPr lang="fr-FR" sz="1000" b="0" i="0" u="none" strike="noStrike" kern="1200" spc="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</a:t>
                </a:r>
                <a:r>
                  <a:rPr lang="fr-FR" sz="1000" b="0" i="0" u="none" strike="noStrike" baseline="0" dirty="0">
                    <a:effectLst/>
                  </a:rPr>
                  <a:t> (Shore A)</a:t>
                </a:r>
                <a:endParaRPr lang="fr-FR" sz="1000" b="0" i="0" u="none" strike="noStrike" kern="1200" spc="0" baseline="-20000" dirty="0">
                  <a:solidFill>
                    <a:sysClr val="windowText" lastClr="000000">
                      <a:lumMod val="65000"/>
                      <a:lumOff val="35000"/>
                    </a:sysClr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35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400" b="1" i="0" baseline="0" dirty="0">
                <a:effectLst/>
              </a:rPr>
              <a:t>Loss</a:t>
            </a:r>
            <a:r>
              <a:rPr lang="en-US" sz="1400" b="1" i="0" baseline="0" dirty="0">
                <a:effectLst/>
              </a:rPr>
              <a:t>FW</a:t>
            </a:r>
            <a:r>
              <a:rPr lang="en-US" sz="1400" b="1" i="0" baseline="-20000" dirty="0">
                <a:effectLst/>
              </a:rPr>
              <a:t>T14</a:t>
            </a:r>
            <a:endParaRPr lang="en-US" sz="1400" baseline="-20000" dirty="0">
              <a:effectLst/>
            </a:endParaRPr>
          </a:p>
        </c:rich>
      </c:tx>
      <c:layout>
        <c:manualLayout>
          <c:xMode val="edge"/>
          <c:yMode val="edge"/>
          <c:x val="0.41053021140863677"/>
          <c:y val="4.623247215949693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767604119242403"/>
          <c:y val="0.1344902615119766"/>
          <c:w val="0.81503629614526274"/>
          <c:h val="0.710414719836679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I$35:$AI$46</c:f>
              <c:numCache>
                <c:formatCode>0.00%</c:formatCode>
                <c:ptCount val="12"/>
                <c:pt idx="0">
                  <c:v>1.4999999999999999E-2</c:v>
                </c:pt>
                <c:pt idx="1">
                  <c:v>1.95E-2</c:v>
                </c:pt>
                <c:pt idx="2">
                  <c:v>2.4E-2</c:v>
                </c:pt>
                <c:pt idx="3">
                  <c:v>2.8500000000000001E-2</c:v>
                </c:pt>
                <c:pt idx="4">
                  <c:v>3.3000000000000002E-2</c:v>
                </c:pt>
                <c:pt idx="5">
                  <c:v>3.7499999999999999E-2</c:v>
                </c:pt>
                <c:pt idx="6">
                  <c:v>4.2000000000000003E-2</c:v>
                </c:pt>
                <c:pt idx="7">
                  <c:v>4.65E-2</c:v>
                </c:pt>
                <c:pt idx="8">
                  <c:v>5.0999999999999997E-2</c:v>
                </c:pt>
                <c:pt idx="9">
                  <c:v>5.5500000000000001E-2</c:v>
                </c:pt>
                <c:pt idx="10">
                  <c:v>0.06</c:v>
                </c:pt>
                <c:pt idx="11">
                  <c:v>6.4500000000000002E-2</c:v>
                </c:pt>
              </c:numCache>
            </c:numRef>
          </c:cat>
          <c:val>
            <c:numRef>
              <c:f>'Sampl-clean-work'!$AJ$35:$AJ$46</c:f>
              <c:numCache>
                <c:formatCode>General</c:formatCode>
                <c:ptCount val="12"/>
                <c:pt idx="0">
                  <c:v>1</c:v>
                </c:pt>
                <c:pt idx="1">
                  <c:v>36</c:v>
                </c:pt>
                <c:pt idx="2">
                  <c:v>70</c:v>
                </c:pt>
                <c:pt idx="3">
                  <c:v>49</c:v>
                </c:pt>
                <c:pt idx="4">
                  <c:v>20</c:v>
                </c:pt>
                <c:pt idx="5">
                  <c:v>11</c:v>
                </c:pt>
                <c:pt idx="6">
                  <c:v>10</c:v>
                </c:pt>
                <c:pt idx="7">
                  <c:v>6</c:v>
                </c:pt>
                <c:pt idx="8">
                  <c:v>7</c:v>
                </c:pt>
                <c:pt idx="9">
                  <c:v>1</c:v>
                </c:pt>
                <c:pt idx="10">
                  <c:v>2</c:v>
                </c:pt>
                <c:pt idx="1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44-4777-AA64-8F5B896DA1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431580272"/>
        <c:axId val="431575960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AK$35:$AK$46</c:f>
              <c:numCache>
                <c:formatCode>0.00</c:formatCode>
                <c:ptCount val="12"/>
                <c:pt idx="0">
                  <c:v>18.968642661259963</c:v>
                </c:pt>
                <c:pt idx="1">
                  <c:v>31.893124720436816</c:v>
                </c:pt>
                <c:pt idx="2">
                  <c:v>41.94418126384187</c:v>
                </c:pt>
                <c:pt idx="3">
                  <c:v>43.147953910733001</c:v>
                </c:pt>
                <c:pt idx="4">
                  <c:v>34.718625646947778</c:v>
                </c:pt>
                <c:pt idx="5">
                  <c:v>21.851370378227571</c:v>
                </c:pt>
                <c:pt idx="6">
                  <c:v>10.757433396593816</c:v>
                </c:pt>
                <c:pt idx="7">
                  <c:v>4.1424043364584717</c:v>
                </c:pt>
                <c:pt idx="8">
                  <c:v>1.2476999103746926</c:v>
                </c:pt>
                <c:pt idx="9">
                  <c:v>0.29395552975771005</c:v>
                </c:pt>
                <c:pt idx="10">
                  <c:v>5.417101326642746E-2</c:v>
                </c:pt>
                <c:pt idx="11">
                  <c:v>7.8084730945360758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C44-4777-AA64-8F5B896DA1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1580664"/>
        <c:axId val="431574392"/>
      </c:lineChart>
      <c:catAx>
        <c:axId val="431580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dirty="0"/>
                  <a:t>Loss</a:t>
                </a:r>
                <a:r>
                  <a:rPr lang="en-US" dirty="0"/>
                  <a:t>FW</a:t>
                </a:r>
                <a:r>
                  <a:rPr lang="en-US" baseline="-20000" dirty="0"/>
                  <a:t>T14</a:t>
                </a:r>
                <a:r>
                  <a:rPr lang="en-US" dirty="0"/>
                  <a:t> bin</a:t>
                </a:r>
              </a:p>
            </c:rich>
          </c:tx>
          <c:layout>
            <c:manualLayout>
              <c:xMode val="edge"/>
              <c:yMode val="edge"/>
              <c:x val="0.38557314349525407"/>
              <c:y val="0.924281089036055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75960"/>
        <c:crosses val="autoZero"/>
        <c:auto val="1"/>
        <c:lblAlgn val="ctr"/>
        <c:lblOffset val="100"/>
        <c:noMultiLvlLbl val="0"/>
      </c:catAx>
      <c:valAx>
        <c:axId val="431575960"/>
        <c:scaling>
          <c:orientation val="minMax"/>
          <c:max val="8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0"/>
              <c:y val="0.377468113245530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80272"/>
        <c:crosses val="autoZero"/>
        <c:crossBetween val="between"/>
      </c:valAx>
      <c:valAx>
        <c:axId val="431574392"/>
        <c:scaling>
          <c:orientation val="minMax"/>
          <c:max val="45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580664"/>
        <c:crosses val="max"/>
        <c:crossBetween val="between"/>
      </c:valAx>
      <c:catAx>
        <c:axId val="431580664"/>
        <c:scaling>
          <c:orientation val="minMax"/>
        </c:scaling>
        <c:delete val="1"/>
        <c:axPos val="b"/>
        <c:majorTickMark val="out"/>
        <c:minorTickMark val="none"/>
        <c:tickLblPos val="nextTo"/>
        <c:crossAx val="4315743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ENEA</a:t>
            </a:r>
          </a:p>
        </c:rich>
      </c:tx>
      <c:layout>
        <c:manualLayout>
          <c:xMode val="edge"/>
          <c:yMode val="edge"/>
          <c:x val="0.40104647109299579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231544299045372"/>
          <c:y val="0.17171296296296296"/>
          <c:w val="0.63362953180306769"/>
          <c:h val="0.6291283902012248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F$1</c:f>
              <c:strCache>
                <c:ptCount val="1"/>
                <c:pt idx="0">
                  <c:v>LossFWT1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B$2:$B$246</c:f>
              <c:numCache>
                <c:formatCode>0.0</c:formatCode>
                <c:ptCount val="245"/>
                <c:pt idx="0">
                  <c:v>55.482000000000006</c:v>
                </c:pt>
                <c:pt idx="1">
                  <c:v>56.105999999999995</c:v>
                </c:pt>
                <c:pt idx="2">
                  <c:v>45.001999999999995</c:v>
                </c:pt>
                <c:pt idx="3">
                  <c:v>66.405999999999992</c:v>
                </c:pt>
                <c:pt idx="4">
                  <c:v>80.287999999999997</c:v>
                </c:pt>
                <c:pt idx="5">
                  <c:v>63.820000000000007</c:v>
                </c:pt>
                <c:pt idx="6">
                  <c:v>61.323999999999998</c:v>
                </c:pt>
                <c:pt idx="7">
                  <c:v>154.434</c:v>
                </c:pt>
                <c:pt idx="8">
                  <c:v>200.10399999999998</c:v>
                </c:pt>
                <c:pt idx="9">
                  <c:v>60.15</c:v>
                </c:pt>
                <c:pt idx="10">
                  <c:v>52.886000000000003</c:v>
                </c:pt>
                <c:pt idx="11">
                  <c:v>67.245999999999995</c:v>
                </c:pt>
                <c:pt idx="12">
                  <c:v>87.206000000000003</c:v>
                </c:pt>
                <c:pt idx="13">
                  <c:v>79.126000000000005</c:v>
                </c:pt>
                <c:pt idx="14">
                  <c:v>63.159999999999989</c:v>
                </c:pt>
                <c:pt idx="15">
                  <c:v>56.386000000000003</c:v>
                </c:pt>
                <c:pt idx="16">
                  <c:v>91.061999999999998</c:v>
                </c:pt>
                <c:pt idx="17">
                  <c:v>50.245999999999995</c:v>
                </c:pt>
                <c:pt idx="18">
                  <c:v>62.878</c:v>
                </c:pt>
                <c:pt idx="19">
                  <c:v>73.182000000000002</c:v>
                </c:pt>
                <c:pt idx="20">
                  <c:v>63.634</c:v>
                </c:pt>
                <c:pt idx="21">
                  <c:v>70.823999999999998</c:v>
                </c:pt>
                <c:pt idx="22">
                  <c:v>64.293999999999997</c:v>
                </c:pt>
                <c:pt idx="23">
                  <c:v>74.740000000000009</c:v>
                </c:pt>
                <c:pt idx="24">
                  <c:v>76.19</c:v>
                </c:pt>
                <c:pt idx="25">
                  <c:v>77.524000000000001</c:v>
                </c:pt>
                <c:pt idx="26">
                  <c:v>47.279999999999994</c:v>
                </c:pt>
                <c:pt idx="27">
                  <c:v>62.398000000000003</c:v>
                </c:pt>
                <c:pt idx="28">
                  <c:v>94.362000000000009</c:v>
                </c:pt>
                <c:pt idx="29">
                  <c:v>82.544000000000011</c:v>
                </c:pt>
                <c:pt idx="30">
                  <c:v>51.258000000000003</c:v>
                </c:pt>
                <c:pt idx="31">
                  <c:v>81.867999999999995</c:v>
                </c:pt>
                <c:pt idx="32">
                  <c:v>76.882000000000005</c:v>
                </c:pt>
                <c:pt idx="33">
                  <c:v>81.78</c:v>
                </c:pt>
                <c:pt idx="34">
                  <c:v>71.358000000000004</c:v>
                </c:pt>
                <c:pt idx="35">
                  <c:v>50.694000000000003</c:v>
                </c:pt>
                <c:pt idx="36">
                  <c:v>60.42</c:v>
                </c:pt>
                <c:pt idx="37">
                  <c:v>63.507999999999996</c:v>
                </c:pt>
                <c:pt idx="38">
                  <c:v>139.262</c:v>
                </c:pt>
                <c:pt idx="39">
                  <c:v>87.358000000000004</c:v>
                </c:pt>
                <c:pt idx="40">
                  <c:v>63.77</c:v>
                </c:pt>
                <c:pt idx="41">
                  <c:v>54.996000000000002</c:v>
                </c:pt>
                <c:pt idx="42">
                  <c:v>74.286000000000001</c:v>
                </c:pt>
                <c:pt idx="43">
                  <c:v>56.841999999999999</c:v>
                </c:pt>
                <c:pt idx="44">
                  <c:v>78.548000000000002</c:v>
                </c:pt>
                <c:pt idx="45">
                  <c:v>41.874000000000002</c:v>
                </c:pt>
                <c:pt idx="46">
                  <c:v>58.533999999999992</c:v>
                </c:pt>
                <c:pt idx="47">
                  <c:v>55.378</c:v>
                </c:pt>
                <c:pt idx="48">
                  <c:v>72.895999999999987</c:v>
                </c:pt>
                <c:pt idx="49">
                  <c:v>48.622</c:v>
                </c:pt>
                <c:pt idx="50">
                  <c:v>50.071999999999996</c:v>
                </c:pt>
                <c:pt idx="51">
                  <c:v>132.084</c:v>
                </c:pt>
                <c:pt idx="52">
                  <c:v>85.301999999999992</c:v>
                </c:pt>
                <c:pt idx="53">
                  <c:v>43.082000000000001</c:v>
                </c:pt>
                <c:pt idx="54">
                  <c:v>59.552</c:v>
                </c:pt>
                <c:pt idx="55">
                  <c:v>92.88</c:v>
                </c:pt>
                <c:pt idx="56">
                  <c:v>63.322000000000003</c:v>
                </c:pt>
                <c:pt idx="57">
                  <c:v>74.445999999999998</c:v>
                </c:pt>
                <c:pt idx="58">
                  <c:v>83.097999999999999</c:v>
                </c:pt>
                <c:pt idx="59">
                  <c:v>177.36999999999998</c:v>
                </c:pt>
                <c:pt idx="60">
                  <c:v>67.944000000000003</c:v>
                </c:pt>
                <c:pt idx="61">
                  <c:v>229.86199999999999</c:v>
                </c:pt>
                <c:pt idx="62">
                  <c:v>64.27600000000001</c:v>
                </c:pt>
                <c:pt idx="63">
                  <c:v>49.06</c:v>
                </c:pt>
                <c:pt idx="64">
                  <c:v>97.893999999999991</c:v>
                </c:pt>
                <c:pt idx="65">
                  <c:v>66.655999999999992</c:v>
                </c:pt>
                <c:pt idx="66">
                  <c:v>162.93800000000002</c:v>
                </c:pt>
                <c:pt idx="67">
                  <c:v>50.323999999999998</c:v>
                </c:pt>
                <c:pt idx="68">
                  <c:v>50.673999999999999</c:v>
                </c:pt>
                <c:pt idx="69">
                  <c:v>63.573999999999998</c:v>
                </c:pt>
                <c:pt idx="70">
                  <c:v>79.765999999999991</c:v>
                </c:pt>
                <c:pt idx="71">
                  <c:v>58.713999999999999</c:v>
                </c:pt>
                <c:pt idx="72">
                  <c:v>55.058000000000007</c:v>
                </c:pt>
                <c:pt idx="73">
                  <c:v>146.13400000000001</c:v>
                </c:pt>
                <c:pt idx="74">
                  <c:v>72.001999999999995</c:v>
                </c:pt>
                <c:pt idx="75">
                  <c:v>61.326000000000001</c:v>
                </c:pt>
                <c:pt idx="76">
                  <c:v>59.144000000000005</c:v>
                </c:pt>
                <c:pt idx="77">
                  <c:v>85.956000000000003</c:v>
                </c:pt>
                <c:pt idx="78">
                  <c:v>58.326000000000001</c:v>
                </c:pt>
                <c:pt idx="79">
                  <c:v>151.09800000000001</c:v>
                </c:pt>
                <c:pt idx="80">
                  <c:v>53.442000000000007</c:v>
                </c:pt>
                <c:pt idx="81">
                  <c:v>68.77600000000001</c:v>
                </c:pt>
                <c:pt idx="82">
                  <c:v>66.783999999999992</c:v>
                </c:pt>
                <c:pt idx="83">
                  <c:v>68.289999999999992</c:v>
                </c:pt>
                <c:pt idx="84">
                  <c:v>64.953999999999994</c:v>
                </c:pt>
                <c:pt idx="85">
                  <c:v>68.801999999999992</c:v>
                </c:pt>
                <c:pt idx="86">
                  <c:v>129.316</c:v>
                </c:pt>
                <c:pt idx="87">
                  <c:v>70.623999999999995</c:v>
                </c:pt>
                <c:pt idx="88">
                  <c:v>61.042000000000009</c:v>
                </c:pt>
                <c:pt idx="89">
                  <c:v>102.928</c:v>
                </c:pt>
                <c:pt idx="90">
                  <c:v>68.772000000000006</c:v>
                </c:pt>
                <c:pt idx="91">
                  <c:v>59.131999999999991</c:v>
                </c:pt>
                <c:pt idx="92">
                  <c:v>95.53</c:v>
                </c:pt>
                <c:pt idx="93">
                  <c:v>70.171999999999997</c:v>
                </c:pt>
                <c:pt idx="94">
                  <c:v>58.093999999999994</c:v>
                </c:pt>
                <c:pt idx="95">
                  <c:v>84.639999999999986</c:v>
                </c:pt>
                <c:pt idx="96">
                  <c:v>100.648</c:v>
                </c:pt>
                <c:pt idx="97">
                  <c:v>50.402000000000001</c:v>
                </c:pt>
                <c:pt idx="98">
                  <c:v>64.443999999999988</c:v>
                </c:pt>
                <c:pt idx="99">
                  <c:v>55.884</c:v>
                </c:pt>
                <c:pt idx="100">
                  <c:v>43.512</c:v>
                </c:pt>
                <c:pt idx="101">
                  <c:v>117.81199999999998</c:v>
                </c:pt>
                <c:pt idx="102">
                  <c:v>74.904000000000011</c:v>
                </c:pt>
                <c:pt idx="103">
                  <c:v>100.14</c:v>
                </c:pt>
                <c:pt idx="104">
                  <c:v>88.988</c:v>
                </c:pt>
                <c:pt idx="105">
                  <c:v>53.194000000000003</c:v>
                </c:pt>
                <c:pt idx="106">
                  <c:v>73.205999999999989</c:v>
                </c:pt>
                <c:pt idx="107">
                  <c:v>69.158000000000001</c:v>
                </c:pt>
                <c:pt idx="108">
                  <c:v>47.841999999999999</c:v>
                </c:pt>
                <c:pt idx="109">
                  <c:v>63.772000000000006</c:v>
                </c:pt>
                <c:pt idx="110">
                  <c:v>58.025999999999996</c:v>
                </c:pt>
                <c:pt idx="111">
                  <c:v>62.108000000000018</c:v>
                </c:pt>
                <c:pt idx="112">
                  <c:v>86.918000000000006</c:v>
                </c:pt>
                <c:pt idx="113">
                  <c:v>52.088000000000001</c:v>
                </c:pt>
                <c:pt idx="114">
                  <c:v>48.682000000000002</c:v>
                </c:pt>
                <c:pt idx="115">
                  <c:v>66.88000000000001</c:v>
                </c:pt>
                <c:pt idx="116">
                  <c:v>66.373999999999995</c:v>
                </c:pt>
                <c:pt idx="117">
                  <c:v>56.572000000000003</c:v>
                </c:pt>
                <c:pt idx="118">
                  <c:v>66.686000000000007</c:v>
                </c:pt>
                <c:pt idx="119">
                  <c:v>65.460000000000008</c:v>
                </c:pt>
                <c:pt idx="120">
                  <c:v>52.251999999999995</c:v>
                </c:pt>
                <c:pt idx="121">
                  <c:v>54.827999999999996</c:v>
                </c:pt>
                <c:pt idx="122">
                  <c:v>54.844000000000008</c:v>
                </c:pt>
                <c:pt idx="123">
                  <c:v>57.396000000000001</c:v>
                </c:pt>
                <c:pt idx="124">
                  <c:v>45.622</c:v>
                </c:pt>
                <c:pt idx="125">
                  <c:v>58.529999999999994</c:v>
                </c:pt>
                <c:pt idx="126">
                  <c:v>47.368000000000002</c:v>
                </c:pt>
                <c:pt idx="127">
                  <c:v>95.792000000000002</c:v>
                </c:pt>
                <c:pt idx="128">
                  <c:v>62.39</c:v>
                </c:pt>
                <c:pt idx="129">
                  <c:v>70.617999999999995</c:v>
                </c:pt>
                <c:pt idx="130">
                  <c:v>75.063999999999993</c:v>
                </c:pt>
                <c:pt idx="131">
                  <c:v>112.72999999999999</c:v>
                </c:pt>
                <c:pt idx="132">
                  <c:v>53.108000000000004</c:v>
                </c:pt>
                <c:pt idx="133">
                  <c:v>68.975999999999999</c:v>
                </c:pt>
                <c:pt idx="134">
                  <c:v>50.788000000000004</c:v>
                </c:pt>
                <c:pt idx="135">
                  <c:v>63.408000000000001</c:v>
                </c:pt>
                <c:pt idx="136">
                  <c:v>75.52000000000001</c:v>
                </c:pt>
                <c:pt idx="137">
                  <c:v>53.076000000000001</c:v>
                </c:pt>
                <c:pt idx="138">
                  <c:v>70.935999999999993</c:v>
                </c:pt>
                <c:pt idx="139">
                  <c:v>44.706000000000003</c:v>
                </c:pt>
                <c:pt idx="140">
                  <c:v>64.372</c:v>
                </c:pt>
                <c:pt idx="141">
                  <c:v>65.465999999999994</c:v>
                </c:pt>
                <c:pt idx="142">
                  <c:v>70.98</c:v>
                </c:pt>
                <c:pt idx="143">
                  <c:v>55.754000000000005</c:v>
                </c:pt>
                <c:pt idx="144">
                  <c:v>67.436000000000007</c:v>
                </c:pt>
                <c:pt idx="145">
                  <c:v>56.321999999999989</c:v>
                </c:pt>
                <c:pt idx="146">
                  <c:v>55.802</c:v>
                </c:pt>
                <c:pt idx="147">
                  <c:v>50.891999999999996</c:v>
                </c:pt>
                <c:pt idx="148">
                  <c:v>84.897999999999996</c:v>
                </c:pt>
                <c:pt idx="149">
                  <c:v>62.652000000000001</c:v>
                </c:pt>
                <c:pt idx="150">
                  <c:v>88.032000000000011</c:v>
                </c:pt>
                <c:pt idx="151">
                  <c:v>50.245999999999995</c:v>
                </c:pt>
                <c:pt idx="152">
                  <c:v>47.606000000000009</c:v>
                </c:pt>
                <c:pt idx="153">
                  <c:v>132.012</c:v>
                </c:pt>
                <c:pt idx="154">
                  <c:v>76.617999999999995</c:v>
                </c:pt>
                <c:pt idx="155">
                  <c:v>63.89</c:v>
                </c:pt>
                <c:pt idx="156">
                  <c:v>55.052</c:v>
                </c:pt>
                <c:pt idx="157">
                  <c:v>65.23599999999999</c:v>
                </c:pt>
                <c:pt idx="158">
                  <c:v>63.863999999999997</c:v>
                </c:pt>
                <c:pt idx="159">
                  <c:v>62.459999999999994</c:v>
                </c:pt>
                <c:pt idx="160">
                  <c:v>50.132000000000005</c:v>
                </c:pt>
                <c:pt idx="161">
                  <c:v>93.083999999999989</c:v>
                </c:pt>
                <c:pt idx="162">
                  <c:v>62.057999999999993</c:v>
                </c:pt>
                <c:pt idx="163">
                  <c:v>70.578000000000003</c:v>
                </c:pt>
                <c:pt idx="164">
                  <c:v>121.274</c:v>
                </c:pt>
                <c:pt idx="165">
                  <c:v>79.011999999999986</c:v>
                </c:pt>
                <c:pt idx="166">
                  <c:v>67.61399999999999</c:v>
                </c:pt>
                <c:pt idx="167">
                  <c:v>75.075999999999993</c:v>
                </c:pt>
                <c:pt idx="168">
                  <c:v>56.387999999999998</c:v>
                </c:pt>
                <c:pt idx="169">
                  <c:v>66.599999999999994</c:v>
                </c:pt>
                <c:pt idx="170">
                  <c:v>75.742000000000004</c:v>
                </c:pt>
                <c:pt idx="171">
                  <c:v>60.265999999999998</c:v>
                </c:pt>
                <c:pt idx="172">
                  <c:v>48.39</c:v>
                </c:pt>
                <c:pt idx="173">
                  <c:v>80.02000000000001</c:v>
                </c:pt>
                <c:pt idx="174">
                  <c:v>67.92</c:v>
                </c:pt>
                <c:pt idx="175">
                  <c:v>61.178000000000011</c:v>
                </c:pt>
                <c:pt idx="176">
                  <c:v>63.77</c:v>
                </c:pt>
                <c:pt idx="177">
                  <c:v>113.556</c:v>
                </c:pt>
                <c:pt idx="178">
                  <c:v>69.162000000000006</c:v>
                </c:pt>
                <c:pt idx="179">
                  <c:v>63.540000000000006</c:v>
                </c:pt>
                <c:pt idx="180">
                  <c:v>112.25399999999999</c:v>
                </c:pt>
                <c:pt idx="181">
                  <c:v>72.831999999999994</c:v>
                </c:pt>
                <c:pt idx="182">
                  <c:v>56.847999999999999</c:v>
                </c:pt>
                <c:pt idx="183">
                  <c:v>41.537999999999997</c:v>
                </c:pt>
                <c:pt idx="184">
                  <c:v>88.894000000000005</c:v>
                </c:pt>
                <c:pt idx="185">
                  <c:v>80.300000000000011</c:v>
                </c:pt>
                <c:pt idx="186">
                  <c:v>108.98400000000001</c:v>
                </c:pt>
                <c:pt idx="187">
                  <c:v>60.898000000000003</c:v>
                </c:pt>
                <c:pt idx="188">
                  <c:v>90.214000000000013</c:v>
                </c:pt>
                <c:pt idx="189">
                  <c:v>50.457999999999998</c:v>
                </c:pt>
                <c:pt idx="190">
                  <c:v>64.015999999999991</c:v>
                </c:pt>
                <c:pt idx="191">
                  <c:v>51.64200000000001</c:v>
                </c:pt>
                <c:pt idx="192">
                  <c:v>51.847999999999999</c:v>
                </c:pt>
                <c:pt idx="193">
                  <c:v>45.153999999999996</c:v>
                </c:pt>
                <c:pt idx="194">
                  <c:v>58.405999999999992</c:v>
                </c:pt>
                <c:pt idx="195">
                  <c:v>84.137999999999991</c:v>
                </c:pt>
                <c:pt idx="196">
                  <c:v>52.58</c:v>
                </c:pt>
                <c:pt idx="197">
                  <c:v>37.671999999999997</c:v>
                </c:pt>
                <c:pt idx="198">
                  <c:v>68.031999999999996</c:v>
                </c:pt>
                <c:pt idx="199">
                  <c:v>90.158000000000015</c:v>
                </c:pt>
                <c:pt idx="200">
                  <c:v>74.353999999999999</c:v>
                </c:pt>
                <c:pt idx="201">
                  <c:v>57.672000000000004</c:v>
                </c:pt>
                <c:pt idx="202">
                  <c:v>66.346000000000004</c:v>
                </c:pt>
                <c:pt idx="203">
                  <c:v>77.364000000000004</c:v>
                </c:pt>
                <c:pt idx="204">
                  <c:v>60.176000000000002</c:v>
                </c:pt>
                <c:pt idx="205">
                  <c:v>61.982000000000006</c:v>
                </c:pt>
                <c:pt idx="206">
                  <c:v>66.76400000000001</c:v>
                </c:pt>
                <c:pt idx="207">
                  <c:v>81.881999999999991</c:v>
                </c:pt>
                <c:pt idx="208">
                  <c:v>67.679999999999993</c:v>
                </c:pt>
                <c:pt idx="209">
                  <c:v>65.542000000000002</c:v>
                </c:pt>
                <c:pt idx="210">
                  <c:v>50.69</c:v>
                </c:pt>
                <c:pt idx="211">
                  <c:v>61.936000000000014</c:v>
                </c:pt>
                <c:pt idx="212">
                  <c:v>54.368000000000009</c:v>
                </c:pt>
                <c:pt idx="213">
                  <c:v>60.775999999999996</c:v>
                </c:pt>
                <c:pt idx="214">
                  <c:v>57.758000000000003</c:v>
                </c:pt>
              </c:numCache>
            </c:numRef>
          </c:xVal>
          <c:yVal>
            <c:numRef>
              <c:f>Feuil1!$F$2:$F$246</c:f>
              <c:numCache>
                <c:formatCode>0.0%</c:formatCode>
                <c:ptCount val="245"/>
                <c:pt idx="0">
                  <c:v>2.4191798934177333E-2</c:v>
                </c:pt>
                <c:pt idx="1">
                  <c:v>2.1934891026392588E-2</c:v>
                </c:pt>
                <c:pt idx="2">
                  <c:v>2.2023185301810667E-2</c:v>
                </c:pt>
                <c:pt idx="3">
                  <c:v>1.6368255093411044E-2</c:v>
                </c:pt>
                <c:pt idx="4">
                  <c:v>1.6989980301916209E-2</c:v>
                </c:pt>
                <c:pt idx="5">
                  <c:v>2.3982785204777101E-2</c:v>
                </c:pt>
                <c:pt idx="6">
                  <c:v>1.9540130679921643E-2</c:v>
                </c:pt>
                <c:pt idx="7">
                  <c:v>2.3040825212303419E-2</c:v>
                </c:pt>
                <c:pt idx="8">
                  <c:v>2.1050907273790574E-2</c:v>
                </c:pt>
                <c:pt idx="9">
                  <c:v>3.5992954860094531E-2</c:v>
                </c:pt>
                <c:pt idx="10">
                  <c:v>2.3341945779087679E-2</c:v>
                </c:pt>
                <c:pt idx="11">
                  <c:v>4.2613940961755546E-2</c:v>
                </c:pt>
                <c:pt idx="12">
                  <c:v>2.7266088001616961E-2</c:v>
                </c:pt>
                <c:pt idx="13">
                  <c:v>1.990719448828655E-2</c:v>
                </c:pt>
                <c:pt idx="14">
                  <c:v>2.4556247397660092E-2</c:v>
                </c:pt>
                <c:pt idx="15">
                  <c:v>4.8774076177098925E-2</c:v>
                </c:pt>
                <c:pt idx="16">
                  <c:v>2.395498089766792E-2</c:v>
                </c:pt>
                <c:pt idx="17">
                  <c:v>2.2086347757921933E-2</c:v>
                </c:pt>
                <c:pt idx="18">
                  <c:v>2.3583829104797126E-2</c:v>
                </c:pt>
                <c:pt idx="19">
                  <c:v>2.8361565719942351E-2</c:v>
                </c:pt>
                <c:pt idx="20">
                  <c:v>2.7889447337214945E-2</c:v>
                </c:pt>
                <c:pt idx="21">
                  <c:v>2.5558323156631403E-2</c:v>
                </c:pt>
                <c:pt idx="22">
                  <c:v>1.9208334585642195E-2</c:v>
                </c:pt>
                <c:pt idx="23">
                  <c:v>3.8217696976206292E-2</c:v>
                </c:pt>
                <c:pt idx="24">
                  <c:v>1.8956200233033994E-2</c:v>
                </c:pt>
                <c:pt idx="25">
                  <c:v>3.3679399832271396E-2</c:v>
                </c:pt>
                <c:pt idx="26">
                  <c:v>4.7072244156455431E-2</c:v>
                </c:pt>
                <c:pt idx="27">
                  <c:v>2.3297499076222916E-2</c:v>
                </c:pt>
                <c:pt idx="28">
                  <c:v>1.8205330289727751E-2</c:v>
                </c:pt>
                <c:pt idx="29">
                  <c:v>3.0200589545108646E-2</c:v>
                </c:pt>
                <c:pt idx="30">
                  <c:v>2.8169306602574461E-2</c:v>
                </c:pt>
                <c:pt idx="31">
                  <c:v>2.4284644267561495E-2</c:v>
                </c:pt>
                <c:pt idx="32">
                  <c:v>2.6647754054810992E-2</c:v>
                </c:pt>
                <c:pt idx="33">
                  <c:v>2.6075941625886334E-2</c:v>
                </c:pt>
                <c:pt idx="34">
                  <c:v>4.1349763362123773E-2</c:v>
                </c:pt>
                <c:pt idx="35">
                  <c:v>5.3717170365650754E-2</c:v>
                </c:pt>
                <c:pt idx="36">
                  <c:v>2.0984229354021243E-2</c:v>
                </c:pt>
                <c:pt idx="37">
                  <c:v>2.0828220942988196E-2</c:v>
                </c:pt>
                <c:pt idx="38">
                  <c:v>1.8357982615619738E-2</c:v>
                </c:pt>
                <c:pt idx="39">
                  <c:v>2.3315857961108889E-2</c:v>
                </c:pt>
                <c:pt idx="40">
                  <c:v>2.3103877856646183E-2</c:v>
                </c:pt>
                <c:pt idx="41">
                  <c:v>1.9106597295248905E-2</c:v>
                </c:pt>
                <c:pt idx="42">
                  <c:v>4.0613658316079305E-2</c:v>
                </c:pt>
                <c:pt idx="43">
                  <c:v>2.2025016086335603E-2</c:v>
                </c:pt>
                <c:pt idx="44">
                  <c:v>2.1360153245782887E-2</c:v>
                </c:pt>
                <c:pt idx="45">
                  <c:v>2.8230655427272943E-2</c:v>
                </c:pt>
                <c:pt idx="46">
                  <c:v>3.3003721144496609E-2</c:v>
                </c:pt>
                <c:pt idx="47">
                  <c:v>3.5077307337220809E-2</c:v>
                </c:pt>
                <c:pt idx="48">
                  <c:v>2.4890972438733637E-2</c:v>
                </c:pt>
                <c:pt idx="49">
                  <c:v>2.3411120067989132E-2</c:v>
                </c:pt>
                <c:pt idx="50">
                  <c:v>2.4827561303442592E-2</c:v>
                </c:pt>
                <c:pt idx="51">
                  <c:v>2.0303412788554697E-2</c:v>
                </c:pt>
                <c:pt idx="52">
                  <c:v>1.8825740805657399E-2</c:v>
                </c:pt>
                <c:pt idx="53">
                  <c:v>3.2197957147335796E-2</c:v>
                </c:pt>
                <c:pt idx="54">
                  <c:v>1.639081252223442E-2</c:v>
                </c:pt>
                <c:pt idx="55">
                  <c:v>1.6871299493005122E-2</c:v>
                </c:pt>
                <c:pt idx="56">
                  <c:v>1.6967026738989664E-2</c:v>
                </c:pt>
                <c:pt idx="57">
                  <c:v>3.0583905360308326E-2</c:v>
                </c:pt>
                <c:pt idx="58">
                  <c:v>2.2579082917833525E-2</c:v>
                </c:pt>
                <c:pt idx="59">
                  <c:v>2.3497961268631774E-2</c:v>
                </c:pt>
                <c:pt idx="60">
                  <c:v>2.0899369446986761E-2</c:v>
                </c:pt>
                <c:pt idx="61">
                  <c:v>2.0657703927090165E-2</c:v>
                </c:pt>
                <c:pt idx="62">
                  <c:v>2.3161861542298202E-2</c:v>
                </c:pt>
                <c:pt idx="63">
                  <c:v>2.0921200713923317E-2</c:v>
                </c:pt>
                <c:pt idx="64">
                  <c:v>1.7175440156774524E-2</c:v>
                </c:pt>
                <c:pt idx="65">
                  <c:v>2.3277065937944673E-2</c:v>
                </c:pt>
                <c:pt idx="66">
                  <c:v>1.6392671670856472E-2</c:v>
                </c:pt>
                <c:pt idx="67">
                  <c:v>1.9524594595089949E-2</c:v>
                </c:pt>
                <c:pt idx="68">
                  <c:v>2.3589219306213736E-2</c:v>
                </c:pt>
                <c:pt idx="69">
                  <c:v>4.3653945648611713E-2</c:v>
                </c:pt>
                <c:pt idx="70">
                  <c:v>4.2580813054753142E-2</c:v>
                </c:pt>
                <c:pt idx="71">
                  <c:v>4.8077938415226985E-2</c:v>
                </c:pt>
                <c:pt idx="72">
                  <c:v>4.9526096443264042E-2</c:v>
                </c:pt>
                <c:pt idx="73">
                  <c:v>1.8434679062297277E-2</c:v>
                </c:pt>
                <c:pt idx="74">
                  <c:v>2.5544152231607685E-2</c:v>
                </c:pt>
                <c:pt idx="75">
                  <c:v>2.5528941666102756E-2</c:v>
                </c:pt>
                <c:pt idx="76">
                  <c:v>3.034003298079424E-2</c:v>
                </c:pt>
                <c:pt idx="77">
                  <c:v>1.479561142450685E-2</c:v>
                </c:pt>
                <c:pt idx="78">
                  <c:v>2.3734764775950223E-2</c:v>
                </c:pt>
                <c:pt idx="79">
                  <c:v>2.8303275945784391E-2</c:v>
                </c:pt>
                <c:pt idx="80">
                  <c:v>4.0128520626043218E-2</c:v>
                </c:pt>
                <c:pt idx="81">
                  <c:v>1.8375825717181393E-2</c:v>
                </c:pt>
                <c:pt idx="82">
                  <c:v>3.1339111824532306E-2</c:v>
                </c:pt>
                <c:pt idx="83">
                  <c:v>3.1030356419708971E-2</c:v>
                </c:pt>
                <c:pt idx="84">
                  <c:v>2.8177054040520243E-2</c:v>
                </c:pt>
                <c:pt idx="85">
                  <c:v>3.0487563976510378E-2</c:v>
                </c:pt>
                <c:pt idx="86">
                  <c:v>1.6611624093017398E-2</c:v>
                </c:pt>
                <c:pt idx="87">
                  <c:v>2.9305046641732078E-2</c:v>
                </c:pt>
                <c:pt idx="88">
                  <c:v>4.3405913520435727E-2</c:v>
                </c:pt>
                <c:pt idx="89">
                  <c:v>2.2832621003916899E-2</c:v>
                </c:pt>
                <c:pt idx="90">
                  <c:v>2.159873337303737E-2</c:v>
                </c:pt>
                <c:pt idx="91">
                  <c:v>2.2483017699719832E-2</c:v>
                </c:pt>
                <c:pt idx="92">
                  <c:v>2.0464796553583176E-2</c:v>
                </c:pt>
                <c:pt idx="93">
                  <c:v>3.2636270974856885E-2</c:v>
                </c:pt>
                <c:pt idx="94">
                  <c:v>2.1243818473650887E-2</c:v>
                </c:pt>
                <c:pt idx="95">
                  <c:v>2.1029821346256306E-2</c:v>
                </c:pt>
                <c:pt idx="96">
                  <c:v>1.6046694745677971E-2</c:v>
                </c:pt>
                <c:pt idx="97">
                  <c:v>4.0719748056919157E-2</c:v>
                </c:pt>
                <c:pt idx="98">
                  <c:v>2.7046702987314264E-2</c:v>
                </c:pt>
                <c:pt idx="99">
                  <c:v>4.2938445724251983E-2</c:v>
                </c:pt>
                <c:pt idx="100">
                  <c:v>6.0468560067905977E-2</c:v>
                </c:pt>
                <c:pt idx="101">
                  <c:v>1.827227364752404E-2</c:v>
                </c:pt>
                <c:pt idx="102">
                  <c:v>2.1312277552664027E-2</c:v>
                </c:pt>
                <c:pt idx="103">
                  <c:v>1.9733940939761618E-2</c:v>
                </c:pt>
                <c:pt idx="104">
                  <c:v>3.184143127990393E-2</c:v>
                </c:pt>
                <c:pt idx="105">
                  <c:v>6.1234588082844502E-2</c:v>
                </c:pt>
                <c:pt idx="106">
                  <c:v>2.5193538412324766E-2</c:v>
                </c:pt>
                <c:pt idx="107">
                  <c:v>2.7876868792363174E-2</c:v>
                </c:pt>
                <c:pt idx="108">
                  <c:v>3.253434656242582E-2</c:v>
                </c:pt>
                <c:pt idx="109">
                  <c:v>2.436516145392149E-2</c:v>
                </c:pt>
                <c:pt idx="110">
                  <c:v>4.0603317913460987E-2</c:v>
                </c:pt>
                <c:pt idx="111">
                  <c:v>2.0403766529088218E-2</c:v>
                </c:pt>
                <c:pt idx="112">
                  <c:v>3.5916445305553976E-2</c:v>
                </c:pt>
                <c:pt idx="113">
                  <c:v>5.8392929831549714E-2</c:v>
                </c:pt>
                <c:pt idx="114">
                  <c:v>2.0255419404879516E-2</c:v>
                </c:pt>
                <c:pt idx="115">
                  <c:v>4.1795322861711573E-2</c:v>
                </c:pt>
                <c:pt idx="116">
                  <c:v>3.3929247357634897E-2</c:v>
                </c:pt>
                <c:pt idx="117">
                  <c:v>3.1136608078338623E-2</c:v>
                </c:pt>
                <c:pt idx="118">
                  <c:v>1.8208511192164822E-2</c:v>
                </c:pt>
                <c:pt idx="119">
                  <c:v>2.0623465096461402E-2</c:v>
                </c:pt>
                <c:pt idx="120">
                  <c:v>2.5218415871352651E-2</c:v>
                </c:pt>
                <c:pt idx="121">
                  <c:v>2.219161183943661E-2</c:v>
                </c:pt>
                <c:pt idx="122">
                  <c:v>1.956888936446375E-2</c:v>
                </c:pt>
                <c:pt idx="123">
                  <c:v>4.7518671960819069E-2</c:v>
                </c:pt>
                <c:pt idx="124">
                  <c:v>5.7407582838607807E-2</c:v>
                </c:pt>
                <c:pt idx="125">
                  <c:v>1.7597556254618008E-2</c:v>
                </c:pt>
                <c:pt idx="126">
                  <c:v>1.8258246823628265E-2</c:v>
                </c:pt>
                <c:pt idx="127">
                  <c:v>2.4427743199197584E-2</c:v>
                </c:pt>
                <c:pt idx="128">
                  <c:v>2.5351820152769888E-2</c:v>
                </c:pt>
                <c:pt idx="129">
                  <c:v>2.2809970562314864E-2</c:v>
                </c:pt>
                <c:pt idx="130">
                  <c:v>2.1346908640888042E-2</c:v>
                </c:pt>
                <c:pt idx="131">
                  <c:v>2.0717892483536126E-2</c:v>
                </c:pt>
                <c:pt idx="132">
                  <c:v>4.068903973336635E-2</c:v>
                </c:pt>
                <c:pt idx="133">
                  <c:v>3.3659992492053425E-2</c:v>
                </c:pt>
                <c:pt idx="134">
                  <c:v>2.9882522346979922E-2</c:v>
                </c:pt>
                <c:pt idx="135">
                  <c:v>3.0339294217743683E-2</c:v>
                </c:pt>
                <c:pt idx="136">
                  <c:v>2.2365236077981555E-2</c:v>
                </c:pt>
                <c:pt idx="137">
                  <c:v>3.3895849992871471E-2</c:v>
                </c:pt>
                <c:pt idx="138">
                  <c:v>2.8544736123782832E-2</c:v>
                </c:pt>
                <c:pt idx="139">
                  <c:v>4.8288562397720523E-2</c:v>
                </c:pt>
                <c:pt idx="140">
                  <c:v>2.2457779703007351E-2</c:v>
                </c:pt>
                <c:pt idx="141">
                  <c:v>2.3101368067781358E-2</c:v>
                </c:pt>
                <c:pt idx="142">
                  <c:v>2.2566061252443249E-2</c:v>
                </c:pt>
                <c:pt idx="143">
                  <c:v>1.9931905459290866E-2</c:v>
                </c:pt>
                <c:pt idx="144">
                  <c:v>2.4400085557815431E-2</c:v>
                </c:pt>
                <c:pt idx="145">
                  <c:v>2.6229785593652279E-2</c:v>
                </c:pt>
                <c:pt idx="146">
                  <c:v>2.6677804299450901E-2</c:v>
                </c:pt>
                <c:pt idx="147">
                  <c:v>3.8105729435905976E-2</c:v>
                </c:pt>
                <c:pt idx="148">
                  <c:v>2.3662119857438137E-2</c:v>
                </c:pt>
                <c:pt idx="149">
                  <c:v>2.2780063126479309E-2</c:v>
                </c:pt>
                <c:pt idx="150">
                  <c:v>1.764811909033661E-2</c:v>
                </c:pt>
                <c:pt idx="151">
                  <c:v>2.3485103066478552E-2</c:v>
                </c:pt>
                <c:pt idx="152">
                  <c:v>2.8025395922291363E-2</c:v>
                </c:pt>
                <c:pt idx="153">
                  <c:v>1.7467899540518063E-2</c:v>
                </c:pt>
                <c:pt idx="154">
                  <c:v>2.4775905304179457E-2</c:v>
                </c:pt>
                <c:pt idx="155">
                  <c:v>2.563260721999152E-2</c:v>
                </c:pt>
                <c:pt idx="156">
                  <c:v>2.2588819841454933E-2</c:v>
                </c:pt>
                <c:pt idx="157">
                  <c:v>2.6303578094930734E-2</c:v>
                </c:pt>
                <c:pt idx="158">
                  <c:v>2.4685682346016823E-2</c:v>
                </c:pt>
                <c:pt idx="159">
                  <c:v>1.9043097837567614E-2</c:v>
                </c:pt>
                <c:pt idx="160">
                  <c:v>2.9517136069113749E-2</c:v>
                </c:pt>
                <c:pt idx="161">
                  <c:v>1.8973044954248806E-2</c:v>
                </c:pt>
                <c:pt idx="162">
                  <c:v>3.5145668568897025E-2</c:v>
                </c:pt>
                <c:pt idx="163">
                  <c:v>2.7714476583584346E-2</c:v>
                </c:pt>
                <c:pt idx="164">
                  <c:v>2.036628552393982E-2</c:v>
                </c:pt>
                <c:pt idx="165">
                  <c:v>1.7787873039190116E-2</c:v>
                </c:pt>
                <c:pt idx="166">
                  <c:v>2.483370070743951E-2</c:v>
                </c:pt>
                <c:pt idx="167">
                  <c:v>2.3492076311842757E-2</c:v>
                </c:pt>
                <c:pt idx="168">
                  <c:v>2.5655349896131961E-2</c:v>
                </c:pt>
                <c:pt idx="169">
                  <c:v>2.7407042227607571E-2</c:v>
                </c:pt>
                <c:pt idx="170">
                  <c:v>2.003856178372989E-2</c:v>
                </c:pt>
                <c:pt idx="171">
                  <c:v>1.9850155460586348E-2</c:v>
                </c:pt>
                <c:pt idx="172">
                  <c:v>2.5613672912678288E-2</c:v>
                </c:pt>
                <c:pt idx="173">
                  <c:v>1.9317869077817761E-2</c:v>
                </c:pt>
                <c:pt idx="174">
                  <c:v>2.1839798329134519E-2</c:v>
                </c:pt>
                <c:pt idx="175">
                  <c:v>2.5550570909149427E-2</c:v>
                </c:pt>
                <c:pt idx="176">
                  <c:v>2.7273193790773486E-2</c:v>
                </c:pt>
                <c:pt idx="177">
                  <c:v>2.2117821231795731E-2</c:v>
                </c:pt>
                <c:pt idx="178">
                  <c:v>2.4790367008223659E-2</c:v>
                </c:pt>
                <c:pt idx="179">
                  <c:v>1.8690064441697806E-2</c:v>
                </c:pt>
                <c:pt idx="180">
                  <c:v>2.2823581090491853E-2</c:v>
                </c:pt>
                <c:pt idx="181">
                  <c:v>2.4311527016228695E-2</c:v>
                </c:pt>
                <c:pt idx="182">
                  <c:v>1.9655852821944396E-2</c:v>
                </c:pt>
                <c:pt idx="183">
                  <c:v>3.1729779657297286E-2</c:v>
                </c:pt>
                <c:pt idx="184">
                  <c:v>1.8225541551693248E-2</c:v>
                </c:pt>
                <c:pt idx="185">
                  <c:v>1.8634160895073238E-2</c:v>
                </c:pt>
                <c:pt idx="186">
                  <c:v>2.7395469352666679E-2</c:v>
                </c:pt>
                <c:pt idx="187">
                  <c:v>2.6631650177682008E-2</c:v>
                </c:pt>
                <c:pt idx="188">
                  <c:v>1.8242632806534865E-2</c:v>
                </c:pt>
                <c:pt idx="189">
                  <c:v>2.3391715647105359E-2</c:v>
                </c:pt>
                <c:pt idx="190">
                  <c:v>1.8084265023221156E-2</c:v>
                </c:pt>
                <c:pt idx="191">
                  <c:v>3.1949396265490114E-2</c:v>
                </c:pt>
                <c:pt idx="192">
                  <c:v>1.9168096113519505E-2</c:v>
                </c:pt>
                <c:pt idx="193">
                  <c:v>2.4131073458703689E-2</c:v>
                </c:pt>
                <c:pt idx="194">
                  <c:v>2.0848915094523579E-2</c:v>
                </c:pt>
                <c:pt idx="195">
                  <c:v>3.4882253259573906E-2</c:v>
                </c:pt>
                <c:pt idx="196">
                  <c:v>4.9224675823481688E-2</c:v>
                </c:pt>
                <c:pt idx="197">
                  <c:v>2.5111003137151443E-2</c:v>
                </c:pt>
                <c:pt idx="198">
                  <c:v>1.9256943495039501E-2</c:v>
                </c:pt>
                <c:pt idx="199">
                  <c:v>1.960292735363689E-2</c:v>
                </c:pt>
                <c:pt idx="200">
                  <c:v>3.1349100009579044E-2</c:v>
                </c:pt>
                <c:pt idx="201">
                  <c:v>2.2867577416564422E-2</c:v>
                </c:pt>
                <c:pt idx="202">
                  <c:v>3.5610078822238565E-2</c:v>
                </c:pt>
                <c:pt idx="203">
                  <c:v>2.3336980287997577E-2</c:v>
                </c:pt>
                <c:pt idx="204">
                  <c:v>1.7351650538181683E-2</c:v>
                </c:pt>
                <c:pt idx="205">
                  <c:v>2.0177665736236895E-2</c:v>
                </c:pt>
                <c:pt idx="206">
                  <c:v>2.2446148784074738E-2</c:v>
                </c:pt>
                <c:pt idx="207">
                  <c:v>1.8520393103206034E-2</c:v>
                </c:pt>
                <c:pt idx="208">
                  <c:v>2.4598388842822748E-2</c:v>
                </c:pt>
                <c:pt idx="209">
                  <c:v>2.7530226939379787E-2</c:v>
                </c:pt>
                <c:pt idx="210">
                  <c:v>4.4304022826641296E-2</c:v>
                </c:pt>
                <c:pt idx="211">
                  <c:v>2.4823938729412555E-2</c:v>
                </c:pt>
                <c:pt idx="212">
                  <c:v>3.9247947116407889E-2</c:v>
                </c:pt>
                <c:pt idx="213">
                  <c:v>3.1870788765713497E-2</c:v>
                </c:pt>
                <c:pt idx="214">
                  <c:v>2.466468013987184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EED-204C-BB4E-567E2CD642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5330592"/>
        <c:axId val="535325888"/>
      </c:scatterChart>
      <c:valAx>
        <c:axId val="535330592"/>
        <c:scaling>
          <c:orientation val="minMax"/>
          <c:max val="2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050" dirty="0"/>
                  <a:t>FW</a:t>
                </a:r>
                <a:r>
                  <a:rPr lang="fr-FR" sz="1050" baseline="-20000" dirty="0"/>
                  <a:t>T0</a:t>
                </a:r>
                <a:r>
                  <a:rPr lang="fr-FR" sz="1050" b="0" i="0" u="none" strike="noStrike" baseline="0" dirty="0">
                    <a:effectLst/>
                  </a:rPr>
                  <a:t> (grams)</a:t>
                </a:r>
                <a:endParaRPr lang="fr-FR" sz="1050" baseline="-20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5888"/>
        <c:crosses val="autoZero"/>
        <c:crossBetween val="midCat"/>
        <c:majorUnit val="50"/>
      </c:valAx>
      <c:valAx>
        <c:axId val="535325888"/>
        <c:scaling>
          <c:orientation val="minMax"/>
          <c:max val="0.1200000000000000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50" b="0" i="0" u="none" strike="noStrike" kern="1200" baseline="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LossFW</a:t>
                </a:r>
                <a:r>
                  <a:rPr lang="en-US" sz="1050" b="0" i="0" u="none" strike="noStrike" kern="1200" baseline="-20000" dirty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T14 </a:t>
                </a:r>
                <a:endParaRPr lang="fr-FR" sz="1050" baseline="-20000" dirty="0"/>
              </a:p>
            </c:rich>
          </c:tx>
          <c:layout>
            <c:manualLayout>
              <c:xMode val="edge"/>
              <c:yMode val="edge"/>
              <c:x val="6.1149509278129351E-2"/>
              <c:y val="0.375837343248760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30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b="1" dirty="0"/>
              <a:t>Loss</a:t>
            </a:r>
            <a:r>
              <a:rPr lang="en-US" b="1" baseline="0" dirty="0"/>
              <a:t>FW</a:t>
            </a:r>
            <a:r>
              <a:rPr lang="en-US" b="1" baseline="-20000" dirty="0"/>
              <a:t>T1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6760588413646"/>
          <c:y val="0.13186408349300036"/>
          <c:w val="0.81361530398322857"/>
          <c:h val="0.70515261870887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BSA-Seq LossFW'!$Q$39:$Q$49</c:f>
              <c:numCache>
                <c:formatCode>0.00%</c:formatCode>
                <c:ptCount val="11"/>
                <c:pt idx="0">
                  <c:v>1.4999999999999999E-2</c:v>
                </c:pt>
                <c:pt idx="1">
                  <c:v>0.02</c:v>
                </c:pt>
                <c:pt idx="2">
                  <c:v>2.5000000000000001E-2</c:v>
                </c:pt>
                <c:pt idx="3">
                  <c:v>0.03</c:v>
                </c:pt>
                <c:pt idx="4">
                  <c:v>3.5000000000000003E-2</c:v>
                </c:pt>
                <c:pt idx="5">
                  <c:v>0.04</c:v>
                </c:pt>
                <c:pt idx="6">
                  <c:v>4.4999999999999998E-2</c:v>
                </c:pt>
                <c:pt idx="7">
                  <c:v>0.05</c:v>
                </c:pt>
                <c:pt idx="8">
                  <c:v>5.5E-2</c:v>
                </c:pt>
                <c:pt idx="9">
                  <c:v>0.06</c:v>
                </c:pt>
                <c:pt idx="10">
                  <c:v>6.5000000000000002E-2</c:v>
                </c:pt>
              </c:numCache>
            </c:numRef>
          </c:cat>
          <c:val>
            <c:numRef>
              <c:f>'BSA-Seq LossFW'!$R$39:$R$49</c:f>
              <c:numCache>
                <c:formatCode>General</c:formatCode>
                <c:ptCount val="11"/>
                <c:pt idx="0">
                  <c:v>1</c:v>
                </c:pt>
                <c:pt idx="1">
                  <c:v>44</c:v>
                </c:pt>
                <c:pt idx="2">
                  <c:v>75</c:v>
                </c:pt>
                <c:pt idx="3">
                  <c:v>36</c:v>
                </c:pt>
                <c:pt idx="4">
                  <c:v>22</c:v>
                </c:pt>
                <c:pt idx="5">
                  <c:v>8</c:v>
                </c:pt>
                <c:pt idx="6">
                  <c:v>13</c:v>
                </c:pt>
                <c:pt idx="7">
                  <c:v>7</c:v>
                </c:pt>
                <c:pt idx="8">
                  <c:v>1</c:v>
                </c:pt>
                <c:pt idx="9">
                  <c:v>2</c:v>
                </c:pt>
                <c:pt idx="1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F6-444E-AEB7-FE1AC76EC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35331768"/>
        <c:axId val="535327456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SA-Seq LossFW'!$S$39:$S$49</c:f>
              <c:numCache>
                <c:formatCode>0.0</c:formatCode>
                <c:ptCount val="11"/>
                <c:pt idx="0">
                  <c:v>18.968642661259963</c:v>
                </c:pt>
                <c:pt idx="1">
                  <c:v>33.280123513551352</c:v>
                </c:pt>
                <c:pt idx="2">
                  <c:v>43.114394178343346</c:v>
                </c:pt>
                <c:pt idx="3">
                  <c:v>41.242817923802441</c:v>
                </c:pt>
                <c:pt idx="4">
                  <c:v>29.131514139361109</c:v>
                </c:pt>
                <c:pt idx="5">
                  <c:v>15.193802248662529</c:v>
                </c:pt>
                <c:pt idx="6">
                  <c:v>5.8513835376659191</c:v>
                </c:pt>
                <c:pt idx="7">
                  <c:v>1.6639464509262702</c:v>
                </c:pt>
                <c:pt idx="8">
                  <c:v>0.34938866414093628</c:v>
                </c:pt>
                <c:pt idx="9">
                  <c:v>5.417101326642746E-2</c:v>
                </c:pt>
                <c:pt idx="10">
                  <c:v>6.2017433882131006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2F6-444E-AEB7-FE1AC76EC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5327848"/>
        <c:axId val="535324320"/>
      </c:lineChart>
      <c:catAx>
        <c:axId val="535331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Loss</a:t>
                </a:r>
                <a:r>
                  <a:rPr lang="en-US" dirty="0"/>
                  <a:t>FW</a:t>
                </a:r>
                <a:r>
                  <a:rPr lang="en-US" baseline="-20000" dirty="0"/>
                  <a:t>T14</a:t>
                </a:r>
                <a:r>
                  <a:rPr lang="en-US" dirty="0"/>
                  <a:t> bin</a:t>
                </a:r>
              </a:p>
            </c:rich>
          </c:tx>
          <c:layout>
            <c:manualLayout>
              <c:xMode val="edge"/>
              <c:yMode val="edge"/>
              <c:x val="0.42533613181803925"/>
              <c:y val="0.913461431832619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7456"/>
        <c:crosses val="autoZero"/>
        <c:auto val="1"/>
        <c:lblAlgn val="ctr"/>
        <c:lblOffset val="100"/>
        <c:noMultiLvlLbl val="0"/>
      </c:catAx>
      <c:valAx>
        <c:axId val="5353274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0"/>
              <c:y val="0.354478457241620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31768"/>
        <c:crosses val="autoZero"/>
        <c:crossBetween val="between"/>
      </c:valAx>
      <c:valAx>
        <c:axId val="535324320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7848"/>
        <c:crosses val="max"/>
        <c:crossBetween val="between"/>
      </c:valAx>
      <c:catAx>
        <c:axId val="535327848"/>
        <c:scaling>
          <c:orientation val="minMax"/>
        </c:scaling>
        <c:delete val="1"/>
        <c:axPos val="b"/>
        <c:majorTickMark val="out"/>
        <c:minorTickMark val="none"/>
        <c:tickLblPos val="nextTo"/>
        <c:crossAx val="53532432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285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 dirty="0">
                <a:effectLst/>
              </a:rPr>
              <a:t>FF</a:t>
            </a:r>
            <a:r>
              <a:rPr lang="en-US" sz="1400" b="1" i="0" baseline="-20000" dirty="0">
                <a:effectLst/>
              </a:rPr>
              <a:t>T14</a:t>
            </a:r>
            <a:endParaRPr lang="en-US" sz="1100" baseline="-200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82204522272679"/>
          <c:y val="0.12946009389671365"/>
          <c:w val="0.79720988584938235"/>
          <c:h val="0.699760954616588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BSA-Seq Firm'!$S$28:$S$38</c:f>
              <c:numCache>
                <c:formatCode>General</c:formatCode>
                <c:ptCount val="11"/>
                <c:pt idx="0">
                  <c:v>30</c:v>
                </c:pt>
                <c:pt idx="1">
                  <c:v>32.75</c:v>
                </c:pt>
                <c:pt idx="2">
                  <c:v>35.5</c:v>
                </c:pt>
                <c:pt idx="3">
                  <c:v>38.25</c:v>
                </c:pt>
                <c:pt idx="4">
                  <c:v>41</c:v>
                </c:pt>
                <c:pt idx="5">
                  <c:v>43.75</c:v>
                </c:pt>
                <c:pt idx="6">
                  <c:v>46.5</c:v>
                </c:pt>
                <c:pt idx="7">
                  <c:v>49.25</c:v>
                </c:pt>
                <c:pt idx="8">
                  <c:v>52</c:v>
                </c:pt>
                <c:pt idx="9">
                  <c:v>54.75</c:v>
                </c:pt>
                <c:pt idx="10">
                  <c:v>57.5</c:v>
                </c:pt>
              </c:numCache>
            </c:numRef>
          </c:cat>
          <c:val>
            <c:numRef>
              <c:f>'BSA-Seq Firm'!$T$28:$T$38</c:f>
              <c:numCache>
                <c:formatCode>General</c:formatCode>
                <c:ptCount val="11"/>
                <c:pt idx="0">
                  <c:v>2</c:v>
                </c:pt>
                <c:pt idx="1">
                  <c:v>7</c:v>
                </c:pt>
                <c:pt idx="2">
                  <c:v>20</c:v>
                </c:pt>
                <c:pt idx="3">
                  <c:v>41</c:v>
                </c:pt>
                <c:pt idx="4">
                  <c:v>35</c:v>
                </c:pt>
                <c:pt idx="5">
                  <c:v>35</c:v>
                </c:pt>
                <c:pt idx="6">
                  <c:v>42</c:v>
                </c:pt>
                <c:pt idx="7">
                  <c:v>18</c:v>
                </c:pt>
                <c:pt idx="8">
                  <c:v>9</c:v>
                </c:pt>
                <c:pt idx="9">
                  <c:v>3</c:v>
                </c:pt>
                <c:pt idx="1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DB-4D92-9AA1-63B215CE5F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535321968"/>
        <c:axId val="535332552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SA-Seq Firm'!$U$28:$U$38</c:f>
              <c:numCache>
                <c:formatCode>General</c:formatCode>
                <c:ptCount val="11"/>
                <c:pt idx="0">
                  <c:v>7.3875458622195758E-3</c:v>
                </c:pt>
                <c:pt idx="1">
                  <c:v>1.9815195612033841E-2</c:v>
                </c:pt>
                <c:pt idx="2">
                  <c:v>4.0538758697262874E-2</c:v>
                </c:pt>
                <c:pt idx="3">
                  <c:v>6.3258142803835807E-2</c:v>
                </c:pt>
                <c:pt idx="4">
                  <c:v>7.5289833497815803E-2</c:v>
                </c:pt>
                <c:pt idx="5">
                  <c:v>6.8348682047797676E-2</c:v>
                </c:pt>
                <c:pt idx="6">
                  <c:v>4.7325788763264008E-2</c:v>
                </c:pt>
                <c:pt idx="7">
                  <c:v>2.4994214106599359E-2</c:v>
                </c:pt>
                <c:pt idx="8">
                  <c:v>1.00682738396182E-2</c:v>
                </c:pt>
                <c:pt idx="9">
                  <c:v>3.0934596876558041E-3</c:v>
                </c:pt>
                <c:pt idx="10">
                  <c:v>7.2494959433938642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0DB-4D92-9AA1-63B215CE5F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5322360"/>
        <c:axId val="535332944"/>
      </c:lineChart>
      <c:catAx>
        <c:axId val="5353219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F</a:t>
                </a:r>
                <a:r>
                  <a:rPr lang="en-US" baseline="-20000" dirty="0"/>
                  <a:t>T14</a:t>
                </a:r>
                <a:r>
                  <a:rPr lang="en-US" dirty="0"/>
                  <a:t> bin</a:t>
                </a:r>
              </a:p>
            </c:rich>
          </c:tx>
          <c:layout>
            <c:manualLayout>
              <c:xMode val="edge"/>
              <c:yMode val="edge"/>
              <c:x val="0.46539741863045619"/>
              <c:y val="0.914593662848532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32552"/>
        <c:crosses val="autoZero"/>
        <c:auto val="1"/>
        <c:lblAlgn val="ctr"/>
        <c:lblOffset val="100"/>
        <c:noMultiLvlLbl val="0"/>
      </c:catAx>
      <c:valAx>
        <c:axId val="5353325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1.0041880704565761E-2"/>
              <c:y val="0.385863698115632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1968"/>
        <c:crosses val="autoZero"/>
        <c:crossBetween val="between"/>
      </c:valAx>
      <c:valAx>
        <c:axId val="535332944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5322360"/>
        <c:crosses val="max"/>
        <c:crossBetween val="between"/>
      </c:valAx>
      <c:catAx>
        <c:axId val="535322360"/>
        <c:scaling>
          <c:orientation val="minMax"/>
        </c:scaling>
        <c:delete val="1"/>
        <c:axPos val="b"/>
        <c:majorTickMark val="out"/>
        <c:minorTickMark val="none"/>
        <c:tickLblPos val="nextTo"/>
        <c:crossAx val="5353329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285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b="1" dirty="0"/>
              <a:t>FF</a:t>
            </a:r>
            <a:r>
              <a:rPr lang="en-US" b="1" baseline="-30000" dirty="0"/>
              <a:t>T0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548381452318461"/>
          <c:y val="0.12202582159624413"/>
          <c:w val="0.82060192475940508"/>
          <c:h val="0.71542605633802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BSA-Seq'!$S$3:$S$11</c:f>
              <c:numCache>
                <c:formatCode>General</c:formatCode>
                <c:ptCount val="9"/>
                <c:pt idx="0">
                  <c:v>70</c:v>
                </c:pt>
                <c:pt idx="1">
                  <c:v>74</c:v>
                </c:pt>
                <c:pt idx="2">
                  <c:v>78</c:v>
                </c:pt>
                <c:pt idx="3">
                  <c:v>82</c:v>
                </c:pt>
                <c:pt idx="4">
                  <c:v>86</c:v>
                </c:pt>
                <c:pt idx="5">
                  <c:v>90</c:v>
                </c:pt>
                <c:pt idx="6">
                  <c:v>94</c:v>
                </c:pt>
                <c:pt idx="7">
                  <c:v>98</c:v>
                </c:pt>
                <c:pt idx="8">
                  <c:v>102</c:v>
                </c:pt>
              </c:numCache>
            </c:numRef>
          </c:cat>
          <c:val>
            <c:numRef>
              <c:f>'BSA-Seq'!$T$3:$T$11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4</c:v>
                </c:pt>
                <c:pt idx="3">
                  <c:v>9</c:v>
                </c:pt>
                <c:pt idx="4">
                  <c:v>43</c:v>
                </c:pt>
                <c:pt idx="5">
                  <c:v>82</c:v>
                </c:pt>
                <c:pt idx="6">
                  <c:v>56</c:v>
                </c:pt>
                <c:pt idx="7">
                  <c:v>2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25-4785-9A93-4F5A667ED5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5324712"/>
        <c:axId val="535334120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SA-Seq'!$U$3:$U$11</c:f>
              <c:numCache>
                <c:formatCode>0.00E+00</c:formatCode>
                <c:ptCount val="9"/>
                <c:pt idx="0">
                  <c:v>5.5087670187885998E-5</c:v>
                </c:pt>
                <c:pt idx="1">
                  <c:v>9.6799656375303887E-4</c:v>
                </c:pt>
                <c:pt idx="2">
                  <c:v>8.3841711323730059E-3</c:v>
                </c:pt>
                <c:pt idx="3">
                  <c:v>3.5794257757530888E-2</c:v>
                </c:pt>
                <c:pt idx="4">
                  <c:v>7.5324021089968357E-2</c:v>
                </c:pt>
                <c:pt idx="5">
                  <c:v>7.8130488498518474E-2</c:v>
                </c:pt>
                <c:pt idx="6">
                  <c:v>3.9946109789098454E-2</c:v>
                </c:pt>
                <c:pt idx="7">
                  <c:v>1.0066890649691781E-2</c:v>
                </c:pt>
                <c:pt idx="8">
                  <c:v>1.2504983392208049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725-4785-9A93-4F5A667ED5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5329808"/>
        <c:axId val="535325104"/>
      </c:lineChart>
      <c:catAx>
        <c:axId val="5353247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000" b="0" i="0" baseline="0">
                    <a:effectLst/>
                  </a:rPr>
                  <a:t>FF</a:t>
                </a:r>
                <a:r>
                  <a:rPr lang="en-US" sz="1000" b="0" i="0" baseline="-20000">
                    <a:effectLst/>
                  </a:rPr>
                  <a:t>T0</a:t>
                </a:r>
                <a:r>
                  <a:rPr lang="en-US" sz="1000" b="0" i="0" baseline="0">
                    <a:effectLst/>
                  </a:rPr>
                  <a:t> bin</a:t>
                </a:r>
                <a:endParaRPr lang="en-US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0.47960411198600172"/>
              <c:y val="0.911087780694079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34120"/>
        <c:crosses val="autoZero"/>
        <c:auto val="1"/>
        <c:lblAlgn val="ctr"/>
        <c:lblOffset val="100"/>
        <c:noMultiLvlLbl val="0"/>
      </c:catAx>
      <c:valAx>
        <c:axId val="535334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24712"/>
        <c:crosses val="autoZero"/>
        <c:crossBetween val="between"/>
      </c:valAx>
      <c:valAx>
        <c:axId val="535325104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29808"/>
        <c:crosses val="max"/>
        <c:crossBetween val="between"/>
      </c:valAx>
      <c:catAx>
        <c:axId val="535329808"/>
        <c:scaling>
          <c:orientation val="minMax"/>
        </c:scaling>
        <c:delete val="1"/>
        <c:axPos val="b"/>
        <c:majorTickMark val="out"/>
        <c:minorTickMark val="none"/>
        <c:tickLblPos val="nextTo"/>
        <c:crossAx val="53532510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28575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sz="1400" b="1" i="0" baseline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Loss</a:t>
            </a:r>
            <a:r>
              <a:rPr lang="en-US" sz="1400" b="1" i="0" baseline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F</a:t>
            </a:r>
            <a:r>
              <a:rPr lang="en-US" sz="1400" b="1" i="0" baseline="-3000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14</a:t>
            </a:r>
            <a:endParaRPr lang="en-US" sz="1400" dirty="0"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371907756813416"/>
          <c:y val="0.1240935054773083"/>
          <c:w val="0.81168553459119497"/>
          <c:h val="0.714904147104851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BSA-Seq'!$Y$3:$Y$12</c:f>
              <c:numCache>
                <c:formatCode>0%</c:formatCode>
                <c:ptCount val="10"/>
                <c:pt idx="0">
                  <c:v>0.1</c:v>
                </c:pt>
                <c:pt idx="1">
                  <c:v>0.15</c:v>
                </c:pt>
                <c:pt idx="2">
                  <c:v>0.2</c:v>
                </c:pt>
                <c:pt idx="3">
                  <c:v>0.25</c:v>
                </c:pt>
                <c:pt idx="4">
                  <c:v>0.3</c:v>
                </c:pt>
                <c:pt idx="5">
                  <c:v>0.35</c:v>
                </c:pt>
                <c:pt idx="6">
                  <c:v>0.4</c:v>
                </c:pt>
                <c:pt idx="7">
                  <c:v>0.45</c:v>
                </c:pt>
                <c:pt idx="8">
                  <c:v>0.5</c:v>
                </c:pt>
                <c:pt idx="9">
                  <c:v>0.55000000000000004</c:v>
                </c:pt>
              </c:numCache>
            </c:numRef>
          </c:cat>
          <c:val>
            <c:numRef>
              <c:f>'BSA-Seq'!$Z$3:$Z$12</c:f>
              <c:numCache>
                <c:formatCode>General</c:formatCode>
                <c:ptCount val="10"/>
                <c:pt idx="0">
                  <c:v>1</c:v>
                </c:pt>
                <c:pt idx="1">
                  <c:v>6</c:v>
                </c:pt>
                <c:pt idx="2">
                  <c:v>25</c:v>
                </c:pt>
                <c:pt idx="3">
                  <c:v>55</c:v>
                </c:pt>
                <c:pt idx="4">
                  <c:v>68</c:v>
                </c:pt>
                <c:pt idx="5">
                  <c:v>44</c:v>
                </c:pt>
                <c:pt idx="6">
                  <c:v>14</c:v>
                </c:pt>
                <c:pt idx="7">
                  <c:v>3</c:v>
                </c:pt>
                <c:pt idx="8">
                  <c:v>2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38-4395-8562-56C008731E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5330984"/>
        <c:axId val="535322752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SA-Seq'!$AA$3:$AA$12</c:f>
              <c:numCache>
                <c:formatCode>0.00E+00</c:formatCode>
                <c:ptCount val="10"/>
                <c:pt idx="0">
                  <c:v>0.24231037683962833</c:v>
                </c:pt>
                <c:pt idx="1">
                  <c:v>1.2192005043923428</c:v>
                </c:pt>
                <c:pt idx="2">
                  <c:v>3.500996324309289</c:v>
                </c:pt>
                <c:pt idx="3">
                  <c:v>5.7374851754614609</c:v>
                </c:pt>
                <c:pt idx="4">
                  <c:v>5.3661758262444454</c:v>
                </c:pt>
                <c:pt idx="5">
                  <c:v>2.8643205648172323</c:v>
                </c:pt>
                <c:pt idx="6">
                  <c:v>0.87255285554893114</c:v>
                </c:pt>
                <c:pt idx="7">
                  <c:v>0.15169639765343668</c:v>
                </c:pt>
                <c:pt idx="8">
                  <c:v>1.5051236910152631E-2</c:v>
                </c:pt>
                <c:pt idx="9">
                  <c:v>8.5228042977170593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438-4395-8562-56C008731E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5333336"/>
        <c:axId val="535326672"/>
      </c:lineChart>
      <c:catAx>
        <c:axId val="535330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it-IT" sz="1000" b="0" i="0" baseline="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Loss</a:t>
                </a:r>
                <a:r>
                  <a:rPr lang="en-US" sz="1000" b="0" i="0" baseline="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FF</a:t>
                </a:r>
                <a:r>
                  <a:rPr lang="en-US" sz="1000" b="0" i="0" baseline="-2000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T14</a:t>
                </a:r>
                <a:r>
                  <a:rPr lang="en-US" sz="1000" b="0" i="0" baseline="0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 bin</a:t>
                </a:r>
                <a:endParaRPr lang="en-US" sz="1000" dirty="0">
                  <a:effectLst/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layout>
            <c:manualLayout>
              <c:xMode val="edge"/>
              <c:yMode val="edge"/>
              <c:x val="0.45068740425614956"/>
              <c:y val="0.906658694532342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22752"/>
        <c:crosses val="autoZero"/>
        <c:auto val="1"/>
        <c:lblAlgn val="ctr"/>
        <c:lblOffset val="100"/>
        <c:noMultiLvlLbl val="0"/>
      </c:catAx>
      <c:valAx>
        <c:axId val="535322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1.3312368972746331E-2"/>
              <c:y val="0.333602503912363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30984"/>
        <c:crosses val="autoZero"/>
        <c:crossBetween val="between"/>
      </c:valAx>
      <c:valAx>
        <c:axId val="535326672"/>
        <c:scaling>
          <c:orientation val="minMax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5333336"/>
        <c:crosses val="max"/>
        <c:crossBetween val="between"/>
      </c:valAx>
      <c:catAx>
        <c:axId val="535333336"/>
        <c:scaling>
          <c:orientation val="minMax"/>
        </c:scaling>
        <c:delete val="1"/>
        <c:axPos val="b"/>
        <c:majorTickMark val="out"/>
        <c:minorTickMark val="none"/>
        <c:tickLblPos val="nextTo"/>
        <c:crossAx val="5353266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28575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b="1" dirty="0">
                <a:latin typeface="Calibri" panose="020F0502020204030204" pitchFamily="34" charset="0"/>
                <a:cs typeface="Calibri" panose="020F0502020204030204" pitchFamily="34" charset="0"/>
              </a:rPr>
              <a:t>Loss</a:t>
            </a:r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FW</a:t>
            </a:r>
            <a:r>
              <a:rPr lang="en-US" b="1" baseline="-30000" dirty="0">
                <a:latin typeface="Calibri" panose="020F0502020204030204" pitchFamily="34" charset="0"/>
                <a:cs typeface="Calibri" panose="020F0502020204030204" pitchFamily="34" charset="0"/>
              </a:rPr>
              <a:t>T14</a:t>
            </a:r>
          </a:p>
        </c:rich>
      </c:tx>
      <c:layout>
        <c:manualLayout>
          <c:xMode val="edge"/>
          <c:yMode val="edge"/>
          <c:x val="0.40804927630440141"/>
          <c:y val="8.7785449596290612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179732400502972"/>
          <c:y val="0.1351008793021414"/>
          <c:w val="0.82094751535455057"/>
          <c:h val="0.7119701187753961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A$41:$AA$52</c:f>
              <c:numCache>
                <c:formatCode>0.00%</c:formatCode>
                <c:ptCount val="12"/>
                <c:pt idx="0">
                  <c:v>1.4999999999999999E-2</c:v>
                </c:pt>
                <c:pt idx="1">
                  <c:v>1.95E-2</c:v>
                </c:pt>
                <c:pt idx="2">
                  <c:v>2.4E-2</c:v>
                </c:pt>
                <c:pt idx="3">
                  <c:v>2.8500000000000001E-2</c:v>
                </c:pt>
                <c:pt idx="4">
                  <c:v>3.3000000000000002E-2</c:v>
                </c:pt>
                <c:pt idx="5">
                  <c:v>3.7499999999999999E-2</c:v>
                </c:pt>
                <c:pt idx="6">
                  <c:v>4.2000000000000003E-2</c:v>
                </c:pt>
                <c:pt idx="7">
                  <c:v>4.65E-2</c:v>
                </c:pt>
                <c:pt idx="8">
                  <c:v>5.0999999999999997E-2</c:v>
                </c:pt>
                <c:pt idx="9">
                  <c:v>5.5500000000000001E-2</c:v>
                </c:pt>
                <c:pt idx="10">
                  <c:v>0.06</c:v>
                </c:pt>
                <c:pt idx="11">
                  <c:v>6.4500000000000002E-2</c:v>
                </c:pt>
              </c:numCache>
            </c:numRef>
          </c:cat>
          <c:val>
            <c:numRef>
              <c:f>'Table S1 INRAe pheno'!$AB$41:$AB$52</c:f>
              <c:numCache>
                <c:formatCode>General</c:formatCode>
                <c:ptCount val="12"/>
                <c:pt idx="0">
                  <c:v>3</c:v>
                </c:pt>
                <c:pt idx="1">
                  <c:v>66</c:v>
                </c:pt>
                <c:pt idx="2">
                  <c:v>80</c:v>
                </c:pt>
                <c:pt idx="3">
                  <c:v>28</c:v>
                </c:pt>
                <c:pt idx="4">
                  <c:v>17</c:v>
                </c:pt>
                <c:pt idx="5">
                  <c:v>6</c:v>
                </c:pt>
                <c:pt idx="6">
                  <c:v>0</c:v>
                </c:pt>
                <c:pt idx="7">
                  <c:v>0</c:v>
                </c:pt>
                <c:pt idx="8">
                  <c:v>4</c:v>
                </c:pt>
                <c:pt idx="9">
                  <c:v>1</c:v>
                </c:pt>
                <c:pt idx="10">
                  <c:v>2</c:v>
                </c:pt>
                <c:pt idx="1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13-4E2B-B9A1-349B76D613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431574784"/>
        <c:axId val="431575176"/>
      </c:barChart>
      <c:lineChart>
        <c:grouping val="standard"/>
        <c:varyColors val="0"/>
        <c:ser>
          <c:idx val="1"/>
          <c:order val="1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C$41:$AC$52</c:f>
              <c:numCache>
                <c:formatCode>0.00000</c:formatCode>
                <c:ptCount val="12"/>
                <c:pt idx="0">
                  <c:v>24.44630919768964</c:v>
                </c:pt>
                <c:pt idx="1">
                  <c:v>31.13516988711643</c:v>
                </c:pt>
                <c:pt idx="2">
                  <c:v>34.168639780215209</c:v>
                </c:pt>
                <c:pt idx="3">
                  <c:v>32.310423619905713</c:v>
                </c:pt>
                <c:pt idx="4">
                  <c:v>26.326681842398695</c:v>
                </c:pt>
                <c:pt idx="5">
                  <c:v>18.483665871691304</c:v>
                </c:pt>
                <c:pt idx="6">
                  <c:v>11.181977256151203</c:v>
                </c:pt>
                <c:pt idx="7">
                  <c:v>5.828913508780369</c:v>
                </c:pt>
                <c:pt idx="8">
                  <c:v>2.6181536429609711</c:v>
                </c:pt>
                <c:pt idx="9">
                  <c:v>1.0133072687478497</c:v>
                </c:pt>
                <c:pt idx="10">
                  <c:v>0.33792918289314228</c:v>
                </c:pt>
                <c:pt idx="11">
                  <c:v>9.71066002743281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E13-4E2B-B9A1-349B76D613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1579096"/>
        <c:axId val="431576352"/>
      </c:lineChart>
      <c:catAx>
        <c:axId val="431574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it-IT" sz="1000" b="0" i="0" u="none" strike="noStrike" baseline="0" dirty="0">
                    <a:effectLst/>
                  </a:rPr>
                  <a:t>Loss</a:t>
                </a:r>
                <a:r>
                  <a:rPr lang="en-US" sz="1000" b="0" i="0" baseline="0" dirty="0">
                    <a:effectLst/>
                  </a:rPr>
                  <a:t>FW</a:t>
                </a:r>
                <a:r>
                  <a:rPr lang="en-US" sz="1000" b="0" i="0" baseline="-30000" dirty="0">
                    <a:effectLst/>
                  </a:rPr>
                  <a:t>T14</a:t>
                </a:r>
                <a:r>
                  <a:rPr lang="en-US" sz="1000" b="0" i="0" baseline="0" dirty="0">
                    <a:effectLst/>
                  </a:rPr>
                  <a:t> bin</a:t>
                </a:r>
                <a:endParaRPr lang="en-US" sz="1000" b="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1259966499162487"/>
              <c:y val="0.927797645327446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431575176"/>
        <c:crosses val="autoZero"/>
        <c:auto val="1"/>
        <c:lblAlgn val="ctr"/>
        <c:lblOffset val="100"/>
        <c:noMultiLvlLbl val="0"/>
      </c:catAx>
      <c:valAx>
        <c:axId val="431575176"/>
        <c:scaling>
          <c:orientation val="minMax"/>
          <c:max val="8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000" b="0" i="0" u="none" strike="noStrike" baseline="0">
                    <a:effectLst/>
                  </a:rPr>
                  <a:t>Frequency</a:t>
                </a:r>
                <a:endParaRPr 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431574784"/>
        <c:crosses val="autoZero"/>
        <c:crossBetween val="between"/>
      </c:valAx>
      <c:valAx>
        <c:axId val="431576352"/>
        <c:scaling>
          <c:orientation val="minMax"/>
          <c:max val="35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431579096"/>
        <c:crosses val="max"/>
        <c:crossBetween val="between"/>
      </c:valAx>
      <c:catAx>
        <c:axId val="431579096"/>
        <c:scaling>
          <c:orientation val="minMax"/>
        </c:scaling>
        <c:delete val="1"/>
        <c:axPos val="b"/>
        <c:majorTickMark val="out"/>
        <c:minorTickMark val="none"/>
        <c:tickLblPos val="nextTo"/>
        <c:crossAx val="43157635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400" b="1" i="0" u="none" strike="noStrike" baseline="0" dirty="0">
                <a:effectLst/>
              </a:rPr>
              <a:t>Loss</a:t>
            </a:r>
            <a:r>
              <a:rPr lang="en-US" b="1" dirty="0"/>
              <a:t>FF</a:t>
            </a:r>
            <a:r>
              <a:rPr lang="en-US" b="1" baseline="-30000" dirty="0"/>
              <a:t>T14</a:t>
            </a:r>
          </a:p>
        </c:rich>
      </c:tx>
      <c:layout>
        <c:manualLayout>
          <c:xMode val="edge"/>
          <c:yMode val="edge"/>
          <c:x val="0.43792685650474594"/>
          <c:y val="2.33627667402501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243774427694025"/>
          <c:y val="0.10788925680647535"/>
          <c:w val="0.78874706867671696"/>
          <c:h val="0.73135945548197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AQ$33:$AQ$43</c:f>
              <c:numCache>
                <c:formatCode>0%</c:formatCode>
                <c:ptCount val="11"/>
                <c:pt idx="0">
                  <c:v>0.11</c:v>
                </c:pt>
                <c:pt idx="1">
                  <c:v>0.16</c:v>
                </c:pt>
                <c:pt idx="2">
                  <c:v>0.21</c:v>
                </c:pt>
                <c:pt idx="3">
                  <c:v>0.26</c:v>
                </c:pt>
                <c:pt idx="4">
                  <c:v>0.31</c:v>
                </c:pt>
                <c:pt idx="5">
                  <c:v>0.36</c:v>
                </c:pt>
                <c:pt idx="6">
                  <c:v>0.41</c:v>
                </c:pt>
                <c:pt idx="7">
                  <c:v>0.46</c:v>
                </c:pt>
                <c:pt idx="8">
                  <c:v>0.51</c:v>
                </c:pt>
                <c:pt idx="9">
                  <c:v>0.56000000000000005</c:v>
                </c:pt>
                <c:pt idx="10">
                  <c:v>0.61</c:v>
                </c:pt>
              </c:numCache>
            </c:numRef>
          </c:cat>
          <c:val>
            <c:numRef>
              <c:f>'Sampl-clean-work'!$AR$33:$AR$4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3</c:v>
                </c:pt>
                <c:pt idx="4">
                  <c:v>8</c:v>
                </c:pt>
                <c:pt idx="5">
                  <c:v>29</c:v>
                </c:pt>
                <c:pt idx="6">
                  <c:v>65</c:v>
                </c:pt>
                <c:pt idx="7">
                  <c:v>69</c:v>
                </c:pt>
                <c:pt idx="8">
                  <c:v>27</c:v>
                </c:pt>
                <c:pt idx="9">
                  <c:v>8</c:v>
                </c:pt>
                <c:pt idx="10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4A-4AE0-9641-FB07CE66CB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398144"/>
        <c:axId val="533391872"/>
      </c:barChart>
      <c:lineChart>
        <c:grouping val="standard"/>
        <c:varyColors val="0"/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Sampl-clean-work'!$AQ$33:$AQ$43</c:f>
              <c:numCache>
                <c:formatCode>0%</c:formatCode>
                <c:ptCount val="11"/>
                <c:pt idx="0">
                  <c:v>0.11</c:v>
                </c:pt>
                <c:pt idx="1">
                  <c:v>0.16</c:v>
                </c:pt>
                <c:pt idx="2">
                  <c:v>0.21</c:v>
                </c:pt>
                <c:pt idx="3">
                  <c:v>0.26</c:v>
                </c:pt>
                <c:pt idx="4">
                  <c:v>0.31</c:v>
                </c:pt>
                <c:pt idx="5">
                  <c:v>0.36</c:v>
                </c:pt>
                <c:pt idx="6">
                  <c:v>0.41</c:v>
                </c:pt>
                <c:pt idx="7">
                  <c:v>0.46</c:v>
                </c:pt>
                <c:pt idx="8">
                  <c:v>0.51</c:v>
                </c:pt>
                <c:pt idx="9">
                  <c:v>0.56000000000000005</c:v>
                </c:pt>
                <c:pt idx="10">
                  <c:v>0.61</c:v>
                </c:pt>
              </c:numCache>
            </c:numRef>
          </c:cat>
          <c:val>
            <c:numRef>
              <c:f>'Sampl-clean-work'!$AS$33:$AS$43</c:f>
              <c:numCache>
                <c:formatCode>0.00</c:formatCode>
                <c:ptCount val="11"/>
                <c:pt idx="0">
                  <c:v>1.4735689868369863E-4</c:v>
                </c:pt>
                <c:pt idx="1">
                  <c:v>3.7307044940022823E-3</c:v>
                </c:pt>
                <c:pt idx="2">
                  <c:v>5.2676440242474185E-2</c:v>
                </c:pt>
                <c:pt idx="3">
                  <c:v>0.4148080515838925</c:v>
                </c:pt>
                <c:pt idx="4">
                  <c:v>1.8217262961710319</c:v>
                </c:pt>
                <c:pt idx="5">
                  <c:v>4.4619455651512245</c:v>
                </c:pt>
                <c:pt idx="6">
                  <c:v>6.0949563363398775</c:v>
                </c:pt>
                <c:pt idx="7">
                  <c:v>4.6432505671838236</c:v>
                </c:pt>
                <c:pt idx="8">
                  <c:v>1.9727808015792503</c:v>
                </c:pt>
                <c:pt idx="9">
                  <c:v>0.46745599725995479</c:v>
                </c:pt>
                <c:pt idx="10">
                  <c:v>6.177429955626448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E4A-4AE0-9641-FB07CE66CB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399320"/>
        <c:axId val="533392264"/>
      </c:lineChart>
      <c:catAx>
        <c:axId val="5333981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000" b="0" i="0" baseline="0" dirty="0">
                    <a:effectLst/>
                  </a:rPr>
                  <a:t>LossFF</a:t>
                </a:r>
                <a:r>
                  <a:rPr lang="en-US" sz="1000" b="0" i="0" baseline="-30000" dirty="0">
                    <a:effectLst/>
                  </a:rPr>
                  <a:t>T14</a:t>
                </a:r>
                <a:r>
                  <a:rPr lang="en-US" sz="1000" b="0" i="0" baseline="0" dirty="0">
                    <a:effectLst/>
                  </a:rPr>
                  <a:t> bin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3592378559463985"/>
              <c:y val="0.910263428991905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1872"/>
        <c:crosses val="autoZero"/>
        <c:auto val="1"/>
        <c:lblAlgn val="ctr"/>
        <c:lblOffset val="100"/>
        <c:noMultiLvlLbl val="0"/>
      </c:catAx>
      <c:valAx>
        <c:axId val="533391872"/>
        <c:scaling>
          <c:orientation val="minMax"/>
          <c:max val="7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1.7727526521496371E-2"/>
              <c:y val="0.372244665194996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8144"/>
        <c:crosses val="autoZero"/>
        <c:crossBetween val="between"/>
      </c:valAx>
      <c:valAx>
        <c:axId val="533392264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9320"/>
        <c:crosses val="max"/>
        <c:crossBetween val="between"/>
      </c:valAx>
      <c:catAx>
        <c:axId val="533399320"/>
        <c:scaling>
          <c:orientation val="minMax"/>
        </c:scaling>
        <c:delete val="1"/>
        <c:axPos val="b"/>
        <c:numFmt formatCode="0%" sourceLinked="1"/>
        <c:majorTickMark val="out"/>
        <c:minorTickMark val="none"/>
        <c:tickLblPos val="nextTo"/>
        <c:crossAx val="53339226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/>
              <a:t>FF</a:t>
            </a:r>
            <a:r>
              <a:rPr lang="en-US" b="1" baseline="-30000" dirty="0"/>
              <a:t>T0</a:t>
            </a:r>
          </a:p>
        </c:rich>
      </c:tx>
      <c:layout>
        <c:manualLayout>
          <c:xMode val="edge"/>
          <c:yMode val="edge"/>
          <c:x val="0.49609616893612357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46515334762596"/>
          <c:y val="0.10226851851851852"/>
          <c:w val="0.79365304694433703"/>
          <c:h val="0.738456911636045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Sampl-clean-work'!$BQ$20:$BQ$29</c:f>
              <c:numCache>
                <c:formatCode>General</c:formatCode>
                <c:ptCount val="10"/>
                <c:pt idx="0">
                  <c:v>50</c:v>
                </c:pt>
                <c:pt idx="1">
                  <c:v>56</c:v>
                </c:pt>
                <c:pt idx="2">
                  <c:v>62</c:v>
                </c:pt>
                <c:pt idx="3">
                  <c:v>68</c:v>
                </c:pt>
                <c:pt idx="4">
                  <c:v>74</c:v>
                </c:pt>
                <c:pt idx="5">
                  <c:v>80</c:v>
                </c:pt>
                <c:pt idx="6">
                  <c:v>86</c:v>
                </c:pt>
                <c:pt idx="7">
                  <c:v>92</c:v>
                </c:pt>
                <c:pt idx="8">
                  <c:v>98</c:v>
                </c:pt>
                <c:pt idx="9">
                  <c:v>104</c:v>
                </c:pt>
              </c:numCache>
            </c:numRef>
          </c:cat>
          <c:val>
            <c:numRef>
              <c:f>'Sampl-clean-work'!$BR$20:$BR$29</c:f>
              <c:numCache>
                <c:formatCode>General</c:formatCode>
                <c:ptCount val="10"/>
                <c:pt idx="0">
                  <c:v>1</c:v>
                </c:pt>
                <c:pt idx="1">
                  <c:v>6</c:v>
                </c:pt>
                <c:pt idx="2">
                  <c:v>23</c:v>
                </c:pt>
                <c:pt idx="3">
                  <c:v>45</c:v>
                </c:pt>
                <c:pt idx="4">
                  <c:v>59</c:v>
                </c:pt>
                <c:pt idx="5">
                  <c:v>58</c:v>
                </c:pt>
                <c:pt idx="6">
                  <c:v>22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6A-424B-9C64-F6BDF29246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392656"/>
        <c:axId val="533393440"/>
      </c:barChart>
      <c:lineChart>
        <c:grouping val="standard"/>
        <c:varyColors val="0"/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Sampl-clean-work'!$BS$20:$BS$29</c:f>
              <c:numCache>
                <c:formatCode>General</c:formatCode>
                <c:ptCount val="10"/>
                <c:pt idx="0">
                  <c:v>1.4941404034773996E-3</c:v>
                </c:pt>
                <c:pt idx="1">
                  <c:v>8.6414736839967223E-3</c:v>
                </c:pt>
                <c:pt idx="2">
                  <c:v>2.7542920694826247E-2</c:v>
                </c:pt>
                <c:pt idx="3">
                  <c:v>4.8379118340962139E-2</c:v>
                </c:pt>
                <c:pt idx="4">
                  <c:v>4.6830811712002207E-2</c:v>
                </c:pt>
                <c:pt idx="5">
                  <c:v>2.498222982082083E-2</c:v>
                </c:pt>
                <c:pt idx="6">
                  <c:v>7.3444028611869046E-3</c:v>
                </c:pt>
                <c:pt idx="7">
                  <c:v>1.1898920446819152E-3</c:v>
                </c:pt>
                <c:pt idx="8">
                  <c:v>1.0623910631853154E-4</c:v>
                </c:pt>
                <c:pt idx="9">
                  <c:v>5.2274156598722359E-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6A-424B-9C64-F6BDF29246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398928"/>
        <c:axId val="533393048"/>
      </c:lineChart>
      <c:catAx>
        <c:axId val="533392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F</a:t>
                </a:r>
                <a:r>
                  <a:rPr lang="en-US" baseline="-30000" dirty="0"/>
                  <a:t>T0</a:t>
                </a:r>
                <a:r>
                  <a:rPr lang="en-US" dirty="0"/>
                  <a:t> bin (Shore A)</a:t>
                </a:r>
              </a:p>
            </c:rich>
          </c:tx>
          <c:layout>
            <c:manualLayout>
              <c:xMode val="edge"/>
              <c:yMode val="edge"/>
              <c:x val="0.39902484645449465"/>
              <c:y val="0.911216703458425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3440"/>
        <c:crosses val="autoZero"/>
        <c:auto val="1"/>
        <c:lblAlgn val="ctr"/>
        <c:lblOffset val="100"/>
        <c:noMultiLvlLbl val="0"/>
      </c:catAx>
      <c:valAx>
        <c:axId val="533393440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7.0978746615934559E-3"/>
              <c:y val="0.347538641003207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2656"/>
        <c:crosses val="autoZero"/>
        <c:crossBetween val="between"/>
      </c:valAx>
      <c:valAx>
        <c:axId val="533393048"/>
        <c:scaling>
          <c:orientation val="minMax"/>
          <c:max val="9.0000000000000024E-2"/>
        </c:scaling>
        <c:delete val="0"/>
        <c:axPos val="r"/>
        <c:numFmt formatCode="#,##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3398928"/>
        <c:crosses val="max"/>
        <c:crossBetween val="between"/>
      </c:valAx>
      <c:catAx>
        <c:axId val="533398928"/>
        <c:scaling>
          <c:orientation val="minMax"/>
        </c:scaling>
        <c:delete val="1"/>
        <c:axPos val="b"/>
        <c:majorTickMark val="out"/>
        <c:minorTickMark val="none"/>
        <c:tickLblPos val="nextTo"/>
        <c:crossAx val="5333930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b="1"/>
              <a:t>FF</a:t>
            </a:r>
            <a:r>
              <a:rPr lang="en-US" b="1" baseline="-30000"/>
              <a:t>T0</a:t>
            </a:r>
          </a:p>
        </c:rich>
      </c:tx>
      <c:layout>
        <c:manualLayout>
          <c:xMode val="edge"/>
          <c:yMode val="edge"/>
          <c:x val="0.5138297872340426"/>
          <c:y val="1.861955771952935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026302563243425"/>
          <c:y val="0.13075584408539487"/>
          <c:w val="0.80091025855810571"/>
          <c:h val="0.6904810076845994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N$5:$AN$14</c:f>
              <c:numCache>
                <c:formatCode>General</c:formatCode>
                <c:ptCount val="10"/>
                <c:pt idx="0">
                  <c:v>50</c:v>
                </c:pt>
                <c:pt idx="1">
                  <c:v>56</c:v>
                </c:pt>
                <c:pt idx="2">
                  <c:v>62</c:v>
                </c:pt>
                <c:pt idx="3">
                  <c:v>68</c:v>
                </c:pt>
                <c:pt idx="4">
                  <c:v>74</c:v>
                </c:pt>
                <c:pt idx="5">
                  <c:v>80</c:v>
                </c:pt>
                <c:pt idx="6">
                  <c:v>86</c:v>
                </c:pt>
                <c:pt idx="7">
                  <c:v>92</c:v>
                </c:pt>
                <c:pt idx="8">
                  <c:v>98</c:v>
                </c:pt>
                <c:pt idx="9">
                  <c:v>104</c:v>
                </c:pt>
              </c:numCache>
            </c:numRef>
          </c:cat>
          <c:val>
            <c:numRef>
              <c:f>'Table S1 INRAe pheno'!$AO$5:$AO$1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  <c:pt idx="5">
                  <c:v>8</c:v>
                </c:pt>
                <c:pt idx="6">
                  <c:v>48</c:v>
                </c:pt>
                <c:pt idx="7">
                  <c:v>114</c:v>
                </c:pt>
                <c:pt idx="8">
                  <c:v>44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9C-4004-999E-83B2AD129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394224"/>
        <c:axId val="533393832"/>
      </c:barChart>
      <c:lineChart>
        <c:grouping val="standard"/>
        <c:varyColors val="0"/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P$5:$AP$14</c:f>
              <c:numCache>
                <c:formatCode>0.00000</c:formatCode>
                <c:ptCount val="10"/>
                <c:pt idx="0">
                  <c:v>8.0995516070897743E-16</c:v>
                </c:pt>
                <c:pt idx="1">
                  <c:v>9.2198927943797983E-12</c:v>
                </c:pt>
                <c:pt idx="2">
                  <c:v>2.136565981055834E-8</c:v>
                </c:pt>
                <c:pt idx="3">
                  <c:v>1.0079344534756447E-5</c:v>
                </c:pt>
                <c:pt idx="4">
                  <c:v>9.6799656375303887E-4</c:v>
                </c:pt>
                <c:pt idx="5">
                  <c:v>1.8925217709712245E-2</c:v>
                </c:pt>
                <c:pt idx="6">
                  <c:v>7.5324021089968357E-2</c:v>
                </c:pt>
                <c:pt idx="7">
                  <c:v>6.1031163853857255E-2</c:v>
                </c:pt>
                <c:pt idx="8">
                  <c:v>1.0066890649691781E-2</c:v>
                </c:pt>
                <c:pt idx="9">
                  <c:v>3.3803727642988963E-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C9C-4004-999E-83B2AD129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394616"/>
        <c:axId val="533397360"/>
      </c:lineChart>
      <c:catAx>
        <c:axId val="5333942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/>
                  <a:t>FF</a:t>
                </a:r>
                <a:r>
                  <a:rPr lang="en-US" baseline="-30000" dirty="0"/>
                  <a:t>T0</a:t>
                </a:r>
                <a:r>
                  <a:rPr lang="en-US" dirty="0"/>
                  <a:t> bin</a:t>
                </a:r>
                <a:r>
                  <a:rPr lang="en-US" sz="1000" b="0" i="0" u="none" strike="noStrike" baseline="0" dirty="0">
                    <a:effectLst/>
                  </a:rPr>
                  <a:t> (Shore A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39262411347517728"/>
              <c:y val="0.901828550404709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3832"/>
        <c:crosses val="autoZero"/>
        <c:auto val="1"/>
        <c:lblAlgn val="ctr"/>
        <c:lblOffset val="100"/>
        <c:noMultiLvlLbl val="0"/>
      </c:catAx>
      <c:valAx>
        <c:axId val="533393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/>
                  <a:t>Frequency</a:t>
                </a:r>
              </a:p>
            </c:rich>
          </c:tx>
          <c:layout>
            <c:manualLayout>
              <c:xMode val="edge"/>
              <c:yMode val="edge"/>
              <c:x val="7.0921985815602835E-3"/>
              <c:y val="0.356016572872477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4224"/>
        <c:crosses val="autoZero"/>
        <c:crossBetween val="between"/>
      </c:valAx>
      <c:valAx>
        <c:axId val="533397360"/>
        <c:scaling>
          <c:orientation val="minMax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4616"/>
        <c:crosses val="max"/>
        <c:crossBetween val="between"/>
      </c:valAx>
      <c:catAx>
        <c:axId val="533394616"/>
        <c:scaling>
          <c:orientation val="minMax"/>
        </c:scaling>
        <c:delete val="1"/>
        <c:axPos val="b"/>
        <c:majorTickMark val="out"/>
        <c:minorTickMark val="none"/>
        <c:tickLblPos val="nextTo"/>
        <c:crossAx val="53339736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it-IT" sz="1400" b="1" i="0" baseline="0" dirty="0">
                <a:effectLst/>
              </a:rPr>
              <a:t>Loss</a:t>
            </a:r>
            <a:r>
              <a:rPr lang="en-US" sz="1400" b="1" i="0" baseline="0" dirty="0">
                <a:effectLst/>
              </a:rPr>
              <a:t>FF</a:t>
            </a:r>
            <a:r>
              <a:rPr lang="en-US" sz="1400" b="1" i="0" baseline="-30000" dirty="0">
                <a:effectLst/>
              </a:rPr>
              <a:t>T14</a:t>
            </a:r>
            <a:endParaRPr lang="en-US" sz="1400" dirty="0">
              <a:effectLst/>
            </a:endParaRPr>
          </a:p>
        </c:rich>
      </c:tx>
      <c:layout>
        <c:manualLayout>
          <c:xMode val="edge"/>
          <c:yMode val="edge"/>
          <c:x val="0.42683850060858947"/>
          <c:y val="9.259259259259258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262053596885953"/>
          <c:y val="8.8379629629629614E-2"/>
          <c:w val="0.79813650550820503"/>
          <c:h val="0.743086541265675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I$41:$AI$51</c:f>
              <c:numCache>
                <c:formatCode>0%</c:formatCode>
                <c:ptCount val="11"/>
                <c:pt idx="0">
                  <c:v>0.11</c:v>
                </c:pt>
                <c:pt idx="1">
                  <c:v>0.16</c:v>
                </c:pt>
                <c:pt idx="2">
                  <c:v>0.21</c:v>
                </c:pt>
                <c:pt idx="3">
                  <c:v>0.26</c:v>
                </c:pt>
                <c:pt idx="4">
                  <c:v>0.31</c:v>
                </c:pt>
                <c:pt idx="5">
                  <c:v>0.36</c:v>
                </c:pt>
                <c:pt idx="6">
                  <c:v>0.41</c:v>
                </c:pt>
                <c:pt idx="7">
                  <c:v>0.46</c:v>
                </c:pt>
                <c:pt idx="8">
                  <c:v>0.51</c:v>
                </c:pt>
                <c:pt idx="9">
                  <c:v>0.56000000000000005</c:v>
                </c:pt>
                <c:pt idx="10">
                  <c:v>0.61</c:v>
                </c:pt>
              </c:numCache>
            </c:numRef>
          </c:cat>
          <c:val>
            <c:numRef>
              <c:f>'Table S1 INRAe pheno'!$AJ$41:$AJ$51</c:f>
              <c:numCache>
                <c:formatCode>General</c:formatCode>
                <c:ptCount val="11"/>
                <c:pt idx="0">
                  <c:v>1</c:v>
                </c:pt>
                <c:pt idx="1">
                  <c:v>8</c:v>
                </c:pt>
                <c:pt idx="2">
                  <c:v>35</c:v>
                </c:pt>
                <c:pt idx="3">
                  <c:v>55</c:v>
                </c:pt>
                <c:pt idx="4">
                  <c:v>66</c:v>
                </c:pt>
                <c:pt idx="5">
                  <c:v>40</c:v>
                </c:pt>
                <c:pt idx="6">
                  <c:v>8</c:v>
                </c:pt>
                <c:pt idx="7">
                  <c:v>3</c:v>
                </c:pt>
                <c:pt idx="8">
                  <c:v>2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DA-4203-9CBA-69E89AED3B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3396968"/>
        <c:axId val="533395792"/>
      </c:barChart>
      <c:lineChart>
        <c:grouping val="standard"/>
        <c:varyColors val="0"/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K$41:$AK$51</c:f>
              <c:numCache>
                <c:formatCode>0.00000</c:formatCode>
                <c:ptCount val="11"/>
                <c:pt idx="0">
                  <c:v>0.350106009256822</c:v>
                </c:pt>
                <c:pt idx="1">
                  <c:v>1.5746548162527152</c:v>
                </c:pt>
                <c:pt idx="2">
                  <c:v>4.0418907172275507</c:v>
                </c:pt>
                <c:pt idx="3">
                  <c:v>5.9210287358057805</c:v>
                </c:pt>
                <c:pt idx="4">
                  <c:v>4.9502048460447181</c:v>
                </c:pt>
                <c:pt idx="5">
                  <c:v>2.3619058055715114</c:v>
                </c:pt>
                <c:pt idx="6">
                  <c:v>0.64315459503559169</c:v>
                </c:pt>
                <c:pt idx="7">
                  <c:v>9.9949719684479674E-2</c:v>
                </c:pt>
                <c:pt idx="8">
                  <c:v>8.8646416596575555E-3</c:v>
                </c:pt>
                <c:pt idx="9">
                  <c:v>4.4869805726020215E-4</c:v>
                </c:pt>
                <c:pt idx="10">
                  <c:v>1.2961659076013753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9DA-4203-9CBA-69E89AED3B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3395400"/>
        <c:axId val="533395008"/>
      </c:lineChart>
      <c:catAx>
        <c:axId val="5333969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it-IT" sz="1000" b="0" i="0" baseline="0" dirty="0">
                    <a:effectLst/>
                  </a:rPr>
                  <a:t>LossFF</a:t>
                </a:r>
                <a:r>
                  <a:rPr lang="en-US" sz="1000" b="0" i="0" baseline="-30000" dirty="0">
                    <a:effectLst/>
                  </a:rPr>
                  <a:t>T14</a:t>
                </a:r>
                <a:r>
                  <a:rPr lang="en-US" sz="1000" b="0" i="0" baseline="0" dirty="0">
                    <a:effectLst/>
                  </a:rPr>
                  <a:t> bin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2267346204398981"/>
              <c:y val="0.897198891805190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5792"/>
        <c:crosses val="autoZero"/>
        <c:auto val="1"/>
        <c:lblAlgn val="ctr"/>
        <c:lblOffset val="100"/>
        <c:noMultiLvlLbl val="0"/>
      </c:catAx>
      <c:valAx>
        <c:axId val="5333957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7.1350900074749896E-3"/>
              <c:y val="0.361427529892096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6968"/>
        <c:crosses val="autoZero"/>
        <c:crossBetween val="between"/>
      </c:valAx>
      <c:valAx>
        <c:axId val="533395008"/>
        <c:scaling>
          <c:orientation val="minMax"/>
          <c:max val="6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3395400"/>
        <c:crosses val="max"/>
        <c:crossBetween val="between"/>
      </c:valAx>
      <c:catAx>
        <c:axId val="533395400"/>
        <c:scaling>
          <c:orientation val="minMax"/>
        </c:scaling>
        <c:delete val="1"/>
        <c:axPos val="b"/>
        <c:majorTickMark val="out"/>
        <c:minorTickMark val="none"/>
        <c:tickLblPos val="nextTo"/>
        <c:crossAx val="53339500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r>
              <a:rPr lang="en-US" b="1" dirty="0"/>
              <a:t>L*</a:t>
            </a:r>
            <a:r>
              <a:rPr lang="en-US" b="1" baseline="-30000" dirty="0"/>
              <a:t>T0</a:t>
            </a:r>
          </a:p>
        </c:rich>
      </c:tx>
      <c:layout>
        <c:manualLayout>
          <c:xMode val="edge"/>
          <c:yMode val="edge"/>
          <c:x val="0.49955984720248386"/>
          <c:y val="2.32198170717214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33779294488247"/>
          <c:y val="0.12580496889458678"/>
          <c:w val="0.78393476234011927"/>
          <c:h val="0.72835922190575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Table S1 INRAe pheno'!$AT$5:$AT$12</c:f>
              <c:numCache>
                <c:formatCode>General</c:formatCode>
                <c:ptCount val="8"/>
                <c:pt idx="0">
                  <c:v>47.5</c:v>
                </c:pt>
                <c:pt idx="1">
                  <c:v>50</c:v>
                </c:pt>
                <c:pt idx="2">
                  <c:v>52.5</c:v>
                </c:pt>
                <c:pt idx="3">
                  <c:v>55</c:v>
                </c:pt>
                <c:pt idx="4">
                  <c:v>57.5</c:v>
                </c:pt>
                <c:pt idx="5">
                  <c:v>60</c:v>
                </c:pt>
                <c:pt idx="6">
                  <c:v>62.5</c:v>
                </c:pt>
                <c:pt idx="7">
                  <c:v>65</c:v>
                </c:pt>
              </c:numCache>
            </c:numRef>
          </c:cat>
          <c:val>
            <c:numRef>
              <c:f>'Table S1 INRAe pheno'!$AU$5:$AU$12</c:f>
              <c:numCache>
                <c:formatCode>General</c:formatCode>
                <c:ptCount val="8"/>
                <c:pt idx="0">
                  <c:v>2</c:v>
                </c:pt>
                <c:pt idx="1">
                  <c:v>9</c:v>
                </c:pt>
                <c:pt idx="2">
                  <c:v>61</c:v>
                </c:pt>
                <c:pt idx="3">
                  <c:v>96</c:v>
                </c:pt>
                <c:pt idx="4">
                  <c:v>40</c:v>
                </c:pt>
                <c:pt idx="5">
                  <c:v>9</c:v>
                </c:pt>
                <c:pt idx="6">
                  <c:v>2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E3-42A1-B41B-1DA0CB0D0F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532833400"/>
        <c:axId val="532840064"/>
      </c:barChart>
      <c:lineChart>
        <c:grouping val="standard"/>
        <c:varyColors val="0"/>
        <c:ser>
          <c:idx val="1"/>
          <c:order val="1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Table S1 INRAe pheno'!$AV$5:$AV$12</c:f>
              <c:numCache>
                <c:formatCode>0.00000</c:formatCode>
                <c:ptCount val="8"/>
                <c:pt idx="0">
                  <c:v>7.060008719393219E-3</c:v>
                </c:pt>
                <c:pt idx="1">
                  <c:v>5.6944721032300458E-2</c:v>
                </c:pt>
                <c:pt idx="2">
                  <c:v>0.153134037039792</c:v>
                </c:pt>
                <c:pt idx="3">
                  <c:v>0.13729667630947379</c:v>
                </c:pt>
                <c:pt idx="4">
                  <c:v>4.1041038899695112E-2</c:v>
                </c:pt>
                <c:pt idx="5">
                  <c:v>4.0902202792876758E-3</c:v>
                </c:pt>
                <c:pt idx="6">
                  <c:v>1.3590801807514616E-4</c:v>
                </c:pt>
                <c:pt idx="7">
                  <c:v>1.5056134674827087E-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1E3-42A1-B41B-1DA0CB0D0F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2836144"/>
        <c:axId val="532836928"/>
      </c:lineChart>
      <c:catAx>
        <c:axId val="532833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it-IT" sz="1000" b="0" i="0" baseline="0" dirty="0">
                    <a:effectLst/>
                  </a:rPr>
                  <a:t>L</a:t>
                </a:r>
                <a:r>
                  <a:rPr lang="en-US" sz="1000" b="0" i="0" baseline="0" dirty="0">
                    <a:effectLst/>
                  </a:rPr>
                  <a:t>*</a:t>
                </a:r>
                <a:r>
                  <a:rPr lang="en-US" sz="1000" b="0" i="0" baseline="-20000" dirty="0">
                    <a:effectLst/>
                  </a:rPr>
                  <a:t>T0</a:t>
                </a:r>
                <a:r>
                  <a:rPr lang="en-US" sz="1000" b="0" i="0" baseline="0" dirty="0">
                    <a:effectLst/>
                  </a:rPr>
                  <a:t> bin</a:t>
                </a:r>
                <a:r>
                  <a:rPr lang="en-US" sz="1000" b="0" i="0" u="none" strike="noStrike" baseline="0" dirty="0">
                    <a:effectLst/>
                  </a:rPr>
                  <a:t> (absolute units)</a:t>
                </a:r>
                <a:endParaRPr lang="en-U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35818230039084309"/>
              <c:y val="0.92015746872700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40064"/>
        <c:crosses val="autoZero"/>
        <c:auto val="1"/>
        <c:lblAlgn val="ctr"/>
        <c:lblOffset val="100"/>
        <c:noMultiLvlLbl val="0"/>
      </c:catAx>
      <c:valAx>
        <c:axId val="53284006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1.0777520299077603E-2"/>
              <c:y val="0.370286240009536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33400"/>
        <c:crosses val="autoZero"/>
        <c:crossBetween val="between"/>
      </c:valAx>
      <c:valAx>
        <c:axId val="532836928"/>
        <c:scaling>
          <c:orientation val="minMax"/>
          <c:max val="0.16000000000000003"/>
        </c:scaling>
        <c:delete val="0"/>
        <c:axPos val="r"/>
        <c:numFmt formatCode="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32836144"/>
        <c:crosses val="max"/>
        <c:crossBetween val="between"/>
      </c:valAx>
      <c:catAx>
        <c:axId val="532836144"/>
        <c:scaling>
          <c:orientation val="minMax"/>
        </c:scaling>
        <c:delete val="1"/>
        <c:axPos val="b"/>
        <c:majorTickMark val="out"/>
        <c:minorTickMark val="none"/>
        <c:tickLblPos val="nextTo"/>
        <c:crossAx val="5328369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9050">
      <a:solidFill>
        <a:schemeClr val="tx1"/>
      </a:solidFill>
    </a:ln>
    <a:effectLst/>
  </c:spPr>
  <c:txPr>
    <a:bodyPr/>
    <a:lstStyle/>
    <a:p>
      <a:pPr>
        <a:defRPr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904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559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43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578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829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82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898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668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827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068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927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97621-3AE5-4C42-AAD3-43DC2F3BFACA}" type="datetimeFigureOut">
              <a:rPr lang="en-US" smtClean="0"/>
              <a:t>7/2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D2FE1-33CB-4968-B037-BACF4E413ED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750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4.xml"/><Relationship Id="rId4" Type="http://schemas.openxmlformats.org/officeDocument/2006/relationships/chart" Target="../charts/chart3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7.xml"/><Relationship Id="rId3" Type="http://schemas.openxmlformats.org/officeDocument/2006/relationships/chart" Target="../charts/chart22.xml"/><Relationship Id="rId7" Type="http://schemas.openxmlformats.org/officeDocument/2006/relationships/chart" Target="../charts/chart26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5.xml"/><Relationship Id="rId11" Type="http://schemas.openxmlformats.org/officeDocument/2006/relationships/chart" Target="../charts/chart30.xml"/><Relationship Id="rId5" Type="http://schemas.openxmlformats.org/officeDocument/2006/relationships/chart" Target="../charts/chart24.xml"/><Relationship Id="rId10" Type="http://schemas.openxmlformats.org/officeDocument/2006/relationships/chart" Target="../charts/chart29.xml"/><Relationship Id="rId4" Type="http://schemas.openxmlformats.org/officeDocument/2006/relationships/chart" Target="../charts/chart23.xml"/><Relationship Id="rId9" Type="http://schemas.openxmlformats.org/officeDocument/2006/relationships/chart" Target="../charts/chart2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7478959"/>
              </p:ext>
            </p:extLst>
          </p:nvPr>
        </p:nvGraphicFramePr>
        <p:xfrm>
          <a:off x="2486630" y="2932256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2156147" y="114536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2183936" y="2940215"/>
            <a:ext cx="347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</a:lstStyle>
          <a:p>
            <a:pPr algn="ctr"/>
            <a:r>
              <a:rPr lang="it-IT" dirty="0"/>
              <a:t>B</a:t>
            </a:r>
            <a:endParaRPr lang="en-US" dirty="0"/>
          </a:p>
        </p:txBody>
      </p:sp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9192972"/>
              </p:ext>
            </p:extLst>
          </p:nvPr>
        </p:nvGraphicFramePr>
        <p:xfrm>
          <a:off x="2486630" y="126483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7" name="Straight Connector 26"/>
          <p:cNvCxnSpPr/>
          <p:nvPr/>
        </p:nvCxnSpPr>
        <p:spPr>
          <a:xfrm flipV="1">
            <a:off x="4114924" y="426962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3702763" y="40729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3490866" y="419903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3507329" y="41990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3"/>
          <p:cNvSpPr/>
          <p:nvPr/>
        </p:nvSpPr>
        <p:spPr>
          <a:xfrm>
            <a:off x="5902095" y="380664"/>
            <a:ext cx="121037" cy="2182268"/>
          </a:xfrm>
          <a:prstGeom prst="rect">
            <a:avLst/>
          </a:prstGeom>
          <a:solidFill>
            <a:schemeClr val="bg1"/>
          </a:solidFill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171450" y="5862697"/>
            <a:ext cx="118586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. Distribution charts of FW- and FF-related traits in studied F2 populations.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A-B: Distribution charts of FW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ENEA (A) and INRAE (B). C-D: Distribution charts of LossFW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ENEA (C) and INRAE (D). Blue histograms: F2 progeny bins. Dark blue dotted line: average of F2 population. Red line: average of P1. Green line: average of P2. Orange line: average of F1 hybrid. Black line: distribution curve of F2 popul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9675649" y="2932256"/>
            <a:ext cx="347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</a:lstStyle>
          <a:p>
            <a:pPr algn="ctr"/>
            <a:r>
              <a:rPr lang="it-IT" dirty="0"/>
              <a:t>D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9674540" y="112417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C</a:t>
            </a:r>
            <a:endParaRPr lang="en-US" dirty="0"/>
          </a:p>
        </p:txBody>
      </p:sp>
      <p:graphicFrame>
        <p:nvGraphicFramePr>
          <p:cNvPr id="52" name="Chart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5800903"/>
              </p:ext>
            </p:extLst>
          </p:nvPr>
        </p:nvGraphicFramePr>
        <p:xfrm>
          <a:off x="6150842" y="126483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5" name="Rectangle 64"/>
          <p:cNvSpPr/>
          <p:nvPr/>
        </p:nvSpPr>
        <p:spPr>
          <a:xfrm>
            <a:off x="9575806" y="366202"/>
            <a:ext cx="133967" cy="2182268"/>
          </a:xfrm>
          <a:prstGeom prst="rect">
            <a:avLst/>
          </a:prstGeom>
          <a:solidFill>
            <a:schemeClr val="bg1"/>
          </a:solidFill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6" name="Straight Connector 65"/>
          <p:cNvCxnSpPr/>
          <p:nvPr/>
        </p:nvCxnSpPr>
        <p:spPr>
          <a:xfrm flipV="1">
            <a:off x="7438794" y="425346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V="1">
            <a:off x="7802189" y="424983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7525323" y="41990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10434576" y="1150546"/>
            <a:ext cx="1262835" cy="9387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100" dirty="0"/>
              <a:t>P1 avg</a:t>
            </a:r>
          </a:p>
          <a:p>
            <a:r>
              <a:rPr lang="it-IT" sz="1100" dirty="0"/>
              <a:t>P2 avg</a:t>
            </a:r>
          </a:p>
          <a:p>
            <a:r>
              <a:rPr lang="it-IT" sz="1100" dirty="0"/>
              <a:t>F1 avg</a:t>
            </a:r>
          </a:p>
          <a:p>
            <a:r>
              <a:rPr lang="it-IT" sz="1100" dirty="0"/>
              <a:t>F2</a:t>
            </a:r>
          </a:p>
          <a:p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74" name="Rectangle 73"/>
          <p:cNvSpPr/>
          <p:nvPr/>
        </p:nvSpPr>
        <p:spPr>
          <a:xfrm>
            <a:off x="11022732" y="1737077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6" name="Straight Connector 75"/>
          <p:cNvCxnSpPr/>
          <p:nvPr/>
        </p:nvCxnSpPr>
        <p:spPr>
          <a:xfrm>
            <a:off x="11022732" y="1283057"/>
            <a:ext cx="54404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11022732" y="1462671"/>
            <a:ext cx="544049" cy="0"/>
          </a:xfrm>
          <a:prstGeom prst="line">
            <a:avLst/>
          </a:prstGeom>
          <a:ln w="28575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11022732" y="1619905"/>
            <a:ext cx="544049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11022732" y="1952528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210977" y="1411900"/>
            <a:ext cx="75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15245" y="4213077"/>
            <a:ext cx="895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INRA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5888751" y="3048679"/>
            <a:ext cx="161015" cy="2263839"/>
          </a:xfrm>
          <a:prstGeom prst="rect">
            <a:avLst/>
          </a:prstGeom>
          <a:solidFill>
            <a:schemeClr val="bg1"/>
          </a:solidFill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3560056" y="3210057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V="1">
            <a:off x="4048015" y="3211452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V="1">
            <a:off x="4026914" y="3210042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V="1">
            <a:off x="4156204" y="3209857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5" name="Chart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0785274"/>
              </p:ext>
            </p:extLst>
          </p:nvPr>
        </p:nvGraphicFramePr>
        <p:xfrm>
          <a:off x="6150842" y="2932256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7" name="Rectangle 46"/>
          <p:cNvSpPr/>
          <p:nvPr/>
        </p:nvSpPr>
        <p:spPr>
          <a:xfrm>
            <a:off x="9579760" y="3130251"/>
            <a:ext cx="133967" cy="2182268"/>
          </a:xfrm>
          <a:prstGeom prst="rect">
            <a:avLst/>
          </a:prstGeom>
          <a:solidFill>
            <a:schemeClr val="bg1"/>
          </a:solidFill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3" name="Straight Connector 52"/>
          <p:cNvCxnSpPr/>
          <p:nvPr/>
        </p:nvCxnSpPr>
        <p:spPr>
          <a:xfrm flipV="1">
            <a:off x="7074130" y="3232824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V="1">
            <a:off x="7302791" y="3220416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V="1">
            <a:off x="7272568" y="3226167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7453762" y="419903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V="1">
            <a:off x="7255773" y="3228851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32304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ce réservé du contenu 4">
            <a:extLst>
              <a:ext uri="{FF2B5EF4-FFF2-40B4-BE49-F238E27FC236}">
                <a16:creationId xmlns:a16="http://schemas.microsoft.com/office/drawing/2014/main" id="{EF7674FA-BB2D-4607-0941-25792A19AFF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92241" y="971516"/>
            <a:ext cx="6117070" cy="4078046"/>
          </a:xfrm>
          <a:ln>
            <a:solidFill>
              <a:schemeClr val="tx1"/>
            </a:solidFill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CDB48581-171C-E2FF-0A04-30B65D263986}"/>
              </a:ext>
            </a:extLst>
          </p:cNvPr>
          <p:cNvSpPr txBox="1"/>
          <p:nvPr/>
        </p:nvSpPr>
        <p:spPr>
          <a:xfrm>
            <a:off x="160682" y="5040795"/>
            <a:ext cx="662111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5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Polymorphism and SNP density distributions in parental lines of ENEA and INRAE populations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: Polymorphism distributions of Agriplex SNP panel in parental lines of ENEA (green) and INRAE (red) populations. Black lines: SNP marker position. B-C: SNP density distributions in genome sequences of parental lines of ENEA (B) and INRAE (C) populations.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9924" y="168857"/>
            <a:ext cx="4714875" cy="3143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9924" y="3469170"/>
            <a:ext cx="4714875" cy="31432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-1429" y="899067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A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6694164" y="168857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B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6702981" y="3469170"/>
            <a:ext cx="306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89701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ce réservé du contenu 4">
            <a:extLst>
              <a:ext uri="{FF2B5EF4-FFF2-40B4-BE49-F238E27FC236}">
                <a16:creationId xmlns:a16="http://schemas.microsoft.com/office/drawing/2014/main" id="{A7C7CFCA-8B4C-FF1E-6CAB-F9861FEE37A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r="52111"/>
          <a:stretch>
            <a:fillRect/>
          </a:stretch>
        </p:blipFill>
        <p:spPr>
          <a:xfrm>
            <a:off x="2013860" y="499673"/>
            <a:ext cx="8173278" cy="3011840"/>
          </a:xfr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C76DA419-4A15-B297-FB76-E7C874C1BAE1}"/>
              </a:ext>
            </a:extLst>
          </p:cNvPr>
          <p:cNvSpPr txBox="1"/>
          <p:nvPr/>
        </p:nvSpPr>
        <p:spPr>
          <a:xfrm>
            <a:off x="5529938" y="23366"/>
            <a:ext cx="688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NEA</a:t>
            </a:r>
          </a:p>
        </p:txBody>
      </p:sp>
      <p:pic>
        <p:nvPicPr>
          <p:cNvPr id="7" name="Espace réservé du contenu 4">
            <a:extLst>
              <a:ext uri="{FF2B5EF4-FFF2-40B4-BE49-F238E27FC236}">
                <a16:creationId xmlns:a16="http://schemas.microsoft.com/office/drawing/2014/main" id="{049AC77F-09E0-435B-5A87-0CED53A0109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6866"/>
          <a:stretch>
            <a:fillRect/>
          </a:stretch>
        </p:blipFill>
        <p:spPr>
          <a:xfrm>
            <a:off x="1482681" y="3571902"/>
            <a:ext cx="9032890" cy="3000033"/>
          </a:xfrm>
          <a:prstGeom prst="rect">
            <a:avLst/>
          </a:prstGeom>
        </p:spPr>
      </p:pic>
      <p:sp>
        <p:nvSpPr>
          <p:cNvPr id="2" name="Ellipse 1">
            <a:extLst>
              <a:ext uri="{FF2B5EF4-FFF2-40B4-BE49-F238E27FC236}">
                <a16:creationId xmlns:a16="http://schemas.microsoft.com/office/drawing/2014/main" id="{C6E8DE27-1D04-159E-E0F2-232DB8892160}"/>
              </a:ext>
            </a:extLst>
          </p:cNvPr>
          <p:cNvSpPr/>
          <p:nvPr/>
        </p:nvSpPr>
        <p:spPr>
          <a:xfrm>
            <a:off x="3328895" y="3808136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Ellipse 2">
            <a:extLst>
              <a:ext uri="{FF2B5EF4-FFF2-40B4-BE49-F238E27FC236}">
                <a16:creationId xmlns:a16="http://schemas.microsoft.com/office/drawing/2014/main" id="{BB877F33-7E9E-9755-A953-5B5CDC806752}"/>
              </a:ext>
            </a:extLst>
          </p:cNvPr>
          <p:cNvSpPr/>
          <p:nvPr/>
        </p:nvSpPr>
        <p:spPr>
          <a:xfrm>
            <a:off x="3004460" y="858549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Ellipse 3">
            <a:extLst>
              <a:ext uri="{FF2B5EF4-FFF2-40B4-BE49-F238E27FC236}">
                <a16:creationId xmlns:a16="http://schemas.microsoft.com/office/drawing/2014/main" id="{E45A771E-FBF5-99A9-6EBF-5741DD22E836}"/>
              </a:ext>
            </a:extLst>
          </p:cNvPr>
          <p:cNvSpPr/>
          <p:nvPr/>
        </p:nvSpPr>
        <p:spPr>
          <a:xfrm>
            <a:off x="1780048" y="4490623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Ellipse 7">
            <a:extLst>
              <a:ext uri="{FF2B5EF4-FFF2-40B4-BE49-F238E27FC236}">
                <a16:creationId xmlns:a16="http://schemas.microsoft.com/office/drawing/2014/main" id="{7ACFBB26-CA8E-AF4B-AAA9-CD6092E4D33E}"/>
              </a:ext>
            </a:extLst>
          </p:cNvPr>
          <p:cNvSpPr/>
          <p:nvPr/>
        </p:nvSpPr>
        <p:spPr>
          <a:xfrm>
            <a:off x="3323926" y="5016532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Ellipse 8">
            <a:extLst>
              <a:ext uri="{FF2B5EF4-FFF2-40B4-BE49-F238E27FC236}">
                <a16:creationId xmlns:a16="http://schemas.microsoft.com/office/drawing/2014/main" id="{C835F5F3-8B09-DE5C-58C2-1E2AA760EF53}"/>
              </a:ext>
            </a:extLst>
          </p:cNvPr>
          <p:cNvSpPr/>
          <p:nvPr/>
        </p:nvSpPr>
        <p:spPr>
          <a:xfrm>
            <a:off x="7521552" y="4095506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5ACAEA5A-615C-7BA0-DEAC-626AA0E8F404}"/>
              </a:ext>
            </a:extLst>
          </p:cNvPr>
          <p:cNvSpPr/>
          <p:nvPr/>
        </p:nvSpPr>
        <p:spPr>
          <a:xfrm>
            <a:off x="9065430" y="4867445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4A109DFC-2E81-6977-F744-E1AFBB225C79}"/>
              </a:ext>
            </a:extLst>
          </p:cNvPr>
          <p:cNvSpPr txBox="1"/>
          <p:nvPr/>
        </p:nvSpPr>
        <p:spPr>
          <a:xfrm>
            <a:off x="298173" y="6380713"/>
            <a:ext cx="115623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>
              <a:defRPr sz="1400" b="1"/>
            </a:lvl1pPr>
          </a:lstStyle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Genetic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map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onstructed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polymorphic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SNP markers. </a:t>
            </a:r>
            <a:r>
              <a:rPr lang="fr-FR" b="0" dirty="0">
                <a:latin typeface="Arial" panose="020B0604020202020204" pitchFamily="34" charset="0"/>
                <a:cs typeface="Arial" panose="020B0604020202020204" pitchFamily="34" charset="0"/>
              </a:rPr>
              <a:t>A: ENEA </a:t>
            </a:r>
            <a:r>
              <a:rPr lang="fr-FR" b="0" dirty="0" err="1">
                <a:latin typeface="Arial" panose="020B0604020202020204" pitchFamily="34" charset="0"/>
                <a:cs typeface="Arial" panose="020B0604020202020204" pitchFamily="34" charset="0"/>
              </a:rPr>
              <a:t>map</a:t>
            </a:r>
            <a:r>
              <a:rPr lang="fr-FR" b="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b="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b="0" dirty="0">
                <a:latin typeface="Arial" panose="020B0604020202020204" pitchFamily="34" charset="0"/>
                <a:cs typeface="Arial" panose="020B0604020202020204" pitchFamily="34" charset="0"/>
              </a:rPr>
              <a:t> dots </a:t>
            </a:r>
            <a:r>
              <a:rPr lang="fr-FR" b="0" dirty="0" err="1"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fr-FR" b="0" dirty="0">
                <a:latin typeface="Arial" panose="020B0604020202020204" pitchFamily="34" charset="0"/>
                <a:cs typeface="Arial" panose="020B0604020202020204" pitchFamily="34" charset="0"/>
              </a:rPr>
              <a:t> clusters of markers.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082800" y="37656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</a:t>
            </a:r>
            <a:endParaRPr lang="en-US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855528" y="37656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2</a:t>
            </a:r>
            <a:endParaRPr lang="en-US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411133" y="37656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3</a:t>
            </a:r>
            <a:endParaRPr lang="en-US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183416" y="38218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4</a:t>
            </a:r>
            <a:endParaRPr lang="en-US" sz="10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436440" y="338728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6A</a:t>
            </a:r>
            <a:endParaRPr lang="en-US" sz="1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967340" y="37656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5</a:t>
            </a:r>
            <a:endParaRPr lang="en-US" sz="1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8187754" y="338728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6B</a:t>
            </a:r>
            <a:endParaRPr lang="en-US" sz="1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8999187" y="33872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7</a:t>
            </a:r>
            <a:endParaRPr lang="en-US" sz="1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634325" y="346887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8</a:t>
            </a:r>
            <a:endParaRPr lang="en-US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164270" y="346682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9</a:t>
            </a:r>
            <a:endParaRPr lang="en-US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608463" y="3466820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0A</a:t>
            </a:r>
            <a:endParaRPr lang="en-US" sz="1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347884" y="3466820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0B</a:t>
            </a:r>
            <a:endParaRPr lang="en-US" sz="1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7293768" y="3468496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1B</a:t>
            </a:r>
            <a:endParaRPr lang="en-US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6489036" y="3466819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1A</a:t>
            </a:r>
            <a:endParaRPr lang="en-US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8844411" y="3451562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2</a:t>
            </a:r>
            <a:endParaRPr lang="en-US" sz="1000" b="1" dirty="0"/>
          </a:p>
        </p:txBody>
      </p:sp>
      <p:sp>
        <p:nvSpPr>
          <p:cNvPr id="28" name="Rectangle 27"/>
          <p:cNvSpPr/>
          <p:nvPr/>
        </p:nvSpPr>
        <p:spPr>
          <a:xfrm>
            <a:off x="441011" y="489217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20764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ce réservé du contenu 4">
            <a:extLst>
              <a:ext uri="{FF2B5EF4-FFF2-40B4-BE49-F238E27FC236}">
                <a16:creationId xmlns:a16="http://schemas.microsoft.com/office/drawing/2014/main" id="{C023C864-0724-9568-FABC-196F9F10DD4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r="52181" b="2848"/>
          <a:stretch/>
        </p:blipFill>
        <p:spPr>
          <a:xfrm>
            <a:off x="1621245" y="464827"/>
            <a:ext cx="8976029" cy="3218173"/>
          </a:xfrm>
        </p:spPr>
      </p:pic>
      <p:pic>
        <p:nvPicPr>
          <p:cNvPr id="9" name="Espace réservé du contenu 4">
            <a:extLst>
              <a:ext uri="{FF2B5EF4-FFF2-40B4-BE49-F238E27FC236}">
                <a16:creationId xmlns:a16="http://schemas.microsoft.com/office/drawing/2014/main" id="{964ED8FB-BA38-E52A-A279-320AC7B16D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523" b="19402"/>
          <a:stretch/>
        </p:blipFill>
        <p:spPr>
          <a:xfrm>
            <a:off x="1501361" y="3739699"/>
            <a:ext cx="9237568" cy="2503721"/>
          </a:xfrm>
          <a:prstGeom prst="rect">
            <a:avLst/>
          </a:prstGeom>
        </p:spPr>
      </p:pic>
      <p:sp>
        <p:nvSpPr>
          <p:cNvPr id="10" name="Ellipse 9">
            <a:extLst>
              <a:ext uri="{FF2B5EF4-FFF2-40B4-BE49-F238E27FC236}">
                <a16:creationId xmlns:a16="http://schemas.microsoft.com/office/drawing/2014/main" id="{D4CA3A61-FEA9-164D-35EC-27C8A3B2FFA6}"/>
              </a:ext>
            </a:extLst>
          </p:cNvPr>
          <p:cNvSpPr/>
          <p:nvPr/>
        </p:nvSpPr>
        <p:spPr>
          <a:xfrm>
            <a:off x="3090691" y="947530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id="{BB4371F3-ADD2-D26F-2A64-D5534E4A6E1D}"/>
              </a:ext>
            </a:extLst>
          </p:cNvPr>
          <p:cNvSpPr/>
          <p:nvPr/>
        </p:nvSpPr>
        <p:spPr>
          <a:xfrm>
            <a:off x="4685811" y="1679050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C6AB58A-56FC-71BE-689B-FB891358D34D}"/>
              </a:ext>
            </a:extLst>
          </p:cNvPr>
          <p:cNvSpPr txBox="1"/>
          <p:nvPr/>
        </p:nvSpPr>
        <p:spPr>
          <a:xfrm>
            <a:off x="695958" y="6306049"/>
            <a:ext cx="107993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B: INRA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ap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dots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ndicat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clusters of markers.</a:t>
            </a:r>
          </a:p>
        </p:txBody>
      </p:sp>
      <p:sp>
        <p:nvSpPr>
          <p:cNvPr id="8" name="ZoneTexte 5">
            <a:extLst>
              <a:ext uri="{FF2B5EF4-FFF2-40B4-BE49-F238E27FC236}">
                <a16:creationId xmlns:a16="http://schemas.microsoft.com/office/drawing/2014/main" id="{C76DA419-4A15-B297-FB76-E7C874C1BAE1}"/>
              </a:ext>
            </a:extLst>
          </p:cNvPr>
          <p:cNvSpPr txBox="1"/>
          <p:nvPr/>
        </p:nvSpPr>
        <p:spPr>
          <a:xfrm>
            <a:off x="5529938" y="2336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INRA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710260" y="36915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</a:t>
            </a:r>
            <a:endParaRPr lang="en-US" sz="1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923261" y="36915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2</a:t>
            </a:r>
            <a:endParaRPr lang="en-US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533893" y="36915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3</a:t>
            </a:r>
            <a:endParaRPr lang="en-US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096751" y="37477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4</a:t>
            </a:r>
            <a:endParaRPr lang="en-US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502175" y="331319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6A</a:t>
            </a:r>
            <a:endParaRPr lang="en-US" sz="10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937825" y="36915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5</a:t>
            </a:r>
            <a:endParaRPr lang="en-US" sz="1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758314" y="331319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6B</a:t>
            </a:r>
            <a:endParaRPr lang="en-US" sz="1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527027" y="363069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7</a:t>
            </a:r>
            <a:endParaRPr lang="en-US" sz="1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997112" y="363069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8</a:t>
            </a:r>
            <a:endParaRPr lang="en-US" sz="1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756587" y="3628640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9A</a:t>
            </a:r>
            <a:endParaRPr lang="en-US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6030519" y="3628639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0</a:t>
            </a:r>
            <a:endParaRPr lang="en-US" sz="1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8665022" y="3630315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2A</a:t>
            </a:r>
            <a:endParaRPr lang="en-US" sz="1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7580886" y="3628638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1</a:t>
            </a:r>
            <a:endParaRPr lang="en-US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9834661" y="3613381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12B</a:t>
            </a:r>
            <a:endParaRPr lang="en-US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901485" y="3631652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CHR9B</a:t>
            </a:r>
            <a:endParaRPr lang="en-US" sz="1000" b="1" dirty="0"/>
          </a:p>
        </p:txBody>
      </p:sp>
      <p:sp>
        <p:nvSpPr>
          <p:cNvPr id="23" name="Rectangle 22"/>
          <p:cNvSpPr/>
          <p:nvPr/>
        </p:nvSpPr>
        <p:spPr>
          <a:xfrm>
            <a:off x="441011" y="489217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B</a:t>
            </a:r>
            <a:endParaRPr lang="en-US" dirty="0"/>
          </a:p>
        </p:txBody>
      </p:sp>
      <p:sp>
        <p:nvSpPr>
          <p:cNvPr id="3" name="Ellipse 2">
            <a:extLst>
              <a:ext uri="{FF2B5EF4-FFF2-40B4-BE49-F238E27FC236}">
                <a16:creationId xmlns:a16="http://schemas.microsoft.com/office/drawing/2014/main" id="{B57DA952-2317-B464-7A08-4934340F7E72}"/>
              </a:ext>
            </a:extLst>
          </p:cNvPr>
          <p:cNvSpPr/>
          <p:nvPr/>
        </p:nvSpPr>
        <p:spPr>
          <a:xfrm>
            <a:off x="6256040" y="5180824"/>
            <a:ext cx="149087" cy="149087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70877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F0CE4A84-6ADE-E83C-8243-782D1EBBE077}"/>
              </a:ext>
            </a:extLst>
          </p:cNvPr>
          <p:cNvSpPr txBox="1"/>
          <p:nvPr/>
        </p:nvSpPr>
        <p:spPr>
          <a:xfrm>
            <a:off x="409159" y="5590652"/>
            <a:ext cx="11273855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7. Genetic maps of QTLs detected in the ENEA and INRAE F2 populations by Composite Interval Mapping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: Map of the ENEA population. QTLs for each trait (and experimental stage) are represented with bars of different colors. Bar length indicates the confidence interval of each QTL. FF: fruit firmness; LossFF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: Loss of FF at T14; FW: fruit weight; LossFW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T7/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: Loss of FW at T7 or T14; L*: fruit skin brightness; a*: red/green color; b*: yellow/blue color.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id="{0237A825-E218-47FC-B9BC-CA9D1D0AD375}"/>
              </a:ext>
            </a:extLst>
          </p:cNvPr>
          <p:cNvGrpSpPr/>
          <p:nvPr/>
        </p:nvGrpSpPr>
        <p:grpSpPr>
          <a:xfrm rot="5400000">
            <a:off x="2594104" y="-993672"/>
            <a:ext cx="5237922" cy="7626143"/>
            <a:chOff x="292102" y="1"/>
            <a:chExt cx="5237922" cy="7626143"/>
          </a:xfrm>
        </p:grpSpPr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54893588-4FF5-42B5-A604-82FDAD6FE549}"/>
                </a:ext>
              </a:extLst>
            </p:cNvPr>
            <p:cNvGrpSpPr/>
            <p:nvPr/>
          </p:nvGrpSpPr>
          <p:grpSpPr>
            <a:xfrm rot="16200000">
              <a:off x="-902009" y="1194112"/>
              <a:ext cx="7626143" cy="5237922"/>
              <a:chOff x="1262269" y="0"/>
              <a:chExt cx="7626143" cy="5237922"/>
            </a:xfrm>
          </p:grpSpPr>
          <p:pic>
            <p:nvPicPr>
              <p:cNvPr id="49" name="Image 48">
                <a:extLst>
                  <a:ext uri="{FF2B5EF4-FFF2-40B4-BE49-F238E27FC236}">
                    <a16:creationId xmlns:a16="http://schemas.microsoft.com/office/drawing/2014/main" id="{B21055F4-1B7B-4E57-B92D-8D420F6F10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r="46667" b="34754"/>
              <a:stretch>
                <a:fillRect/>
              </a:stretch>
            </p:blipFill>
            <p:spPr>
              <a:xfrm>
                <a:off x="1262269" y="0"/>
                <a:ext cx="7626143" cy="2623931"/>
              </a:xfrm>
              <a:prstGeom prst="rect">
                <a:avLst/>
              </a:prstGeom>
            </p:spPr>
          </p:pic>
          <p:pic>
            <p:nvPicPr>
              <p:cNvPr id="50" name="Image 49">
                <a:extLst>
                  <a:ext uri="{FF2B5EF4-FFF2-40B4-BE49-F238E27FC236}">
                    <a16:creationId xmlns:a16="http://schemas.microsoft.com/office/drawing/2014/main" id="{AD71EDB1-91C2-4FDD-8872-4913E090AC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53302" b="34754"/>
              <a:stretch>
                <a:fillRect/>
              </a:stretch>
            </p:blipFill>
            <p:spPr>
              <a:xfrm>
                <a:off x="1480928" y="2623931"/>
                <a:ext cx="6652037" cy="2613991"/>
              </a:xfrm>
              <a:prstGeom prst="rect">
                <a:avLst/>
              </a:prstGeom>
            </p:spPr>
          </p:pic>
        </p:grp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BD25463-CF1F-479D-9877-9884CF170BE1}"/>
                </a:ext>
              </a:extLst>
            </p:cNvPr>
            <p:cNvSpPr/>
            <p:nvPr/>
          </p:nvSpPr>
          <p:spPr>
            <a:xfrm>
              <a:off x="900598" y="1587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2A14C87-BBF4-473A-9899-43011F5260FF}"/>
                </a:ext>
              </a:extLst>
            </p:cNvPr>
            <p:cNvSpPr/>
            <p:nvPr/>
          </p:nvSpPr>
          <p:spPr>
            <a:xfrm>
              <a:off x="1218098" y="62229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FC84935-82A5-45E8-A00A-EA355554995B}"/>
                </a:ext>
              </a:extLst>
            </p:cNvPr>
            <p:cNvSpPr/>
            <p:nvPr/>
          </p:nvSpPr>
          <p:spPr>
            <a:xfrm>
              <a:off x="1275248" y="212724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8F3401C6-410A-42F5-ADBE-6F80E1DFF41F}"/>
                </a:ext>
              </a:extLst>
            </p:cNvPr>
            <p:cNvSpPr/>
            <p:nvPr/>
          </p:nvSpPr>
          <p:spPr>
            <a:xfrm>
              <a:off x="1446698" y="41275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0C622CC-245D-413F-910B-496116FA18C4}"/>
                </a:ext>
              </a:extLst>
            </p:cNvPr>
            <p:cNvSpPr/>
            <p:nvPr/>
          </p:nvSpPr>
          <p:spPr>
            <a:xfrm>
              <a:off x="1332398" y="815974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F9CFB517-9BCA-4B62-A7BB-C9DC1E6EC5F8}"/>
                </a:ext>
              </a:extLst>
            </p:cNvPr>
            <p:cNvSpPr/>
            <p:nvPr/>
          </p:nvSpPr>
          <p:spPr>
            <a:xfrm>
              <a:off x="1281598" y="100965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418D218-361E-409C-9E46-0F13003F467B}"/>
                </a:ext>
              </a:extLst>
            </p:cNvPr>
            <p:cNvSpPr/>
            <p:nvPr/>
          </p:nvSpPr>
          <p:spPr>
            <a:xfrm>
              <a:off x="1230798" y="120332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BF0DA7A-78CE-498F-B33C-A9D284586EE9}"/>
                </a:ext>
              </a:extLst>
            </p:cNvPr>
            <p:cNvSpPr/>
            <p:nvPr/>
          </p:nvSpPr>
          <p:spPr>
            <a:xfrm>
              <a:off x="793102" y="139700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185E3775-1672-4937-9788-1605D5E2F2CF}"/>
                </a:ext>
              </a:extLst>
            </p:cNvPr>
            <p:cNvSpPr/>
            <p:nvPr/>
          </p:nvSpPr>
          <p:spPr>
            <a:xfrm>
              <a:off x="776773" y="1609724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9F146729-73B9-4ABE-B2A1-C7AA89C54B4A}"/>
                </a:ext>
              </a:extLst>
            </p:cNvPr>
            <p:cNvSpPr/>
            <p:nvPr/>
          </p:nvSpPr>
          <p:spPr>
            <a:xfrm>
              <a:off x="776773" y="180624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21EF5BDF-D4AC-4076-A3E4-986A6E0DB82C}"/>
                </a:ext>
              </a:extLst>
            </p:cNvPr>
            <p:cNvSpPr/>
            <p:nvPr/>
          </p:nvSpPr>
          <p:spPr>
            <a:xfrm>
              <a:off x="1655160" y="526868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7C32FF3-98F6-452C-A412-55FFB9622D6E}"/>
                </a:ext>
              </a:extLst>
            </p:cNvPr>
            <p:cNvSpPr/>
            <p:nvPr/>
          </p:nvSpPr>
          <p:spPr>
            <a:xfrm>
              <a:off x="1655158" y="546326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E10ADD3-FA4F-437B-A1B5-9706753E5E70}"/>
                </a:ext>
              </a:extLst>
            </p:cNvPr>
            <p:cNvSpPr/>
            <p:nvPr/>
          </p:nvSpPr>
          <p:spPr>
            <a:xfrm>
              <a:off x="1655157" y="566737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EF45101E-08A5-4E45-A954-D86E37E0C8E1}"/>
                </a:ext>
              </a:extLst>
            </p:cNvPr>
            <p:cNvSpPr/>
            <p:nvPr/>
          </p:nvSpPr>
          <p:spPr>
            <a:xfrm>
              <a:off x="3535012" y="142635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FEC32369-D750-4522-8D40-C2CD7EA23629}"/>
                </a:ext>
              </a:extLst>
            </p:cNvPr>
            <p:cNvSpPr/>
            <p:nvPr/>
          </p:nvSpPr>
          <p:spPr>
            <a:xfrm>
              <a:off x="3673006" y="162859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372754A-6541-42E3-83FD-D5257C688E18}"/>
                </a:ext>
              </a:extLst>
            </p:cNvPr>
            <p:cNvSpPr/>
            <p:nvPr/>
          </p:nvSpPr>
          <p:spPr>
            <a:xfrm>
              <a:off x="3701945" y="182511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12DCA42-7635-4003-AE51-810776CDE3C3}"/>
                </a:ext>
              </a:extLst>
            </p:cNvPr>
            <p:cNvSpPr/>
            <p:nvPr/>
          </p:nvSpPr>
          <p:spPr>
            <a:xfrm>
              <a:off x="3687656" y="202640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138515E6-06B4-418B-A363-2032786A825C}"/>
                </a:ext>
              </a:extLst>
            </p:cNvPr>
            <p:cNvSpPr/>
            <p:nvPr/>
          </p:nvSpPr>
          <p:spPr>
            <a:xfrm>
              <a:off x="3689717" y="221315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98E25BD5-A7A4-4A74-BCEA-F7CEBCFE195E}"/>
                </a:ext>
              </a:extLst>
            </p:cNvPr>
            <p:cNvSpPr/>
            <p:nvPr/>
          </p:nvSpPr>
          <p:spPr>
            <a:xfrm>
              <a:off x="1664989" y="447357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45D6881-C7DA-4BD4-88B1-1FAA0151567C}"/>
                </a:ext>
              </a:extLst>
            </p:cNvPr>
            <p:cNvSpPr/>
            <p:nvPr/>
          </p:nvSpPr>
          <p:spPr>
            <a:xfrm>
              <a:off x="1655159" y="466724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  <a:endPara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10F5F94-899B-402A-A444-94CD3558A06F}"/>
                </a:ext>
              </a:extLst>
            </p:cNvPr>
            <p:cNvSpPr/>
            <p:nvPr/>
          </p:nvSpPr>
          <p:spPr>
            <a:xfrm>
              <a:off x="2106008" y="4866633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D8546088-342C-4FF2-BA41-20545646EA67}"/>
                </a:ext>
              </a:extLst>
            </p:cNvPr>
            <p:cNvSpPr/>
            <p:nvPr/>
          </p:nvSpPr>
          <p:spPr>
            <a:xfrm>
              <a:off x="1965645" y="507222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9DB5B8FB-112F-49EA-B669-FFF133BD98FF}"/>
                </a:ext>
              </a:extLst>
            </p:cNvPr>
            <p:cNvSpPr/>
            <p:nvPr/>
          </p:nvSpPr>
          <p:spPr>
            <a:xfrm>
              <a:off x="3063833" y="336298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2D0AE887-61C3-4559-8C5B-8FA3A8B9FE2A}"/>
                </a:ext>
              </a:extLst>
            </p:cNvPr>
            <p:cNvSpPr/>
            <p:nvPr/>
          </p:nvSpPr>
          <p:spPr>
            <a:xfrm>
              <a:off x="3420994" y="4955033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FCDAA2C0-56D7-40EE-B0FA-9EA4445920C8}"/>
                </a:ext>
              </a:extLst>
            </p:cNvPr>
            <p:cNvSpPr/>
            <p:nvPr/>
          </p:nvSpPr>
          <p:spPr>
            <a:xfrm>
              <a:off x="3351878" y="515407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9251074A-A485-41EF-B8D7-1EEC2F24FC51}"/>
                </a:ext>
              </a:extLst>
            </p:cNvPr>
            <p:cNvSpPr/>
            <p:nvPr/>
          </p:nvSpPr>
          <p:spPr>
            <a:xfrm>
              <a:off x="3295789" y="535193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9921C74F-60E1-4E99-B261-7D7278C29493}"/>
                </a:ext>
              </a:extLst>
            </p:cNvPr>
            <p:cNvSpPr/>
            <p:nvPr/>
          </p:nvSpPr>
          <p:spPr>
            <a:xfrm>
              <a:off x="3846961" y="4388091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7AA7E65-25A4-4990-B79C-965C215A610A}"/>
                </a:ext>
              </a:extLst>
            </p:cNvPr>
            <p:cNvSpPr/>
            <p:nvPr/>
          </p:nvSpPr>
          <p:spPr>
            <a:xfrm>
              <a:off x="1306929" y="622909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187067E7-4ABC-4271-B73E-5BB0257C6B44}"/>
                </a:ext>
              </a:extLst>
            </p:cNvPr>
            <p:cNvSpPr/>
            <p:nvPr/>
          </p:nvSpPr>
          <p:spPr>
            <a:xfrm>
              <a:off x="1479626" y="642740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976474E4-D95E-46EB-94CF-1DFA7A2125F8}"/>
                </a:ext>
              </a:extLst>
            </p:cNvPr>
            <p:cNvSpPr/>
            <p:nvPr/>
          </p:nvSpPr>
          <p:spPr>
            <a:xfrm>
              <a:off x="1332398" y="6626857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2FDE9070-858B-4150-AB56-9CE3D0249819}"/>
                </a:ext>
              </a:extLst>
            </p:cNvPr>
            <p:cNvSpPr/>
            <p:nvPr/>
          </p:nvSpPr>
          <p:spPr>
            <a:xfrm>
              <a:off x="1072895" y="681814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CE4CDDD-D254-437F-A643-E9494A4CAF83}"/>
                </a:ext>
              </a:extLst>
            </p:cNvPr>
            <p:cNvSpPr/>
            <p:nvPr/>
          </p:nvSpPr>
          <p:spPr>
            <a:xfrm>
              <a:off x="2092787" y="273259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BA94B2C-F7FF-4613-B417-2A69D48D7C59}"/>
                </a:ext>
              </a:extLst>
            </p:cNvPr>
            <p:cNvSpPr/>
            <p:nvPr/>
          </p:nvSpPr>
          <p:spPr>
            <a:xfrm>
              <a:off x="2082958" y="292627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7</a:t>
              </a:r>
              <a:endPara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BDDE32B4-A7C3-4ECA-88F6-EE67839A970C}"/>
                </a:ext>
              </a:extLst>
            </p:cNvPr>
            <p:cNvSpPr/>
            <p:nvPr/>
          </p:nvSpPr>
          <p:spPr>
            <a:xfrm>
              <a:off x="1989921" y="332455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64D5C1B2-E9F6-4D71-BAD2-AD7C43D1AD5D}"/>
                </a:ext>
              </a:extLst>
            </p:cNvPr>
            <p:cNvSpPr/>
            <p:nvPr/>
          </p:nvSpPr>
          <p:spPr>
            <a:xfrm>
              <a:off x="2033017" y="3517981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65782D7-D49B-4A4F-AC90-FC479EF491D3}"/>
                </a:ext>
              </a:extLst>
            </p:cNvPr>
            <p:cNvSpPr/>
            <p:nvPr/>
          </p:nvSpPr>
          <p:spPr>
            <a:xfrm>
              <a:off x="2112728" y="3126300"/>
              <a:ext cx="917238" cy="947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55A2FA8B-30FA-4CBD-A035-65F380E3031D}"/>
                </a:ext>
              </a:extLst>
            </p:cNvPr>
            <p:cNvSpPr/>
            <p:nvPr/>
          </p:nvSpPr>
          <p:spPr>
            <a:xfrm>
              <a:off x="1968780" y="371876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FF35778D-C4B8-49E0-B541-1C1882479060}"/>
                </a:ext>
              </a:extLst>
            </p:cNvPr>
            <p:cNvSpPr/>
            <p:nvPr/>
          </p:nvSpPr>
          <p:spPr>
            <a:xfrm>
              <a:off x="2042247" y="390761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201C6372-9AE8-47A0-9E04-7BCC4A4690EE}"/>
                </a:ext>
              </a:extLst>
            </p:cNvPr>
            <p:cNvSpPr/>
            <p:nvPr/>
          </p:nvSpPr>
          <p:spPr>
            <a:xfrm>
              <a:off x="3318494" y="554268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Rectangle 50"/>
          <p:cNvSpPr/>
          <p:nvPr/>
        </p:nvSpPr>
        <p:spPr>
          <a:xfrm>
            <a:off x="1075865" y="200438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85789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6044992"/>
            <a:ext cx="118970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7 continued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B: Map of the INRAE F2 population. QTLs for each trait (and experimental stage) are represented with bars of different colors. Bar length indicates the confidence interval of each QTL. FF: fruit firmness; LossFF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: Loss of FF at T14; FW: fruit weight; LossFW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T7/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: Loss of FW at T7 or T14; L*: fruit skin brightness; a*: red/green color; b*: yellow/blue color.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2538EFD7-1F3A-4B7B-8E33-16FE8909AFA3}"/>
              </a:ext>
            </a:extLst>
          </p:cNvPr>
          <p:cNvGrpSpPr/>
          <p:nvPr/>
        </p:nvGrpSpPr>
        <p:grpSpPr>
          <a:xfrm rot="5400000">
            <a:off x="2482419" y="-976317"/>
            <a:ext cx="5985330" cy="8829795"/>
            <a:chOff x="1610886" y="-810887"/>
            <a:chExt cx="5985330" cy="8829795"/>
          </a:xfrm>
        </p:grpSpPr>
        <p:grpSp>
          <p:nvGrpSpPr>
            <p:cNvPr id="11" name="Groupe 10">
              <a:extLst>
                <a:ext uri="{FF2B5EF4-FFF2-40B4-BE49-F238E27FC236}">
                  <a16:creationId xmlns:a16="http://schemas.microsoft.com/office/drawing/2014/main" id="{ADB93DF8-6070-45A8-A008-C1A751F5BECF}"/>
                </a:ext>
              </a:extLst>
            </p:cNvPr>
            <p:cNvGrpSpPr/>
            <p:nvPr/>
          </p:nvGrpSpPr>
          <p:grpSpPr>
            <a:xfrm rot="16200000">
              <a:off x="188653" y="611346"/>
              <a:ext cx="8829795" cy="5985330"/>
              <a:chOff x="9667568" y="0"/>
              <a:chExt cx="8829795" cy="5985330"/>
            </a:xfrm>
          </p:grpSpPr>
          <p:pic>
            <p:nvPicPr>
              <p:cNvPr id="41" name="Image 40">
                <a:extLst>
                  <a:ext uri="{FF2B5EF4-FFF2-40B4-BE49-F238E27FC236}">
                    <a16:creationId xmlns:a16="http://schemas.microsoft.com/office/drawing/2014/main" id="{8F08B5E0-1A0A-4F70-A320-F1A1087A1C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r="51305" b="30208"/>
              <a:stretch>
                <a:fillRect/>
              </a:stretch>
            </p:blipFill>
            <p:spPr>
              <a:xfrm>
                <a:off x="9667568" y="0"/>
                <a:ext cx="7944571" cy="3202505"/>
              </a:xfrm>
              <a:prstGeom prst="rect">
                <a:avLst/>
              </a:prstGeom>
            </p:spPr>
          </p:pic>
          <p:pic>
            <p:nvPicPr>
              <p:cNvPr id="42" name="Image 41">
                <a:extLst>
                  <a:ext uri="{FF2B5EF4-FFF2-40B4-BE49-F238E27FC236}">
                    <a16:creationId xmlns:a16="http://schemas.microsoft.com/office/drawing/2014/main" id="{4C5B5431-C035-4455-95D4-64CB1C1655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47581" b="30208"/>
              <a:stretch>
                <a:fillRect/>
              </a:stretch>
            </p:blipFill>
            <p:spPr>
              <a:xfrm>
                <a:off x="10340650" y="2930935"/>
                <a:ext cx="8156713" cy="3054395"/>
              </a:xfrm>
              <a:prstGeom prst="rect">
                <a:avLst/>
              </a:prstGeom>
            </p:spPr>
          </p:pic>
        </p:grp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B341C88-F554-4A1B-B43F-65DD5CA716CA}"/>
                </a:ext>
              </a:extLst>
            </p:cNvPr>
            <p:cNvSpPr/>
            <p:nvPr/>
          </p:nvSpPr>
          <p:spPr>
            <a:xfrm>
              <a:off x="5930443" y="2433224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FCDDA85-0E67-43A0-9FEC-28EE42221E48}"/>
                </a:ext>
              </a:extLst>
            </p:cNvPr>
            <p:cNvSpPr/>
            <p:nvPr/>
          </p:nvSpPr>
          <p:spPr>
            <a:xfrm>
              <a:off x="5540471" y="82594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51822480-5186-418D-98F7-011DB78B2820}"/>
                </a:ext>
              </a:extLst>
            </p:cNvPr>
            <p:cNvSpPr/>
            <p:nvPr/>
          </p:nvSpPr>
          <p:spPr>
            <a:xfrm>
              <a:off x="5239954" y="103714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00F0D9D-2EE5-446F-B26D-17BEFA5F7919}"/>
                </a:ext>
              </a:extLst>
            </p:cNvPr>
            <p:cNvSpPr/>
            <p:nvPr/>
          </p:nvSpPr>
          <p:spPr>
            <a:xfrm>
              <a:off x="5561022" y="125462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C3C0DCAA-5792-4BBB-B461-F96F91AE3667}"/>
                </a:ext>
              </a:extLst>
            </p:cNvPr>
            <p:cNvSpPr/>
            <p:nvPr/>
          </p:nvSpPr>
          <p:spPr>
            <a:xfrm>
              <a:off x="5561022" y="146560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6215018F-BF9F-4DB1-A1CB-B1A0474A93A3}"/>
                </a:ext>
              </a:extLst>
            </p:cNvPr>
            <p:cNvSpPr/>
            <p:nvPr/>
          </p:nvSpPr>
          <p:spPr>
            <a:xfrm>
              <a:off x="5973773" y="221479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BF80433E-D034-44C6-BAD6-CCA7700EF35D}"/>
                </a:ext>
              </a:extLst>
            </p:cNvPr>
            <p:cNvSpPr/>
            <p:nvPr/>
          </p:nvSpPr>
          <p:spPr>
            <a:xfrm>
              <a:off x="4710145" y="3323651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A0040280-BAC0-4874-9434-A28ADE754D1D}"/>
                </a:ext>
              </a:extLst>
            </p:cNvPr>
            <p:cNvSpPr/>
            <p:nvPr/>
          </p:nvSpPr>
          <p:spPr>
            <a:xfrm>
              <a:off x="4710145" y="353870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989C9C6-2524-453C-B23E-919D63F01596}"/>
                </a:ext>
              </a:extLst>
            </p:cNvPr>
            <p:cNvSpPr/>
            <p:nvPr/>
          </p:nvSpPr>
          <p:spPr>
            <a:xfrm>
              <a:off x="5168717" y="449569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1B9A6B44-ECEE-4A08-B7C4-214B2114A639}"/>
                </a:ext>
              </a:extLst>
            </p:cNvPr>
            <p:cNvSpPr/>
            <p:nvPr/>
          </p:nvSpPr>
          <p:spPr>
            <a:xfrm>
              <a:off x="5666631" y="471437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99658F56-F1C3-4F9A-B82D-D534C65A7BCA}"/>
                </a:ext>
              </a:extLst>
            </p:cNvPr>
            <p:cNvSpPr/>
            <p:nvPr/>
          </p:nvSpPr>
          <p:spPr>
            <a:xfrm>
              <a:off x="5300697" y="492432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16315B8-F38F-4900-A91A-3EC8AFE57D96}"/>
                </a:ext>
              </a:extLst>
            </p:cNvPr>
            <p:cNvSpPr/>
            <p:nvPr/>
          </p:nvSpPr>
          <p:spPr>
            <a:xfrm>
              <a:off x="5626106" y="513613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5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F4D2096-B1A7-4DAF-A60A-D43F5A14498C}"/>
                </a:ext>
              </a:extLst>
            </p:cNvPr>
            <p:cNvSpPr/>
            <p:nvPr/>
          </p:nvSpPr>
          <p:spPr>
            <a:xfrm>
              <a:off x="2678458" y="3948411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23DBE5BD-460F-42FD-8E48-60D8C5030B1B}"/>
                </a:ext>
              </a:extLst>
            </p:cNvPr>
            <p:cNvSpPr/>
            <p:nvPr/>
          </p:nvSpPr>
          <p:spPr>
            <a:xfrm>
              <a:off x="2802472" y="4167093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909CE95-01E6-4289-8A4A-408CCC326998}"/>
                </a:ext>
              </a:extLst>
            </p:cNvPr>
            <p:cNvSpPr/>
            <p:nvPr/>
          </p:nvSpPr>
          <p:spPr>
            <a:xfrm>
              <a:off x="2897715" y="439070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FDB9C41F-2FFB-4722-9A45-EC570EB3996A}"/>
                </a:ext>
              </a:extLst>
            </p:cNvPr>
            <p:cNvSpPr/>
            <p:nvPr/>
          </p:nvSpPr>
          <p:spPr>
            <a:xfrm>
              <a:off x="2897715" y="461738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6EA4CB9-D85E-490F-BA9D-CD9778CE6B93}"/>
                </a:ext>
              </a:extLst>
            </p:cNvPr>
            <p:cNvSpPr/>
            <p:nvPr/>
          </p:nvSpPr>
          <p:spPr>
            <a:xfrm>
              <a:off x="2107974" y="1768616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85460D33-B04F-440C-B7E3-9CBE169180FE}"/>
                </a:ext>
              </a:extLst>
            </p:cNvPr>
            <p:cNvSpPr/>
            <p:nvPr/>
          </p:nvSpPr>
          <p:spPr>
            <a:xfrm>
              <a:off x="2193648" y="199951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F270F87B-83B4-416F-9C66-15F6E91E0FD6}"/>
                </a:ext>
              </a:extLst>
            </p:cNvPr>
            <p:cNvSpPr/>
            <p:nvPr/>
          </p:nvSpPr>
          <p:spPr>
            <a:xfrm>
              <a:off x="2336524" y="222248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F4C731F8-0D99-445C-B4EC-0702CA681EC0}"/>
                </a:ext>
              </a:extLst>
            </p:cNvPr>
            <p:cNvSpPr/>
            <p:nvPr/>
          </p:nvSpPr>
          <p:spPr>
            <a:xfrm>
              <a:off x="2403198" y="244550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5361679F-642A-47B0-9705-3B46B8A543D5}"/>
                </a:ext>
              </a:extLst>
            </p:cNvPr>
            <p:cNvSpPr/>
            <p:nvPr/>
          </p:nvSpPr>
          <p:spPr>
            <a:xfrm>
              <a:off x="1755549" y="313090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1CCF90B-9F43-4C41-B257-9E11A354BB63}"/>
                </a:ext>
              </a:extLst>
            </p:cNvPr>
            <p:cNvSpPr/>
            <p:nvPr/>
          </p:nvSpPr>
          <p:spPr>
            <a:xfrm>
              <a:off x="1765073" y="538259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F8C66B5F-8ECE-4CE5-B83C-5DDB7C26BA18}"/>
                </a:ext>
              </a:extLst>
            </p:cNvPr>
            <p:cNvSpPr/>
            <p:nvPr/>
          </p:nvSpPr>
          <p:spPr>
            <a:xfrm>
              <a:off x="1955573" y="76494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88BE7FAB-69EC-4FDA-BBB2-76BB1CB0F374}"/>
                </a:ext>
              </a:extLst>
            </p:cNvPr>
            <p:cNvSpPr/>
            <p:nvPr/>
          </p:nvSpPr>
          <p:spPr>
            <a:xfrm>
              <a:off x="2378104" y="659551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EAB31EB-A065-414D-8E30-613BA3A29CA9}"/>
                </a:ext>
              </a:extLst>
            </p:cNvPr>
            <p:cNvSpPr/>
            <p:nvPr/>
          </p:nvSpPr>
          <p:spPr>
            <a:xfrm>
              <a:off x="3067089" y="585453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A49D021-0763-4E21-98AC-84A7DA4C6C45}"/>
                </a:ext>
              </a:extLst>
            </p:cNvPr>
            <p:cNvSpPr/>
            <p:nvPr/>
          </p:nvSpPr>
          <p:spPr>
            <a:xfrm>
              <a:off x="5887580" y="6602052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F5CF289-16D5-4124-A246-BF5D31D4EF9C}"/>
                </a:ext>
              </a:extLst>
            </p:cNvPr>
            <p:cNvSpPr/>
            <p:nvPr/>
          </p:nvSpPr>
          <p:spPr>
            <a:xfrm>
              <a:off x="5742285" y="5958715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0CBAAC53-74D2-497D-84C9-CF8E66DBF5CF}"/>
                </a:ext>
              </a:extLst>
            </p:cNvPr>
            <p:cNvSpPr/>
            <p:nvPr/>
          </p:nvSpPr>
          <p:spPr>
            <a:xfrm>
              <a:off x="5920919" y="6179508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  <a:r>
                <a:rPr lang="fr-FR" sz="800" b="1" baseline="-2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14</a:t>
              </a:r>
              <a:endParaRPr lang="en-US" sz="800" b="1" baseline="-2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FC738F9-C8DE-42F3-8C68-00BCD8EBCAB9}"/>
                </a:ext>
              </a:extLst>
            </p:cNvPr>
            <p:cNvSpPr/>
            <p:nvPr/>
          </p:nvSpPr>
          <p:spPr>
            <a:xfrm>
              <a:off x="6078544" y="6384914"/>
              <a:ext cx="996950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it-IT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8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Rectangle 42"/>
          <p:cNvSpPr/>
          <p:nvPr/>
        </p:nvSpPr>
        <p:spPr>
          <a:xfrm>
            <a:off x="736058" y="445915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042432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0018187"/>
              </p:ext>
            </p:extLst>
          </p:nvPr>
        </p:nvGraphicFramePr>
        <p:xfrm>
          <a:off x="5944740" y="207861"/>
          <a:ext cx="3816000" cy="2554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6812489" y="1556364"/>
            <a:ext cx="1882" cy="792778"/>
          </a:xfrm>
          <a:prstGeom prst="line">
            <a:avLst/>
          </a:prstGeom>
          <a:ln w="38100">
            <a:solidFill>
              <a:srgbClr val="66FF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8804943" y="1547486"/>
            <a:ext cx="1882" cy="792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9569783" y="496033"/>
            <a:ext cx="160022" cy="1944000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7343510" y="1200963"/>
            <a:ext cx="119" cy="1129469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680328" y="5471795"/>
            <a:ext cx="2510712" cy="50783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numCol="2" spcCol="360000" rtlCol="0">
            <a:spAutoFit/>
          </a:bodyPr>
          <a:lstStyle/>
          <a:p>
            <a:pPr>
              <a:spcBef>
                <a:spcPts val="600"/>
              </a:spcBef>
            </a:pPr>
            <a:r>
              <a:rPr lang="it-IT" sz="1100" dirty="0"/>
              <a:t>Hi Segr avg</a:t>
            </a:r>
          </a:p>
          <a:p>
            <a:pPr>
              <a:spcBef>
                <a:spcPts val="600"/>
              </a:spcBef>
            </a:pPr>
            <a:r>
              <a:rPr lang="it-IT" sz="1100" dirty="0"/>
              <a:t>Lo Segr avg</a:t>
            </a:r>
          </a:p>
          <a:p>
            <a:pPr>
              <a:spcBef>
                <a:spcPts val="600"/>
              </a:spcBef>
            </a:pPr>
            <a:r>
              <a:rPr lang="it-IT" sz="1100" dirty="0"/>
              <a:t>F2</a:t>
            </a:r>
          </a:p>
          <a:p>
            <a:pPr>
              <a:spcBef>
                <a:spcPts val="600"/>
              </a:spcBef>
            </a:pPr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16" name="Rectangle 15"/>
          <p:cNvSpPr/>
          <p:nvPr/>
        </p:nvSpPr>
        <p:spPr>
          <a:xfrm>
            <a:off x="6564821" y="5568794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>
            <a:off x="5486562" y="5622062"/>
            <a:ext cx="544049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477684" y="5854944"/>
            <a:ext cx="544049" cy="0"/>
          </a:xfrm>
          <a:prstGeom prst="line">
            <a:avLst/>
          </a:prstGeom>
          <a:ln w="38100">
            <a:solidFill>
              <a:srgbClr val="66FF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564821" y="5837513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0855851"/>
              </p:ext>
            </p:extLst>
          </p:nvPr>
        </p:nvGraphicFramePr>
        <p:xfrm>
          <a:off x="2069415" y="206734"/>
          <a:ext cx="3816000" cy="25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5" name="Straight Connector 24"/>
          <p:cNvCxnSpPr/>
          <p:nvPr/>
        </p:nvCxnSpPr>
        <p:spPr>
          <a:xfrm>
            <a:off x="3222606" y="1537796"/>
            <a:ext cx="1882" cy="792778"/>
          </a:xfrm>
          <a:prstGeom prst="line">
            <a:avLst/>
          </a:prstGeom>
          <a:ln w="38100">
            <a:solidFill>
              <a:srgbClr val="66FF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022372" y="1516411"/>
            <a:ext cx="1882" cy="792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061047" y="1188187"/>
            <a:ext cx="119" cy="1129469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49004" y="5994542"/>
            <a:ext cx="1198107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8. Average trait values of selected F2 segregants used for BSA-Seq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to the population distribution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-B: ENEA FF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A) and LossFW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B). C-D: INRAE FF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(C) and LossFF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(D). Blue histograms: F2 progeny bins. Dark blue dotted line: average of F2. Light green line: average of low-trait segregants. Dark green line: average of high-trait segregant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54900" y="175861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1754899" y="2759858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C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9701255" y="175616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B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9701255" y="2759858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D</a:t>
            </a:r>
            <a:endParaRPr lang="en-US" dirty="0"/>
          </a:p>
        </p:txBody>
      </p:sp>
      <p:sp>
        <p:nvSpPr>
          <p:cNvPr id="36" name="Rectangle 35"/>
          <p:cNvSpPr/>
          <p:nvPr/>
        </p:nvSpPr>
        <p:spPr>
          <a:xfrm>
            <a:off x="5683292" y="456705"/>
            <a:ext cx="172627" cy="1972800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1117752" y="1373767"/>
            <a:ext cx="756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ENEA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1117752" y="3973257"/>
            <a:ext cx="895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INRAE</a:t>
            </a:r>
            <a:endParaRPr lang="en-US" dirty="0"/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2067536"/>
              </p:ext>
            </p:extLst>
          </p:nvPr>
        </p:nvGraphicFramePr>
        <p:xfrm>
          <a:off x="2069415" y="2817475"/>
          <a:ext cx="3816000" cy="25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0" name="Rectangle 39"/>
          <p:cNvSpPr/>
          <p:nvPr/>
        </p:nvSpPr>
        <p:spPr>
          <a:xfrm>
            <a:off x="5719947" y="3053920"/>
            <a:ext cx="144000" cy="193759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7893030"/>
              </p:ext>
            </p:extLst>
          </p:nvPr>
        </p:nvGraphicFramePr>
        <p:xfrm>
          <a:off x="5944740" y="2817475"/>
          <a:ext cx="3816000" cy="25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42" name="Straight Connector 41"/>
          <p:cNvCxnSpPr/>
          <p:nvPr/>
        </p:nvCxnSpPr>
        <p:spPr>
          <a:xfrm>
            <a:off x="7776100" y="3817654"/>
            <a:ext cx="119" cy="1129469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7058489" y="4165477"/>
            <a:ext cx="1882" cy="792778"/>
          </a:xfrm>
          <a:prstGeom prst="line">
            <a:avLst/>
          </a:prstGeom>
          <a:ln w="38100">
            <a:solidFill>
              <a:srgbClr val="66FF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8603382" y="4158334"/>
            <a:ext cx="1882" cy="792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5151279" y="4148630"/>
            <a:ext cx="1882" cy="792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568846" y="4166801"/>
            <a:ext cx="1882" cy="792778"/>
          </a:xfrm>
          <a:prstGeom prst="line">
            <a:avLst/>
          </a:prstGeom>
          <a:ln w="38100">
            <a:solidFill>
              <a:srgbClr val="66FF3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462952" y="3818954"/>
            <a:ext cx="119" cy="1129469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9596417" y="3053919"/>
            <a:ext cx="144000" cy="1937593"/>
          </a:xfrm>
          <a:prstGeom prst="rect">
            <a:avLst/>
          </a:prstGeom>
          <a:solidFill>
            <a:schemeClr val="bg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2648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3D93C1-9C3D-C79D-C5E7-7DA740F4FD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B8DF9CA-EE57-AD79-0890-C050517F6DE3}"/>
              </a:ext>
            </a:extLst>
          </p:cNvPr>
          <p:cNvSpPr txBox="1"/>
          <p:nvPr/>
        </p:nvSpPr>
        <p:spPr>
          <a:xfrm>
            <a:off x="161927" y="5199666"/>
            <a:ext cx="1198107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600" b="1" dirty="0">
                <a:cs typeface="Arial" panose="020B0604020202020204" pitchFamily="34" charset="0"/>
              </a:rPr>
              <a:t>Suppl. Figure S9a</a:t>
            </a:r>
            <a:r>
              <a:rPr lang="it-IT" sz="1600" dirty="0">
                <a:cs typeface="Arial" panose="020B0604020202020204" pitchFamily="34" charset="0"/>
              </a:rPr>
              <a:t>. </a:t>
            </a:r>
            <a:r>
              <a:rPr lang="fr-FR" sz="1600" dirty="0"/>
              <a:t>BSA-Seq </a:t>
            </a:r>
            <a:r>
              <a:rPr lang="fr-FR" sz="1600" dirty="0" err="1"/>
              <a:t>analysis</a:t>
            </a:r>
            <a:r>
              <a:rPr lang="fr-FR" sz="1600" dirty="0"/>
              <a:t> of shelf life </a:t>
            </a:r>
            <a:r>
              <a:rPr lang="fr-FR" sz="1600" dirty="0" err="1"/>
              <a:t>related</a:t>
            </a:r>
            <a:r>
              <a:rPr lang="fr-FR" sz="1600" dirty="0"/>
              <a:t> traits in </a:t>
            </a:r>
            <a:r>
              <a:rPr lang="fr-FR" sz="1600" dirty="0" err="1"/>
              <a:t>tomato</a:t>
            </a:r>
            <a:r>
              <a:rPr lang="fr-FR" sz="1600" dirty="0"/>
              <a:t> ENEA F₂ population for </a:t>
            </a:r>
            <a:r>
              <a:rPr lang="en-CA" sz="1600" dirty="0"/>
              <a:t>LossFW</a:t>
            </a:r>
            <a:r>
              <a:rPr lang="en-CA" sz="1600" baseline="-25000" dirty="0"/>
              <a:t>T14</a:t>
            </a:r>
            <a:r>
              <a:rPr lang="fr-FR" sz="1200" dirty="0"/>
              <a:t> </a:t>
            </a:r>
            <a:r>
              <a:rPr lang="fr-FR" sz="1600" dirty="0"/>
              <a:t>(panel A)</a:t>
            </a:r>
            <a:r>
              <a:rPr lang="it-IT" sz="1600" dirty="0"/>
              <a:t> and </a:t>
            </a:r>
            <a:r>
              <a:rPr lang="en-CA" sz="1600" dirty="0"/>
              <a:t>FF</a:t>
            </a:r>
            <a:r>
              <a:rPr lang="en-CA" sz="1600" baseline="-25000" dirty="0"/>
              <a:t>T14</a:t>
            </a:r>
            <a:r>
              <a:rPr lang="fr-FR" sz="1600" dirty="0"/>
              <a:t> (panel B). </a:t>
            </a:r>
            <a:r>
              <a:rPr lang="fr-FR" sz="1600" dirty="0" err="1"/>
              <a:t>Each</a:t>
            </a:r>
            <a:r>
              <a:rPr lang="fr-FR" sz="1600" dirty="0"/>
              <a:t> panel shows the </a:t>
            </a:r>
            <a:r>
              <a:rPr lang="fr-FR" sz="1600" dirty="0" err="1"/>
              <a:t>genome-wide</a:t>
            </a:r>
            <a:r>
              <a:rPr lang="fr-FR" sz="1600" dirty="0"/>
              <a:t> distribution of the </a:t>
            </a:r>
            <a:r>
              <a:rPr lang="el-GR" sz="1600" dirty="0"/>
              <a:t>Δ</a:t>
            </a:r>
            <a:r>
              <a:rPr lang="fr-FR" sz="1600" dirty="0"/>
              <a:t>SNP-index (</a:t>
            </a:r>
            <a:r>
              <a:rPr lang="fr-FR" sz="1600" dirty="0" err="1"/>
              <a:t>blue</a:t>
            </a:r>
            <a:r>
              <a:rPr lang="fr-FR" sz="1600" dirty="0"/>
              <a:t> dots) </a:t>
            </a:r>
            <a:r>
              <a:rPr lang="fr-FR" sz="1600" dirty="0" err="1"/>
              <a:t>along</a:t>
            </a:r>
            <a:r>
              <a:rPr lang="fr-FR" sz="1600" dirty="0"/>
              <a:t> the 12 chromosomes of </a:t>
            </a:r>
            <a:r>
              <a:rPr lang="fr-FR" sz="1600" i="1" dirty="0"/>
              <a:t>Solanum lycopersicum</a:t>
            </a:r>
            <a:r>
              <a:rPr lang="fr-FR" sz="1600" dirty="0"/>
              <a:t>, </a:t>
            </a:r>
            <a:r>
              <a:rPr lang="fr-FR" sz="1600" dirty="0" err="1"/>
              <a:t>obtained</a:t>
            </a:r>
            <a:r>
              <a:rPr lang="fr-FR" sz="1600" dirty="0"/>
              <a:t> by QTL-</a:t>
            </a:r>
            <a:r>
              <a:rPr lang="fr-FR" sz="1600" dirty="0" err="1"/>
              <a:t>seq</a:t>
            </a:r>
            <a:r>
              <a:rPr lang="fr-FR" sz="1600" dirty="0"/>
              <a:t> </a:t>
            </a:r>
            <a:r>
              <a:rPr lang="fr-FR" sz="1600" dirty="0" err="1"/>
              <a:t>analysis</a:t>
            </a:r>
            <a:r>
              <a:rPr lang="fr-FR" sz="1600" dirty="0"/>
              <a:t> (Sugihara et al., 2022; Takagi et al., 2013) of </a:t>
            </a:r>
            <a:r>
              <a:rPr lang="fr-FR" sz="1600" dirty="0" err="1"/>
              <a:t>extreme</a:t>
            </a:r>
            <a:r>
              <a:rPr lang="fr-FR" sz="1600" dirty="0"/>
              <a:t> bulk </a:t>
            </a:r>
            <a:r>
              <a:rPr lang="fr-FR" sz="1600" dirty="0" err="1"/>
              <a:t>segregants</a:t>
            </a:r>
            <a:r>
              <a:rPr lang="fr-FR" sz="1600" dirty="0"/>
              <a:t>. The </a:t>
            </a:r>
            <a:r>
              <a:rPr lang="fr-FR" sz="1600" dirty="0" err="1"/>
              <a:t>red</a:t>
            </a:r>
            <a:r>
              <a:rPr lang="fr-FR" sz="1600" dirty="0"/>
              <a:t> </a:t>
            </a:r>
            <a:r>
              <a:rPr lang="fr-FR" sz="1600" dirty="0" err="1"/>
              <a:t>dashed</a:t>
            </a:r>
            <a:r>
              <a:rPr lang="fr-FR" sz="1600" dirty="0"/>
              <a:t> </a:t>
            </a:r>
            <a:r>
              <a:rPr lang="fr-FR" sz="1600" dirty="0" err="1"/>
              <a:t>lines</a:t>
            </a:r>
            <a:r>
              <a:rPr lang="fr-FR" sz="1600" dirty="0"/>
              <a:t> </a:t>
            </a:r>
            <a:r>
              <a:rPr lang="fr-FR" sz="1600" dirty="0" err="1"/>
              <a:t>indicate</a:t>
            </a:r>
            <a:r>
              <a:rPr lang="fr-FR" sz="1600" dirty="0"/>
              <a:t> the position-</a:t>
            </a:r>
            <a:r>
              <a:rPr lang="fr-FR" sz="1600" dirty="0" err="1"/>
              <a:t>specific</a:t>
            </a:r>
            <a:r>
              <a:rPr lang="fr-FR" sz="1600" dirty="0"/>
              <a:t> (P&lt;0.01) </a:t>
            </a:r>
            <a:r>
              <a:rPr lang="fr-FR" sz="1600" dirty="0" err="1"/>
              <a:t>significance</a:t>
            </a:r>
            <a:r>
              <a:rPr lang="fr-FR" sz="1600" dirty="0"/>
              <a:t> </a:t>
            </a:r>
            <a:r>
              <a:rPr lang="fr-FR" sz="1600" dirty="0" err="1"/>
              <a:t>threshold</a:t>
            </a:r>
            <a:r>
              <a:rPr lang="fr-FR" sz="1600" dirty="0"/>
              <a:t> </a:t>
            </a:r>
            <a:r>
              <a:rPr lang="fr-FR" sz="1600" dirty="0" err="1"/>
              <a:t>estimated</a:t>
            </a:r>
            <a:r>
              <a:rPr lang="fr-FR" sz="1600" dirty="0"/>
              <a:t> by simulation. </a:t>
            </a:r>
            <a:r>
              <a:rPr lang="fr-FR" sz="1600" dirty="0" err="1"/>
              <a:t>Genomic</a:t>
            </a:r>
            <a:r>
              <a:rPr lang="fr-FR" sz="1600" dirty="0"/>
              <a:t> </a:t>
            </a:r>
            <a:r>
              <a:rPr lang="fr-FR" sz="1600" dirty="0" err="1"/>
              <a:t>regions</a:t>
            </a:r>
            <a:r>
              <a:rPr lang="fr-FR" sz="1600" dirty="0"/>
              <a:t> </a:t>
            </a:r>
            <a:r>
              <a:rPr lang="fr-FR" sz="1600" dirty="0" err="1"/>
              <a:t>where</a:t>
            </a:r>
            <a:r>
              <a:rPr lang="fr-FR" sz="1600" dirty="0"/>
              <a:t> the </a:t>
            </a:r>
            <a:r>
              <a:rPr lang="el-GR" sz="1600" dirty="0"/>
              <a:t>Δ</a:t>
            </a:r>
            <a:r>
              <a:rPr lang="fr-FR" sz="1600" dirty="0"/>
              <a:t>SNP-index </a:t>
            </a:r>
            <a:r>
              <a:rPr lang="fr-FR" sz="1600" dirty="0" err="1"/>
              <a:t>exceeded</a:t>
            </a:r>
            <a:r>
              <a:rPr lang="fr-FR" sz="1600" dirty="0"/>
              <a:t> the </a:t>
            </a:r>
            <a:r>
              <a:rPr lang="fr-FR" sz="1600" dirty="0" err="1"/>
              <a:t>threshold</a:t>
            </a:r>
            <a:r>
              <a:rPr lang="fr-FR" sz="1600" dirty="0"/>
              <a:t>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expanded</a:t>
            </a:r>
            <a:r>
              <a:rPr lang="fr-FR" sz="1600" dirty="0"/>
              <a:t> </a:t>
            </a:r>
            <a:r>
              <a:rPr lang="fr-FR" sz="1600" dirty="0" err="1"/>
              <a:t>based</a:t>
            </a:r>
            <a:r>
              <a:rPr lang="fr-FR" sz="1600" dirty="0"/>
              <a:t> on linkage </a:t>
            </a:r>
            <a:r>
              <a:rPr lang="fr-FR" sz="1600" dirty="0" err="1"/>
              <a:t>decay</a:t>
            </a:r>
            <a:r>
              <a:rPr lang="fr-FR" sz="1600" dirty="0"/>
              <a:t> to a minimum r² of 0.2. </a:t>
            </a:r>
            <a:r>
              <a:rPr lang="fr-FR" sz="1600" dirty="0" err="1"/>
              <a:t>Intervals</a:t>
            </a:r>
            <a:r>
              <a:rPr lang="fr-FR" sz="1600" dirty="0"/>
              <a:t> </a:t>
            </a:r>
            <a:r>
              <a:rPr lang="fr-FR" sz="1600" dirty="0" err="1"/>
              <a:t>narrower</a:t>
            </a:r>
            <a:r>
              <a:rPr lang="fr-FR" sz="1600" dirty="0"/>
              <a:t> </a:t>
            </a:r>
            <a:r>
              <a:rPr lang="fr-FR" sz="1600" dirty="0" err="1"/>
              <a:t>than</a:t>
            </a:r>
            <a:r>
              <a:rPr lang="fr-FR" sz="1600" dirty="0"/>
              <a:t> 3.5 Mb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retained</a:t>
            </a:r>
            <a:r>
              <a:rPr lang="fr-FR" sz="1600" dirty="0"/>
              <a:t>; </a:t>
            </a:r>
            <a:r>
              <a:rPr lang="fr-FR" sz="1600" dirty="0" err="1"/>
              <a:t>overlapping</a:t>
            </a:r>
            <a:r>
              <a:rPr lang="fr-FR" sz="1600" dirty="0"/>
              <a:t> </a:t>
            </a:r>
            <a:r>
              <a:rPr lang="fr-FR" sz="1600" dirty="0" err="1"/>
              <a:t>intervals</a:t>
            </a:r>
            <a:r>
              <a:rPr lang="fr-FR" sz="1600" dirty="0"/>
              <a:t>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merged</a:t>
            </a:r>
            <a:r>
              <a:rPr lang="fr-FR" sz="1600" dirty="0"/>
              <a:t> and are </a:t>
            </a:r>
            <a:r>
              <a:rPr lang="fr-FR" sz="1600" dirty="0" err="1"/>
              <a:t>shown</a:t>
            </a:r>
            <a:r>
              <a:rPr lang="fr-FR" sz="1600" dirty="0"/>
              <a:t> as green </a:t>
            </a:r>
            <a:r>
              <a:rPr lang="fr-FR" sz="1600" dirty="0" err="1"/>
              <a:t>shaded</a:t>
            </a:r>
            <a:r>
              <a:rPr lang="fr-FR" sz="1600" dirty="0"/>
              <a:t> areas. 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FF438AF1-7304-5DBC-B996-D5052E53F0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27" y="744234"/>
            <a:ext cx="5867400" cy="4191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ED1D21C8-F46B-D289-9227-1FDDDDF429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2675" y="744234"/>
            <a:ext cx="5867400" cy="4191000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B4286F23-71E8-7489-6163-E5AEE6B25846}"/>
              </a:ext>
            </a:extLst>
          </p:cNvPr>
          <p:cNvSpPr txBox="1"/>
          <p:nvPr/>
        </p:nvSpPr>
        <p:spPr>
          <a:xfrm>
            <a:off x="3004844" y="4938848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7BC0715C-1237-BF50-33B6-86B43B39F7BF}"/>
              </a:ext>
            </a:extLst>
          </p:cNvPr>
          <p:cNvSpPr txBox="1"/>
          <p:nvPr/>
        </p:nvSpPr>
        <p:spPr>
          <a:xfrm>
            <a:off x="9021367" y="49864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358281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>
            <a:extLst>
              <a:ext uri="{FF2B5EF4-FFF2-40B4-BE49-F238E27FC236}">
                <a16:creationId xmlns:a16="http://schemas.microsoft.com/office/drawing/2014/main" id="{ED57A758-D69B-90D6-6E75-9412DD482759}"/>
              </a:ext>
            </a:extLst>
          </p:cNvPr>
          <p:cNvSpPr txBox="1"/>
          <p:nvPr/>
        </p:nvSpPr>
        <p:spPr>
          <a:xfrm>
            <a:off x="2990986" y="4671521"/>
            <a:ext cx="178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C 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CD752CB4-0B69-11F4-3322-6855997756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87" y="298303"/>
            <a:ext cx="6122505" cy="4373218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AD916F4F-7C9C-D03D-858B-B48CF73438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5453" y="367878"/>
            <a:ext cx="6025102" cy="4303644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AB3BB513-D372-AEB5-EAEC-FABDECDAC3E4}"/>
              </a:ext>
            </a:extLst>
          </p:cNvPr>
          <p:cNvSpPr txBox="1"/>
          <p:nvPr/>
        </p:nvSpPr>
        <p:spPr>
          <a:xfrm>
            <a:off x="9126729" y="4734470"/>
            <a:ext cx="178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D </a:t>
            </a:r>
          </a:p>
        </p:txBody>
      </p:sp>
      <p:sp>
        <p:nvSpPr>
          <p:cNvPr id="23" name="TextBox 3">
            <a:extLst>
              <a:ext uri="{FF2B5EF4-FFF2-40B4-BE49-F238E27FC236}">
                <a16:creationId xmlns:a16="http://schemas.microsoft.com/office/drawing/2014/main" id="{25701AD7-1983-3028-CB91-5F41A1B97C01}"/>
              </a:ext>
            </a:extLst>
          </p:cNvPr>
          <p:cNvSpPr txBox="1"/>
          <p:nvPr/>
        </p:nvSpPr>
        <p:spPr>
          <a:xfrm>
            <a:off x="151156" y="5103801"/>
            <a:ext cx="1198107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600" b="1" dirty="0">
                <a:cs typeface="Arial" panose="020B0604020202020204" pitchFamily="34" charset="0"/>
              </a:rPr>
              <a:t>Suppl. Figure S9b</a:t>
            </a:r>
            <a:r>
              <a:rPr lang="it-IT" sz="1600" dirty="0">
                <a:cs typeface="Arial" panose="020B0604020202020204" pitchFamily="34" charset="0"/>
              </a:rPr>
              <a:t>. </a:t>
            </a:r>
            <a:r>
              <a:rPr lang="fr-FR" sz="1600" dirty="0"/>
              <a:t>BSA-Seq </a:t>
            </a:r>
            <a:r>
              <a:rPr lang="fr-FR" sz="1600" dirty="0" err="1"/>
              <a:t>analysis</a:t>
            </a:r>
            <a:r>
              <a:rPr lang="fr-FR" sz="1600" dirty="0"/>
              <a:t> of shelf life </a:t>
            </a:r>
            <a:r>
              <a:rPr lang="fr-FR" sz="1600" dirty="0" err="1"/>
              <a:t>related</a:t>
            </a:r>
            <a:r>
              <a:rPr lang="fr-FR" sz="1600" dirty="0"/>
              <a:t> traits in </a:t>
            </a:r>
            <a:r>
              <a:rPr lang="fr-FR" sz="1600" dirty="0" err="1"/>
              <a:t>tomato</a:t>
            </a:r>
            <a:r>
              <a:rPr lang="fr-FR" sz="1600" dirty="0"/>
              <a:t> INRAE F₂ population for </a:t>
            </a:r>
            <a:r>
              <a:rPr lang="en-CA" sz="1600" dirty="0"/>
              <a:t>LossFF</a:t>
            </a:r>
            <a:r>
              <a:rPr lang="en-CA" sz="1600" baseline="-25000" dirty="0"/>
              <a:t>T14</a:t>
            </a:r>
            <a:r>
              <a:rPr lang="fr-FR" sz="1200" dirty="0"/>
              <a:t> </a:t>
            </a:r>
            <a:r>
              <a:rPr lang="fr-FR" sz="1600" dirty="0"/>
              <a:t>(panel C)</a:t>
            </a:r>
            <a:r>
              <a:rPr lang="it-IT" sz="1600" dirty="0"/>
              <a:t> and </a:t>
            </a:r>
            <a:r>
              <a:rPr lang="en-CA" sz="1600" dirty="0"/>
              <a:t>FF</a:t>
            </a:r>
            <a:r>
              <a:rPr lang="en-CA" sz="1600" baseline="-25000" dirty="0"/>
              <a:t>T0</a:t>
            </a:r>
            <a:r>
              <a:rPr lang="fr-FR" sz="1600" dirty="0"/>
              <a:t> (panel D). </a:t>
            </a:r>
            <a:r>
              <a:rPr lang="fr-FR" sz="1600" dirty="0" err="1"/>
              <a:t>Each</a:t>
            </a:r>
            <a:r>
              <a:rPr lang="fr-FR" sz="1600" dirty="0"/>
              <a:t> panel shows the </a:t>
            </a:r>
            <a:r>
              <a:rPr lang="fr-FR" sz="1600" dirty="0" err="1"/>
              <a:t>genome-wide</a:t>
            </a:r>
            <a:r>
              <a:rPr lang="fr-FR" sz="1600" dirty="0"/>
              <a:t> distribution of the </a:t>
            </a:r>
            <a:r>
              <a:rPr lang="el-GR" sz="1600" dirty="0"/>
              <a:t>Δ</a:t>
            </a:r>
            <a:r>
              <a:rPr lang="fr-FR" sz="1600" dirty="0"/>
              <a:t>SNP-index (</a:t>
            </a:r>
            <a:r>
              <a:rPr lang="fr-FR" sz="1600" dirty="0" err="1"/>
              <a:t>blue</a:t>
            </a:r>
            <a:r>
              <a:rPr lang="fr-FR" sz="1600" dirty="0"/>
              <a:t> dots) </a:t>
            </a:r>
            <a:r>
              <a:rPr lang="fr-FR" sz="1600" dirty="0" err="1"/>
              <a:t>along</a:t>
            </a:r>
            <a:r>
              <a:rPr lang="fr-FR" sz="1600" dirty="0"/>
              <a:t> the 12 chromosomes of </a:t>
            </a:r>
            <a:r>
              <a:rPr lang="fr-FR" sz="1600" i="1" dirty="0"/>
              <a:t>Solanum lycopersicum</a:t>
            </a:r>
            <a:r>
              <a:rPr lang="fr-FR" sz="1600" dirty="0"/>
              <a:t>, </a:t>
            </a:r>
            <a:r>
              <a:rPr lang="fr-FR" sz="1600" dirty="0" err="1"/>
              <a:t>obtained</a:t>
            </a:r>
            <a:r>
              <a:rPr lang="fr-FR" sz="1600" dirty="0"/>
              <a:t> by QTL-</a:t>
            </a:r>
            <a:r>
              <a:rPr lang="fr-FR" sz="1600" dirty="0" err="1"/>
              <a:t>seq</a:t>
            </a:r>
            <a:r>
              <a:rPr lang="fr-FR" sz="1600" dirty="0"/>
              <a:t> </a:t>
            </a:r>
            <a:r>
              <a:rPr lang="fr-FR" sz="1600" dirty="0" err="1"/>
              <a:t>analysis</a:t>
            </a:r>
            <a:r>
              <a:rPr lang="fr-FR" sz="1600" dirty="0"/>
              <a:t> (Sugihara et al., 2022; Takagi et al., 2013) of </a:t>
            </a:r>
            <a:r>
              <a:rPr lang="fr-FR" sz="1600" dirty="0" err="1"/>
              <a:t>extreme</a:t>
            </a:r>
            <a:r>
              <a:rPr lang="fr-FR" sz="1600" dirty="0"/>
              <a:t> bulk </a:t>
            </a:r>
            <a:r>
              <a:rPr lang="fr-FR" sz="1600" dirty="0" err="1"/>
              <a:t>segregants</a:t>
            </a:r>
            <a:r>
              <a:rPr lang="fr-FR" sz="1600" dirty="0"/>
              <a:t>. The </a:t>
            </a:r>
            <a:r>
              <a:rPr lang="fr-FR" sz="1600" dirty="0" err="1"/>
              <a:t>red</a:t>
            </a:r>
            <a:r>
              <a:rPr lang="fr-FR" sz="1600" dirty="0"/>
              <a:t> </a:t>
            </a:r>
            <a:r>
              <a:rPr lang="fr-FR" sz="1600" dirty="0" err="1"/>
              <a:t>dashed</a:t>
            </a:r>
            <a:r>
              <a:rPr lang="fr-FR" sz="1600" dirty="0"/>
              <a:t> </a:t>
            </a:r>
            <a:r>
              <a:rPr lang="fr-FR" sz="1600" dirty="0" err="1"/>
              <a:t>lines</a:t>
            </a:r>
            <a:r>
              <a:rPr lang="fr-FR" sz="1600" dirty="0"/>
              <a:t> </a:t>
            </a:r>
            <a:r>
              <a:rPr lang="fr-FR" sz="1600" dirty="0" err="1"/>
              <a:t>indicate</a:t>
            </a:r>
            <a:r>
              <a:rPr lang="fr-FR" sz="1600" dirty="0"/>
              <a:t> the position-</a:t>
            </a:r>
            <a:r>
              <a:rPr lang="fr-FR" sz="1600" dirty="0" err="1"/>
              <a:t>specific</a:t>
            </a:r>
            <a:r>
              <a:rPr lang="fr-FR" sz="1600" dirty="0"/>
              <a:t> (P&lt;0.01) </a:t>
            </a:r>
            <a:r>
              <a:rPr lang="fr-FR" sz="1600" dirty="0" err="1"/>
              <a:t>significance</a:t>
            </a:r>
            <a:r>
              <a:rPr lang="fr-FR" sz="1600" dirty="0"/>
              <a:t> </a:t>
            </a:r>
            <a:r>
              <a:rPr lang="fr-FR" sz="1600" dirty="0" err="1"/>
              <a:t>threshold</a:t>
            </a:r>
            <a:r>
              <a:rPr lang="fr-FR" sz="1600" dirty="0"/>
              <a:t> </a:t>
            </a:r>
            <a:r>
              <a:rPr lang="fr-FR" sz="1600" dirty="0" err="1"/>
              <a:t>estimated</a:t>
            </a:r>
            <a:r>
              <a:rPr lang="fr-FR" sz="1600" dirty="0"/>
              <a:t> by simulation. </a:t>
            </a:r>
            <a:r>
              <a:rPr lang="fr-FR" sz="1600" dirty="0" err="1"/>
              <a:t>Genomic</a:t>
            </a:r>
            <a:r>
              <a:rPr lang="fr-FR" sz="1600" dirty="0"/>
              <a:t> </a:t>
            </a:r>
            <a:r>
              <a:rPr lang="fr-FR" sz="1600" dirty="0" err="1"/>
              <a:t>regions</a:t>
            </a:r>
            <a:r>
              <a:rPr lang="fr-FR" sz="1600" dirty="0"/>
              <a:t> </a:t>
            </a:r>
            <a:r>
              <a:rPr lang="fr-FR" sz="1600" dirty="0" err="1"/>
              <a:t>where</a:t>
            </a:r>
            <a:r>
              <a:rPr lang="fr-FR" sz="1600" dirty="0"/>
              <a:t> the </a:t>
            </a:r>
            <a:r>
              <a:rPr lang="el-GR" sz="1600" dirty="0"/>
              <a:t>Δ</a:t>
            </a:r>
            <a:r>
              <a:rPr lang="fr-FR" sz="1600" dirty="0"/>
              <a:t>SNP-index </a:t>
            </a:r>
            <a:r>
              <a:rPr lang="fr-FR" sz="1600" dirty="0" err="1"/>
              <a:t>exceeded</a:t>
            </a:r>
            <a:r>
              <a:rPr lang="fr-FR" sz="1600" dirty="0"/>
              <a:t> the </a:t>
            </a:r>
            <a:r>
              <a:rPr lang="fr-FR" sz="1600" dirty="0" err="1"/>
              <a:t>threshold</a:t>
            </a:r>
            <a:r>
              <a:rPr lang="fr-FR" sz="1600" dirty="0"/>
              <a:t>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expanded</a:t>
            </a:r>
            <a:r>
              <a:rPr lang="fr-FR" sz="1600" dirty="0"/>
              <a:t> </a:t>
            </a:r>
            <a:r>
              <a:rPr lang="fr-FR" sz="1600" dirty="0" err="1"/>
              <a:t>based</a:t>
            </a:r>
            <a:r>
              <a:rPr lang="fr-FR" sz="1600" dirty="0"/>
              <a:t> on linkage </a:t>
            </a:r>
            <a:r>
              <a:rPr lang="fr-FR" sz="1600" dirty="0" err="1"/>
              <a:t>decay</a:t>
            </a:r>
            <a:r>
              <a:rPr lang="fr-FR" sz="1600" dirty="0"/>
              <a:t> to a minimum r² of 0.2. </a:t>
            </a:r>
            <a:r>
              <a:rPr lang="fr-FR" sz="1600" dirty="0" err="1"/>
              <a:t>Intervals</a:t>
            </a:r>
            <a:r>
              <a:rPr lang="fr-FR" sz="1600" dirty="0"/>
              <a:t> </a:t>
            </a:r>
            <a:r>
              <a:rPr lang="fr-FR" sz="1600" dirty="0" err="1"/>
              <a:t>narrower</a:t>
            </a:r>
            <a:r>
              <a:rPr lang="fr-FR" sz="1600" dirty="0"/>
              <a:t> </a:t>
            </a:r>
            <a:r>
              <a:rPr lang="fr-FR" sz="1600" dirty="0" err="1"/>
              <a:t>than</a:t>
            </a:r>
            <a:r>
              <a:rPr lang="fr-FR" sz="1600" dirty="0"/>
              <a:t> 3.5 Mb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retained</a:t>
            </a:r>
            <a:r>
              <a:rPr lang="fr-FR" sz="1600" dirty="0"/>
              <a:t>; </a:t>
            </a:r>
            <a:r>
              <a:rPr lang="fr-FR" sz="1600" dirty="0" err="1"/>
              <a:t>overlapping</a:t>
            </a:r>
            <a:r>
              <a:rPr lang="fr-FR" sz="1600" dirty="0"/>
              <a:t> </a:t>
            </a:r>
            <a:r>
              <a:rPr lang="fr-FR" sz="1600" dirty="0" err="1"/>
              <a:t>intervals</a:t>
            </a:r>
            <a:r>
              <a:rPr lang="fr-FR" sz="1600" dirty="0"/>
              <a:t> </a:t>
            </a:r>
            <a:r>
              <a:rPr lang="fr-FR" sz="1600" dirty="0" err="1"/>
              <a:t>were</a:t>
            </a:r>
            <a:r>
              <a:rPr lang="fr-FR" sz="1600" dirty="0"/>
              <a:t> </a:t>
            </a:r>
            <a:r>
              <a:rPr lang="fr-FR" sz="1600" dirty="0" err="1"/>
              <a:t>merged</a:t>
            </a:r>
            <a:r>
              <a:rPr lang="fr-FR" sz="1600" dirty="0"/>
              <a:t> and are </a:t>
            </a:r>
            <a:r>
              <a:rPr lang="fr-FR" sz="1600" dirty="0" err="1"/>
              <a:t>shown</a:t>
            </a:r>
            <a:r>
              <a:rPr lang="fr-FR" sz="1600" dirty="0"/>
              <a:t> as green </a:t>
            </a:r>
            <a:r>
              <a:rPr lang="fr-FR" sz="1600" dirty="0" err="1"/>
              <a:t>shaded</a:t>
            </a:r>
            <a:r>
              <a:rPr lang="fr-FR" sz="1600" dirty="0"/>
              <a:t> areas. </a:t>
            </a:r>
            <a:endParaRPr 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8421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Chart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4186666"/>
              </p:ext>
            </p:extLst>
          </p:nvPr>
        </p:nvGraphicFramePr>
        <p:xfrm>
          <a:off x="6115435" y="261448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7" name="TextBox 56"/>
          <p:cNvSpPr txBox="1"/>
          <p:nvPr/>
        </p:nvSpPr>
        <p:spPr>
          <a:xfrm>
            <a:off x="2130994" y="1767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E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10399514" y="1168601"/>
            <a:ext cx="1262835" cy="9387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100" dirty="0"/>
              <a:t>P1 avg</a:t>
            </a:r>
          </a:p>
          <a:p>
            <a:r>
              <a:rPr lang="it-IT" sz="1100" dirty="0"/>
              <a:t>P2 avg</a:t>
            </a:r>
          </a:p>
          <a:p>
            <a:r>
              <a:rPr lang="it-IT" sz="1100" dirty="0"/>
              <a:t>F1 avg</a:t>
            </a:r>
          </a:p>
          <a:p>
            <a:r>
              <a:rPr lang="it-IT" sz="1100" dirty="0"/>
              <a:t>F2</a:t>
            </a:r>
          </a:p>
          <a:p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59" name="Rectangle 58"/>
          <p:cNvSpPr/>
          <p:nvPr/>
        </p:nvSpPr>
        <p:spPr>
          <a:xfrm>
            <a:off x="10987670" y="1755132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0" name="Straight Connector 59"/>
          <p:cNvCxnSpPr/>
          <p:nvPr/>
        </p:nvCxnSpPr>
        <p:spPr>
          <a:xfrm>
            <a:off x="10987670" y="1301112"/>
            <a:ext cx="54404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0987670" y="1480726"/>
            <a:ext cx="544049" cy="0"/>
          </a:xfrm>
          <a:prstGeom prst="line">
            <a:avLst/>
          </a:prstGeom>
          <a:ln w="28575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0987670" y="1637960"/>
            <a:ext cx="544049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10987670" y="1970583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2130994" y="3054706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F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171450" y="5862697"/>
            <a:ext cx="118586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 continued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E-F: Distribution charts of FF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E) and INRAE (F). G-H: Distribution charts of LossFF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G) and INRAE (H). Blue histograms: F2 progeny bins. Dark blue dotted line: average of F2 population. Red line: average of P1. Green line: average of P2. Orange line: average of F1 hybrid. Black line: distribution curve of F2 popul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9640703" y="161864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G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9640703" y="303982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H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1210977" y="1411900"/>
            <a:ext cx="75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215245" y="4213077"/>
            <a:ext cx="895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INRA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5381816"/>
              </p:ext>
            </p:extLst>
          </p:nvPr>
        </p:nvGraphicFramePr>
        <p:xfrm>
          <a:off x="2457182" y="261448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3484102"/>
              </p:ext>
            </p:extLst>
          </p:nvPr>
        </p:nvGraphicFramePr>
        <p:xfrm>
          <a:off x="2457450" y="3054706"/>
          <a:ext cx="35814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2" name="Chart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2109881"/>
              </p:ext>
            </p:extLst>
          </p:nvPr>
        </p:nvGraphicFramePr>
        <p:xfrm>
          <a:off x="6115435" y="3054706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3" name="Rectangle 42"/>
          <p:cNvSpPr/>
          <p:nvPr/>
        </p:nvSpPr>
        <p:spPr>
          <a:xfrm>
            <a:off x="5821084" y="326629"/>
            <a:ext cx="149465" cy="22913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9484887" y="449690"/>
            <a:ext cx="149465" cy="22913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5831694" y="3219276"/>
            <a:ext cx="149465" cy="22913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9466024" y="3166365"/>
            <a:ext cx="149465" cy="229130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3069709" y="543388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4230555" y="537292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4328213" y="541028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4836014" y="543388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V="1">
            <a:off x="8428390" y="537980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V="1">
            <a:off x="8478798" y="537980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V="1">
            <a:off x="7959759" y="537980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V="1">
            <a:off x="5269193" y="3283882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flipV="1">
            <a:off x="5043212" y="3280834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flipV="1">
            <a:off x="5059262" y="3283882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7083246" y="3308647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V="1">
            <a:off x="7683176" y="3301863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7938150" y="3310330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8338321" y="3307959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flipV="1">
            <a:off x="5069094" y="3283882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flipV="1">
            <a:off x="8412623" y="537980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87636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1759" y="5775936"/>
            <a:ext cx="1177211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. Pearson correlation matrice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etween traits in studied F2 population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: ENEA. B: INRAE. a*: red/green color; b*: yellow/blue color; delta a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a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- a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delta b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b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- b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delta L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L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- L*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; FF: fruit firmness; FW: fruit weight; L*: fruit skin brightness; Los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400" baseline="-3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loss of FF at T14;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LossFW</a:t>
            </a:r>
            <a:r>
              <a:rPr lang="en-US" sz="1400" baseline="-30000" dirty="0" err="1">
                <a:latin typeface="Arial" panose="020B0604020202020204" pitchFamily="34" charset="0"/>
                <a:cs typeface="Arial" panose="020B0604020202020204" pitchFamily="34" charset="0"/>
              </a:rPr>
              <a:t>T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loss of FW at T7 or T14. Blue: positive correlation. Red: negative correlation. White: no correlation. Yellow boxes highlight key correlations between shelf life-related traits discussed in the text.</a:t>
            </a:r>
          </a:p>
        </p:txBody>
      </p:sp>
      <p:sp>
        <p:nvSpPr>
          <p:cNvPr id="10" name="Rectangle 9"/>
          <p:cNvSpPr/>
          <p:nvPr/>
        </p:nvSpPr>
        <p:spPr>
          <a:xfrm>
            <a:off x="588612" y="1280401"/>
            <a:ext cx="5228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1200" dirty="0"/>
              <a:t>ENEA</a:t>
            </a:r>
          </a:p>
        </p:txBody>
      </p:sp>
      <p:sp>
        <p:nvSpPr>
          <p:cNvPr id="12" name="Rectangle 11"/>
          <p:cNvSpPr/>
          <p:nvPr/>
        </p:nvSpPr>
        <p:spPr>
          <a:xfrm>
            <a:off x="882575" y="145194"/>
            <a:ext cx="3177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588612" y="4070135"/>
            <a:ext cx="5709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1200" dirty="0"/>
              <a:t>INRAE</a:t>
            </a:r>
          </a:p>
        </p:txBody>
      </p:sp>
      <p:sp>
        <p:nvSpPr>
          <p:cNvPr id="14" name="Rectangle 13"/>
          <p:cNvSpPr/>
          <p:nvPr/>
        </p:nvSpPr>
        <p:spPr>
          <a:xfrm>
            <a:off x="891453" y="3025134"/>
            <a:ext cx="3177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dirty="0"/>
              <a:t>B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358" t="17" r="645" b="-1"/>
          <a:stretch/>
        </p:blipFill>
        <p:spPr>
          <a:xfrm>
            <a:off x="1371600" y="76200"/>
            <a:ext cx="8779933" cy="5419573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321110" y="1242803"/>
            <a:ext cx="468000" cy="14400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321110" y="4058284"/>
            <a:ext cx="468000" cy="144000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1927160" y="664952"/>
            <a:ext cx="1431990" cy="29389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1927160" y="3479272"/>
            <a:ext cx="1431990" cy="293897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359150" y="954929"/>
            <a:ext cx="961960" cy="43187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357530" y="3765549"/>
            <a:ext cx="961960" cy="431873"/>
          </a:xfrm>
          <a:prstGeom prst="rect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089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DD5B0B-4B19-54C1-BA99-247EA81699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Rectangle 170">
            <a:extLst>
              <a:ext uri="{FF2B5EF4-FFF2-40B4-BE49-F238E27FC236}">
                <a16:creationId xmlns:a16="http://schemas.microsoft.com/office/drawing/2014/main" id="{D5783CAC-2A27-DFC0-4981-2AC43D128173}"/>
              </a:ext>
            </a:extLst>
          </p:cNvPr>
          <p:cNvSpPr/>
          <p:nvPr/>
        </p:nvSpPr>
        <p:spPr>
          <a:xfrm>
            <a:off x="118872" y="6084729"/>
            <a:ext cx="1187805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. Combined QTL map for Shelf Life-related FW and FF trait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TLs from genetic maps (CIM) and BSA-Seq data of both ENEA and INRAE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F2 populations are shown. Key ripening-related genes were added as reference (in red). Conserved regions between populations on chr9 and chr12 are highlighted (red boxes)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2AED8A82-11E5-D53D-EA79-4CD40A9D88A4}"/>
              </a:ext>
            </a:extLst>
          </p:cNvPr>
          <p:cNvGrpSpPr/>
          <p:nvPr/>
        </p:nvGrpSpPr>
        <p:grpSpPr>
          <a:xfrm>
            <a:off x="2937997" y="59866"/>
            <a:ext cx="5559959" cy="6024863"/>
            <a:chOff x="2441041" y="267556"/>
            <a:chExt cx="5272994" cy="5711619"/>
          </a:xfrm>
        </p:grpSpPr>
        <p:pic>
          <p:nvPicPr>
            <p:cNvPr id="27" name="Picture 26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E2D29DFF-EBA2-7577-D869-CAB0B94F79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286" r="5611"/>
            <a:stretch/>
          </p:blipFill>
          <p:spPr>
            <a:xfrm>
              <a:off x="2441041" y="276225"/>
              <a:ext cx="5272994" cy="57029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Rectangle 13"/>
            <p:cNvSpPr/>
            <p:nvPr/>
          </p:nvSpPr>
          <p:spPr>
            <a:xfrm>
              <a:off x="6247918" y="4022429"/>
              <a:ext cx="36420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3091395" y="4022573"/>
              <a:ext cx="36420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6670710" y="269372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366398" y="1223694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6422521" y="2196266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964163" y="2195707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948845" y="5089061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322313" y="5571662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296912" y="5379593"/>
              <a:ext cx="58702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939462" y="4896992"/>
              <a:ext cx="58702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3382467" y="2972843"/>
              <a:ext cx="58702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328361" y="3063772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5893393" y="1528995"/>
              <a:ext cx="58702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3868095" y="2292950"/>
              <a:ext cx="6174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3913280" y="844422"/>
              <a:ext cx="6174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5509546" y="1327687"/>
              <a:ext cx="6174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6223801" y="2291067"/>
              <a:ext cx="61747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3442205" y="2219193"/>
              <a:ext cx="2772000" cy="0"/>
            </a:xfrm>
            <a:prstGeom prst="line">
              <a:avLst/>
            </a:prstGeom>
            <a:ln w="38100">
              <a:solidFill>
                <a:srgbClr val="00FF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5757067" y="5117124"/>
              <a:ext cx="108000" cy="0"/>
            </a:xfrm>
            <a:prstGeom prst="line">
              <a:avLst/>
            </a:prstGeom>
            <a:ln w="38100">
              <a:solidFill>
                <a:srgbClr val="00FF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5777171" y="5032485"/>
              <a:ext cx="508473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7+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5523583" y="629939"/>
              <a:ext cx="5261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7+T14</a:t>
              </a:r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5169292" y="662573"/>
              <a:ext cx="432000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67"/>
            <p:cNvSpPr/>
            <p:nvPr/>
          </p:nvSpPr>
          <p:spPr>
            <a:xfrm>
              <a:off x="6658964" y="4170452"/>
              <a:ext cx="977199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BSA-Seq QTLs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Rectangle 2"/>
            <p:cNvSpPr/>
            <p:nvPr/>
          </p:nvSpPr>
          <p:spPr>
            <a:xfrm>
              <a:off x="6677844" y="3714522"/>
              <a:ext cx="936000" cy="47693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6689759" y="3524487"/>
              <a:ext cx="920081" cy="2188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CIM QTL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6790193" y="3704198"/>
              <a:ext cx="679318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</a:p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</a:p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</a:p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734646" y="3799522"/>
              <a:ext cx="108000" cy="0"/>
            </a:xfrm>
            <a:prstGeom prst="line">
              <a:avLst/>
            </a:prstGeom>
            <a:ln w="38100">
              <a:solidFill>
                <a:srgbClr val="00FF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734646" y="4102523"/>
              <a:ext cx="1080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734646" y="3900522"/>
              <a:ext cx="108000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734646" y="4001522"/>
              <a:ext cx="10800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angle 74"/>
            <p:cNvSpPr/>
            <p:nvPr/>
          </p:nvSpPr>
          <p:spPr>
            <a:xfrm>
              <a:off x="5523567" y="571834"/>
              <a:ext cx="492443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5931976" y="1216112"/>
              <a:ext cx="252000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Rectangle 76"/>
            <p:cNvSpPr/>
            <p:nvPr/>
          </p:nvSpPr>
          <p:spPr>
            <a:xfrm>
              <a:off x="6101462" y="1132776"/>
              <a:ext cx="51007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Loss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5932831" y="1257641"/>
              <a:ext cx="25200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198448" y="2127577"/>
              <a:ext cx="11520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3322313" y="3641098"/>
              <a:ext cx="259200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Rectangle 84"/>
            <p:cNvSpPr/>
            <p:nvPr/>
          </p:nvSpPr>
          <p:spPr>
            <a:xfrm>
              <a:off x="5253669" y="1086498"/>
              <a:ext cx="351378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4382340" y="2084332"/>
              <a:ext cx="43313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5051126" y="2648256"/>
              <a:ext cx="35779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5417957" y="2599133"/>
              <a:ext cx="33374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5057662" y="3207799"/>
              <a:ext cx="33374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3079833" y="3255872"/>
              <a:ext cx="35779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96"/>
            <p:cNvSpPr/>
            <p:nvPr/>
          </p:nvSpPr>
          <p:spPr>
            <a:xfrm>
              <a:off x="4527226" y="575817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066125" y="743937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5346113" y="706847"/>
              <a:ext cx="252000" cy="0"/>
            </a:xfrm>
            <a:prstGeom prst="line">
              <a:avLst/>
            </a:prstGeom>
            <a:ln w="38100">
              <a:solidFill>
                <a:srgbClr val="00FF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4679061" y="655746"/>
              <a:ext cx="364202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5621050" y="5089061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6189033" y="4120951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3779606" y="267556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3316620" y="4268544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6189088" y="4249586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412884" y="4338693"/>
              <a:ext cx="19800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Rectangle 110"/>
            <p:cNvSpPr/>
            <p:nvPr/>
          </p:nvSpPr>
          <p:spPr>
            <a:xfrm>
              <a:off x="5430067" y="2740078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4889751" y="2793424"/>
              <a:ext cx="335348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3222971" y="3607359"/>
              <a:ext cx="335348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3367385" y="4123412"/>
              <a:ext cx="397866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4529756" y="4211738"/>
              <a:ext cx="335348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20"/>
            <p:cNvSpPr/>
            <p:nvPr/>
          </p:nvSpPr>
          <p:spPr>
            <a:xfrm>
              <a:off x="5997655" y="4716141"/>
              <a:ext cx="335348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A920DEDA-61F4-98A0-2919-EDD0C8FF0D89}"/>
                </a:ext>
              </a:extLst>
            </p:cNvPr>
            <p:cNvCxnSpPr/>
            <p:nvPr/>
          </p:nvCxnSpPr>
          <p:spPr>
            <a:xfrm>
              <a:off x="6336557" y="4749928"/>
              <a:ext cx="57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Rectangle 122"/>
            <p:cNvSpPr/>
            <p:nvPr/>
          </p:nvSpPr>
          <p:spPr>
            <a:xfrm>
              <a:off x="5960721" y="4660326"/>
              <a:ext cx="47000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3479473" y="3655626"/>
              <a:ext cx="47000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5879811" y="2034579"/>
              <a:ext cx="41069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Straight Connector 156"/>
            <p:cNvCxnSpPr/>
            <p:nvPr/>
          </p:nvCxnSpPr>
          <p:spPr>
            <a:xfrm flipV="1">
              <a:off x="3355145" y="4685840"/>
              <a:ext cx="0" cy="20005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3191721" y="4572155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6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</a:t>
              </a:r>
              <a:endParaRPr lang="en-US" sz="6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Rectangle 171"/>
            <p:cNvSpPr/>
            <p:nvPr/>
          </p:nvSpPr>
          <p:spPr>
            <a:xfrm>
              <a:off x="3365005" y="3272038"/>
              <a:ext cx="1782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Rectangle 172"/>
            <p:cNvSpPr/>
            <p:nvPr/>
          </p:nvSpPr>
          <p:spPr>
            <a:xfrm>
              <a:off x="5500576" y="1152469"/>
              <a:ext cx="540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Rectangle 173"/>
            <p:cNvSpPr/>
            <p:nvPr/>
          </p:nvSpPr>
          <p:spPr>
            <a:xfrm>
              <a:off x="4720225" y="2159406"/>
              <a:ext cx="1746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Rectangle 174"/>
            <p:cNvSpPr/>
            <p:nvPr/>
          </p:nvSpPr>
          <p:spPr>
            <a:xfrm>
              <a:off x="5390883" y="2669379"/>
              <a:ext cx="108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Rectangle 175"/>
            <p:cNvSpPr/>
            <p:nvPr/>
          </p:nvSpPr>
          <p:spPr>
            <a:xfrm>
              <a:off x="3357804" y="3319750"/>
              <a:ext cx="90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Rectangle 176"/>
            <p:cNvSpPr/>
            <p:nvPr/>
          </p:nvSpPr>
          <p:spPr>
            <a:xfrm>
              <a:off x="5317173" y="2719481"/>
              <a:ext cx="180000" cy="36000"/>
            </a:xfrm>
            <a:prstGeom prst="rect">
              <a:avLst/>
            </a:prstGeom>
            <a:pattFill prst="pct75">
              <a:fgClr>
                <a:srgbClr val="00FFFF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6677844" y="3271906"/>
              <a:ext cx="936000" cy="2633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Rectangle 178"/>
            <p:cNvSpPr/>
            <p:nvPr/>
          </p:nvSpPr>
          <p:spPr>
            <a:xfrm>
              <a:off x="6689759" y="3081871"/>
              <a:ext cx="920081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900" dirty="0">
                  <a:latin typeface="Arial" panose="020B0604020202020204" pitchFamily="34" charset="0"/>
                  <a:cs typeface="Arial" panose="020B0604020202020204" pitchFamily="34" charset="0"/>
                </a:rPr>
                <a:t>Populatio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Rectangle 179"/>
            <p:cNvSpPr/>
            <p:nvPr/>
          </p:nvSpPr>
          <p:spPr>
            <a:xfrm>
              <a:off x="6790193" y="3248196"/>
              <a:ext cx="53679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ENEA</a:t>
              </a:r>
            </a:p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INRAE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6740618" y="3303976"/>
              <a:ext cx="90000" cy="900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Rectangle 181"/>
            <p:cNvSpPr/>
            <p:nvPr/>
          </p:nvSpPr>
          <p:spPr>
            <a:xfrm>
              <a:off x="6740618" y="3410595"/>
              <a:ext cx="90000" cy="90000"/>
            </a:xfrm>
            <a:prstGeom prst="rect">
              <a:avLst/>
            </a:prstGeom>
            <a:pattFill prst="pct75">
              <a:fgClr>
                <a:schemeClr val="bg1"/>
              </a:fgClr>
              <a:bgClr>
                <a:schemeClr val="tx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Rectangle 187"/>
            <p:cNvSpPr/>
            <p:nvPr/>
          </p:nvSpPr>
          <p:spPr>
            <a:xfrm>
              <a:off x="3354375" y="3222848"/>
              <a:ext cx="72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Rectangle 188"/>
            <p:cNvSpPr/>
            <p:nvPr/>
          </p:nvSpPr>
          <p:spPr>
            <a:xfrm>
              <a:off x="5187526" y="2807379"/>
              <a:ext cx="324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Rectangle 189"/>
            <p:cNvSpPr/>
            <p:nvPr/>
          </p:nvSpPr>
          <p:spPr>
            <a:xfrm>
              <a:off x="5130166" y="2855798"/>
              <a:ext cx="3852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Rectangle 190"/>
            <p:cNvSpPr/>
            <p:nvPr/>
          </p:nvSpPr>
          <p:spPr>
            <a:xfrm>
              <a:off x="3440778" y="3674086"/>
              <a:ext cx="2574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3119743" y="3155162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Rectangle 191"/>
            <p:cNvSpPr/>
            <p:nvPr/>
          </p:nvSpPr>
          <p:spPr>
            <a:xfrm>
              <a:off x="6246550" y="4785918"/>
              <a:ext cx="252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Rectangle 192"/>
            <p:cNvSpPr/>
            <p:nvPr/>
          </p:nvSpPr>
          <p:spPr>
            <a:xfrm>
              <a:off x="3535584" y="4327881"/>
              <a:ext cx="1080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Rectangle 193"/>
            <p:cNvSpPr/>
            <p:nvPr/>
          </p:nvSpPr>
          <p:spPr>
            <a:xfrm>
              <a:off x="3408345" y="4284769"/>
              <a:ext cx="1206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091769" y="3558880"/>
              <a:ext cx="31130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Rectangle 194"/>
            <p:cNvSpPr/>
            <p:nvPr/>
          </p:nvSpPr>
          <p:spPr>
            <a:xfrm>
              <a:off x="3864679" y="3722065"/>
              <a:ext cx="1602000" cy="360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Rectangle 204"/>
            <p:cNvSpPr/>
            <p:nvPr/>
          </p:nvSpPr>
          <p:spPr>
            <a:xfrm>
              <a:off x="3536512" y="319847"/>
              <a:ext cx="324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205"/>
            <p:cNvSpPr/>
            <p:nvPr/>
          </p:nvSpPr>
          <p:spPr>
            <a:xfrm>
              <a:off x="6337925" y="319360"/>
              <a:ext cx="414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Rectangle 206"/>
            <p:cNvSpPr/>
            <p:nvPr/>
          </p:nvSpPr>
          <p:spPr>
            <a:xfrm>
              <a:off x="4749707" y="648519"/>
              <a:ext cx="396000" cy="360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Rectangle 207"/>
            <p:cNvSpPr/>
            <p:nvPr/>
          </p:nvSpPr>
          <p:spPr>
            <a:xfrm>
              <a:off x="4950995" y="712232"/>
              <a:ext cx="72000" cy="936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208"/>
            <p:cNvSpPr/>
            <p:nvPr/>
          </p:nvSpPr>
          <p:spPr>
            <a:xfrm>
              <a:off x="5059357" y="802165"/>
              <a:ext cx="90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Rectangle 209"/>
            <p:cNvSpPr/>
            <p:nvPr/>
          </p:nvSpPr>
          <p:spPr>
            <a:xfrm>
              <a:off x="6039185" y="1283558"/>
              <a:ext cx="396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Rectangle 210"/>
            <p:cNvSpPr/>
            <p:nvPr/>
          </p:nvSpPr>
          <p:spPr>
            <a:xfrm>
              <a:off x="6039789" y="1379718"/>
              <a:ext cx="3420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5610246" y="1177280"/>
              <a:ext cx="41069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F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Rectangle 211"/>
            <p:cNvSpPr/>
            <p:nvPr/>
          </p:nvSpPr>
          <p:spPr>
            <a:xfrm>
              <a:off x="4440475" y="896515"/>
              <a:ext cx="3312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Rectangle 212"/>
            <p:cNvSpPr/>
            <p:nvPr/>
          </p:nvSpPr>
          <p:spPr>
            <a:xfrm>
              <a:off x="4991645" y="900656"/>
              <a:ext cx="5580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Rectangle 213"/>
            <p:cNvSpPr/>
            <p:nvPr/>
          </p:nvSpPr>
          <p:spPr>
            <a:xfrm>
              <a:off x="5706973" y="897521"/>
              <a:ext cx="1368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3431359" y="2246737"/>
              <a:ext cx="612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Rectangle 215"/>
            <p:cNvSpPr/>
            <p:nvPr/>
          </p:nvSpPr>
          <p:spPr>
            <a:xfrm>
              <a:off x="3646042" y="2342782"/>
              <a:ext cx="2880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Rectangle 216"/>
            <p:cNvSpPr/>
            <p:nvPr/>
          </p:nvSpPr>
          <p:spPr>
            <a:xfrm>
              <a:off x="6155243" y="2341505"/>
              <a:ext cx="144000" cy="936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Rectangle 217"/>
            <p:cNvSpPr/>
            <p:nvPr/>
          </p:nvSpPr>
          <p:spPr>
            <a:xfrm>
              <a:off x="6391473" y="1579665"/>
              <a:ext cx="900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Rectangle 218"/>
            <p:cNvSpPr/>
            <p:nvPr/>
          </p:nvSpPr>
          <p:spPr>
            <a:xfrm>
              <a:off x="5868550" y="2246659"/>
              <a:ext cx="630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3019882" y="2128876"/>
              <a:ext cx="508473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500" dirty="0">
                  <a:latin typeface="Arial" panose="020B0604020202020204" pitchFamily="34" charset="0"/>
                  <a:cs typeface="Arial" panose="020B0604020202020204" pitchFamily="34" charset="0"/>
                </a:rPr>
                <a:t>FW</a:t>
              </a:r>
              <a:r>
                <a:rPr lang="it-IT" sz="5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0+T7+T1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162"/>
            <p:cNvSpPr/>
            <p:nvPr/>
          </p:nvSpPr>
          <p:spPr>
            <a:xfrm>
              <a:off x="3340827" y="3118038"/>
              <a:ext cx="64800" cy="936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Rectangle 163"/>
            <p:cNvSpPr/>
            <p:nvPr/>
          </p:nvSpPr>
          <p:spPr>
            <a:xfrm>
              <a:off x="3295313" y="3024658"/>
              <a:ext cx="540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164"/>
            <p:cNvSpPr/>
            <p:nvPr/>
          </p:nvSpPr>
          <p:spPr>
            <a:xfrm>
              <a:off x="3371883" y="3024830"/>
              <a:ext cx="972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>
              <a:off x="5886038" y="4081952"/>
              <a:ext cx="450000" cy="936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Rectangle 167"/>
            <p:cNvSpPr/>
            <p:nvPr/>
          </p:nvSpPr>
          <p:spPr>
            <a:xfrm>
              <a:off x="5988339" y="4174879"/>
              <a:ext cx="288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180"/>
            <p:cNvSpPr/>
            <p:nvPr/>
          </p:nvSpPr>
          <p:spPr>
            <a:xfrm>
              <a:off x="3327764" y="4176734"/>
              <a:ext cx="1224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Rectangle 196"/>
            <p:cNvSpPr/>
            <p:nvPr/>
          </p:nvSpPr>
          <p:spPr>
            <a:xfrm>
              <a:off x="3372769" y="4083131"/>
              <a:ext cx="522000" cy="93600"/>
            </a:xfrm>
            <a:prstGeom prst="rect">
              <a:avLst/>
            </a:prstGeom>
            <a:pattFill prst="pct75">
              <a:fgClr>
                <a:srgbClr val="FFC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Rectangle 219"/>
            <p:cNvSpPr/>
            <p:nvPr/>
          </p:nvSpPr>
          <p:spPr>
            <a:xfrm>
              <a:off x="3675100" y="4954824"/>
              <a:ext cx="3456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Rectangle 220"/>
            <p:cNvSpPr/>
            <p:nvPr/>
          </p:nvSpPr>
          <p:spPr>
            <a:xfrm>
              <a:off x="3567735" y="5140538"/>
              <a:ext cx="468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Rectangle 221"/>
            <p:cNvSpPr/>
            <p:nvPr/>
          </p:nvSpPr>
          <p:spPr>
            <a:xfrm>
              <a:off x="5450181" y="5140156"/>
              <a:ext cx="252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Rectangle 222"/>
            <p:cNvSpPr/>
            <p:nvPr/>
          </p:nvSpPr>
          <p:spPr>
            <a:xfrm>
              <a:off x="3329005" y="5619515"/>
              <a:ext cx="72000" cy="93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Rectangle 223"/>
            <p:cNvSpPr/>
            <p:nvPr/>
          </p:nvSpPr>
          <p:spPr>
            <a:xfrm>
              <a:off x="3296632" y="5434928"/>
              <a:ext cx="792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Rectangle 224"/>
            <p:cNvSpPr/>
            <p:nvPr/>
          </p:nvSpPr>
          <p:spPr>
            <a:xfrm>
              <a:off x="6336038" y="4732221"/>
              <a:ext cx="61200" cy="360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Rectangle 226"/>
            <p:cNvSpPr/>
            <p:nvPr/>
          </p:nvSpPr>
          <p:spPr>
            <a:xfrm>
              <a:off x="6334458" y="4471829"/>
              <a:ext cx="68400" cy="93600"/>
            </a:xfrm>
            <a:prstGeom prst="rect">
              <a:avLst/>
            </a:prstGeom>
            <a:pattFill prst="pct75">
              <a:fgClr>
                <a:srgbClr val="FF0000"/>
              </a:fgClr>
              <a:bgClr>
                <a:schemeClr val="tx1"/>
              </a:bgClr>
            </a:pattFill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Rectangle 227"/>
            <p:cNvSpPr/>
            <p:nvPr/>
          </p:nvSpPr>
          <p:spPr>
            <a:xfrm>
              <a:off x="5835377" y="4417172"/>
              <a:ext cx="587020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700" dirty="0">
                  <a:latin typeface="Arial" panose="020B0604020202020204" pitchFamily="34" charset="0"/>
                  <a:cs typeface="Arial" panose="020B0604020202020204" pitchFamily="34" charset="0"/>
                </a:rPr>
                <a:t>LossFF</a:t>
              </a:r>
              <a:r>
                <a:rPr lang="it-IT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14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6677844" y="4356640"/>
              <a:ext cx="1031658" cy="612000"/>
              <a:chOff x="7953045" y="4320769"/>
              <a:chExt cx="1031658" cy="612000"/>
            </a:xfrm>
          </p:grpSpPr>
          <p:sp>
            <p:nvSpPr>
              <p:cNvPr id="229" name="Rectangle 228"/>
              <p:cNvSpPr/>
              <p:nvPr/>
            </p:nvSpPr>
            <p:spPr>
              <a:xfrm>
                <a:off x="7953045" y="4320769"/>
                <a:ext cx="936000" cy="61200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Rectangle 229"/>
              <p:cNvSpPr/>
              <p:nvPr/>
            </p:nvSpPr>
            <p:spPr>
              <a:xfrm>
                <a:off x="8063103" y="4351018"/>
                <a:ext cx="921600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ssFW</a:t>
                </a:r>
                <a:r>
                  <a:rPr lang="it-IT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T14</a:t>
                </a:r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ENEA</a:t>
                </a:r>
              </a:p>
            </p:txBody>
          </p:sp>
          <p:sp>
            <p:nvSpPr>
              <p:cNvPr id="233" name="Rectangle 232"/>
              <p:cNvSpPr/>
              <p:nvPr/>
            </p:nvSpPr>
            <p:spPr>
              <a:xfrm>
                <a:off x="8020946" y="4401503"/>
                <a:ext cx="93600" cy="93600"/>
              </a:xfrm>
              <a:prstGeom prst="rect">
                <a:avLst/>
              </a:prstGeom>
              <a:solidFill>
                <a:srgbClr val="0000FF"/>
              </a:solidFill>
              <a:ln w="3175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Rectangle 233"/>
              <p:cNvSpPr/>
              <p:nvPr/>
            </p:nvSpPr>
            <p:spPr>
              <a:xfrm>
                <a:off x="8020946" y="4523742"/>
                <a:ext cx="93600" cy="936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Rectangle 234"/>
              <p:cNvSpPr/>
              <p:nvPr/>
            </p:nvSpPr>
            <p:spPr>
              <a:xfrm>
                <a:off x="8020946" y="4645981"/>
                <a:ext cx="93600" cy="93600"/>
              </a:xfrm>
              <a:prstGeom prst="rect">
                <a:avLst/>
              </a:prstGeom>
              <a:pattFill prst="pct75">
                <a:fgClr>
                  <a:srgbClr val="FFC000"/>
                </a:fgClr>
                <a:bgClr>
                  <a:schemeClr val="tx1"/>
                </a:bgClr>
              </a:pattFill>
              <a:ln w="3175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Rectangle 235"/>
              <p:cNvSpPr/>
              <p:nvPr/>
            </p:nvSpPr>
            <p:spPr>
              <a:xfrm>
                <a:off x="8020946" y="4768221"/>
                <a:ext cx="93600" cy="93600"/>
              </a:xfrm>
              <a:prstGeom prst="rect">
                <a:avLst/>
              </a:prstGeom>
              <a:pattFill prst="pct75">
                <a:fgClr>
                  <a:srgbClr val="FF0000"/>
                </a:fgClr>
                <a:bgClr>
                  <a:schemeClr val="tx1"/>
                </a:bgClr>
              </a:pattFill>
              <a:ln w="31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Rectangle 236"/>
              <p:cNvSpPr/>
              <p:nvPr/>
            </p:nvSpPr>
            <p:spPr>
              <a:xfrm>
                <a:off x="8061881" y="4473566"/>
                <a:ext cx="921600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F</a:t>
                </a:r>
                <a:r>
                  <a:rPr lang="it-IT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T14</a:t>
                </a:r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ENEA</a:t>
                </a:r>
              </a:p>
            </p:txBody>
          </p:sp>
          <p:sp>
            <p:nvSpPr>
              <p:cNvPr id="238" name="Rectangle 237"/>
              <p:cNvSpPr/>
              <p:nvPr/>
            </p:nvSpPr>
            <p:spPr>
              <a:xfrm>
                <a:off x="8061881" y="4596114"/>
                <a:ext cx="921600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F</a:t>
                </a:r>
                <a:r>
                  <a:rPr lang="it-IT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T0</a:t>
                </a:r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INRAE</a:t>
                </a:r>
              </a:p>
            </p:txBody>
          </p:sp>
          <p:sp>
            <p:nvSpPr>
              <p:cNvPr id="239" name="Rectangle 238"/>
              <p:cNvSpPr/>
              <p:nvPr/>
            </p:nvSpPr>
            <p:spPr>
              <a:xfrm>
                <a:off x="8061881" y="4718661"/>
                <a:ext cx="921600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ssFF</a:t>
                </a:r>
                <a:r>
                  <a:rPr lang="it-IT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T14</a:t>
                </a:r>
                <a:r>
                  <a:rPr lang="it-IT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INRAE</a:t>
                </a:r>
              </a:p>
            </p:txBody>
          </p:sp>
        </p:grpSp>
      </p:grpSp>
      <p:cxnSp>
        <p:nvCxnSpPr>
          <p:cNvPr id="143" name="Straight Connector 142"/>
          <p:cNvCxnSpPr/>
          <p:nvPr/>
        </p:nvCxnSpPr>
        <p:spPr>
          <a:xfrm flipV="1">
            <a:off x="4105947" y="2088879"/>
            <a:ext cx="0" cy="2988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3975433" y="19635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6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n</a:t>
            </a:r>
            <a:endParaRPr lang="en-US" sz="600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314133" y="517719"/>
            <a:ext cx="588542" cy="1947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w2.2</a:t>
            </a:r>
            <a:r>
              <a:rPr lang="it-IT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NR</a:t>
            </a:r>
            <a:endParaRPr 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134"/>
          <p:cNvCxnSpPr/>
          <p:nvPr/>
        </p:nvCxnSpPr>
        <p:spPr>
          <a:xfrm flipV="1">
            <a:off x="6568626" y="5088439"/>
            <a:ext cx="0" cy="34176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6311540" y="4957502"/>
            <a:ext cx="586852" cy="1947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s, fw11.3</a:t>
            </a:r>
            <a:endParaRPr 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6"/>
          <p:cNvSpPr/>
          <p:nvPr/>
        </p:nvSpPr>
        <p:spPr>
          <a:xfrm>
            <a:off x="6846984" y="1868665"/>
            <a:ext cx="1033075" cy="1947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F cluster (4+ genes)</a:t>
            </a:r>
          </a:p>
        </p:txBody>
      </p:sp>
      <p:cxnSp>
        <p:nvCxnSpPr>
          <p:cNvPr id="138" name="Straight Connector 137"/>
          <p:cNvCxnSpPr/>
          <p:nvPr/>
        </p:nvCxnSpPr>
        <p:spPr>
          <a:xfrm flipV="1">
            <a:off x="6430304" y="652293"/>
            <a:ext cx="0" cy="21102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/>
          <p:nvPr/>
        </p:nvCxnSpPr>
        <p:spPr>
          <a:xfrm flipV="1">
            <a:off x="6949726" y="1984270"/>
            <a:ext cx="0" cy="39873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3909791" y="4049773"/>
            <a:ext cx="100800" cy="36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Rectangle 140"/>
          <p:cNvSpPr/>
          <p:nvPr/>
        </p:nvSpPr>
        <p:spPr>
          <a:xfrm>
            <a:off x="3868935" y="5491930"/>
            <a:ext cx="57600" cy="439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3158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317F2A-68EE-84DA-CAAB-714E40CEE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27314" y="2487839"/>
            <a:ext cx="10515600" cy="1325563"/>
          </a:xfrm>
        </p:spPr>
        <p:txBody>
          <a:bodyPr/>
          <a:lstStyle/>
          <a:p>
            <a:pPr algn="ctr"/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gures</a:t>
            </a:r>
          </a:p>
        </p:txBody>
      </p:sp>
    </p:spTree>
    <p:extLst>
      <p:ext uri="{BB962C8B-B14F-4D97-AF65-F5344CB8AC3E}">
        <p14:creationId xmlns:p14="http://schemas.microsoft.com/office/powerpoint/2010/main" val="6320127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2902D3-CAD4-9777-7D5B-A3238AB16C2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201A240-19DF-91E4-97B9-C512FDF09340}"/>
              </a:ext>
            </a:extLst>
          </p:cNvPr>
          <p:cNvSpPr txBox="1"/>
          <p:nvPr/>
        </p:nvSpPr>
        <p:spPr>
          <a:xfrm>
            <a:off x="10429797" y="1099775"/>
            <a:ext cx="1262835" cy="9387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100" dirty="0"/>
              <a:t>P1 avg</a:t>
            </a:r>
          </a:p>
          <a:p>
            <a:r>
              <a:rPr lang="it-IT" sz="1100" dirty="0"/>
              <a:t>P2 avg</a:t>
            </a:r>
          </a:p>
          <a:p>
            <a:r>
              <a:rPr lang="it-IT" sz="1100" dirty="0"/>
              <a:t>F1 avg</a:t>
            </a:r>
          </a:p>
          <a:p>
            <a:r>
              <a:rPr lang="it-IT" sz="1100" dirty="0"/>
              <a:t>F2</a:t>
            </a:r>
          </a:p>
          <a:p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59C44EA-58BE-D1CA-FFD2-81A613354838}"/>
              </a:ext>
            </a:extLst>
          </p:cNvPr>
          <p:cNvSpPr/>
          <p:nvPr/>
        </p:nvSpPr>
        <p:spPr>
          <a:xfrm>
            <a:off x="11017953" y="1686306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920DEDA-61F4-98A0-2919-EDD0C8FF0D89}"/>
              </a:ext>
            </a:extLst>
          </p:cNvPr>
          <p:cNvCxnSpPr/>
          <p:nvPr/>
        </p:nvCxnSpPr>
        <p:spPr>
          <a:xfrm>
            <a:off x="11017953" y="1232286"/>
            <a:ext cx="54404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E7F1BCB-7F87-E555-E00A-5396C998D74B}"/>
              </a:ext>
            </a:extLst>
          </p:cNvPr>
          <p:cNvCxnSpPr/>
          <p:nvPr/>
        </p:nvCxnSpPr>
        <p:spPr>
          <a:xfrm>
            <a:off x="11017953" y="1411900"/>
            <a:ext cx="544049" cy="0"/>
          </a:xfrm>
          <a:prstGeom prst="line">
            <a:avLst/>
          </a:prstGeom>
          <a:ln w="28575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AC41F40-DF39-2AFD-53BE-97C0850531FC}"/>
              </a:ext>
            </a:extLst>
          </p:cNvPr>
          <p:cNvCxnSpPr/>
          <p:nvPr/>
        </p:nvCxnSpPr>
        <p:spPr>
          <a:xfrm>
            <a:off x="11017953" y="1569134"/>
            <a:ext cx="544049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EB26B74-0076-24F6-6B8F-05E7F0263898}"/>
              </a:ext>
            </a:extLst>
          </p:cNvPr>
          <p:cNvCxnSpPr/>
          <p:nvPr/>
        </p:nvCxnSpPr>
        <p:spPr>
          <a:xfrm>
            <a:off x="11017953" y="1901757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D191791C-8841-58CB-700C-01FA7BE85545}"/>
              </a:ext>
            </a:extLst>
          </p:cNvPr>
          <p:cNvSpPr txBox="1"/>
          <p:nvPr/>
        </p:nvSpPr>
        <p:spPr>
          <a:xfrm>
            <a:off x="2150658" y="3006806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B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048E3F2-D325-956F-FC2D-9FDCC63E7C33}"/>
              </a:ext>
            </a:extLst>
          </p:cNvPr>
          <p:cNvSpPr txBox="1"/>
          <p:nvPr/>
        </p:nvSpPr>
        <p:spPr>
          <a:xfrm>
            <a:off x="9695879" y="299192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D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53DA4A6-AE23-E2E0-8CB5-93C79EBDAF07}"/>
              </a:ext>
            </a:extLst>
          </p:cNvPr>
          <p:cNvSpPr txBox="1"/>
          <p:nvPr/>
        </p:nvSpPr>
        <p:spPr>
          <a:xfrm>
            <a:off x="152400" y="5862697"/>
            <a:ext cx="1187767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istribution charts of color space L*-related traits in studied F2 populations.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A-B: Distribution charts of L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A) and INRAE (B). C-D: Distribution charts of delta L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C) and INRAE (D). Blue histograms: F2 progeny bins. Dark blue dotted line: average of F2 population. Red line: average of P1. Green line: average of P2. Orange line: average of F1 hybrid. Black line: distribution curve of F2 popul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BC97FA-CC38-9DB2-27BB-2FD351DECC1E}"/>
              </a:ext>
            </a:extLst>
          </p:cNvPr>
          <p:cNvSpPr txBox="1"/>
          <p:nvPr/>
        </p:nvSpPr>
        <p:spPr>
          <a:xfrm>
            <a:off x="2138354" y="1714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7EFFE0C-6A05-1003-D9E8-583566CA93C9}"/>
              </a:ext>
            </a:extLst>
          </p:cNvPr>
          <p:cNvSpPr txBox="1"/>
          <p:nvPr/>
        </p:nvSpPr>
        <p:spPr>
          <a:xfrm>
            <a:off x="9695879" y="1714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C</a:t>
            </a:r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B533D04-3C00-4AB4-5A3C-445311E21FC5}"/>
              </a:ext>
            </a:extLst>
          </p:cNvPr>
          <p:cNvSpPr txBox="1"/>
          <p:nvPr/>
        </p:nvSpPr>
        <p:spPr>
          <a:xfrm>
            <a:off x="1210977" y="1411900"/>
            <a:ext cx="75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686E4EB-FA6F-F9CD-9C39-F916A76C011F}"/>
              </a:ext>
            </a:extLst>
          </p:cNvPr>
          <p:cNvSpPr txBox="1"/>
          <p:nvPr/>
        </p:nvSpPr>
        <p:spPr>
          <a:xfrm>
            <a:off x="1215245" y="4213077"/>
            <a:ext cx="895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INRA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Chart 41">
            <a:extLst>
              <a:ext uri="{FF2B5EF4-FFF2-40B4-BE49-F238E27FC236}">
                <a16:creationId xmlns:a16="http://schemas.microsoft.com/office/drawing/2014/main" id="{3A6987FE-E494-2ACB-F58D-17E7659360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4530415"/>
              </p:ext>
            </p:extLst>
          </p:nvPr>
        </p:nvGraphicFramePr>
        <p:xfrm>
          <a:off x="2487730" y="2988362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3" name="Rectangle 42">
            <a:extLst>
              <a:ext uri="{FF2B5EF4-FFF2-40B4-BE49-F238E27FC236}">
                <a16:creationId xmlns:a16="http://schemas.microsoft.com/office/drawing/2014/main" id="{65E2E7B2-A9D8-A749-47DF-03F9D6CD81E4}"/>
              </a:ext>
            </a:extLst>
          </p:cNvPr>
          <p:cNvSpPr/>
          <p:nvPr/>
        </p:nvSpPr>
        <p:spPr>
          <a:xfrm>
            <a:off x="5848535" y="3134656"/>
            <a:ext cx="138839" cy="23590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4" name="Chart 43">
            <a:extLst>
              <a:ext uri="{FF2B5EF4-FFF2-40B4-BE49-F238E27FC236}">
                <a16:creationId xmlns:a16="http://schemas.microsoft.com/office/drawing/2014/main" id="{73F5605A-1879-4E80-9038-6E05568EC5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0328901"/>
              </p:ext>
            </p:extLst>
          </p:nvPr>
        </p:nvGraphicFramePr>
        <p:xfrm>
          <a:off x="2487730" y="191184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5" name="Rectangle 44">
            <a:extLst>
              <a:ext uri="{FF2B5EF4-FFF2-40B4-BE49-F238E27FC236}">
                <a16:creationId xmlns:a16="http://schemas.microsoft.com/office/drawing/2014/main" id="{C687DCC2-FC78-9158-08A9-C2082ED63904}"/>
              </a:ext>
            </a:extLst>
          </p:cNvPr>
          <p:cNvSpPr/>
          <p:nvPr/>
        </p:nvSpPr>
        <p:spPr>
          <a:xfrm>
            <a:off x="5918097" y="405092"/>
            <a:ext cx="122761" cy="2207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6" name="Chart 45">
            <a:extLst>
              <a:ext uri="{FF2B5EF4-FFF2-40B4-BE49-F238E27FC236}">
                <a16:creationId xmlns:a16="http://schemas.microsoft.com/office/drawing/2014/main" id="{7E996715-5ECA-7EE5-A5E4-343302C552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1731948"/>
              </p:ext>
            </p:extLst>
          </p:nvPr>
        </p:nvGraphicFramePr>
        <p:xfrm>
          <a:off x="6162676" y="191184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7" name="Rectangle 46">
            <a:extLst>
              <a:ext uri="{FF2B5EF4-FFF2-40B4-BE49-F238E27FC236}">
                <a16:creationId xmlns:a16="http://schemas.microsoft.com/office/drawing/2014/main" id="{8BCE1C6D-E2A0-A572-780A-5E5734BD4A64}"/>
              </a:ext>
            </a:extLst>
          </p:cNvPr>
          <p:cNvSpPr/>
          <p:nvPr/>
        </p:nvSpPr>
        <p:spPr>
          <a:xfrm>
            <a:off x="9598745" y="426272"/>
            <a:ext cx="122761" cy="2207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8" name="Chart 47">
            <a:extLst>
              <a:ext uri="{FF2B5EF4-FFF2-40B4-BE49-F238E27FC236}">
                <a16:creationId xmlns:a16="http://schemas.microsoft.com/office/drawing/2014/main" id="{8CF72479-59F8-9671-C844-DF5EAF5E5D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5444677"/>
              </p:ext>
            </p:extLst>
          </p:nvPr>
        </p:nvGraphicFramePr>
        <p:xfrm>
          <a:off x="6162676" y="2988362"/>
          <a:ext cx="3582000" cy="271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9" name="Rectangle 48">
            <a:extLst>
              <a:ext uri="{FF2B5EF4-FFF2-40B4-BE49-F238E27FC236}">
                <a16:creationId xmlns:a16="http://schemas.microsoft.com/office/drawing/2014/main" id="{AA6E843F-CB1B-E00E-7F21-450CCB120043}"/>
              </a:ext>
            </a:extLst>
          </p:cNvPr>
          <p:cNvSpPr/>
          <p:nvPr/>
        </p:nvSpPr>
        <p:spPr>
          <a:xfrm>
            <a:off x="9557391" y="3189301"/>
            <a:ext cx="122761" cy="2207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F08E135-83B8-9237-75A4-FBB76A6FC3D3}"/>
              </a:ext>
            </a:extLst>
          </p:cNvPr>
          <p:cNvCxnSpPr/>
          <p:nvPr/>
        </p:nvCxnSpPr>
        <p:spPr>
          <a:xfrm flipV="1">
            <a:off x="4342668" y="470202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D45472E-1DEE-3523-2B49-89D60747AD1A}"/>
              </a:ext>
            </a:extLst>
          </p:cNvPr>
          <p:cNvCxnSpPr/>
          <p:nvPr/>
        </p:nvCxnSpPr>
        <p:spPr>
          <a:xfrm flipV="1">
            <a:off x="4447990" y="470202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C04524A-E620-61F3-B7BD-0B8A923C06F6}"/>
              </a:ext>
            </a:extLst>
          </p:cNvPr>
          <p:cNvCxnSpPr/>
          <p:nvPr/>
        </p:nvCxnSpPr>
        <p:spPr>
          <a:xfrm flipV="1">
            <a:off x="4420761" y="470202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A69260F4-F191-1D6D-EA5E-6336D7FEB251}"/>
              </a:ext>
            </a:extLst>
          </p:cNvPr>
          <p:cNvCxnSpPr/>
          <p:nvPr/>
        </p:nvCxnSpPr>
        <p:spPr>
          <a:xfrm flipV="1">
            <a:off x="4704249" y="470202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F9BB503-2950-4EE0-249E-6B60CCD59CA8}"/>
              </a:ext>
            </a:extLst>
          </p:cNvPr>
          <p:cNvCxnSpPr/>
          <p:nvPr/>
        </p:nvCxnSpPr>
        <p:spPr>
          <a:xfrm flipV="1">
            <a:off x="4381996" y="3305360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677238B-1450-054A-8A4B-A02CA4DE96E5}"/>
              </a:ext>
            </a:extLst>
          </p:cNvPr>
          <p:cNvCxnSpPr/>
          <p:nvPr/>
        </p:nvCxnSpPr>
        <p:spPr>
          <a:xfrm flipV="1">
            <a:off x="4196091" y="3303243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DE36091-9FF3-2193-3353-4F8CF26FF442}"/>
              </a:ext>
            </a:extLst>
          </p:cNvPr>
          <p:cNvCxnSpPr/>
          <p:nvPr/>
        </p:nvCxnSpPr>
        <p:spPr>
          <a:xfrm flipV="1">
            <a:off x="4302772" y="3306418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B4C834E2-F600-2975-4471-78AF864B7EB8}"/>
              </a:ext>
            </a:extLst>
          </p:cNvPr>
          <p:cNvCxnSpPr/>
          <p:nvPr/>
        </p:nvCxnSpPr>
        <p:spPr>
          <a:xfrm flipV="1">
            <a:off x="4910728" y="3306418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DFDC3FC5-E4C8-53A8-C754-724374371373}"/>
              </a:ext>
            </a:extLst>
          </p:cNvPr>
          <p:cNvCxnSpPr/>
          <p:nvPr/>
        </p:nvCxnSpPr>
        <p:spPr>
          <a:xfrm flipV="1">
            <a:off x="7985519" y="497888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2E864A7-BB48-5235-DE72-A2300DB0CF70}"/>
              </a:ext>
            </a:extLst>
          </p:cNvPr>
          <p:cNvCxnSpPr/>
          <p:nvPr/>
        </p:nvCxnSpPr>
        <p:spPr>
          <a:xfrm flipV="1">
            <a:off x="7779963" y="494406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9AAEF4A-C1BC-F0F3-DF7A-2716B1AE23C3}"/>
              </a:ext>
            </a:extLst>
          </p:cNvPr>
          <p:cNvCxnSpPr/>
          <p:nvPr/>
        </p:nvCxnSpPr>
        <p:spPr>
          <a:xfrm flipV="1">
            <a:off x="7670323" y="499698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AD8A202-2318-25E1-509C-AACF952D79D9}"/>
              </a:ext>
            </a:extLst>
          </p:cNvPr>
          <p:cNvCxnSpPr/>
          <p:nvPr/>
        </p:nvCxnSpPr>
        <p:spPr>
          <a:xfrm flipV="1">
            <a:off x="7619516" y="498279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655B7593-192B-300E-F366-1620557FE302}"/>
              </a:ext>
            </a:extLst>
          </p:cNvPr>
          <p:cNvCxnSpPr/>
          <p:nvPr/>
        </p:nvCxnSpPr>
        <p:spPr>
          <a:xfrm flipV="1">
            <a:off x="8130165" y="3317295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41FDDD43-D0F4-587A-ECED-CEBED9D192A0}"/>
              </a:ext>
            </a:extLst>
          </p:cNvPr>
          <p:cNvCxnSpPr/>
          <p:nvPr/>
        </p:nvCxnSpPr>
        <p:spPr>
          <a:xfrm flipV="1">
            <a:off x="8012181" y="3317295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D6CEA9E4-EFE0-62AF-F249-2118624089DE}"/>
              </a:ext>
            </a:extLst>
          </p:cNvPr>
          <p:cNvCxnSpPr/>
          <p:nvPr/>
        </p:nvCxnSpPr>
        <p:spPr>
          <a:xfrm flipV="1">
            <a:off x="7887199" y="3317602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FEFFA167-F24E-415F-D851-2980F171D193}"/>
              </a:ext>
            </a:extLst>
          </p:cNvPr>
          <p:cNvCxnSpPr/>
          <p:nvPr/>
        </p:nvCxnSpPr>
        <p:spPr>
          <a:xfrm flipV="1">
            <a:off x="7439697" y="3317295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76184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49996" y="2990228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680985" y="2975342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D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71450" y="5862697"/>
            <a:ext cx="118586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2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istribution charts of color space a*-related traits in studied F2 populations.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A-B: Distribution charts of a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A) and INRAE (B). C-D: Distribution charts of delta a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C) and INRAE (D). Blue histograms: F2 progeny bins. Dark blue dotted line: average of F2 population. Red line: average of P1. Green line: average of P2. Orange line: average of F1 hybrid. Black line: distribution curve of F2 popul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447863" y="1119440"/>
            <a:ext cx="1262835" cy="9387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100" dirty="0"/>
              <a:t>P1 avg</a:t>
            </a:r>
          </a:p>
          <a:p>
            <a:r>
              <a:rPr lang="it-IT" sz="1100" dirty="0"/>
              <a:t>P2 avg</a:t>
            </a:r>
          </a:p>
          <a:p>
            <a:r>
              <a:rPr lang="it-IT" sz="1100" dirty="0"/>
              <a:t>F1 avg</a:t>
            </a:r>
          </a:p>
          <a:p>
            <a:r>
              <a:rPr lang="it-IT" sz="1100" dirty="0"/>
              <a:t>F2</a:t>
            </a:r>
          </a:p>
          <a:p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12" name="Rectangle 11"/>
          <p:cNvSpPr/>
          <p:nvPr/>
        </p:nvSpPr>
        <p:spPr>
          <a:xfrm>
            <a:off x="11036019" y="1705971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/>
          <p:nvPr/>
        </p:nvCxnSpPr>
        <p:spPr>
          <a:xfrm>
            <a:off x="11036019" y="1251951"/>
            <a:ext cx="54404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1036019" y="1431565"/>
            <a:ext cx="544049" cy="0"/>
          </a:xfrm>
          <a:prstGeom prst="line">
            <a:avLst/>
          </a:prstGeom>
          <a:ln w="28575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1036019" y="1588799"/>
            <a:ext cx="544049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1036019" y="1921422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6433609"/>
              </p:ext>
            </p:extLst>
          </p:nvPr>
        </p:nvGraphicFramePr>
        <p:xfrm>
          <a:off x="2487825" y="157843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2" name="Rectangle 21"/>
          <p:cNvSpPr/>
          <p:nvPr/>
        </p:nvSpPr>
        <p:spPr>
          <a:xfrm>
            <a:off x="5921828" y="224665"/>
            <a:ext cx="103543" cy="2420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9680985" y="161618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C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149996" y="1767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 flipV="1">
            <a:off x="4656087" y="510690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4259491" y="510167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4475402" y="513865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4082165"/>
              </p:ext>
            </p:extLst>
          </p:nvPr>
        </p:nvGraphicFramePr>
        <p:xfrm>
          <a:off x="6145082" y="157843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Rectangle 29"/>
          <p:cNvSpPr/>
          <p:nvPr/>
        </p:nvSpPr>
        <p:spPr>
          <a:xfrm>
            <a:off x="9607895" y="288576"/>
            <a:ext cx="103543" cy="2420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1210977" y="1314192"/>
            <a:ext cx="75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210977" y="4221544"/>
            <a:ext cx="895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INRA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 flipV="1">
            <a:off x="8234128" y="53381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8049429" y="536346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flipV="1">
            <a:off x="8545958" y="536801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7561519" y="535296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3801952"/>
              </p:ext>
            </p:extLst>
          </p:nvPr>
        </p:nvGraphicFramePr>
        <p:xfrm>
          <a:off x="2487825" y="2995443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9" name="Rectangle 38"/>
          <p:cNvSpPr/>
          <p:nvPr/>
        </p:nvSpPr>
        <p:spPr>
          <a:xfrm>
            <a:off x="5952755" y="3160008"/>
            <a:ext cx="103543" cy="2420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4457713"/>
              </p:ext>
            </p:extLst>
          </p:nvPr>
        </p:nvGraphicFramePr>
        <p:xfrm>
          <a:off x="6145082" y="2995443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1" name="Rectangle 40"/>
          <p:cNvSpPr/>
          <p:nvPr/>
        </p:nvSpPr>
        <p:spPr>
          <a:xfrm>
            <a:off x="9607894" y="3083873"/>
            <a:ext cx="103543" cy="2420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2" name="Straight Connector 41"/>
          <p:cNvCxnSpPr/>
          <p:nvPr/>
        </p:nvCxnSpPr>
        <p:spPr>
          <a:xfrm flipV="1">
            <a:off x="8396577" y="327682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V="1">
            <a:off x="8543469" y="3280003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V="1">
            <a:off x="8346676" y="328000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8708708" y="3280003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3992199" y="327682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V="1">
            <a:off x="3777355" y="3280003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4203544" y="328000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V="1">
            <a:off x="3751667" y="3280003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4247147" y="506992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27156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6ED19C-C7AB-AD1F-54AD-12809A2627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Chart 50">
            <a:extLst>
              <a:ext uri="{FF2B5EF4-FFF2-40B4-BE49-F238E27FC236}">
                <a16:creationId xmlns:a16="http://schemas.microsoft.com/office/drawing/2014/main" id="{433E94CF-8EC3-32B6-964D-3DFB4E590A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5858929"/>
              </p:ext>
            </p:extLst>
          </p:nvPr>
        </p:nvGraphicFramePr>
        <p:xfrm>
          <a:off x="2490770" y="171450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A247F6C-CDFB-3380-E0C7-40AB757CDA91}"/>
              </a:ext>
            </a:extLst>
          </p:cNvPr>
          <p:cNvSpPr txBox="1"/>
          <p:nvPr/>
        </p:nvSpPr>
        <p:spPr>
          <a:xfrm>
            <a:off x="2158874" y="3014514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B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E1F0605-0369-E571-B63B-E20B2CCA16B5}"/>
              </a:ext>
            </a:extLst>
          </p:cNvPr>
          <p:cNvSpPr txBox="1"/>
          <p:nvPr/>
        </p:nvSpPr>
        <p:spPr>
          <a:xfrm>
            <a:off x="9696401" y="2999628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D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13F4785-95BA-CB11-868F-26E977400B86}"/>
              </a:ext>
            </a:extLst>
          </p:cNvPr>
          <p:cNvSpPr txBox="1"/>
          <p:nvPr/>
        </p:nvSpPr>
        <p:spPr>
          <a:xfrm>
            <a:off x="190500" y="5862697"/>
            <a:ext cx="1183957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3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Distribution charts of color space b*-related traits in studied F2 populations.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A-B: Distribution charts of b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0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A) and INRAE (B). C-D: Distribution charts of delta b*</a:t>
            </a:r>
            <a:r>
              <a:rPr lang="it-IT" sz="1400" baseline="-20000" dirty="0">
                <a:latin typeface="Arial" panose="020B0604020202020204" pitchFamily="34" charset="0"/>
                <a:cs typeface="Arial" panose="020B0604020202020204" pitchFamily="34" charset="0"/>
              </a:rPr>
              <a:t>T14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in the ENEA (C) and INRAE (D). Blue histograms: F2 progeny bins. Dark blue dotted line: average of F2 population. Red line: average of P1. Green line: average of P2. Orange line: average of F1 hybrid. Black line: distribution curve of F2 popul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B1C11A-E3B2-06D2-B046-38DAB98CF4C4}"/>
              </a:ext>
            </a:extLst>
          </p:cNvPr>
          <p:cNvSpPr txBox="1"/>
          <p:nvPr/>
        </p:nvSpPr>
        <p:spPr>
          <a:xfrm>
            <a:off x="10467528" y="1021117"/>
            <a:ext cx="1262835" cy="9387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100" dirty="0"/>
              <a:t>P1 avg</a:t>
            </a:r>
          </a:p>
          <a:p>
            <a:r>
              <a:rPr lang="it-IT" sz="1100" dirty="0"/>
              <a:t>P2 avg</a:t>
            </a:r>
          </a:p>
          <a:p>
            <a:r>
              <a:rPr lang="it-IT" sz="1100" dirty="0"/>
              <a:t>F1 avg</a:t>
            </a:r>
          </a:p>
          <a:p>
            <a:r>
              <a:rPr lang="it-IT" sz="1100" dirty="0"/>
              <a:t>F2</a:t>
            </a:r>
          </a:p>
          <a:p>
            <a:r>
              <a:rPr lang="it-IT" sz="1100" dirty="0"/>
              <a:t>F2 avg</a:t>
            </a:r>
            <a:endParaRPr lang="en-US" sz="11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8259F4B-C4C7-FACB-8DD0-27D59E6FB9C7}"/>
              </a:ext>
            </a:extLst>
          </p:cNvPr>
          <p:cNvSpPr/>
          <p:nvPr/>
        </p:nvSpPr>
        <p:spPr>
          <a:xfrm>
            <a:off x="11055684" y="1607648"/>
            <a:ext cx="544049" cy="78715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5DA8B9A-7E6D-E98E-DA7A-B5690CC9FE82}"/>
              </a:ext>
            </a:extLst>
          </p:cNvPr>
          <p:cNvCxnSpPr/>
          <p:nvPr/>
        </p:nvCxnSpPr>
        <p:spPr>
          <a:xfrm>
            <a:off x="11055684" y="1153628"/>
            <a:ext cx="54404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48CE272-D248-1658-58D2-79432A1EF782}"/>
              </a:ext>
            </a:extLst>
          </p:cNvPr>
          <p:cNvCxnSpPr/>
          <p:nvPr/>
        </p:nvCxnSpPr>
        <p:spPr>
          <a:xfrm>
            <a:off x="11055684" y="1333242"/>
            <a:ext cx="544049" cy="0"/>
          </a:xfrm>
          <a:prstGeom prst="line">
            <a:avLst/>
          </a:prstGeom>
          <a:ln w="28575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0118145-52AC-83C3-55F9-00FD86F2352E}"/>
              </a:ext>
            </a:extLst>
          </p:cNvPr>
          <p:cNvCxnSpPr/>
          <p:nvPr/>
        </p:nvCxnSpPr>
        <p:spPr>
          <a:xfrm>
            <a:off x="11055684" y="1490476"/>
            <a:ext cx="544049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542D60A-976A-269E-89B5-26C36D0B8C73}"/>
              </a:ext>
            </a:extLst>
          </p:cNvPr>
          <p:cNvCxnSpPr/>
          <p:nvPr/>
        </p:nvCxnSpPr>
        <p:spPr>
          <a:xfrm>
            <a:off x="11055684" y="1823099"/>
            <a:ext cx="544049" cy="0"/>
          </a:xfrm>
          <a:prstGeom prst="line">
            <a:avLst/>
          </a:prstGeom>
          <a:ln w="28575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954760E-7A3A-4752-D150-B88DC377996A}"/>
              </a:ext>
            </a:extLst>
          </p:cNvPr>
          <p:cNvSpPr txBox="1"/>
          <p:nvPr/>
        </p:nvSpPr>
        <p:spPr>
          <a:xfrm>
            <a:off x="9696401" y="1714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C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2C9E44C-9319-EBDB-AB4A-EC4D68C92CC5}"/>
              </a:ext>
            </a:extLst>
          </p:cNvPr>
          <p:cNvSpPr txBox="1"/>
          <p:nvPr/>
        </p:nvSpPr>
        <p:spPr>
          <a:xfrm>
            <a:off x="2158874" y="171450"/>
            <a:ext cx="376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8749E2E-4FED-4481-48CA-D2CB6392BF29}"/>
              </a:ext>
            </a:extLst>
          </p:cNvPr>
          <p:cNvSpPr txBox="1"/>
          <p:nvPr/>
        </p:nvSpPr>
        <p:spPr>
          <a:xfrm>
            <a:off x="1235238" y="1409549"/>
            <a:ext cx="75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34861BB-E731-F093-166B-BEE1E6973CED}"/>
              </a:ext>
            </a:extLst>
          </p:cNvPr>
          <p:cNvSpPr txBox="1"/>
          <p:nvPr/>
        </p:nvSpPr>
        <p:spPr>
          <a:xfrm>
            <a:off x="1235238" y="4221544"/>
            <a:ext cx="895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INRA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1E867516-7528-9440-2776-A66199AD12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3433604"/>
              </p:ext>
            </p:extLst>
          </p:nvPr>
        </p:nvGraphicFramePr>
        <p:xfrm>
          <a:off x="2490770" y="3014514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4" name="Rectangle 43">
            <a:extLst>
              <a:ext uri="{FF2B5EF4-FFF2-40B4-BE49-F238E27FC236}">
                <a16:creationId xmlns:a16="http://schemas.microsoft.com/office/drawing/2014/main" id="{49443BEE-554F-4A2E-8925-4BBAEC6C7861}"/>
              </a:ext>
            </a:extLst>
          </p:cNvPr>
          <p:cNvSpPr/>
          <p:nvPr/>
        </p:nvSpPr>
        <p:spPr>
          <a:xfrm>
            <a:off x="5893884" y="256893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D06EF745-5F3C-5BEB-5AA7-11249A53C806}"/>
              </a:ext>
            </a:extLst>
          </p:cNvPr>
          <p:cNvSpPr/>
          <p:nvPr/>
        </p:nvSpPr>
        <p:spPr>
          <a:xfrm>
            <a:off x="5874834" y="3075247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3F8DC956-46EB-5A0E-03BA-DA21CC493825}"/>
              </a:ext>
            </a:extLst>
          </p:cNvPr>
          <p:cNvSpPr/>
          <p:nvPr/>
        </p:nvSpPr>
        <p:spPr>
          <a:xfrm>
            <a:off x="9543298" y="3090000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7665F10-4721-9B52-21DB-26897EF36620}"/>
              </a:ext>
            </a:extLst>
          </p:cNvPr>
          <p:cNvSpPr/>
          <p:nvPr/>
        </p:nvSpPr>
        <p:spPr>
          <a:xfrm>
            <a:off x="9579492" y="3075247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53" name="Chart 52">
            <a:extLst>
              <a:ext uri="{FF2B5EF4-FFF2-40B4-BE49-F238E27FC236}">
                <a16:creationId xmlns:a16="http://schemas.microsoft.com/office/drawing/2014/main" id="{4780446E-A542-9F4B-489F-906C60A925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840074"/>
              </p:ext>
            </p:extLst>
          </p:nvPr>
        </p:nvGraphicFramePr>
        <p:xfrm>
          <a:off x="6160732" y="171450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4" name="Chart 53">
            <a:extLst>
              <a:ext uri="{FF2B5EF4-FFF2-40B4-BE49-F238E27FC236}">
                <a16:creationId xmlns:a16="http://schemas.microsoft.com/office/drawing/2014/main" id="{D0809566-4A97-3483-B2F1-2D7FEDD703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02660"/>
              </p:ext>
            </p:extLst>
          </p:nvPr>
        </p:nvGraphicFramePr>
        <p:xfrm>
          <a:off x="6160732" y="3014514"/>
          <a:ext cx="3582000" cy="275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5" name="Rectangle 54">
            <a:extLst>
              <a:ext uri="{FF2B5EF4-FFF2-40B4-BE49-F238E27FC236}">
                <a16:creationId xmlns:a16="http://schemas.microsoft.com/office/drawing/2014/main" id="{4506221F-A7F7-AD9F-1DB3-E01BFC4B596A}"/>
              </a:ext>
            </a:extLst>
          </p:cNvPr>
          <p:cNvSpPr/>
          <p:nvPr/>
        </p:nvSpPr>
        <p:spPr>
          <a:xfrm>
            <a:off x="9529077" y="294422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8B74A1B3-5299-2730-CE85-423ED89F8AC0}"/>
              </a:ext>
            </a:extLst>
          </p:cNvPr>
          <p:cNvSpPr/>
          <p:nvPr/>
        </p:nvSpPr>
        <p:spPr>
          <a:xfrm>
            <a:off x="9577939" y="3088853"/>
            <a:ext cx="150406" cy="24112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86543AC-8E7A-B72A-E731-B0AA9F3F814F}"/>
              </a:ext>
            </a:extLst>
          </p:cNvPr>
          <p:cNvCxnSpPr/>
          <p:nvPr/>
        </p:nvCxnSpPr>
        <p:spPr>
          <a:xfrm flipV="1">
            <a:off x="7132355" y="494228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A3D27BA1-BC6A-97C5-8150-2E87FD202BF3}"/>
              </a:ext>
            </a:extLst>
          </p:cNvPr>
          <p:cNvCxnSpPr/>
          <p:nvPr/>
        </p:nvCxnSpPr>
        <p:spPr>
          <a:xfrm flipV="1">
            <a:off x="6901357" y="49173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4B45502-378D-9E20-BB50-827881EBF533}"/>
              </a:ext>
            </a:extLst>
          </p:cNvPr>
          <p:cNvCxnSpPr/>
          <p:nvPr/>
        </p:nvCxnSpPr>
        <p:spPr>
          <a:xfrm flipV="1">
            <a:off x="6979282" y="495220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8616E84-C6AE-FBED-4255-8B0FBC2F8C93}"/>
              </a:ext>
            </a:extLst>
          </p:cNvPr>
          <p:cNvCxnSpPr/>
          <p:nvPr/>
        </p:nvCxnSpPr>
        <p:spPr>
          <a:xfrm flipV="1">
            <a:off x="7046171" y="496880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9B4D14C-5CA2-2764-25F2-5255155A4BC5}"/>
              </a:ext>
            </a:extLst>
          </p:cNvPr>
          <p:cNvCxnSpPr/>
          <p:nvPr/>
        </p:nvCxnSpPr>
        <p:spPr>
          <a:xfrm flipV="1">
            <a:off x="5285229" y="3375924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0E8CB44C-C569-6BF6-571C-1201D2F9F2E1}"/>
              </a:ext>
            </a:extLst>
          </p:cNvPr>
          <p:cNvCxnSpPr/>
          <p:nvPr/>
        </p:nvCxnSpPr>
        <p:spPr>
          <a:xfrm flipV="1">
            <a:off x="4788024" y="3375617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3E88E463-D862-FCA3-141C-8622B1EA6644}"/>
              </a:ext>
            </a:extLst>
          </p:cNvPr>
          <p:cNvCxnSpPr/>
          <p:nvPr/>
        </p:nvCxnSpPr>
        <p:spPr>
          <a:xfrm flipV="1">
            <a:off x="4738864" y="3375617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90DE02F-99D4-2AB4-F24B-045F280CF37B}"/>
              </a:ext>
            </a:extLst>
          </p:cNvPr>
          <p:cNvCxnSpPr/>
          <p:nvPr/>
        </p:nvCxnSpPr>
        <p:spPr>
          <a:xfrm flipV="1">
            <a:off x="4441965" y="337466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D7DBE9A-4A47-BFDF-D935-6DF21682EA79}"/>
              </a:ext>
            </a:extLst>
          </p:cNvPr>
          <p:cNvCxnSpPr/>
          <p:nvPr/>
        </p:nvCxnSpPr>
        <p:spPr>
          <a:xfrm flipV="1">
            <a:off x="4221959" y="494228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F70501B-6BE7-21D3-163B-C6FEC673B58A}"/>
              </a:ext>
            </a:extLst>
          </p:cNvPr>
          <p:cNvCxnSpPr/>
          <p:nvPr/>
        </p:nvCxnSpPr>
        <p:spPr>
          <a:xfrm flipV="1">
            <a:off x="4884456" y="491738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3BE8A9A-76D7-1547-BD3A-6E8D38BEED3D}"/>
              </a:ext>
            </a:extLst>
          </p:cNvPr>
          <p:cNvCxnSpPr/>
          <p:nvPr/>
        </p:nvCxnSpPr>
        <p:spPr>
          <a:xfrm flipV="1">
            <a:off x="4854233" y="494913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07DF8202-C515-4B2D-46DA-8EFEAB8AAF8F}"/>
              </a:ext>
            </a:extLst>
          </p:cNvPr>
          <p:cNvCxnSpPr/>
          <p:nvPr/>
        </p:nvCxnSpPr>
        <p:spPr>
          <a:xfrm flipV="1">
            <a:off x="5093984" y="494913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4A34F09-F3AC-E7F6-9752-A6F1B53B8F01}"/>
              </a:ext>
            </a:extLst>
          </p:cNvPr>
          <p:cNvCxnSpPr/>
          <p:nvPr/>
        </p:nvCxnSpPr>
        <p:spPr>
          <a:xfrm flipV="1">
            <a:off x="8179061" y="3362610"/>
            <a:ext cx="0" cy="1997476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5EB4578-BB1F-A26A-5AD0-46D2F632E3D4}"/>
              </a:ext>
            </a:extLst>
          </p:cNvPr>
          <p:cNvCxnSpPr/>
          <p:nvPr/>
        </p:nvCxnSpPr>
        <p:spPr>
          <a:xfrm flipV="1">
            <a:off x="7609623" y="3362610"/>
            <a:ext cx="0" cy="1997476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E781E53-7F01-1B21-D350-F7F753886037}"/>
              </a:ext>
            </a:extLst>
          </p:cNvPr>
          <p:cNvCxnSpPr/>
          <p:nvPr/>
        </p:nvCxnSpPr>
        <p:spPr>
          <a:xfrm flipV="1">
            <a:off x="7371910" y="3362610"/>
            <a:ext cx="0" cy="1997476"/>
          </a:xfrm>
          <a:prstGeom prst="line">
            <a:avLst/>
          </a:prstGeom>
          <a:ln w="19050"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D2F560F-6688-B7CC-550D-85E5DB6007CF}"/>
              </a:ext>
            </a:extLst>
          </p:cNvPr>
          <p:cNvCxnSpPr/>
          <p:nvPr/>
        </p:nvCxnSpPr>
        <p:spPr>
          <a:xfrm flipV="1">
            <a:off x="7669702" y="3362610"/>
            <a:ext cx="0" cy="19974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134368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3F57A089-64AE-A2A5-09EE-B1F6B43D2A64}"/>
              </a:ext>
            </a:extLst>
          </p:cNvPr>
          <p:cNvGraphicFramePr>
            <a:graphicFrameLocks/>
          </p:cNvGraphicFramePr>
          <p:nvPr/>
        </p:nvGraphicFramePr>
        <p:xfrm>
          <a:off x="2503020" y="2929060"/>
          <a:ext cx="3179619" cy="28943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2635EB16-D74C-3956-B3FE-5343F3D75B48}"/>
              </a:ext>
            </a:extLst>
          </p:cNvPr>
          <p:cNvGraphicFramePr>
            <a:graphicFrameLocks/>
          </p:cNvGraphicFramePr>
          <p:nvPr/>
        </p:nvGraphicFramePr>
        <p:xfrm>
          <a:off x="9666683" y="3093705"/>
          <a:ext cx="350188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id="{C70F97A7-B443-C217-93F4-F7B73AF3A034}"/>
              </a:ext>
            </a:extLst>
          </p:cNvPr>
          <p:cNvGraphicFramePr>
            <a:graphicFrameLocks/>
          </p:cNvGraphicFramePr>
          <p:nvPr/>
        </p:nvGraphicFramePr>
        <p:xfrm>
          <a:off x="6995997" y="516910"/>
          <a:ext cx="307450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Graphique 9">
            <a:extLst>
              <a:ext uri="{FF2B5EF4-FFF2-40B4-BE49-F238E27FC236}">
                <a16:creationId xmlns:a16="http://schemas.microsoft.com/office/drawing/2014/main" id="{DDC688BE-1BE5-2865-DFAB-5A20B73A66C7}"/>
              </a:ext>
            </a:extLst>
          </p:cNvPr>
          <p:cNvGraphicFramePr>
            <a:graphicFrameLocks/>
          </p:cNvGraphicFramePr>
          <p:nvPr/>
        </p:nvGraphicFramePr>
        <p:xfrm>
          <a:off x="4768773" y="3135555"/>
          <a:ext cx="309532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2C1DF4DE-B114-D4FF-4632-CCAB4C7F51EB}"/>
              </a:ext>
            </a:extLst>
          </p:cNvPr>
          <p:cNvGraphicFramePr>
            <a:graphicFrameLocks/>
          </p:cNvGraphicFramePr>
          <p:nvPr/>
        </p:nvGraphicFramePr>
        <p:xfrm>
          <a:off x="7093766" y="3170582"/>
          <a:ext cx="296848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5" name="ZoneTexte 14">
            <a:extLst>
              <a:ext uri="{FF2B5EF4-FFF2-40B4-BE49-F238E27FC236}">
                <a16:creationId xmlns:a16="http://schemas.microsoft.com/office/drawing/2014/main" id="{D951A35D-3D66-1F79-F5CE-5B607D50E6A6}"/>
              </a:ext>
            </a:extLst>
          </p:cNvPr>
          <p:cNvSpPr txBox="1"/>
          <p:nvPr/>
        </p:nvSpPr>
        <p:spPr>
          <a:xfrm>
            <a:off x="519734" y="6123333"/>
            <a:ext cx="112992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S4: Relationships between shelf life-related traits in the two F2 populations. 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Top panels: ENEA. Bottom panels: INRAE. 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8770B514-8528-4FBD-BAE0-DAC76CCF0383}"/>
              </a:ext>
            </a:extLst>
          </p:cNvPr>
          <p:cNvGraphicFramePr>
            <a:graphicFrameLocks/>
          </p:cNvGraphicFramePr>
          <p:nvPr/>
        </p:nvGraphicFramePr>
        <p:xfrm>
          <a:off x="2331650" y="471894"/>
          <a:ext cx="3366995" cy="27029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6" name="Graphique 5">
            <a:extLst>
              <a:ext uri="{FF2B5EF4-FFF2-40B4-BE49-F238E27FC236}">
                <a16:creationId xmlns:a16="http://schemas.microsoft.com/office/drawing/2014/main" id="{624AC802-BEF5-68FF-5D2F-93365C7822F3}"/>
              </a:ext>
            </a:extLst>
          </p:cNvPr>
          <p:cNvGraphicFramePr/>
          <p:nvPr/>
        </p:nvGraphicFramePr>
        <p:xfrm>
          <a:off x="-97696" y="758536"/>
          <a:ext cx="2684318" cy="2389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8" name="Graphique 3">
            <a:extLst>
              <a:ext uri="{FF2B5EF4-FFF2-40B4-BE49-F238E27FC236}">
                <a16:creationId xmlns:a16="http://schemas.microsoft.com/office/drawing/2014/main" id="{1618213B-5187-55DD-9D33-7484E9E09815}"/>
              </a:ext>
            </a:extLst>
          </p:cNvPr>
          <p:cNvGraphicFramePr>
            <a:graphicFrameLocks/>
          </p:cNvGraphicFramePr>
          <p:nvPr/>
        </p:nvGraphicFramePr>
        <p:xfrm>
          <a:off x="-105581" y="3429746"/>
          <a:ext cx="2925957" cy="24102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F777B825-D02C-459C-2659-FC9F951352A6}"/>
              </a:ext>
            </a:extLst>
          </p:cNvPr>
          <p:cNvGraphicFramePr>
            <a:graphicFrameLocks/>
          </p:cNvGraphicFramePr>
          <p:nvPr/>
        </p:nvGraphicFramePr>
        <p:xfrm>
          <a:off x="9666682" y="442054"/>
          <a:ext cx="350188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86270E82-366A-2A62-61E7-BF4373AB947B}"/>
              </a:ext>
            </a:extLst>
          </p:cNvPr>
          <p:cNvGraphicFramePr>
            <a:graphicFrameLocks/>
          </p:cNvGraphicFramePr>
          <p:nvPr/>
        </p:nvGraphicFramePr>
        <p:xfrm>
          <a:off x="4646256" y="442054"/>
          <a:ext cx="29833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15966474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b4c89a4-2935-4f7f-9b17-1d3ec26de21c" xsi:nil="true"/>
    <lcf76f155ced4ddcb4097134ff3c332f xmlns="1345b2b1-df0f-4d21-b9c1-a75372490982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B17DED8ECD4EB34CB4E38E8FB54E556C" ma:contentTypeVersion="13" ma:contentTypeDescription="Creare un nuovo documento." ma:contentTypeScope="" ma:versionID="15151725bdd6d184541f8f57792602b1">
  <xsd:schema xmlns:xsd="http://www.w3.org/2001/XMLSchema" xmlns:xs="http://www.w3.org/2001/XMLSchema" xmlns:p="http://schemas.microsoft.com/office/2006/metadata/properties" xmlns:ns2="1345b2b1-df0f-4d21-b9c1-a75372490982" xmlns:ns3="2b4c89a4-2935-4f7f-9b17-1d3ec26de21c" targetNamespace="http://schemas.microsoft.com/office/2006/metadata/properties" ma:root="true" ma:fieldsID="95fb9f7c0c14440b50e4d3c83c269794" ns2:_="" ns3:_="">
    <xsd:import namespace="1345b2b1-df0f-4d21-b9c1-a75372490982"/>
    <xsd:import namespace="2b4c89a4-2935-4f7f-9b17-1d3ec26de21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45b2b1-df0f-4d21-b9c1-a7537249098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Tag immagine" ma:readOnly="false" ma:fieldId="{5cf76f15-5ced-4ddc-b409-7134ff3c332f}" ma:taxonomyMulti="true" ma:sspId="8dc55828-5dba-4680-8107-5c5d85fd546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b4c89a4-2935-4f7f-9b17-1d3ec26de21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8effc3c6-1f67-4cbf-b210-d452f4464484}" ma:internalName="TaxCatchAll" ma:showField="CatchAllData" ma:web="2b4c89a4-2935-4f7f-9b17-1d3ec26de21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3D04D03-8B95-45C9-9C38-7EB7FEB01D7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CB017E5-12FC-48C8-A2B8-CB20B2FCCD8E}">
  <ds:schemaRefs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purl.org/dc/dcmitype/"/>
    <ds:schemaRef ds:uri="http://schemas.microsoft.com/office/infopath/2007/PartnerControls"/>
    <ds:schemaRef ds:uri="2b4c89a4-2935-4f7f-9b17-1d3ec26de21c"/>
    <ds:schemaRef ds:uri="http://schemas.openxmlformats.org/package/2006/metadata/core-properties"/>
    <ds:schemaRef ds:uri="1345b2b1-df0f-4d21-b9c1-a75372490982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40192973-B9D4-4FF2-9D03-2D0197D5DD4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45b2b1-df0f-4d21-b9c1-a75372490982"/>
    <ds:schemaRef ds:uri="2b4c89a4-2935-4f7f-9b17-1d3ec26de21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148</TotalTime>
  <Words>2020</Words>
  <Application>Microsoft Macintosh PowerPoint</Application>
  <PresentationFormat>Grand écran</PresentationFormat>
  <Paragraphs>358</Paragraphs>
  <Slides>1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Présentation PowerPoint</vt:lpstr>
      <vt:lpstr>Présentation PowerPoint</vt:lpstr>
      <vt:lpstr>Présentation PowerPoint</vt:lpstr>
      <vt:lpstr>Présentation PowerPoint</vt:lpstr>
      <vt:lpstr>Supplementary Figures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o Rosati</dc:creator>
  <cp:lastModifiedBy>Mathilde Causse</cp:lastModifiedBy>
  <cp:revision>503</cp:revision>
  <cp:lastPrinted>2026-04-16T07:30:42Z</cp:lastPrinted>
  <dcterms:created xsi:type="dcterms:W3CDTF">2025-02-03T14:44:15Z</dcterms:created>
  <dcterms:modified xsi:type="dcterms:W3CDTF">2026-07-22T09:45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17DED8ECD4EB34CB4E38E8FB54E556C</vt:lpwstr>
  </property>
  <property fmtid="{D5CDD505-2E9C-101B-9397-08002B2CF9AE}" pid="3" name="MediaServiceImageTags">
    <vt:lpwstr/>
  </property>
</Properties>
</file>